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 id="2147483660" r:id="rId2"/>
  </p:sldMasterIdLst>
  <p:notesMasterIdLst>
    <p:notesMasterId r:id="rId19"/>
  </p:notesMasterIdLst>
  <p:sldIdLst>
    <p:sldId id="266" r:id="rId3"/>
    <p:sldId id="257" r:id="rId4"/>
    <p:sldId id="259" r:id="rId5"/>
    <p:sldId id="260" r:id="rId6"/>
    <p:sldId id="261" r:id="rId7"/>
    <p:sldId id="262" r:id="rId8"/>
    <p:sldId id="264" r:id="rId9"/>
    <p:sldId id="265" r:id="rId10"/>
    <p:sldId id="267" r:id="rId11"/>
    <p:sldId id="268" r:id="rId12"/>
    <p:sldId id="269" r:id="rId13"/>
    <p:sldId id="270" r:id="rId14"/>
    <p:sldId id="263" r:id="rId15"/>
    <p:sldId id="271" r:id="rId16"/>
    <p:sldId id="272" r:id="rId17"/>
    <p:sldId id="273" r:id="rId18"/>
  </p:sldIdLst>
  <p:sldSz cx="9601200" cy="12801600" type="A3"/>
  <p:notesSz cx="9801225" cy="14357350"/>
  <p:defaultTextStyle>
    <a:defPPr>
      <a:defRPr lang="ko-KR"/>
    </a:defPPr>
    <a:lvl1pPr marL="0" algn="l" defTabSz="1279953" rtl="0" eaLnBrk="1" latinLnBrk="1" hangingPunct="1">
      <a:defRPr sz="2500" kern="1200">
        <a:solidFill>
          <a:schemeClr val="tx1"/>
        </a:solidFill>
        <a:latin typeface="+mn-lt"/>
        <a:ea typeface="+mn-ea"/>
        <a:cs typeface="+mn-cs"/>
      </a:defRPr>
    </a:lvl1pPr>
    <a:lvl2pPr marL="639976" algn="l" defTabSz="1279953" rtl="0" eaLnBrk="1" latinLnBrk="1" hangingPunct="1">
      <a:defRPr sz="2500" kern="1200">
        <a:solidFill>
          <a:schemeClr val="tx1"/>
        </a:solidFill>
        <a:latin typeface="+mn-lt"/>
        <a:ea typeface="+mn-ea"/>
        <a:cs typeface="+mn-cs"/>
      </a:defRPr>
    </a:lvl2pPr>
    <a:lvl3pPr marL="1279953" algn="l" defTabSz="1279953" rtl="0" eaLnBrk="1" latinLnBrk="1" hangingPunct="1">
      <a:defRPr sz="2500" kern="1200">
        <a:solidFill>
          <a:schemeClr val="tx1"/>
        </a:solidFill>
        <a:latin typeface="+mn-lt"/>
        <a:ea typeface="+mn-ea"/>
        <a:cs typeface="+mn-cs"/>
      </a:defRPr>
    </a:lvl3pPr>
    <a:lvl4pPr marL="1919929" algn="l" defTabSz="1279953" rtl="0" eaLnBrk="1" latinLnBrk="1" hangingPunct="1">
      <a:defRPr sz="2500" kern="1200">
        <a:solidFill>
          <a:schemeClr val="tx1"/>
        </a:solidFill>
        <a:latin typeface="+mn-lt"/>
        <a:ea typeface="+mn-ea"/>
        <a:cs typeface="+mn-cs"/>
      </a:defRPr>
    </a:lvl4pPr>
    <a:lvl5pPr marL="2559906" algn="l" defTabSz="1279953" rtl="0" eaLnBrk="1" latinLnBrk="1" hangingPunct="1">
      <a:defRPr sz="2500" kern="1200">
        <a:solidFill>
          <a:schemeClr val="tx1"/>
        </a:solidFill>
        <a:latin typeface="+mn-lt"/>
        <a:ea typeface="+mn-ea"/>
        <a:cs typeface="+mn-cs"/>
      </a:defRPr>
    </a:lvl5pPr>
    <a:lvl6pPr marL="3199882" algn="l" defTabSz="1279953" rtl="0" eaLnBrk="1" latinLnBrk="1" hangingPunct="1">
      <a:defRPr sz="2500" kern="1200">
        <a:solidFill>
          <a:schemeClr val="tx1"/>
        </a:solidFill>
        <a:latin typeface="+mn-lt"/>
        <a:ea typeface="+mn-ea"/>
        <a:cs typeface="+mn-cs"/>
      </a:defRPr>
    </a:lvl6pPr>
    <a:lvl7pPr marL="3839859" algn="l" defTabSz="1279953" rtl="0" eaLnBrk="1" latinLnBrk="1" hangingPunct="1">
      <a:defRPr sz="2500" kern="1200">
        <a:solidFill>
          <a:schemeClr val="tx1"/>
        </a:solidFill>
        <a:latin typeface="+mn-lt"/>
        <a:ea typeface="+mn-ea"/>
        <a:cs typeface="+mn-cs"/>
      </a:defRPr>
    </a:lvl7pPr>
    <a:lvl8pPr marL="4479835" algn="l" defTabSz="1279953" rtl="0" eaLnBrk="1" latinLnBrk="1" hangingPunct="1">
      <a:defRPr sz="2500" kern="1200">
        <a:solidFill>
          <a:schemeClr val="tx1"/>
        </a:solidFill>
        <a:latin typeface="+mn-lt"/>
        <a:ea typeface="+mn-ea"/>
        <a:cs typeface="+mn-cs"/>
      </a:defRPr>
    </a:lvl8pPr>
    <a:lvl9pPr marL="5119812" algn="l" defTabSz="1279953" rtl="0" eaLnBrk="1" latinLnBrk="1" hangingPunct="1">
      <a:defRPr sz="25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4032">
          <p15:clr>
            <a:srgbClr val="A4A3A4"/>
          </p15:clr>
        </p15:guide>
        <p15:guide id="2" pos="4748">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1358B"/>
    <a:srgbClr val="689E1D"/>
    <a:srgbClr val="85C01D"/>
    <a:srgbClr val="363636"/>
    <a:srgbClr val="B1C803"/>
    <a:srgbClr val="FF998E"/>
    <a:srgbClr val="106E0E"/>
    <a:srgbClr val="FDF001"/>
    <a:srgbClr val="FDFA01"/>
    <a:srgbClr val="0DC00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2621" autoAdjust="0"/>
    <p:restoredTop sz="94625" autoAdjust="0"/>
  </p:normalViewPr>
  <p:slideViewPr>
    <p:cSldViewPr showGuides="1">
      <p:cViewPr varScale="1">
        <p:scale>
          <a:sx n="55" d="100"/>
          <a:sy n="55" d="100"/>
        </p:scale>
        <p:origin x="2136" y="102"/>
      </p:cViewPr>
      <p:guideLst>
        <p:guide orient="horz" pos="4032"/>
        <p:guide pos="4748"/>
      </p:guideLst>
    </p:cSldViewPr>
  </p:slideViewPr>
  <p:outlineViewPr>
    <p:cViewPr>
      <p:scale>
        <a:sx n="33" d="100"/>
        <a:sy n="33" d="100"/>
      </p:scale>
      <p:origin x="0" y="0"/>
    </p:cViewPr>
  </p:outlin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slide" Target="slides/slide11.xml"/><Relationship Id="rId18" Type="http://schemas.openxmlformats.org/officeDocument/2006/relationships/slide" Target="slides/slide16.xml"/><Relationship Id="rId3" Type="http://schemas.openxmlformats.org/officeDocument/2006/relationships/slide" Target="slides/slide1.xml"/><Relationship Id="rId21" Type="http://schemas.openxmlformats.org/officeDocument/2006/relationships/viewProps" Target="viewProps.xml"/><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slide" Target="slides/slide15.xml"/><Relationship Id="rId2" Type="http://schemas.openxmlformats.org/officeDocument/2006/relationships/slideMaster" Target="slideMasters/slideMaster2.xml"/><Relationship Id="rId16" Type="http://schemas.openxmlformats.org/officeDocument/2006/relationships/slide" Target="slides/slide14.xml"/><Relationship Id="rId20"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5" Type="http://schemas.openxmlformats.org/officeDocument/2006/relationships/slide" Target="slides/slide3.xml"/><Relationship Id="rId15" Type="http://schemas.openxmlformats.org/officeDocument/2006/relationships/slide" Target="slides/slide13.xml"/><Relationship Id="rId23" Type="http://schemas.openxmlformats.org/officeDocument/2006/relationships/tableStyles" Target="tableStyles.xml"/><Relationship Id="rId10" Type="http://schemas.openxmlformats.org/officeDocument/2006/relationships/slide" Target="slides/slide8.xml"/><Relationship Id="rId19" Type="http://schemas.openxmlformats.org/officeDocument/2006/relationships/notesMaster" Target="notesMasters/notesMaster1.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4246884" cy="717550"/>
          </a:xfrm>
          <a:prstGeom prst="rect">
            <a:avLst/>
          </a:prstGeom>
        </p:spPr>
        <p:txBody>
          <a:bodyPr vert="horz" lIns="91440" tIns="45720" rIns="91440" bIns="45720" rtlCol="0"/>
          <a:lstStyle>
            <a:lvl1pPr algn="l">
              <a:defRPr sz="1200"/>
            </a:lvl1pPr>
          </a:lstStyle>
          <a:p>
            <a:endParaRPr lang="ko-KR" altLang="en-US"/>
          </a:p>
        </p:txBody>
      </p:sp>
      <p:sp>
        <p:nvSpPr>
          <p:cNvPr id="3" name="날짜 개체 틀 2"/>
          <p:cNvSpPr>
            <a:spLocks noGrp="1"/>
          </p:cNvSpPr>
          <p:nvPr>
            <p:ph type="dt" idx="1"/>
          </p:nvPr>
        </p:nvSpPr>
        <p:spPr>
          <a:xfrm>
            <a:off x="5551206" y="0"/>
            <a:ext cx="4248452" cy="717550"/>
          </a:xfrm>
          <a:prstGeom prst="rect">
            <a:avLst/>
          </a:prstGeom>
        </p:spPr>
        <p:txBody>
          <a:bodyPr vert="horz" lIns="91440" tIns="45720" rIns="91440" bIns="45720" rtlCol="0"/>
          <a:lstStyle>
            <a:lvl1pPr algn="r">
              <a:defRPr sz="1200"/>
            </a:lvl1pPr>
          </a:lstStyle>
          <a:p>
            <a:fld id="{8E1943AA-A7AF-4987-8E05-4B8AF4059E1A}" type="datetimeFigureOut">
              <a:rPr lang="ko-KR" altLang="en-US" smtClean="0"/>
              <a:pPr/>
              <a:t>2024-12-11</a:t>
            </a:fld>
            <a:endParaRPr lang="ko-KR" altLang="en-US"/>
          </a:p>
        </p:txBody>
      </p:sp>
      <p:sp>
        <p:nvSpPr>
          <p:cNvPr id="4" name="슬라이드 이미지 개체 틀 3"/>
          <p:cNvSpPr>
            <a:spLocks noGrp="1" noRot="1" noChangeAspect="1"/>
          </p:cNvSpPr>
          <p:nvPr>
            <p:ph type="sldImg" idx="2"/>
          </p:nvPr>
        </p:nvSpPr>
        <p:spPr>
          <a:xfrm>
            <a:off x="2881313" y="1076325"/>
            <a:ext cx="4038600" cy="5384800"/>
          </a:xfrm>
          <a:prstGeom prst="rect">
            <a:avLst/>
          </a:prstGeom>
          <a:noFill/>
          <a:ln w="12700">
            <a:solidFill>
              <a:prstClr val="black"/>
            </a:solidFill>
          </a:ln>
        </p:spPr>
        <p:txBody>
          <a:bodyPr vert="horz" lIns="91440" tIns="45720" rIns="91440" bIns="45720" rtlCol="0" anchor="ctr"/>
          <a:lstStyle/>
          <a:p>
            <a:endParaRPr lang="ko-KR" altLang="en-US"/>
          </a:p>
        </p:txBody>
      </p:sp>
      <p:sp>
        <p:nvSpPr>
          <p:cNvPr id="5" name="슬라이드 노트 개체 틀 4"/>
          <p:cNvSpPr>
            <a:spLocks noGrp="1"/>
          </p:cNvSpPr>
          <p:nvPr>
            <p:ph type="body" sz="quarter" idx="3"/>
          </p:nvPr>
        </p:nvSpPr>
        <p:spPr>
          <a:xfrm>
            <a:off x="979810" y="6819901"/>
            <a:ext cx="7841607" cy="6461125"/>
          </a:xfrm>
          <a:prstGeom prst="rect">
            <a:avLst/>
          </a:prstGeom>
        </p:spPr>
        <p:txBody>
          <a:bodyPr vert="horz" lIns="91440" tIns="45720" rIns="91440" bIns="45720" rtlCol="0"/>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6" name="바닥글 개체 틀 5"/>
          <p:cNvSpPr>
            <a:spLocks noGrp="1"/>
          </p:cNvSpPr>
          <p:nvPr>
            <p:ph type="ftr" sz="quarter" idx="4"/>
          </p:nvPr>
        </p:nvSpPr>
        <p:spPr>
          <a:xfrm>
            <a:off x="0" y="13636625"/>
            <a:ext cx="4246884" cy="717550"/>
          </a:xfrm>
          <a:prstGeom prst="rect">
            <a:avLst/>
          </a:prstGeom>
        </p:spPr>
        <p:txBody>
          <a:bodyPr vert="horz" lIns="91440" tIns="45720" rIns="91440" bIns="45720"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5551206" y="13636625"/>
            <a:ext cx="4248452" cy="717550"/>
          </a:xfrm>
          <a:prstGeom prst="rect">
            <a:avLst/>
          </a:prstGeom>
        </p:spPr>
        <p:txBody>
          <a:bodyPr vert="horz" lIns="91440" tIns="45720" rIns="91440" bIns="45720" rtlCol="0" anchor="b"/>
          <a:lstStyle>
            <a:lvl1pPr algn="r">
              <a:defRPr sz="1200"/>
            </a:lvl1pPr>
          </a:lstStyle>
          <a:p>
            <a:fld id="{6B40C71C-3F70-4CE3-9C29-719AB599846E}" type="slidenum">
              <a:rPr lang="ko-KR" altLang="en-US" smtClean="0"/>
              <a:pPr/>
              <a:t>‹#›</a:t>
            </a:fld>
            <a:endParaRPr lang="ko-KR" altLang="en-US"/>
          </a:p>
        </p:txBody>
      </p:sp>
    </p:spTree>
    <p:extLst>
      <p:ext uri="{BB962C8B-B14F-4D97-AF65-F5344CB8AC3E}">
        <p14:creationId xmlns:p14="http://schemas.microsoft.com/office/powerpoint/2010/main" val="679038556"/>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a:p>
        </p:txBody>
      </p:sp>
      <p:sp>
        <p:nvSpPr>
          <p:cNvPr id="4" name="슬라이드 번호 개체 틀 3"/>
          <p:cNvSpPr>
            <a:spLocks noGrp="1"/>
          </p:cNvSpPr>
          <p:nvPr>
            <p:ph type="sldNum" sz="quarter" idx="10"/>
          </p:nvPr>
        </p:nvSpPr>
        <p:spPr/>
        <p:txBody>
          <a:bodyPr/>
          <a:lstStyle/>
          <a:p>
            <a:fld id="{6B40C71C-3F70-4CE3-9C29-719AB599846E}" type="slidenum">
              <a:rPr lang="ko-KR" altLang="en-US" smtClean="0"/>
              <a:pPr/>
              <a:t>2</a:t>
            </a:fld>
            <a:endParaRPr lang="ko-KR" altLang="en-US"/>
          </a:p>
        </p:txBody>
      </p:sp>
    </p:spTree>
    <p:extLst>
      <p:ext uri="{BB962C8B-B14F-4D97-AF65-F5344CB8AC3E}">
        <p14:creationId xmlns:p14="http://schemas.microsoft.com/office/powerpoint/2010/main" val="232371461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a:p>
        </p:txBody>
      </p:sp>
      <p:sp>
        <p:nvSpPr>
          <p:cNvPr id="4" name="슬라이드 번호 개체 틀 3"/>
          <p:cNvSpPr>
            <a:spLocks noGrp="1"/>
          </p:cNvSpPr>
          <p:nvPr>
            <p:ph type="sldNum" sz="quarter" idx="10"/>
          </p:nvPr>
        </p:nvSpPr>
        <p:spPr/>
        <p:txBody>
          <a:bodyPr/>
          <a:lstStyle/>
          <a:p>
            <a:fld id="{6B40C71C-3F70-4CE3-9C29-719AB599846E}" type="slidenum">
              <a:rPr lang="ko-KR" altLang="en-US" smtClean="0"/>
              <a:pPr/>
              <a:t>3</a:t>
            </a:fld>
            <a:endParaRPr lang="ko-KR" altLang="en-US"/>
          </a:p>
        </p:txBody>
      </p:sp>
    </p:spTree>
    <p:extLst>
      <p:ext uri="{BB962C8B-B14F-4D97-AF65-F5344CB8AC3E}">
        <p14:creationId xmlns:p14="http://schemas.microsoft.com/office/powerpoint/2010/main" val="232371461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a:p>
        </p:txBody>
      </p:sp>
      <p:sp>
        <p:nvSpPr>
          <p:cNvPr id="4" name="슬라이드 번호 개체 틀 3"/>
          <p:cNvSpPr>
            <a:spLocks noGrp="1"/>
          </p:cNvSpPr>
          <p:nvPr>
            <p:ph type="sldNum" sz="quarter" idx="10"/>
          </p:nvPr>
        </p:nvSpPr>
        <p:spPr/>
        <p:txBody>
          <a:bodyPr/>
          <a:lstStyle/>
          <a:p>
            <a:fld id="{6B40C71C-3F70-4CE3-9C29-719AB599846E}" type="slidenum">
              <a:rPr lang="ko-KR" altLang="en-US" smtClean="0"/>
              <a:pPr/>
              <a:t>4</a:t>
            </a:fld>
            <a:endParaRPr lang="ko-KR" altLang="en-US"/>
          </a:p>
        </p:txBody>
      </p:sp>
    </p:spTree>
    <p:extLst>
      <p:ext uri="{BB962C8B-B14F-4D97-AF65-F5344CB8AC3E}">
        <p14:creationId xmlns:p14="http://schemas.microsoft.com/office/powerpoint/2010/main" val="232371461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a:p>
        </p:txBody>
      </p:sp>
      <p:sp>
        <p:nvSpPr>
          <p:cNvPr id="4" name="슬라이드 번호 개체 틀 3"/>
          <p:cNvSpPr>
            <a:spLocks noGrp="1"/>
          </p:cNvSpPr>
          <p:nvPr>
            <p:ph type="sldNum" sz="quarter" idx="10"/>
          </p:nvPr>
        </p:nvSpPr>
        <p:spPr/>
        <p:txBody>
          <a:bodyPr/>
          <a:lstStyle/>
          <a:p>
            <a:fld id="{6B40C71C-3F70-4CE3-9C29-719AB599846E}" type="slidenum">
              <a:rPr lang="ko-KR" altLang="en-US" smtClean="0"/>
              <a:pPr/>
              <a:t>5</a:t>
            </a:fld>
            <a:endParaRPr lang="ko-KR" altLang="en-US"/>
          </a:p>
        </p:txBody>
      </p:sp>
    </p:spTree>
    <p:extLst>
      <p:ext uri="{BB962C8B-B14F-4D97-AF65-F5344CB8AC3E}">
        <p14:creationId xmlns:p14="http://schemas.microsoft.com/office/powerpoint/2010/main" val="232371461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a:p>
        </p:txBody>
      </p:sp>
      <p:sp>
        <p:nvSpPr>
          <p:cNvPr id="4" name="슬라이드 번호 개체 틀 3"/>
          <p:cNvSpPr>
            <a:spLocks noGrp="1"/>
          </p:cNvSpPr>
          <p:nvPr>
            <p:ph type="sldNum" sz="quarter" idx="10"/>
          </p:nvPr>
        </p:nvSpPr>
        <p:spPr/>
        <p:txBody>
          <a:bodyPr/>
          <a:lstStyle/>
          <a:p>
            <a:fld id="{6B40C71C-3F70-4CE3-9C29-719AB599846E}" type="slidenum">
              <a:rPr lang="ko-KR" altLang="en-US" smtClean="0"/>
              <a:pPr/>
              <a:t>6</a:t>
            </a:fld>
            <a:endParaRPr lang="ko-KR" altLang="en-US"/>
          </a:p>
        </p:txBody>
      </p:sp>
    </p:spTree>
    <p:extLst>
      <p:ext uri="{BB962C8B-B14F-4D97-AF65-F5344CB8AC3E}">
        <p14:creationId xmlns:p14="http://schemas.microsoft.com/office/powerpoint/2010/main" val="232371461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a:p>
        </p:txBody>
      </p:sp>
      <p:sp>
        <p:nvSpPr>
          <p:cNvPr id="4" name="슬라이드 번호 개체 틀 3"/>
          <p:cNvSpPr>
            <a:spLocks noGrp="1"/>
          </p:cNvSpPr>
          <p:nvPr>
            <p:ph type="sldNum" sz="quarter" idx="10"/>
          </p:nvPr>
        </p:nvSpPr>
        <p:spPr/>
        <p:txBody>
          <a:bodyPr/>
          <a:lstStyle/>
          <a:p>
            <a:fld id="{6B40C71C-3F70-4CE3-9C29-719AB599846E}" type="slidenum">
              <a:rPr lang="ko-KR" altLang="en-US" smtClean="0"/>
              <a:pPr/>
              <a:t>7</a:t>
            </a:fld>
            <a:endParaRPr lang="ko-KR" altLang="en-US"/>
          </a:p>
        </p:txBody>
      </p:sp>
    </p:spTree>
    <p:extLst>
      <p:ext uri="{BB962C8B-B14F-4D97-AF65-F5344CB8AC3E}">
        <p14:creationId xmlns:p14="http://schemas.microsoft.com/office/powerpoint/2010/main" val="2323714618"/>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a:p>
        </p:txBody>
      </p:sp>
      <p:sp>
        <p:nvSpPr>
          <p:cNvPr id="4" name="슬라이드 번호 개체 틀 3"/>
          <p:cNvSpPr>
            <a:spLocks noGrp="1"/>
          </p:cNvSpPr>
          <p:nvPr>
            <p:ph type="sldNum" sz="quarter" idx="10"/>
          </p:nvPr>
        </p:nvSpPr>
        <p:spPr/>
        <p:txBody>
          <a:bodyPr/>
          <a:lstStyle/>
          <a:p>
            <a:fld id="{6B40C71C-3F70-4CE3-9C29-719AB599846E}" type="slidenum">
              <a:rPr lang="ko-KR" altLang="en-US" smtClean="0"/>
              <a:pPr/>
              <a:t>8</a:t>
            </a:fld>
            <a:endParaRPr lang="ko-KR" altLang="en-US"/>
          </a:p>
        </p:txBody>
      </p:sp>
    </p:spTree>
    <p:extLst>
      <p:ext uri="{BB962C8B-B14F-4D97-AF65-F5344CB8AC3E}">
        <p14:creationId xmlns:p14="http://schemas.microsoft.com/office/powerpoint/2010/main" val="232371461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p:cNvSpPr>
            <a:spLocks noGrp="1"/>
          </p:cNvSpPr>
          <p:nvPr>
            <p:ph type="ctrTitle"/>
          </p:nvPr>
        </p:nvSpPr>
        <p:spPr>
          <a:xfrm>
            <a:off x="720090" y="3976796"/>
            <a:ext cx="8161020" cy="2744046"/>
          </a:xfrm>
        </p:spPr>
        <p:txBody>
          <a:bodyPr/>
          <a:lstStyle/>
          <a:p>
            <a:r>
              <a:rPr lang="ko-KR" altLang="en-US"/>
              <a:t>마스터 제목 스타일 편집</a:t>
            </a:r>
          </a:p>
        </p:txBody>
      </p:sp>
      <p:sp>
        <p:nvSpPr>
          <p:cNvPr id="3" name="부제목 2"/>
          <p:cNvSpPr>
            <a:spLocks noGrp="1"/>
          </p:cNvSpPr>
          <p:nvPr>
            <p:ph type="subTitle" idx="1"/>
          </p:nvPr>
        </p:nvSpPr>
        <p:spPr>
          <a:xfrm>
            <a:off x="1440180" y="7254240"/>
            <a:ext cx="6720840" cy="3271520"/>
          </a:xfrm>
        </p:spPr>
        <p:txBody>
          <a:bodyPr/>
          <a:lstStyle>
            <a:lvl1pPr marL="0" indent="0" algn="ctr">
              <a:buNone/>
              <a:defRPr>
                <a:solidFill>
                  <a:schemeClr val="tx1">
                    <a:tint val="75000"/>
                  </a:schemeClr>
                </a:solidFill>
              </a:defRPr>
            </a:lvl1pPr>
            <a:lvl2pPr marL="639976" indent="0" algn="ctr">
              <a:buNone/>
              <a:defRPr>
                <a:solidFill>
                  <a:schemeClr val="tx1">
                    <a:tint val="75000"/>
                  </a:schemeClr>
                </a:solidFill>
              </a:defRPr>
            </a:lvl2pPr>
            <a:lvl3pPr marL="1279953" indent="0" algn="ctr">
              <a:buNone/>
              <a:defRPr>
                <a:solidFill>
                  <a:schemeClr val="tx1">
                    <a:tint val="75000"/>
                  </a:schemeClr>
                </a:solidFill>
              </a:defRPr>
            </a:lvl3pPr>
            <a:lvl4pPr marL="1919929" indent="0" algn="ctr">
              <a:buNone/>
              <a:defRPr>
                <a:solidFill>
                  <a:schemeClr val="tx1">
                    <a:tint val="75000"/>
                  </a:schemeClr>
                </a:solidFill>
              </a:defRPr>
            </a:lvl4pPr>
            <a:lvl5pPr marL="2559906" indent="0" algn="ctr">
              <a:buNone/>
              <a:defRPr>
                <a:solidFill>
                  <a:schemeClr val="tx1">
                    <a:tint val="75000"/>
                  </a:schemeClr>
                </a:solidFill>
              </a:defRPr>
            </a:lvl5pPr>
            <a:lvl6pPr marL="3199882" indent="0" algn="ctr">
              <a:buNone/>
              <a:defRPr>
                <a:solidFill>
                  <a:schemeClr val="tx1">
                    <a:tint val="75000"/>
                  </a:schemeClr>
                </a:solidFill>
              </a:defRPr>
            </a:lvl6pPr>
            <a:lvl7pPr marL="3839859" indent="0" algn="ctr">
              <a:buNone/>
              <a:defRPr>
                <a:solidFill>
                  <a:schemeClr val="tx1">
                    <a:tint val="75000"/>
                  </a:schemeClr>
                </a:solidFill>
              </a:defRPr>
            </a:lvl7pPr>
            <a:lvl8pPr marL="4479835" indent="0" algn="ctr">
              <a:buNone/>
              <a:defRPr>
                <a:solidFill>
                  <a:schemeClr val="tx1">
                    <a:tint val="75000"/>
                  </a:schemeClr>
                </a:solidFill>
              </a:defRPr>
            </a:lvl8pPr>
            <a:lvl9pPr marL="5119812" indent="0" algn="ctr">
              <a:buNone/>
              <a:defRPr>
                <a:solidFill>
                  <a:schemeClr val="tx1">
                    <a:tint val="75000"/>
                  </a:schemeClr>
                </a:solidFill>
              </a:defRPr>
            </a:lvl9pPr>
          </a:lstStyle>
          <a:p>
            <a:r>
              <a:rPr lang="ko-KR" altLang="en-US"/>
              <a:t>마스터 부제목 스타일 편집</a:t>
            </a:r>
          </a:p>
        </p:txBody>
      </p:sp>
      <p:sp>
        <p:nvSpPr>
          <p:cNvPr id="4" name="날짜 개체 틀 3"/>
          <p:cNvSpPr>
            <a:spLocks noGrp="1"/>
          </p:cNvSpPr>
          <p:nvPr>
            <p:ph type="dt" sz="half" idx="10"/>
          </p:nvPr>
        </p:nvSpPr>
        <p:spPr/>
        <p:txBody>
          <a:bodyPr/>
          <a:lstStyle/>
          <a:p>
            <a:fld id="{FC75D36E-F5BB-47E1-8CF6-197642BF9C69}" type="datetimeFigureOut">
              <a:rPr lang="ko-KR" altLang="en-US" smtClean="0"/>
              <a:pPr/>
              <a:t>2024-12-11</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BFDFE31A-9D4B-4AD2-9F2E-CC153BB0E734}" type="slidenum">
              <a:rPr lang="ko-KR" altLang="en-US" smtClean="0"/>
              <a:pPr/>
              <a:t>‹#›</a:t>
            </a:fld>
            <a:endParaRPr lang="ko-KR" altLang="en-US"/>
          </a:p>
        </p:txBody>
      </p:sp>
    </p:spTree>
    <p:extLst>
      <p:ext uri="{BB962C8B-B14F-4D97-AF65-F5344CB8AC3E}">
        <p14:creationId xmlns:p14="http://schemas.microsoft.com/office/powerpoint/2010/main" val="86845902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세로 텍스트 개체 틀 2"/>
          <p:cNvSpPr>
            <a:spLocks noGrp="1"/>
          </p:cNvSpPr>
          <p:nvPr>
            <p:ph type="body" orient="vert" idx="1"/>
          </p:nvPr>
        </p:nvSpPr>
        <p:spPr/>
        <p:txBody>
          <a:bodyPr vert="eaVert"/>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p:cNvSpPr>
            <a:spLocks noGrp="1"/>
          </p:cNvSpPr>
          <p:nvPr>
            <p:ph type="dt" sz="half" idx="10"/>
          </p:nvPr>
        </p:nvSpPr>
        <p:spPr/>
        <p:txBody>
          <a:bodyPr/>
          <a:lstStyle/>
          <a:p>
            <a:fld id="{FC75D36E-F5BB-47E1-8CF6-197642BF9C69}" type="datetimeFigureOut">
              <a:rPr lang="ko-KR" altLang="en-US" smtClean="0"/>
              <a:pPr/>
              <a:t>2024-12-11</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BFDFE31A-9D4B-4AD2-9F2E-CC153BB0E734}" type="slidenum">
              <a:rPr lang="ko-KR" altLang="en-US" smtClean="0"/>
              <a:pPr/>
              <a:t>‹#›</a:t>
            </a:fld>
            <a:endParaRPr lang="ko-KR" altLang="en-US"/>
          </a:p>
        </p:txBody>
      </p:sp>
    </p:spTree>
    <p:extLst>
      <p:ext uri="{BB962C8B-B14F-4D97-AF65-F5344CB8AC3E}">
        <p14:creationId xmlns:p14="http://schemas.microsoft.com/office/powerpoint/2010/main" val="49938143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p:cNvSpPr>
            <a:spLocks noGrp="1"/>
          </p:cNvSpPr>
          <p:nvPr>
            <p:ph type="title" orient="vert"/>
          </p:nvPr>
        </p:nvSpPr>
        <p:spPr>
          <a:xfrm>
            <a:off x="6960870" y="512660"/>
            <a:ext cx="2160270" cy="10922846"/>
          </a:xfrm>
        </p:spPr>
        <p:txBody>
          <a:bodyPr vert="eaVert"/>
          <a:lstStyle/>
          <a:p>
            <a:r>
              <a:rPr lang="ko-KR" altLang="en-US"/>
              <a:t>마스터 제목 스타일 편집</a:t>
            </a:r>
          </a:p>
        </p:txBody>
      </p:sp>
      <p:sp>
        <p:nvSpPr>
          <p:cNvPr id="3" name="세로 텍스트 개체 틀 2"/>
          <p:cNvSpPr>
            <a:spLocks noGrp="1"/>
          </p:cNvSpPr>
          <p:nvPr>
            <p:ph type="body" orient="vert" idx="1"/>
          </p:nvPr>
        </p:nvSpPr>
        <p:spPr>
          <a:xfrm>
            <a:off x="480060" y="512660"/>
            <a:ext cx="6320790" cy="10922846"/>
          </a:xfrm>
        </p:spPr>
        <p:txBody>
          <a:bodyPr vert="eaVert"/>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p:cNvSpPr>
            <a:spLocks noGrp="1"/>
          </p:cNvSpPr>
          <p:nvPr>
            <p:ph type="dt" sz="half" idx="10"/>
          </p:nvPr>
        </p:nvSpPr>
        <p:spPr/>
        <p:txBody>
          <a:bodyPr/>
          <a:lstStyle/>
          <a:p>
            <a:fld id="{FC75D36E-F5BB-47E1-8CF6-197642BF9C69}" type="datetimeFigureOut">
              <a:rPr lang="ko-KR" altLang="en-US" smtClean="0"/>
              <a:pPr/>
              <a:t>2024-12-11</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BFDFE31A-9D4B-4AD2-9F2E-CC153BB0E734}" type="slidenum">
              <a:rPr lang="ko-KR" altLang="en-US" smtClean="0"/>
              <a:pPr/>
              <a:t>‹#›</a:t>
            </a:fld>
            <a:endParaRPr lang="ko-KR" altLang="en-US"/>
          </a:p>
        </p:txBody>
      </p:sp>
    </p:spTree>
    <p:extLst>
      <p:ext uri="{BB962C8B-B14F-4D97-AF65-F5344CB8AC3E}">
        <p14:creationId xmlns:p14="http://schemas.microsoft.com/office/powerpoint/2010/main" val="2185683749"/>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p:cNvSpPr>
            <a:spLocks noGrp="1"/>
          </p:cNvSpPr>
          <p:nvPr>
            <p:ph type="ctrTitle"/>
          </p:nvPr>
        </p:nvSpPr>
        <p:spPr>
          <a:xfrm>
            <a:off x="720090" y="3976796"/>
            <a:ext cx="8161020" cy="2744046"/>
          </a:xfrm>
        </p:spPr>
        <p:txBody>
          <a:bodyPr/>
          <a:lstStyle/>
          <a:p>
            <a:r>
              <a:rPr lang="ko-KR" altLang="en-US"/>
              <a:t>마스터 제목 스타일 편집</a:t>
            </a:r>
          </a:p>
        </p:txBody>
      </p:sp>
      <p:sp>
        <p:nvSpPr>
          <p:cNvPr id="3" name="부제목 2"/>
          <p:cNvSpPr>
            <a:spLocks noGrp="1"/>
          </p:cNvSpPr>
          <p:nvPr>
            <p:ph type="subTitle" idx="1"/>
          </p:nvPr>
        </p:nvSpPr>
        <p:spPr>
          <a:xfrm>
            <a:off x="1440180" y="7254240"/>
            <a:ext cx="6720840" cy="3271520"/>
          </a:xfrm>
        </p:spPr>
        <p:txBody>
          <a:bodyPr/>
          <a:lstStyle>
            <a:lvl1pPr marL="0" indent="0" algn="ctr">
              <a:buNone/>
              <a:defRPr>
                <a:solidFill>
                  <a:schemeClr val="tx1">
                    <a:tint val="75000"/>
                  </a:schemeClr>
                </a:solidFill>
              </a:defRPr>
            </a:lvl1pPr>
            <a:lvl2pPr marL="639976" indent="0" algn="ctr">
              <a:buNone/>
              <a:defRPr>
                <a:solidFill>
                  <a:schemeClr val="tx1">
                    <a:tint val="75000"/>
                  </a:schemeClr>
                </a:solidFill>
              </a:defRPr>
            </a:lvl2pPr>
            <a:lvl3pPr marL="1279953" indent="0" algn="ctr">
              <a:buNone/>
              <a:defRPr>
                <a:solidFill>
                  <a:schemeClr val="tx1">
                    <a:tint val="75000"/>
                  </a:schemeClr>
                </a:solidFill>
              </a:defRPr>
            </a:lvl3pPr>
            <a:lvl4pPr marL="1919929" indent="0" algn="ctr">
              <a:buNone/>
              <a:defRPr>
                <a:solidFill>
                  <a:schemeClr val="tx1">
                    <a:tint val="75000"/>
                  </a:schemeClr>
                </a:solidFill>
              </a:defRPr>
            </a:lvl4pPr>
            <a:lvl5pPr marL="2559906" indent="0" algn="ctr">
              <a:buNone/>
              <a:defRPr>
                <a:solidFill>
                  <a:schemeClr val="tx1">
                    <a:tint val="75000"/>
                  </a:schemeClr>
                </a:solidFill>
              </a:defRPr>
            </a:lvl5pPr>
            <a:lvl6pPr marL="3199882" indent="0" algn="ctr">
              <a:buNone/>
              <a:defRPr>
                <a:solidFill>
                  <a:schemeClr val="tx1">
                    <a:tint val="75000"/>
                  </a:schemeClr>
                </a:solidFill>
              </a:defRPr>
            </a:lvl6pPr>
            <a:lvl7pPr marL="3839859" indent="0" algn="ctr">
              <a:buNone/>
              <a:defRPr>
                <a:solidFill>
                  <a:schemeClr val="tx1">
                    <a:tint val="75000"/>
                  </a:schemeClr>
                </a:solidFill>
              </a:defRPr>
            </a:lvl7pPr>
            <a:lvl8pPr marL="4479835" indent="0" algn="ctr">
              <a:buNone/>
              <a:defRPr>
                <a:solidFill>
                  <a:schemeClr val="tx1">
                    <a:tint val="75000"/>
                  </a:schemeClr>
                </a:solidFill>
              </a:defRPr>
            </a:lvl8pPr>
            <a:lvl9pPr marL="5119812" indent="0" algn="ctr">
              <a:buNone/>
              <a:defRPr>
                <a:solidFill>
                  <a:schemeClr val="tx1">
                    <a:tint val="75000"/>
                  </a:schemeClr>
                </a:solidFill>
              </a:defRPr>
            </a:lvl9pPr>
          </a:lstStyle>
          <a:p>
            <a:r>
              <a:rPr lang="ko-KR" altLang="en-US"/>
              <a:t>마스터 부제목 스타일 편집</a:t>
            </a:r>
          </a:p>
        </p:txBody>
      </p:sp>
      <p:sp>
        <p:nvSpPr>
          <p:cNvPr id="4" name="날짜 개체 틀 3"/>
          <p:cNvSpPr>
            <a:spLocks noGrp="1"/>
          </p:cNvSpPr>
          <p:nvPr>
            <p:ph type="dt" sz="half" idx="10"/>
          </p:nvPr>
        </p:nvSpPr>
        <p:spPr/>
        <p:txBody>
          <a:bodyPr/>
          <a:lstStyle/>
          <a:p>
            <a:fld id="{FC75D36E-F5BB-47E1-8CF6-197642BF9C69}" type="datetimeFigureOut">
              <a:rPr lang="ko-KR" altLang="en-US" smtClean="0"/>
              <a:pPr/>
              <a:t>2024-12-11</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BFDFE31A-9D4B-4AD2-9F2E-CC153BB0E734}" type="slidenum">
              <a:rPr lang="ko-KR" altLang="en-US" smtClean="0"/>
              <a:pPr/>
              <a:t>‹#›</a:t>
            </a:fld>
            <a:endParaRPr lang="ko-KR" altLang="en-US"/>
          </a:p>
        </p:txBody>
      </p:sp>
    </p:spTree>
    <p:extLst>
      <p:ext uri="{BB962C8B-B14F-4D97-AF65-F5344CB8AC3E}">
        <p14:creationId xmlns:p14="http://schemas.microsoft.com/office/powerpoint/2010/main" val="1271673252"/>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내용 개체 틀 2"/>
          <p:cNvSpPr>
            <a:spLocks noGrp="1"/>
          </p:cNvSpPr>
          <p:nvPr>
            <p:ph idx="1"/>
          </p:nvPr>
        </p:nvSpPr>
        <p:spPr/>
        <p:txBody>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p:cNvSpPr>
            <a:spLocks noGrp="1"/>
          </p:cNvSpPr>
          <p:nvPr>
            <p:ph type="dt" sz="half" idx="10"/>
          </p:nvPr>
        </p:nvSpPr>
        <p:spPr/>
        <p:txBody>
          <a:bodyPr/>
          <a:lstStyle/>
          <a:p>
            <a:fld id="{FC75D36E-F5BB-47E1-8CF6-197642BF9C69}" type="datetimeFigureOut">
              <a:rPr lang="ko-KR" altLang="en-US" smtClean="0"/>
              <a:pPr/>
              <a:t>2024-12-11</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BFDFE31A-9D4B-4AD2-9F2E-CC153BB0E734}" type="slidenum">
              <a:rPr lang="ko-KR" altLang="en-US" smtClean="0"/>
              <a:pPr/>
              <a:t>‹#›</a:t>
            </a:fld>
            <a:endParaRPr lang="ko-KR" altLang="en-US"/>
          </a:p>
        </p:txBody>
      </p:sp>
    </p:spTree>
    <p:extLst>
      <p:ext uri="{BB962C8B-B14F-4D97-AF65-F5344CB8AC3E}">
        <p14:creationId xmlns:p14="http://schemas.microsoft.com/office/powerpoint/2010/main" val="271008109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p:cNvSpPr>
            <a:spLocks noGrp="1"/>
          </p:cNvSpPr>
          <p:nvPr>
            <p:ph type="title"/>
          </p:nvPr>
        </p:nvSpPr>
        <p:spPr>
          <a:xfrm>
            <a:off x="758429" y="8226214"/>
            <a:ext cx="8161020" cy="2542540"/>
          </a:xfrm>
        </p:spPr>
        <p:txBody>
          <a:bodyPr anchor="t"/>
          <a:lstStyle>
            <a:lvl1pPr algn="l">
              <a:defRPr sz="5600" b="1" cap="all"/>
            </a:lvl1pPr>
          </a:lstStyle>
          <a:p>
            <a:r>
              <a:rPr lang="ko-KR" altLang="en-US"/>
              <a:t>마스터 제목 스타일 편집</a:t>
            </a:r>
          </a:p>
        </p:txBody>
      </p:sp>
      <p:sp>
        <p:nvSpPr>
          <p:cNvPr id="3" name="텍스트 개체 틀 2"/>
          <p:cNvSpPr>
            <a:spLocks noGrp="1"/>
          </p:cNvSpPr>
          <p:nvPr>
            <p:ph type="body" idx="1"/>
          </p:nvPr>
        </p:nvSpPr>
        <p:spPr>
          <a:xfrm>
            <a:off x="758429" y="5425866"/>
            <a:ext cx="8161020" cy="2800349"/>
          </a:xfrm>
        </p:spPr>
        <p:txBody>
          <a:bodyPr anchor="b"/>
          <a:lstStyle>
            <a:lvl1pPr marL="0" indent="0">
              <a:buNone/>
              <a:defRPr sz="2800">
                <a:solidFill>
                  <a:schemeClr val="tx1">
                    <a:tint val="75000"/>
                  </a:schemeClr>
                </a:solidFill>
              </a:defRPr>
            </a:lvl1pPr>
            <a:lvl2pPr marL="639976" indent="0">
              <a:buNone/>
              <a:defRPr sz="2500">
                <a:solidFill>
                  <a:schemeClr val="tx1">
                    <a:tint val="75000"/>
                  </a:schemeClr>
                </a:solidFill>
              </a:defRPr>
            </a:lvl2pPr>
            <a:lvl3pPr marL="1279953" indent="0">
              <a:buNone/>
              <a:defRPr sz="2300">
                <a:solidFill>
                  <a:schemeClr val="tx1">
                    <a:tint val="75000"/>
                  </a:schemeClr>
                </a:solidFill>
              </a:defRPr>
            </a:lvl3pPr>
            <a:lvl4pPr marL="1919929" indent="0">
              <a:buNone/>
              <a:defRPr sz="2000">
                <a:solidFill>
                  <a:schemeClr val="tx1">
                    <a:tint val="75000"/>
                  </a:schemeClr>
                </a:solidFill>
              </a:defRPr>
            </a:lvl4pPr>
            <a:lvl5pPr marL="2559906" indent="0">
              <a:buNone/>
              <a:defRPr sz="2000">
                <a:solidFill>
                  <a:schemeClr val="tx1">
                    <a:tint val="75000"/>
                  </a:schemeClr>
                </a:solidFill>
              </a:defRPr>
            </a:lvl5pPr>
            <a:lvl6pPr marL="3199882" indent="0">
              <a:buNone/>
              <a:defRPr sz="2000">
                <a:solidFill>
                  <a:schemeClr val="tx1">
                    <a:tint val="75000"/>
                  </a:schemeClr>
                </a:solidFill>
              </a:defRPr>
            </a:lvl6pPr>
            <a:lvl7pPr marL="3839859" indent="0">
              <a:buNone/>
              <a:defRPr sz="2000">
                <a:solidFill>
                  <a:schemeClr val="tx1">
                    <a:tint val="75000"/>
                  </a:schemeClr>
                </a:solidFill>
              </a:defRPr>
            </a:lvl7pPr>
            <a:lvl8pPr marL="4479835" indent="0">
              <a:buNone/>
              <a:defRPr sz="2000">
                <a:solidFill>
                  <a:schemeClr val="tx1">
                    <a:tint val="75000"/>
                  </a:schemeClr>
                </a:solidFill>
              </a:defRPr>
            </a:lvl8pPr>
            <a:lvl9pPr marL="5119812" indent="0">
              <a:buNone/>
              <a:defRPr sz="2000">
                <a:solidFill>
                  <a:schemeClr val="tx1">
                    <a:tint val="75000"/>
                  </a:schemeClr>
                </a:solidFill>
              </a:defRPr>
            </a:lvl9pPr>
          </a:lstStyle>
          <a:p>
            <a:pPr lvl="0"/>
            <a:r>
              <a:rPr lang="ko-KR" altLang="en-US"/>
              <a:t>마스터 텍스트 스타일을 편집합니다</a:t>
            </a:r>
          </a:p>
        </p:txBody>
      </p:sp>
      <p:sp>
        <p:nvSpPr>
          <p:cNvPr id="4" name="날짜 개체 틀 3"/>
          <p:cNvSpPr>
            <a:spLocks noGrp="1"/>
          </p:cNvSpPr>
          <p:nvPr>
            <p:ph type="dt" sz="half" idx="10"/>
          </p:nvPr>
        </p:nvSpPr>
        <p:spPr/>
        <p:txBody>
          <a:bodyPr/>
          <a:lstStyle/>
          <a:p>
            <a:fld id="{FC75D36E-F5BB-47E1-8CF6-197642BF9C69}" type="datetimeFigureOut">
              <a:rPr lang="ko-KR" altLang="en-US" smtClean="0"/>
              <a:pPr/>
              <a:t>2024-12-11</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BFDFE31A-9D4B-4AD2-9F2E-CC153BB0E734}" type="slidenum">
              <a:rPr lang="ko-KR" altLang="en-US" smtClean="0"/>
              <a:pPr/>
              <a:t>‹#›</a:t>
            </a:fld>
            <a:endParaRPr lang="ko-KR" altLang="en-US"/>
          </a:p>
        </p:txBody>
      </p:sp>
    </p:spTree>
    <p:extLst>
      <p:ext uri="{BB962C8B-B14F-4D97-AF65-F5344CB8AC3E}">
        <p14:creationId xmlns:p14="http://schemas.microsoft.com/office/powerpoint/2010/main" val="1421792657"/>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내용 개체 틀 2"/>
          <p:cNvSpPr>
            <a:spLocks noGrp="1"/>
          </p:cNvSpPr>
          <p:nvPr>
            <p:ph sz="half" idx="1"/>
          </p:nvPr>
        </p:nvSpPr>
        <p:spPr>
          <a:xfrm>
            <a:off x="480060" y="2987043"/>
            <a:ext cx="4240530" cy="8448464"/>
          </a:xfrm>
        </p:spPr>
        <p:txBody>
          <a:bodyPr/>
          <a:lstStyle>
            <a:lvl1pPr>
              <a:defRPr sz="3900"/>
            </a:lvl1pPr>
            <a:lvl2pPr>
              <a:defRPr sz="3400"/>
            </a:lvl2pPr>
            <a:lvl3pPr>
              <a:defRPr sz="2800"/>
            </a:lvl3pPr>
            <a:lvl4pPr>
              <a:defRPr sz="2500"/>
            </a:lvl4pPr>
            <a:lvl5pPr>
              <a:defRPr sz="2500"/>
            </a:lvl5pPr>
            <a:lvl6pPr>
              <a:defRPr sz="2500"/>
            </a:lvl6pPr>
            <a:lvl7pPr>
              <a:defRPr sz="2500"/>
            </a:lvl7pPr>
            <a:lvl8pPr>
              <a:defRPr sz="2500"/>
            </a:lvl8pPr>
            <a:lvl9pPr>
              <a:defRPr sz="250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내용 개체 틀 3"/>
          <p:cNvSpPr>
            <a:spLocks noGrp="1"/>
          </p:cNvSpPr>
          <p:nvPr>
            <p:ph sz="half" idx="2"/>
          </p:nvPr>
        </p:nvSpPr>
        <p:spPr>
          <a:xfrm>
            <a:off x="4880610" y="2987043"/>
            <a:ext cx="4240530" cy="8448464"/>
          </a:xfrm>
        </p:spPr>
        <p:txBody>
          <a:bodyPr/>
          <a:lstStyle>
            <a:lvl1pPr>
              <a:defRPr sz="3900"/>
            </a:lvl1pPr>
            <a:lvl2pPr>
              <a:defRPr sz="3400"/>
            </a:lvl2pPr>
            <a:lvl3pPr>
              <a:defRPr sz="2800"/>
            </a:lvl3pPr>
            <a:lvl4pPr>
              <a:defRPr sz="2500"/>
            </a:lvl4pPr>
            <a:lvl5pPr>
              <a:defRPr sz="2500"/>
            </a:lvl5pPr>
            <a:lvl6pPr>
              <a:defRPr sz="2500"/>
            </a:lvl6pPr>
            <a:lvl7pPr>
              <a:defRPr sz="2500"/>
            </a:lvl7pPr>
            <a:lvl8pPr>
              <a:defRPr sz="2500"/>
            </a:lvl8pPr>
            <a:lvl9pPr>
              <a:defRPr sz="250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5" name="날짜 개체 틀 4"/>
          <p:cNvSpPr>
            <a:spLocks noGrp="1"/>
          </p:cNvSpPr>
          <p:nvPr>
            <p:ph type="dt" sz="half" idx="10"/>
          </p:nvPr>
        </p:nvSpPr>
        <p:spPr/>
        <p:txBody>
          <a:bodyPr/>
          <a:lstStyle/>
          <a:p>
            <a:fld id="{FC75D36E-F5BB-47E1-8CF6-197642BF9C69}" type="datetimeFigureOut">
              <a:rPr lang="ko-KR" altLang="en-US" smtClean="0"/>
              <a:pPr/>
              <a:t>2024-12-11</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BFDFE31A-9D4B-4AD2-9F2E-CC153BB0E734}" type="slidenum">
              <a:rPr lang="ko-KR" altLang="en-US" smtClean="0"/>
              <a:pPr/>
              <a:t>‹#›</a:t>
            </a:fld>
            <a:endParaRPr lang="ko-KR" altLang="en-US"/>
          </a:p>
        </p:txBody>
      </p:sp>
    </p:spTree>
    <p:extLst>
      <p:ext uri="{BB962C8B-B14F-4D97-AF65-F5344CB8AC3E}">
        <p14:creationId xmlns:p14="http://schemas.microsoft.com/office/powerpoint/2010/main" val="627497723"/>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lvl1pPr>
              <a:defRPr/>
            </a:lvl1pPr>
          </a:lstStyle>
          <a:p>
            <a:r>
              <a:rPr lang="ko-KR" altLang="en-US"/>
              <a:t>마스터 제목 스타일 편집</a:t>
            </a:r>
          </a:p>
        </p:txBody>
      </p:sp>
      <p:sp>
        <p:nvSpPr>
          <p:cNvPr id="3" name="텍스트 개체 틀 2"/>
          <p:cNvSpPr>
            <a:spLocks noGrp="1"/>
          </p:cNvSpPr>
          <p:nvPr>
            <p:ph type="body" idx="1"/>
          </p:nvPr>
        </p:nvSpPr>
        <p:spPr>
          <a:xfrm>
            <a:off x="480061" y="2865544"/>
            <a:ext cx="4242197" cy="1194222"/>
          </a:xfrm>
        </p:spPr>
        <p:txBody>
          <a:bodyPr anchor="b"/>
          <a:lstStyle>
            <a:lvl1pPr marL="0" indent="0">
              <a:buNone/>
              <a:defRPr sz="3400" b="1"/>
            </a:lvl1pPr>
            <a:lvl2pPr marL="639976" indent="0">
              <a:buNone/>
              <a:defRPr sz="2800" b="1"/>
            </a:lvl2pPr>
            <a:lvl3pPr marL="1279953" indent="0">
              <a:buNone/>
              <a:defRPr sz="2500" b="1"/>
            </a:lvl3pPr>
            <a:lvl4pPr marL="1919929" indent="0">
              <a:buNone/>
              <a:defRPr sz="2300" b="1"/>
            </a:lvl4pPr>
            <a:lvl5pPr marL="2559906" indent="0">
              <a:buNone/>
              <a:defRPr sz="2300" b="1"/>
            </a:lvl5pPr>
            <a:lvl6pPr marL="3199882" indent="0">
              <a:buNone/>
              <a:defRPr sz="2300" b="1"/>
            </a:lvl6pPr>
            <a:lvl7pPr marL="3839859" indent="0">
              <a:buNone/>
              <a:defRPr sz="2300" b="1"/>
            </a:lvl7pPr>
            <a:lvl8pPr marL="4479835" indent="0">
              <a:buNone/>
              <a:defRPr sz="2300" b="1"/>
            </a:lvl8pPr>
            <a:lvl9pPr marL="5119812" indent="0">
              <a:buNone/>
              <a:defRPr sz="2300" b="1"/>
            </a:lvl9pPr>
          </a:lstStyle>
          <a:p>
            <a:pPr lvl="0"/>
            <a:r>
              <a:rPr lang="ko-KR" altLang="en-US"/>
              <a:t>마스터 텍스트 스타일을 편집합니다</a:t>
            </a:r>
          </a:p>
        </p:txBody>
      </p:sp>
      <p:sp>
        <p:nvSpPr>
          <p:cNvPr id="4" name="내용 개체 틀 3"/>
          <p:cNvSpPr>
            <a:spLocks noGrp="1"/>
          </p:cNvSpPr>
          <p:nvPr>
            <p:ph sz="half" idx="2"/>
          </p:nvPr>
        </p:nvSpPr>
        <p:spPr>
          <a:xfrm>
            <a:off x="480061" y="4059766"/>
            <a:ext cx="4242197" cy="7375738"/>
          </a:xfrm>
        </p:spPr>
        <p:txBody>
          <a:bodyPr/>
          <a:lstStyle>
            <a:lvl1pPr>
              <a:defRPr sz="3400"/>
            </a:lvl1pPr>
            <a:lvl2pPr>
              <a:defRPr sz="2800"/>
            </a:lvl2pPr>
            <a:lvl3pPr>
              <a:defRPr sz="2500"/>
            </a:lvl3pPr>
            <a:lvl4pPr>
              <a:defRPr sz="2300"/>
            </a:lvl4pPr>
            <a:lvl5pPr>
              <a:defRPr sz="2300"/>
            </a:lvl5pPr>
            <a:lvl6pPr>
              <a:defRPr sz="2300"/>
            </a:lvl6pPr>
            <a:lvl7pPr>
              <a:defRPr sz="2300"/>
            </a:lvl7pPr>
            <a:lvl8pPr>
              <a:defRPr sz="2300"/>
            </a:lvl8pPr>
            <a:lvl9pPr>
              <a:defRPr sz="230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5" name="텍스트 개체 틀 4"/>
          <p:cNvSpPr>
            <a:spLocks noGrp="1"/>
          </p:cNvSpPr>
          <p:nvPr>
            <p:ph type="body" sz="quarter" idx="3"/>
          </p:nvPr>
        </p:nvSpPr>
        <p:spPr>
          <a:xfrm>
            <a:off x="4877278" y="2865544"/>
            <a:ext cx="4243863" cy="1194222"/>
          </a:xfrm>
        </p:spPr>
        <p:txBody>
          <a:bodyPr anchor="b"/>
          <a:lstStyle>
            <a:lvl1pPr marL="0" indent="0">
              <a:buNone/>
              <a:defRPr sz="3400" b="1"/>
            </a:lvl1pPr>
            <a:lvl2pPr marL="639976" indent="0">
              <a:buNone/>
              <a:defRPr sz="2800" b="1"/>
            </a:lvl2pPr>
            <a:lvl3pPr marL="1279953" indent="0">
              <a:buNone/>
              <a:defRPr sz="2500" b="1"/>
            </a:lvl3pPr>
            <a:lvl4pPr marL="1919929" indent="0">
              <a:buNone/>
              <a:defRPr sz="2300" b="1"/>
            </a:lvl4pPr>
            <a:lvl5pPr marL="2559906" indent="0">
              <a:buNone/>
              <a:defRPr sz="2300" b="1"/>
            </a:lvl5pPr>
            <a:lvl6pPr marL="3199882" indent="0">
              <a:buNone/>
              <a:defRPr sz="2300" b="1"/>
            </a:lvl6pPr>
            <a:lvl7pPr marL="3839859" indent="0">
              <a:buNone/>
              <a:defRPr sz="2300" b="1"/>
            </a:lvl7pPr>
            <a:lvl8pPr marL="4479835" indent="0">
              <a:buNone/>
              <a:defRPr sz="2300" b="1"/>
            </a:lvl8pPr>
            <a:lvl9pPr marL="5119812" indent="0">
              <a:buNone/>
              <a:defRPr sz="2300" b="1"/>
            </a:lvl9pPr>
          </a:lstStyle>
          <a:p>
            <a:pPr lvl="0"/>
            <a:r>
              <a:rPr lang="ko-KR" altLang="en-US"/>
              <a:t>마스터 텍스트 스타일을 편집합니다</a:t>
            </a:r>
          </a:p>
        </p:txBody>
      </p:sp>
      <p:sp>
        <p:nvSpPr>
          <p:cNvPr id="6" name="내용 개체 틀 5"/>
          <p:cNvSpPr>
            <a:spLocks noGrp="1"/>
          </p:cNvSpPr>
          <p:nvPr>
            <p:ph sz="quarter" idx="4"/>
          </p:nvPr>
        </p:nvSpPr>
        <p:spPr>
          <a:xfrm>
            <a:off x="4877278" y="4059766"/>
            <a:ext cx="4243863" cy="7375738"/>
          </a:xfrm>
        </p:spPr>
        <p:txBody>
          <a:bodyPr/>
          <a:lstStyle>
            <a:lvl1pPr>
              <a:defRPr sz="3400"/>
            </a:lvl1pPr>
            <a:lvl2pPr>
              <a:defRPr sz="2800"/>
            </a:lvl2pPr>
            <a:lvl3pPr>
              <a:defRPr sz="2500"/>
            </a:lvl3pPr>
            <a:lvl4pPr>
              <a:defRPr sz="2300"/>
            </a:lvl4pPr>
            <a:lvl5pPr>
              <a:defRPr sz="2300"/>
            </a:lvl5pPr>
            <a:lvl6pPr>
              <a:defRPr sz="2300"/>
            </a:lvl6pPr>
            <a:lvl7pPr>
              <a:defRPr sz="2300"/>
            </a:lvl7pPr>
            <a:lvl8pPr>
              <a:defRPr sz="2300"/>
            </a:lvl8pPr>
            <a:lvl9pPr>
              <a:defRPr sz="230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7" name="날짜 개체 틀 6"/>
          <p:cNvSpPr>
            <a:spLocks noGrp="1"/>
          </p:cNvSpPr>
          <p:nvPr>
            <p:ph type="dt" sz="half" idx="10"/>
          </p:nvPr>
        </p:nvSpPr>
        <p:spPr/>
        <p:txBody>
          <a:bodyPr/>
          <a:lstStyle/>
          <a:p>
            <a:fld id="{FC75D36E-F5BB-47E1-8CF6-197642BF9C69}" type="datetimeFigureOut">
              <a:rPr lang="ko-KR" altLang="en-US" smtClean="0"/>
              <a:pPr/>
              <a:t>2024-12-11</a:t>
            </a:fld>
            <a:endParaRPr lang="ko-KR" altLang="en-US"/>
          </a:p>
        </p:txBody>
      </p:sp>
      <p:sp>
        <p:nvSpPr>
          <p:cNvPr id="8" name="바닥글 개체 틀 7"/>
          <p:cNvSpPr>
            <a:spLocks noGrp="1"/>
          </p:cNvSpPr>
          <p:nvPr>
            <p:ph type="ftr" sz="quarter" idx="11"/>
          </p:nvPr>
        </p:nvSpPr>
        <p:spPr/>
        <p:txBody>
          <a:bodyPr/>
          <a:lstStyle/>
          <a:p>
            <a:endParaRPr lang="ko-KR" altLang="en-US"/>
          </a:p>
        </p:txBody>
      </p:sp>
      <p:sp>
        <p:nvSpPr>
          <p:cNvPr id="9" name="슬라이드 번호 개체 틀 8"/>
          <p:cNvSpPr>
            <a:spLocks noGrp="1"/>
          </p:cNvSpPr>
          <p:nvPr>
            <p:ph type="sldNum" sz="quarter" idx="12"/>
          </p:nvPr>
        </p:nvSpPr>
        <p:spPr/>
        <p:txBody>
          <a:bodyPr/>
          <a:lstStyle/>
          <a:p>
            <a:fld id="{BFDFE31A-9D4B-4AD2-9F2E-CC153BB0E734}" type="slidenum">
              <a:rPr lang="ko-KR" altLang="en-US" smtClean="0"/>
              <a:pPr/>
              <a:t>‹#›</a:t>
            </a:fld>
            <a:endParaRPr lang="ko-KR" altLang="en-US"/>
          </a:p>
        </p:txBody>
      </p:sp>
    </p:spTree>
    <p:extLst>
      <p:ext uri="{BB962C8B-B14F-4D97-AF65-F5344CB8AC3E}">
        <p14:creationId xmlns:p14="http://schemas.microsoft.com/office/powerpoint/2010/main" val="3791146381"/>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날짜 개체 틀 2"/>
          <p:cNvSpPr>
            <a:spLocks noGrp="1"/>
          </p:cNvSpPr>
          <p:nvPr>
            <p:ph type="dt" sz="half" idx="10"/>
          </p:nvPr>
        </p:nvSpPr>
        <p:spPr/>
        <p:txBody>
          <a:bodyPr/>
          <a:lstStyle/>
          <a:p>
            <a:fld id="{FC75D36E-F5BB-47E1-8CF6-197642BF9C69}" type="datetimeFigureOut">
              <a:rPr lang="ko-KR" altLang="en-US" smtClean="0"/>
              <a:pPr/>
              <a:t>2024-12-11</a:t>
            </a:fld>
            <a:endParaRPr lang="ko-KR" altLang="en-US"/>
          </a:p>
        </p:txBody>
      </p:sp>
      <p:sp>
        <p:nvSpPr>
          <p:cNvPr id="4" name="바닥글 개체 틀 3"/>
          <p:cNvSpPr>
            <a:spLocks noGrp="1"/>
          </p:cNvSpPr>
          <p:nvPr>
            <p:ph type="ftr" sz="quarter" idx="11"/>
          </p:nvPr>
        </p:nvSpPr>
        <p:spPr/>
        <p:txBody>
          <a:bodyPr/>
          <a:lstStyle/>
          <a:p>
            <a:endParaRPr lang="ko-KR" altLang="en-US"/>
          </a:p>
        </p:txBody>
      </p:sp>
      <p:sp>
        <p:nvSpPr>
          <p:cNvPr id="5" name="슬라이드 번호 개체 틀 4"/>
          <p:cNvSpPr>
            <a:spLocks noGrp="1"/>
          </p:cNvSpPr>
          <p:nvPr>
            <p:ph type="sldNum" sz="quarter" idx="12"/>
          </p:nvPr>
        </p:nvSpPr>
        <p:spPr/>
        <p:txBody>
          <a:bodyPr/>
          <a:lstStyle/>
          <a:p>
            <a:fld id="{BFDFE31A-9D4B-4AD2-9F2E-CC153BB0E734}" type="slidenum">
              <a:rPr lang="ko-KR" altLang="en-US" smtClean="0"/>
              <a:pPr/>
              <a:t>‹#›</a:t>
            </a:fld>
            <a:endParaRPr lang="ko-KR" altLang="en-US"/>
          </a:p>
        </p:txBody>
      </p:sp>
    </p:spTree>
    <p:extLst>
      <p:ext uri="{BB962C8B-B14F-4D97-AF65-F5344CB8AC3E}">
        <p14:creationId xmlns:p14="http://schemas.microsoft.com/office/powerpoint/2010/main" val="216583665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p:cNvSpPr>
            <a:spLocks noGrp="1"/>
          </p:cNvSpPr>
          <p:nvPr>
            <p:ph type="dt" sz="half" idx="10"/>
          </p:nvPr>
        </p:nvSpPr>
        <p:spPr/>
        <p:txBody>
          <a:bodyPr/>
          <a:lstStyle/>
          <a:p>
            <a:fld id="{FC75D36E-F5BB-47E1-8CF6-197642BF9C69}" type="datetimeFigureOut">
              <a:rPr lang="ko-KR" altLang="en-US" smtClean="0"/>
              <a:pPr/>
              <a:t>2024-12-11</a:t>
            </a:fld>
            <a:endParaRPr lang="ko-KR" altLang="en-US"/>
          </a:p>
        </p:txBody>
      </p:sp>
      <p:sp>
        <p:nvSpPr>
          <p:cNvPr id="3" name="바닥글 개체 틀 2"/>
          <p:cNvSpPr>
            <a:spLocks noGrp="1"/>
          </p:cNvSpPr>
          <p:nvPr>
            <p:ph type="ftr" sz="quarter" idx="11"/>
          </p:nvPr>
        </p:nvSpPr>
        <p:spPr/>
        <p:txBody>
          <a:bodyPr/>
          <a:lstStyle/>
          <a:p>
            <a:endParaRPr lang="ko-KR" altLang="en-US"/>
          </a:p>
        </p:txBody>
      </p:sp>
      <p:sp>
        <p:nvSpPr>
          <p:cNvPr id="4" name="슬라이드 번호 개체 틀 3"/>
          <p:cNvSpPr>
            <a:spLocks noGrp="1"/>
          </p:cNvSpPr>
          <p:nvPr>
            <p:ph type="sldNum" sz="quarter" idx="12"/>
          </p:nvPr>
        </p:nvSpPr>
        <p:spPr/>
        <p:txBody>
          <a:bodyPr/>
          <a:lstStyle/>
          <a:p>
            <a:fld id="{BFDFE31A-9D4B-4AD2-9F2E-CC153BB0E734}" type="slidenum">
              <a:rPr lang="ko-KR" altLang="en-US" smtClean="0"/>
              <a:pPr/>
              <a:t>‹#›</a:t>
            </a:fld>
            <a:endParaRPr lang="ko-KR" altLang="en-US"/>
          </a:p>
        </p:txBody>
      </p:sp>
    </p:spTree>
    <p:extLst>
      <p:ext uri="{BB962C8B-B14F-4D97-AF65-F5344CB8AC3E}">
        <p14:creationId xmlns:p14="http://schemas.microsoft.com/office/powerpoint/2010/main" val="2351932117"/>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p:cNvSpPr>
            <a:spLocks noGrp="1"/>
          </p:cNvSpPr>
          <p:nvPr>
            <p:ph type="title"/>
          </p:nvPr>
        </p:nvSpPr>
        <p:spPr>
          <a:xfrm>
            <a:off x="480061" y="509694"/>
            <a:ext cx="3158729" cy="2169160"/>
          </a:xfrm>
        </p:spPr>
        <p:txBody>
          <a:bodyPr anchor="b"/>
          <a:lstStyle>
            <a:lvl1pPr algn="l">
              <a:defRPr sz="2800" b="1"/>
            </a:lvl1pPr>
          </a:lstStyle>
          <a:p>
            <a:r>
              <a:rPr lang="ko-KR" altLang="en-US"/>
              <a:t>마스터 제목 스타일 편집</a:t>
            </a:r>
          </a:p>
        </p:txBody>
      </p:sp>
      <p:sp>
        <p:nvSpPr>
          <p:cNvPr id="3" name="내용 개체 틀 2"/>
          <p:cNvSpPr>
            <a:spLocks noGrp="1"/>
          </p:cNvSpPr>
          <p:nvPr>
            <p:ph idx="1"/>
          </p:nvPr>
        </p:nvSpPr>
        <p:spPr>
          <a:xfrm>
            <a:off x="3753803" y="509695"/>
            <a:ext cx="5367338" cy="10925812"/>
          </a:xfrm>
        </p:spPr>
        <p:txBody>
          <a:bodyPr/>
          <a:lstStyle>
            <a:lvl1pPr>
              <a:defRPr sz="4500"/>
            </a:lvl1pPr>
            <a:lvl2pPr>
              <a:defRPr sz="3900"/>
            </a:lvl2pPr>
            <a:lvl3pPr>
              <a:defRPr sz="3400"/>
            </a:lvl3pPr>
            <a:lvl4pPr>
              <a:defRPr sz="2800"/>
            </a:lvl4pPr>
            <a:lvl5pPr>
              <a:defRPr sz="2800"/>
            </a:lvl5pPr>
            <a:lvl6pPr>
              <a:defRPr sz="2800"/>
            </a:lvl6pPr>
            <a:lvl7pPr>
              <a:defRPr sz="2800"/>
            </a:lvl7pPr>
            <a:lvl8pPr>
              <a:defRPr sz="2800"/>
            </a:lvl8pPr>
            <a:lvl9pPr>
              <a:defRPr sz="280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텍스트 개체 틀 3"/>
          <p:cNvSpPr>
            <a:spLocks noGrp="1"/>
          </p:cNvSpPr>
          <p:nvPr>
            <p:ph type="body" sz="half" idx="2"/>
          </p:nvPr>
        </p:nvSpPr>
        <p:spPr>
          <a:xfrm>
            <a:off x="480061" y="2678855"/>
            <a:ext cx="3158729" cy="8756652"/>
          </a:xfrm>
        </p:spPr>
        <p:txBody>
          <a:bodyPr/>
          <a:lstStyle>
            <a:lvl1pPr marL="0" indent="0">
              <a:buNone/>
              <a:defRPr sz="2000"/>
            </a:lvl1pPr>
            <a:lvl2pPr marL="639976" indent="0">
              <a:buNone/>
              <a:defRPr sz="1600"/>
            </a:lvl2pPr>
            <a:lvl3pPr marL="1279953" indent="0">
              <a:buNone/>
              <a:defRPr sz="1400"/>
            </a:lvl3pPr>
            <a:lvl4pPr marL="1919929" indent="0">
              <a:buNone/>
              <a:defRPr sz="1300"/>
            </a:lvl4pPr>
            <a:lvl5pPr marL="2559906" indent="0">
              <a:buNone/>
              <a:defRPr sz="1300"/>
            </a:lvl5pPr>
            <a:lvl6pPr marL="3199882" indent="0">
              <a:buNone/>
              <a:defRPr sz="1300"/>
            </a:lvl6pPr>
            <a:lvl7pPr marL="3839859" indent="0">
              <a:buNone/>
              <a:defRPr sz="1300"/>
            </a:lvl7pPr>
            <a:lvl8pPr marL="4479835" indent="0">
              <a:buNone/>
              <a:defRPr sz="1300"/>
            </a:lvl8pPr>
            <a:lvl9pPr marL="5119812" indent="0">
              <a:buNone/>
              <a:defRPr sz="1300"/>
            </a:lvl9pPr>
          </a:lstStyle>
          <a:p>
            <a:pPr lvl="0"/>
            <a:r>
              <a:rPr lang="ko-KR" altLang="en-US"/>
              <a:t>마스터 텍스트 스타일을 편집합니다</a:t>
            </a:r>
          </a:p>
        </p:txBody>
      </p:sp>
      <p:sp>
        <p:nvSpPr>
          <p:cNvPr id="5" name="날짜 개체 틀 4"/>
          <p:cNvSpPr>
            <a:spLocks noGrp="1"/>
          </p:cNvSpPr>
          <p:nvPr>
            <p:ph type="dt" sz="half" idx="10"/>
          </p:nvPr>
        </p:nvSpPr>
        <p:spPr/>
        <p:txBody>
          <a:bodyPr/>
          <a:lstStyle/>
          <a:p>
            <a:fld id="{FC75D36E-F5BB-47E1-8CF6-197642BF9C69}" type="datetimeFigureOut">
              <a:rPr lang="ko-KR" altLang="en-US" smtClean="0"/>
              <a:pPr/>
              <a:t>2024-12-11</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BFDFE31A-9D4B-4AD2-9F2E-CC153BB0E734}" type="slidenum">
              <a:rPr lang="ko-KR" altLang="en-US" smtClean="0"/>
              <a:pPr/>
              <a:t>‹#›</a:t>
            </a:fld>
            <a:endParaRPr lang="ko-KR" altLang="en-US"/>
          </a:p>
        </p:txBody>
      </p:sp>
    </p:spTree>
    <p:extLst>
      <p:ext uri="{BB962C8B-B14F-4D97-AF65-F5344CB8AC3E}">
        <p14:creationId xmlns:p14="http://schemas.microsoft.com/office/powerpoint/2010/main" val="409121185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내용 개체 틀 2"/>
          <p:cNvSpPr>
            <a:spLocks noGrp="1"/>
          </p:cNvSpPr>
          <p:nvPr>
            <p:ph idx="1"/>
          </p:nvPr>
        </p:nvSpPr>
        <p:spPr/>
        <p:txBody>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p:cNvSpPr>
            <a:spLocks noGrp="1"/>
          </p:cNvSpPr>
          <p:nvPr>
            <p:ph type="dt" sz="half" idx="10"/>
          </p:nvPr>
        </p:nvSpPr>
        <p:spPr/>
        <p:txBody>
          <a:bodyPr/>
          <a:lstStyle/>
          <a:p>
            <a:fld id="{FC75D36E-F5BB-47E1-8CF6-197642BF9C69}" type="datetimeFigureOut">
              <a:rPr lang="ko-KR" altLang="en-US" smtClean="0"/>
              <a:pPr/>
              <a:t>2024-12-11</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BFDFE31A-9D4B-4AD2-9F2E-CC153BB0E734}" type="slidenum">
              <a:rPr lang="ko-KR" altLang="en-US" smtClean="0"/>
              <a:pPr/>
              <a:t>‹#›</a:t>
            </a:fld>
            <a:endParaRPr lang="ko-KR" altLang="en-US"/>
          </a:p>
        </p:txBody>
      </p:sp>
    </p:spTree>
    <p:extLst>
      <p:ext uri="{BB962C8B-B14F-4D97-AF65-F5344CB8AC3E}">
        <p14:creationId xmlns:p14="http://schemas.microsoft.com/office/powerpoint/2010/main" val="2584199351"/>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p:cNvSpPr>
            <a:spLocks noGrp="1"/>
          </p:cNvSpPr>
          <p:nvPr>
            <p:ph type="title"/>
          </p:nvPr>
        </p:nvSpPr>
        <p:spPr>
          <a:xfrm>
            <a:off x="1881902" y="8961120"/>
            <a:ext cx="5760720" cy="1057911"/>
          </a:xfrm>
        </p:spPr>
        <p:txBody>
          <a:bodyPr anchor="b"/>
          <a:lstStyle>
            <a:lvl1pPr algn="l">
              <a:defRPr sz="2800" b="1"/>
            </a:lvl1pPr>
          </a:lstStyle>
          <a:p>
            <a:r>
              <a:rPr lang="ko-KR" altLang="en-US"/>
              <a:t>마스터 제목 스타일 편집</a:t>
            </a:r>
          </a:p>
        </p:txBody>
      </p:sp>
      <p:sp>
        <p:nvSpPr>
          <p:cNvPr id="3" name="그림 개체 틀 2"/>
          <p:cNvSpPr>
            <a:spLocks noGrp="1"/>
          </p:cNvSpPr>
          <p:nvPr>
            <p:ph type="pic" idx="1"/>
          </p:nvPr>
        </p:nvSpPr>
        <p:spPr>
          <a:xfrm>
            <a:off x="1881902" y="1143847"/>
            <a:ext cx="5760720" cy="7680960"/>
          </a:xfrm>
        </p:spPr>
        <p:txBody>
          <a:bodyPr/>
          <a:lstStyle>
            <a:lvl1pPr marL="0" indent="0">
              <a:buNone/>
              <a:defRPr sz="4500"/>
            </a:lvl1pPr>
            <a:lvl2pPr marL="639976" indent="0">
              <a:buNone/>
              <a:defRPr sz="3900"/>
            </a:lvl2pPr>
            <a:lvl3pPr marL="1279953" indent="0">
              <a:buNone/>
              <a:defRPr sz="3400"/>
            </a:lvl3pPr>
            <a:lvl4pPr marL="1919929" indent="0">
              <a:buNone/>
              <a:defRPr sz="2800"/>
            </a:lvl4pPr>
            <a:lvl5pPr marL="2559906" indent="0">
              <a:buNone/>
              <a:defRPr sz="2800"/>
            </a:lvl5pPr>
            <a:lvl6pPr marL="3199882" indent="0">
              <a:buNone/>
              <a:defRPr sz="2800"/>
            </a:lvl6pPr>
            <a:lvl7pPr marL="3839859" indent="0">
              <a:buNone/>
              <a:defRPr sz="2800"/>
            </a:lvl7pPr>
            <a:lvl8pPr marL="4479835" indent="0">
              <a:buNone/>
              <a:defRPr sz="2800"/>
            </a:lvl8pPr>
            <a:lvl9pPr marL="5119812" indent="0">
              <a:buNone/>
              <a:defRPr sz="2800"/>
            </a:lvl9pPr>
          </a:lstStyle>
          <a:p>
            <a:endParaRPr lang="ko-KR" altLang="en-US"/>
          </a:p>
        </p:txBody>
      </p:sp>
      <p:sp>
        <p:nvSpPr>
          <p:cNvPr id="4" name="텍스트 개체 틀 3"/>
          <p:cNvSpPr>
            <a:spLocks noGrp="1"/>
          </p:cNvSpPr>
          <p:nvPr>
            <p:ph type="body" sz="half" idx="2"/>
          </p:nvPr>
        </p:nvSpPr>
        <p:spPr>
          <a:xfrm>
            <a:off x="1881902" y="10019032"/>
            <a:ext cx="5760720" cy="1502409"/>
          </a:xfrm>
        </p:spPr>
        <p:txBody>
          <a:bodyPr/>
          <a:lstStyle>
            <a:lvl1pPr marL="0" indent="0">
              <a:buNone/>
              <a:defRPr sz="2000"/>
            </a:lvl1pPr>
            <a:lvl2pPr marL="639976" indent="0">
              <a:buNone/>
              <a:defRPr sz="1600"/>
            </a:lvl2pPr>
            <a:lvl3pPr marL="1279953" indent="0">
              <a:buNone/>
              <a:defRPr sz="1400"/>
            </a:lvl3pPr>
            <a:lvl4pPr marL="1919929" indent="0">
              <a:buNone/>
              <a:defRPr sz="1300"/>
            </a:lvl4pPr>
            <a:lvl5pPr marL="2559906" indent="0">
              <a:buNone/>
              <a:defRPr sz="1300"/>
            </a:lvl5pPr>
            <a:lvl6pPr marL="3199882" indent="0">
              <a:buNone/>
              <a:defRPr sz="1300"/>
            </a:lvl6pPr>
            <a:lvl7pPr marL="3839859" indent="0">
              <a:buNone/>
              <a:defRPr sz="1300"/>
            </a:lvl7pPr>
            <a:lvl8pPr marL="4479835" indent="0">
              <a:buNone/>
              <a:defRPr sz="1300"/>
            </a:lvl8pPr>
            <a:lvl9pPr marL="5119812" indent="0">
              <a:buNone/>
              <a:defRPr sz="1300"/>
            </a:lvl9pPr>
          </a:lstStyle>
          <a:p>
            <a:pPr lvl="0"/>
            <a:r>
              <a:rPr lang="ko-KR" altLang="en-US"/>
              <a:t>마스터 텍스트 스타일을 편집합니다</a:t>
            </a:r>
          </a:p>
        </p:txBody>
      </p:sp>
      <p:sp>
        <p:nvSpPr>
          <p:cNvPr id="5" name="날짜 개체 틀 4"/>
          <p:cNvSpPr>
            <a:spLocks noGrp="1"/>
          </p:cNvSpPr>
          <p:nvPr>
            <p:ph type="dt" sz="half" idx="10"/>
          </p:nvPr>
        </p:nvSpPr>
        <p:spPr/>
        <p:txBody>
          <a:bodyPr/>
          <a:lstStyle/>
          <a:p>
            <a:fld id="{FC75D36E-F5BB-47E1-8CF6-197642BF9C69}" type="datetimeFigureOut">
              <a:rPr lang="ko-KR" altLang="en-US" smtClean="0"/>
              <a:pPr/>
              <a:t>2024-12-11</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BFDFE31A-9D4B-4AD2-9F2E-CC153BB0E734}" type="slidenum">
              <a:rPr lang="ko-KR" altLang="en-US" smtClean="0"/>
              <a:pPr/>
              <a:t>‹#›</a:t>
            </a:fld>
            <a:endParaRPr lang="ko-KR" altLang="en-US"/>
          </a:p>
        </p:txBody>
      </p:sp>
    </p:spTree>
    <p:extLst>
      <p:ext uri="{BB962C8B-B14F-4D97-AF65-F5344CB8AC3E}">
        <p14:creationId xmlns:p14="http://schemas.microsoft.com/office/powerpoint/2010/main" val="340901379"/>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세로 텍스트 개체 틀 2"/>
          <p:cNvSpPr>
            <a:spLocks noGrp="1"/>
          </p:cNvSpPr>
          <p:nvPr>
            <p:ph type="body" orient="vert" idx="1"/>
          </p:nvPr>
        </p:nvSpPr>
        <p:spPr/>
        <p:txBody>
          <a:bodyPr vert="eaVert"/>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p:cNvSpPr>
            <a:spLocks noGrp="1"/>
          </p:cNvSpPr>
          <p:nvPr>
            <p:ph type="dt" sz="half" idx="10"/>
          </p:nvPr>
        </p:nvSpPr>
        <p:spPr/>
        <p:txBody>
          <a:bodyPr/>
          <a:lstStyle/>
          <a:p>
            <a:fld id="{FC75D36E-F5BB-47E1-8CF6-197642BF9C69}" type="datetimeFigureOut">
              <a:rPr lang="ko-KR" altLang="en-US" smtClean="0"/>
              <a:pPr/>
              <a:t>2024-12-11</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BFDFE31A-9D4B-4AD2-9F2E-CC153BB0E734}" type="slidenum">
              <a:rPr lang="ko-KR" altLang="en-US" smtClean="0"/>
              <a:pPr/>
              <a:t>‹#›</a:t>
            </a:fld>
            <a:endParaRPr lang="ko-KR" altLang="en-US"/>
          </a:p>
        </p:txBody>
      </p:sp>
    </p:spTree>
    <p:extLst>
      <p:ext uri="{BB962C8B-B14F-4D97-AF65-F5344CB8AC3E}">
        <p14:creationId xmlns:p14="http://schemas.microsoft.com/office/powerpoint/2010/main" val="2130384363"/>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p:cNvSpPr>
            <a:spLocks noGrp="1"/>
          </p:cNvSpPr>
          <p:nvPr>
            <p:ph type="title" orient="vert"/>
          </p:nvPr>
        </p:nvSpPr>
        <p:spPr>
          <a:xfrm>
            <a:off x="6960870" y="512660"/>
            <a:ext cx="2160270" cy="10922846"/>
          </a:xfrm>
        </p:spPr>
        <p:txBody>
          <a:bodyPr vert="eaVert"/>
          <a:lstStyle/>
          <a:p>
            <a:r>
              <a:rPr lang="ko-KR" altLang="en-US"/>
              <a:t>마스터 제목 스타일 편집</a:t>
            </a:r>
          </a:p>
        </p:txBody>
      </p:sp>
      <p:sp>
        <p:nvSpPr>
          <p:cNvPr id="3" name="세로 텍스트 개체 틀 2"/>
          <p:cNvSpPr>
            <a:spLocks noGrp="1"/>
          </p:cNvSpPr>
          <p:nvPr>
            <p:ph type="body" orient="vert" idx="1"/>
          </p:nvPr>
        </p:nvSpPr>
        <p:spPr>
          <a:xfrm>
            <a:off x="480060" y="512660"/>
            <a:ext cx="6320790" cy="10922846"/>
          </a:xfrm>
        </p:spPr>
        <p:txBody>
          <a:bodyPr vert="eaVert"/>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p:cNvSpPr>
            <a:spLocks noGrp="1"/>
          </p:cNvSpPr>
          <p:nvPr>
            <p:ph type="dt" sz="half" idx="10"/>
          </p:nvPr>
        </p:nvSpPr>
        <p:spPr/>
        <p:txBody>
          <a:bodyPr/>
          <a:lstStyle/>
          <a:p>
            <a:fld id="{FC75D36E-F5BB-47E1-8CF6-197642BF9C69}" type="datetimeFigureOut">
              <a:rPr lang="ko-KR" altLang="en-US" smtClean="0"/>
              <a:pPr/>
              <a:t>2024-12-11</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BFDFE31A-9D4B-4AD2-9F2E-CC153BB0E734}" type="slidenum">
              <a:rPr lang="ko-KR" altLang="en-US" smtClean="0"/>
              <a:pPr/>
              <a:t>‹#›</a:t>
            </a:fld>
            <a:endParaRPr lang="ko-KR" altLang="en-US"/>
          </a:p>
        </p:txBody>
      </p:sp>
    </p:spTree>
    <p:extLst>
      <p:ext uri="{BB962C8B-B14F-4D97-AF65-F5344CB8AC3E}">
        <p14:creationId xmlns:p14="http://schemas.microsoft.com/office/powerpoint/2010/main" val="130792363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p:cNvSpPr>
            <a:spLocks noGrp="1"/>
          </p:cNvSpPr>
          <p:nvPr>
            <p:ph type="title"/>
          </p:nvPr>
        </p:nvSpPr>
        <p:spPr>
          <a:xfrm>
            <a:off x="758429" y="8226214"/>
            <a:ext cx="8161020" cy="2542540"/>
          </a:xfrm>
        </p:spPr>
        <p:txBody>
          <a:bodyPr anchor="t"/>
          <a:lstStyle>
            <a:lvl1pPr algn="l">
              <a:defRPr sz="5600" b="1" cap="all"/>
            </a:lvl1pPr>
          </a:lstStyle>
          <a:p>
            <a:r>
              <a:rPr lang="ko-KR" altLang="en-US"/>
              <a:t>마스터 제목 스타일 편집</a:t>
            </a:r>
          </a:p>
        </p:txBody>
      </p:sp>
      <p:sp>
        <p:nvSpPr>
          <p:cNvPr id="3" name="텍스트 개체 틀 2"/>
          <p:cNvSpPr>
            <a:spLocks noGrp="1"/>
          </p:cNvSpPr>
          <p:nvPr>
            <p:ph type="body" idx="1"/>
          </p:nvPr>
        </p:nvSpPr>
        <p:spPr>
          <a:xfrm>
            <a:off x="758429" y="5425866"/>
            <a:ext cx="8161020" cy="2800349"/>
          </a:xfrm>
        </p:spPr>
        <p:txBody>
          <a:bodyPr anchor="b"/>
          <a:lstStyle>
            <a:lvl1pPr marL="0" indent="0">
              <a:buNone/>
              <a:defRPr sz="2800">
                <a:solidFill>
                  <a:schemeClr val="tx1">
                    <a:tint val="75000"/>
                  </a:schemeClr>
                </a:solidFill>
              </a:defRPr>
            </a:lvl1pPr>
            <a:lvl2pPr marL="639976" indent="0">
              <a:buNone/>
              <a:defRPr sz="2500">
                <a:solidFill>
                  <a:schemeClr val="tx1">
                    <a:tint val="75000"/>
                  </a:schemeClr>
                </a:solidFill>
              </a:defRPr>
            </a:lvl2pPr>
            <a:lvl3pPr marL="1279953" indent="0">
              <a:buNone/>
              <a:defRPr sz="2300">
                <a:solidFill>
                  <a:schemeClr val="tx1">
                    <a:tint val="75000"/>
                  </a:schemeClr>
                </a:solidFill>
              </a:defRPr>
            </a:lvl3pPr>
            <a:lvl4pPr marL="1919929" indent="0">
              <a:buNone/>
              <a:defRPr sz="2000">
                <a:solidFill>
                  <a:schemeClr val="tx1">
                    <a:tint val="75000"/>
                  </a:schemeClr>
                </a:solidFill>
              </a:defRPr>
            </a:lvl4pPr>
            <a:lvl5pPr marL="2559906" indent="0">
              <a:buNone/>
              <a:defRPr sz="2000">
                <a:solidFill>
                  <a:schemeClr val="tx1">
                    <a:tint val="75000"/>
                  </a:schemeClr>
                </a:solidFill>
              </a:defRPr>
            </a:lvl5pPr>
            <a:lvl6pPr marL="3199882" indent="0">
              <a:buNone/>
              <a:defRPr sz="2000">
                <a:solidFill>
                  <a:schemeClr val="tx1">
                    <a:tint val="75000"/>
                  </a:schemeClr>
                </a:solidFill>
              </a:defRPr>
            </a:lvl6pPr>
            <a:lvl7pPr marL="3839859" indent="0">
              <a:buNone/>
              <a:defRPr sz="2000">
                <a:solidFill>
                  <a:schemeClr val="tx1">
                    <a:tint val="75000"/>
                  </a:schemeClr>
                </a:solidFill>
              </a:defRPr>
            </a:lvl7pPr>
            <a:lvl8pPr marL="4479835" indent="0">
              <a:buNone/>
              <a:defRPr sz="2000">
                <a:solidFill>
                  <a:schemeClr val="tx1">
                    <a:tint val="75000"/>
                  </a:schemeClr>
                </a:solidFill>
              </a:defRPr>
            </a:lvl8pPr>
            <a:lvl9pPr marL="5119812" indent="0">
              <a:buNone/>
              <a:defRPr sz="2000">
                <a:solidFill>
                  <a:schemeClr val="tx1">
                    <a:tint val="75000"/>
                  </a:schemeClr>
                </a:solidFill>
              </a:defRPr>
            </a:lvl9pPr>
          </a:lstStyle>
          <a:p>
            <a:pPr lvl="0"/>
            <a:r>
              <a:rPr lang="ko-KR" altLang="en-US"/>
              <a:t>마스터 텍스트 스타일을 편집합니다</a:t>
            </a:r>
          </a:p>
        </p:txBody>
      </p:sp>
      <p:sp>
        <p:nvSpPr>
          <p:cNvPr id="4" name="날짜 개체 틀 3"/>
          <p:cNvSpPr>
            <a:spLocks noGrp="1"/>
          </p:cNvSpPr>
          <p:nvPr>
            <p:ph type="dt" sz="half" idx="10"/>
          </p:nvPr>
        </p:nvSpPr>
        <p:spPr/>
        <p:txBody>
          <a:bodyPr/>
          <a:lstStyle/>
          <a:p>
            <a:fld id="{FC75D36E-F5BB-47E1-8CF6-197642BF9C69}" type="datetimeFigureOut">
              <a:rPr lang="ko-KR" altLang="en-US" smtClean="0"/>
              <a:pPr/>
              <a:t>2024-12-11</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BFDFE31A-9D4B-4AD2-9F2E-CC153BB0E734}" type="slidenum">
              <a:rPr lang="ko-KR" altLang="en-US" smtClean="0"/>
              <a:pPr/>
              <a:t>‹#›</a:t>
            </a:fld>
            <a:endParaRPr lang="ko-KR" altLang="en-US"/>
          </a:p>
        </p:txBody>
      </p:sp>
    </p:spTree>
    <p:extLst>
      <p:ext uri="{BB962C8B-B14F-4D97-AF65-F5344CB8AC3E}">
        <p14:creationId xmlns:p14="http://schemas.microsoft.com/office/powerpoint/2010/main" val="228038600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내용 개체 틀 2"/>
          <p:cNvSpPr>
            <a:spLocks noGrp="1"/>
          </p:cNvSpPr>
          <p:nvPr>
            <p:ph sz="half" idx="1"/>
          </p:nvPr>
        </p:nvSpPr>
        <p:spPr>
          <a:xfrm>
            <a:off x="480060" y="2987043"/>
            <a:ext cx="4240530" cy="8448464"/>
          </a:xfrm>
        </p:spPr>
        <p:txBody>
          <a:bodyPr/>
          <a:lstStyle>
            <a:lvl1pPr>
              <a:defRPr sz="3900"/>
            </a:lvl1pPr>
            <a:lvl2pPr>
              <a:defRPr sz="3400"/>
            </a:lvl2pPr>
            <a:lvl3pPr>
              <a:defRPr sz="2800"/>
            </a:lvl3pPr>
            <a:lvl4pPr>
              <a:defRPr sz="2500"/>
            </a:lvl4pPr>
            <a:lvl5pPr>
              <a:defRPr sz="2500"/>
            </a:lvl5pPr>
            <a:lvl6pPr>
              <a:defRPr sz="2500"/>
            </a:lvl6pPr>
            <a:lvl7pPr>
              <a:defRPr sz="2500"/>
            </a:lvl7pPr>
            <a:lvl8pPr>
              <a:defRPr sz="2500"/>
            </a:lvl8pPr>
            <a:lvl9pPr>
              <a:defRPr sz="250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내용 개체 틀 3"/>
          <p:cNvSpPr>
            <a:spLocks noGrp="1"/>
          </p:cNvSpPr>
          <p:nvPr>
            <p:ph sz="half" idx="2"/>
          </p:nvPr>
        </p:nvSpPr>
        <p:spPr>
          <a:xfrm>
            <a:off x="4880610" y="2987043"/>
            <a:ext cx="4240530" cy="8448464"/>
          </a:xfrm>
        </p:spPr>
        <p:txBody>
          <a:bodyPr/>
          <a:lstStyle>
            <a:lvl1pPr>
              <a:defRPr sz="3900"/>
            </a:lvl1pPr>
            <a:lvl2pPr>
              <a:defRPr sz="3400"/>
            </a:lvl2pPr>
            <a:lvl3pPr>
              <a:defRPr sz="2800"/>
            </a:lvl3pPr>
            <a:lvl4pPr>
              <a:defRPr sz="2500"/>
            </a:lvl4pPr>
            <a:lvl5pPr>
              <a:defRPr sz="2500"/>
            </a:lvl5pPr>
            <a:lvl6pPr>
              <a:defRPr sz="2500"/>
            </a:lvl6pPr>
            <a:lvl7pPr>
              <a:defRPr sz="2500"/>
            </a:lvl7pPr>
            <a:lvl8pPr>
              <a:defRPr sz="2500"/>
            </a:lvl8pPr>
            <a:lvl9pPr>
              <a:defRPr sz="250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5" name="날짜 개체 틀 4"/>
          <p:cNvSpPr>
            <a:spLocks noGrp="1"/>
          </p:cNvSpPr>
          <p:nvPr>
            <p:ph type="dt" sz="half" idx="10"/>
          </p:nvPr>
        </p:nvSpPr>
        <p:spPr/>
        <p:txBody>
          <a:bodyPr/>
          <a:lstStyle/>
          <a:p>
            <a:fld id="{FC75D36E-F5BB-47E1-8CF6-197642BF9C69}" type="datetimeFigureOut">
              <a:rPr lang="ko-KR" altLang="en-US" smtClean="0"/>
              <a:pPr/>
              <a:t>2024-12-11</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BFDFE31A-9D4B-4AD2-9F2E-CC153BB0E734}" type="slidenum">
              <a:rPr lang="ko-KR" altLang="en-US" smtClean="0"/>
              <a:pPr/>
              <a:t>‹#›</a:t>
            </a:fld>
            <a:endParaRPr lang="ko-KR" altLang="en-US"/>
          </a:p>
        </p:txBody>
      </p:sp>
    </p:spTree>
    <p:extLst>
      <p:ext uri="{BB962C8B-B14F-4D97-AF65-F5344CB8AC3E}">
        <p14:creationId xmlns:p14="http://schemas.microsoft.com/office/powerpoint/2010/main" val="10312897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lvl1pPr>
              <a:defRPr/>
            </a:lvl1pPr>
          </a:lstStyle>
          <a:p>
            <a:r>
              <a:rPr lang="ko-KR" altLang="en-US"/>
              <a:t>마스터 제목 스타일 편집</a:t>
            </a:r>
          </a:p>
        </p:txBody>
      </p:sp>
      <p:sp>
        <p:nvSpPr>
          <p:cNvPr id="3" name="텍스트 개체 틀 2"/>
          <p:cNvSpPr>
            <a:spLocks noGrp="1"/>
          </p:cNvSpPr>
          <p:nvPr>
            <p:ph type="body" idx="1"/>
          </p:nvPr>
        </p:nvSpPr>
        <p:spPr>
          <a:xfrm>
            <a:off x="480061" y="2865544"/>
            <a:ext cx="4242197" cy="1194222"/>
          </a:xfrm>
        </p:spPr>
        <p:txBody>
          <a:bodyPr anchor="b"/>
          <a:lstStyle>
            <a:lvl1pPr marL="0" indent="0">
              <a:buNone/>
              <a:defRPr sz="3400" b="1"/>
            </a:lvl1pPr>
            <a:lvl2pPr marL="639976" indent="0">
              <a:buNone/>
              <a:defRPr sz="2800" b="1"/>
            </a:lvl2pPr>
            <a:lvl3pPr marL="1279953" indent="0">
              <a:buNone/>
              <a:defRPr sz="2500" b="1"/>
            </a:lvl3pPr>
            <a:lvl4pPr marL="1919929" indent="0">
              <a:buNone/>
              <a:defRPr sz="2300" b="1"/>
            </a:lvl4pPr>
            <a:lvl5pPr marL="2559906" indent="0">
              <a:buNone/>
              <a:defRPr sz="2300" b="1"/>
            </a:lvl5pPr>
            <a:lvl6pPr marL="3199882" indent="0">
              <a:buNone/>
              <a:defRPr sz="2300" b="1"/>
            </a:lvl6pPr>
            <a:lvl7pPr marL="3839859" indent="0">
              <a:buNone/>
              <a:defRPr sz="2300" b="1"/>
            </a:lvl7pPr>
            <a:lvl8pPr marL="4479835" indent="0">
              <a:buNone/>
              <a:defRPr sz="2300" b="1"/>
            </a:lvl8pPr>
            <a:lvl9pPr marL="5119812" indent="0">
              <a:buNone/>
              <a:defRPr sz="2300" b="1"/>
            </a:lvl9pPr>
          </a:lstStyle>
          <a:p>
            <a:pPr lvl="0"/>
            <a:r>
              <a:rPr lang="ko-KR" altLang="en-US"/>
              <a:t>마스터 텍스트 스타일을 편집합니다</a:t>
            </a:r>
          </a:p>
        </p:txBody>
      </p:sp>
      <p:sp>
        <p:nvSpPr>
          <p:cNvPr id="4" name="내용 개체 틀 3"/>
          <p:cNvSpPr>
            <a:spLocks noGrp="1"/>
          </p:cNvSpPr>
          <p:nvPr>
            <p:ph sz="half" idx="2"/>
          </p:nvPr>
        </p:nvSpPr>
        <p:spPr>
          <a:xfrm>
            <a:off x="480061" y="4059766"/>
            <a:ext cx="4242197" cy="7375738"/>
          </a:xfrm>
        </p:spPr>
        <p:txBody>
          <a:bodyPr/>
          <a:lstStyle>
            <a:lvl1pPr>
              <a:defRPr sz="3400"/>
            </a:lvl1pPr>
            <a:lvl2pPr>
              <a:defRPr sz="2800"/>
            </a:lvl2pPr>
            <a:lvl3pPr>
              <a:defRPr sz="2500"/>
            </a:lvl3pPr>
            <a:lvl4pPr>
              <a:defRPr sz="2300"/>
            </a:lvl4pPr>
            <a:lvl5pPr>
              <a:defRPr sz="2300"/>
            </a:lvl5pPr>
            <a:lvl6pPr>
              <a:defRPr sz="2300"/>
            </a:lvl6pPr>
            <a:lvl7pPr>
              <a:defRPr sz="2300"/>
            </a:lvl7pPr>
            <a:lvl8pPr>
              <a:defRPr sz="2300"/>
            </a:lvl8pPr>
            <a:lvl9pPr>
              <a:defRPr sz="230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5" name="텍스트 개체 틀 4"/>
          <p:cNvSpPr>
            <a:spLocks noGrp="1"/>
          </p:cNvSpPr>
          <p:nvPr>
            <p:ph type="body" sz="quarter" idx="3"/>
          </p:nvPr>
        </p:nvSpPr>
        <p:spPr>
          <a:xfrm>
            <a:off x="4877278" y="2865544"/>
            <a:ext cx="4243863" cy="1194222"/>
          </a:xfrm>
        </p:spPr>
        <p:txBody>
          <a:bodyPr anchor="b"/>
          <a:lstStyle>
            <a:lvl1pPr marL="0" indent="0">
              <a:buNone/>
              <a:defRPr sz="3400" b="1"/>
            </a:lvl1pPr>
            <a:lvl2pPr marL="639976" indent="0">
              <a:buNone/>
              <a:defRPr sz="2800" b="1"/>
            </a:lvl2pPr>
            <a:lvl3pPr marL="1279953" indent="0">
              <a:buNone/>
              <a:defRPr sz="2500" b="1"/>
            </a:lvl3pPr>
            <a:lvl4pPr marL="1919929" indent="0">
              <a:buNone/>
              <a:defRPr sz="2300" b="1"/>
            </a:lvl4pPr>
            <a:lvl5pPr marL="2559906" indent="0">
              <a:buNone/>
              <a:defRPr sz="2300" b="1"/>
            </a:lvl5pPr>
            <a:lvl6pPr marL="3199882" indent="0">
              <a:buNone/>
              <a:defRPr sz="2300" b="1"/>
            </a:lvl6pPr>
            <a:lvl7pPr marL="3839859" indent="0">
              <a:buNone/>
              <a:defRPr sz="2300" b="1"/>
            </a:lvl7pPr>
            <a:lvl8pPr marL="4479835" indent="0">
              <a:buNone/>
              <a:defRPr sz="2300" b="1"/>
            </a:lvl8pPr>
            <a:lvl9pPr marL="5119812" indent="0">
              <a:buNone/>
              <a:defRPr sz="2300" b="1"/>
            </a:lvl9pPr>
          </a:lstStyle>
          <a:p>
            <a:pPr lvl="0"/>
            <a:r>
              <a:rPr lang="ko-KR" altLang="en-US"/>
              <a:t>마스터 텍스트 스타일을 편집합니다</a:t>
            </a:r>
          </a:p>
        </p:txBody>
      </p:sp>
      <p:sp>
        <p:nvSpPr>
          <p:cNvPr id="6" name="내용 개체 틀 5"/>
          <p:cNvSpPr>
            <a:spLocks noGrp="1"/>
          </p:cNvSpPr>
          <p:nvPr>
            <p:ph sz="quarter" idx="4"/>
          </p:nvPr>
        </p:nvSpPr>
        <p:spPr>
          <a:xfrm>
            <a:off x="4877278" y="4059766"/>
            <a:ext cx="4243863" cy="7375738"/>
          </a:xfrm>
        </p:spPr>
        <p:txBody>
          <a:bodyPr/>
          <a:lstStyle>
            <a:lvl1pPr>
              <a:defRPr sz="3400"/>
            </a:lvl1pPr>
            <a:lvl2pPr>
              <a:defRPr sz="2800"/>
            </a:lvl2pPr>
            <a:lvl3pPr>
              <a:defRPr sz="2500"/>
            </a:lvl3pPr>
            <a:lvl4pPr>
              <a:defRPr sz="2300"/>
            </a:lvl4pPr>
            <a:lvl5pPr>
              <a:defRPr sz="2300"/>
            </a:lvl5pPr>
            <a:lvl6pPr>
              <a:defRPr sz="2300"/>
            </a:lvl6pPr>
            <a:lvl7pPr>
              <a:defRPr sz="2300"/>
            </a:lvl7pPr>
            <a:lvl8pPr>
              <a:defRPr sz="2300"/>
            </a:lvl8pPr>
            <a:lvl9pPr>
              <a:defRPr sz="230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7" name="날짜 개체 틀 6"/>
          <p:cNvSpPr>
            <a:spLocks noGrp="1"/>
          </p:cNvSpPr>
          <p:nvPr>
            <p:ph type="dt" sz="half" idx="10"/>
          </p:nvPr>
        </p:nvSpPr>
        <p:spPr/>
        <p:txBody>
          <a:bodyPr/>
          <a:lstStyle/>
          <a:p>
            <a:fld id="{FC75D36E-F5BB-47E1-8CF6-197642BF9C69}" type="datetimeFigureOut">
              <a:rPr lang="ko-KR" altLang="en-US" smtClean="0"/>
              <a:pPr/>
              <a:t>2024-12-11</a:t>
            </a:fld>
            <a:endParaRPr lang="ko-KR" altLang="en-US"/>
          </a:p>
        </p:txBody>
      </p:sp>
      <p:sp>
        <p:nvSpPr>
          <p:cNvPr id="8" name="바닥글 개체 틀 7"/>
          <p:cNvSpPr>
            <a:spLocks noGrp="1"/>
          </p:cNvSpPr>
          <p:nvPr>
            <p:ph type="ftr" sz="quarter" idx="11"/>
          </p:nvPr>
        </p:nvSpPr>
        <p:spPr/>
        <p:txBody>
          <a:bodyPr/>
          <a:lstStyle/>
          <a:p>
            <a:endParaRPr lang="ko-KR" altLang="en-US"/>
          </a:p>
        </p:txBody>
      </p:sp>
      <p:sp>
        <p:nvSpPr>
          <p:cNvPr id="9" name="슬라이드 번호 개체 틀 8"/>
          <p:cNvSpPr>
            <a:spLocks noGrp="1"/>
          </p:cNvSpPr>
          <p:nvPr>
            <p:ph type="sldNum" sz="quarter" idx="12"/>
          </p:nvPr>
        </p:nvSpPr>
        <p:spPr/>
        <p:txBody>
          <a:bodyPr/>
          <a:lstStyle/>
          <a:p>
            <a:fld id="{BFDFE31A-9D4B-4AD2-9F2E-CC153BB0E734}" type="slidenum">
              <a:rPr lang="ko-KR" altLang="en-US" smtClean="0"/>
              <a:pPr/>
              <a:t>‹#›</a:t>
            </a:fld>
            <a:endParaRPr lang="ko-KR" altLang="en-US"/>
          </a:p>
        </p:txBody>
      </p:sp>
    </p:spTree>
    <p:extLst>
      <p:ext uri="{BB962C8B-B14F-4D97-AF65-F5344CB8AC3E}">
        <p14:creationId xmlns:p14="http://schemas.microsoft.com/office/powerpoint/2010/main" val="295271069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날짜 개체 틀 2"/>
          <p:cNvSpPr>
            <a:spLocks noGrp="1"/>
          </p:cNvSpPr>
          <p:nvPr>
            <p:ph type="dt" sz="half" idx="10"/>
          </p:nvPr>
        </p:nvSpPr>
        <p:spPr/>
        <p:txBody>
          <a:bodyPr/>
          <a:lstStyle/>
          <a:p>
            <a:fld id="{FC75D36E-F5BB-47E1-8CF6-197642BF9C69}" type="datetimeFigureOut">
              <a:rPr lang="ko-KR" altLang="en-US" smtClean="0"/>
              <a:pPr/>
              <a:t>2024-12-11</a:t>
            </a:fld>
            <a:endParaRPr lang="ko-KR" altLang="en-US"/>
          </a:p>
        </p:txBody>
      </p:sp>
      <p:sp>
        <p:nvSpPr>
          <p:cNvPr id="4" name="바닥글 개체 틀 3"/>
          <p:cNvSpPr>
            <a:spLocks noGrp="1"/>
          </p:cNvSpPr>
          <p:nvPr>
            <p:ph type="ftr" sz="quarter" idx="11"/>
          </p:nvPr>
        </p:nvSpPr>
        <p:spPr/>
        <p:txBody>
          <a:bodyPr/>
          <a:lstStyle/>
          <a:p>
            <a:endParaRPr lang="ko-KR" altLang="en-US"/>
          </a:p>
        </p:txBody>
      </p:sp>
      <p:sp>
        <p:nvSpPr>
          <p:cNvPr id="5" name="슬라이드 번호 개체 틀 4"/>
          <p:cNvSpPr>
            <a:spLocks noGrp="1"/>
          </p:cNvSpPr>
          <p:nvPr>
            <p:ph type="sldNum" sz="quarter" idx="12"/>
          </p:nvPr>
        </p:nvSpPr>
        <p:spPr/>
        <p:txBody>
          <a:bodyPr/>
          <a:lstStyle/>
          <a:p>
            <a:fld id="{BFDFE31A-9D4B-4AD2-9F2E-CC153BB0E734}" type="slidenum">
              <a:rPr lang="ko-KR" altLang="en-US" smtClean="0"/>
              <a:pPr/>
              <a:t>‹#›</a:t>
            </a:fld>
            <a:endParaRPr lang="ko-KR" altLang="en-US"/>
          </a:p>
        </p:txBody>
      </p:sp>
    </p:spTree>
    <p:extLst>
      <p:ext uri="{BB962C8B-B14F-4D97-AF65-F5344CB8AC3E}">
        <p14:creationId xmlns:p14="http://schemas.microsoft.com/office/powerpoint/2010/main" val="278684088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p:cNvSpPr>
            <a:spLocks noGrp="1"/>
          </p:cNvSpPr>
          <p:nvPr>
            <p:ph type="dt" sz="half" idx="10"/>
          </p:nvPr>
        </p:nvSpPr>
        <p:spPr/>
        <p:txBody>
          <a:bodyPr/>
          <a:lstStyle/>
          <a:p>
            <a:fld id="{FC75D36E-F5BB-47E1-8CF6-197642BF9C69}" type="datetimeFigureOut">
              <a:rPr lang="ko-KR" altLang="en-US" smtClean="0"/>
              <a:pPr/>
              <a:t>2024-12-11</a:t>
            </a:fld>
            <a:endParaRPr lang="ko-KR" altLang="en-US"/>
          </a:p>
        </p:txBody>
      </p:sp>
      <p:sp>
        <p:nvSpPr>
          <p:cNvPr id="3" name="바닥글 개체 틀 2"/>
          <p:cNvSpPr>
            <a:spLocks noGrp="1"/>
          </p:cNvSpPr>
          <p:nvPr>
            <p:ph type="ftr" sz="quarter" idx="11"/>
          </p:nvPr>
        </p:nvSpPr>
        <p:spPr/>
        <p:txBody>
          <a:bodyPr/>
          <a:lstStyle/>
          <a:p>
            <a:endParaRPr lang="ko-KR" altLang="en-US"/>
          </a:p>
        </p:txBody>
      </p:sp>
      <p:sp>
        <p:nvSpPr>
          <p:cNvPr id="4" name="슬라이드 번호 개체 틀 3"/>
          <p:cNvSpPr>
            <a:spLocks noGrp="1"/>
          </p:cNvSpPr>
          <p:nvPr>
            <p:ph type="sldNum" sz="quarter" idx="12"/>
          </p:nvPr>
        </p:nvSpPr>
        <p:spPr/>
        <p:txBody>
          <a:bodyPr/>
          <a:lstStyle/>
          <a:p>
            <a:fld id="{BFDFE31A-9D4B-4AD2-9F2E-CC153BB0E734}" type="slidenum">
              <a:rPr lang="ko-KR" altLang="en-US" smtClean="0"/>
              <a:pPr/>
              <a:t>‹#›</a:t>
            </a:fld>
            <a:endParaRPr lang="ko-KR" altLang="en-US"/>
          </a:p>
        </p:txBody>
      </p:sp>
    </p:spTree>
    <p:extLst>
      <p:ext uri="{BB962C8B-B14F-4D97-AF65-F5344CB8AC3E}">
        <p14:creationId xmlns:p14="http://schemas.microsoft.com/office/powerpoint/2010/main" val="416753496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p:cNvSpPr>
            <a:spLocks noGrp="1"/>
          </p:cNvSpPr>
          <p:nvPr>
            <p:ph type="title"/>
          </p:nvPr>
        </p:nvSpPr>
        <p:spPr>
          <a:xfrm>
            <a:off x="480061" y="509694"/>
            <a:ext cx="3158729" cy="2169160"/>
          </a:xfrm>
        </p:spPr>
        <p:txBody>
          <a:bodyPr anchor="b"/>
          <a:lstStyle>
            <a:lvl1pPr algn="l">
              <a:defRPr sz="2800" b="1"/>
            </a:lvl1pPr>
          </a:lstStyle>
          <a:p>
            <a:r>
              <a:rPr lang="ko-KR" altLang="en-US"/>
              <a:t>마스터 제목 스타일 편집</a:t>
            </a:r>
          </a:p>
        </p:txBody>
      </p:sp>
      <p:sp>
        <p:nvSpPr>
          <p:cNvPr id="3" name="내용 개체 틀 2"/>
          <p:cNvSpPr>
            <a:spLocks noGrp="1"/>
          </p:cNvSpPr>
          <p:nvPr>
            <p:ph idx="1"/>
          </p:nvPr>
        </p:nvSpPr>
        <p:spPr>
          <a:xfrm>
            <a:off x="3753803" y="509695"/>
            <a:ext cx="5367338" cy="10925812"/>
          </a:xfrm>
        </p:spPr>
        <p:txBody>
          <a:bodyPr/>
          <a:lstStyle>
            <a:lvl1pPr>
              <a:defRPr sz="4500"/>
            </a:lvl1pPr>
            <a:lvl2pPr>
              <a:defRPr sz="3900"/>
            </a:lvl2pPr>
            <a:lvl3pPr>
              <a:defRPr sz="3400"/>
            </a:lvl3pPr>
            <a:lvl4pPr>
              <a:defRPr sz="2800"/>
            </a:lvl4pPr>
            <a:lvl5pPr>
              <a:defRPr sz="2800"/>
            </a:lvl5pPr>
            <a:lvl6pPr>
              <a:defRPr sz="2800"/>
            </a:lvl6pPr>
            <a:lvl7pPr>
              <a:defRPr sz="2800"/>
            </a:lvl7pPr>
            <a:lvl8pPr>
              <a:defRPr sz="2800"/>
            </a:lvl8pPr>
            <a:lvl9pPr>
              <a:defRPr sz="280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텍스트 개체 틀 3"/>
          <p:cNvSpPr>
            <a:spLocks noGrp="1"/>
          </p:cNvSpPr>
          <p:nvPr>
            <p:ph type="body" sz="half" idx="2"/>
          </p:nvPr>
        </p:nvSpPr>
        <p:spPr>
          <a:xfrm>
            <a:off x="480061" y="2678855"/>
            <a:ext cx="3158729" cy="8756652"/>
          </a:xfrm>
        </p:spPr>
        <p:txBody>
          <a:bodyPr/>
          <a:lstStyle>
            <a:lvl1pPr marL="0" indent="0">
              <a:buNone/>
              <a:defRPr sz="2000"/>
            </a:lvl1pPr>
            <a:lvl2pPr marL="639976" indent="0">
              <a:buNone/>
              <a:defRPr sz="1600"/>
            </a:lvl2pPr>
            <a:lvl3pPr marL="1279953" indent="0">
              <a:buNone/>
              <a:defRPr sz="1400"/>
            </a:lvl3pPr>
            <a:lvl4pPr marL="1919929" indent="0">
              <a:buNone/>
              <a:defRPr sz="1300"/>
            </a:lvl4pPr>
            <a:lvl5pPr marL="2559906" indent="0">
              <a:buNone/>
              <a:defRPr sz="1300"/>
            </a:lvl5pPr>
            <a:lvl6pPr marL="3199882" indent="0">
              <a:buNone/>
              <a:defRPr sz="1300"/>
            </a:lvl6pPr>
            <a:lvl7pPr marL="3839859" indent="0">
              <a:buNone/>
              <a:defRPr sz="1300"/>
            </a:lvl7pPr>
            <a:lvl8pPr marL="4479835" indent="0">
              <a:buNone/>
              <a:defRPr sz="1300"/>
            </a:lvl8pPr>
            <a:lvl9pPr marL="5119812" indent="0">
              <a:buNone/>
              <a:defRPr sz="1300"/>
            </a:lvl9pPr>
          </a:lstStyle>
          <a:p>
            <a:pPr lvl="0"/>
            <a:r>
              <a:rPr lang="ko-KR" altLang="en-US"/>
              <a:t>마스터 텍스트 스타일을 편집합니다</a:t>
            </a:r>
          </a:p>
        </p:txBody>
      </p:sp>
      <p:sp>
        <p:nvSpPr>
          <p:cNvPr id="5" name="날짜 개체 틀 4"/>
          <p:cNvSpPr>
            <a:spLocks noGrp="1"/>
          </p:cNvSpPr>
          <p:nvPr>
            <p:ph type="dt" sz="half" idx="10"/>
          </p:nvPr>
        </p:nvSpPr>
        <p:spPr/>
        <p:txBody>
          <a:bodyPr/>
          <a:lstStyle/>
          <a:p>
            <a:fld id="{FC75D36E-F5BB-47E1-8CF6-197642BF9C69}" type="datetimeFigureOut">
              <a:rPr lang="ko-KR" altLang="en-US" smtClean="0"/>
              <a:pPr/>
              <a:t>2024-12-11</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BFDFE31A-9D4B-4AD2-9F2E-CC153BB0E734}" type="slidenum">
              <a:rPr lang="ko-KR" altLang="en-US" smtClean="0"/>
              <a:pPr/>
              <a:t>‹#›</a:t>
            </a:fld>
            <a:endParaRPr lang="ko-KR" altLang="en-US"/>
          </a:p>
        </p:txBody>
      </p:sp>
    </p:spTree>
    <p:extLst>
      <p:ext uri="{BB962C8B-B14F-4D97-AF65-F5344CB8AC3E}">
        <p14:creationId xmlns:p14="http://schemas.microsoft.com/office/powerpoint/2010/main" val="151535496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p:cNvSpPr>
            <a:spLocks noGrp="1"/>
          </p:cNvSpPr>
          <p:nvPr>
            <p:ph type="title"/>
          </p:nvPr>
        </p:nvSpPr>
        <p:spPr>
          <a:xfrm>
            <a:off x="1881902" y="8961120"/>
            <a:ext cx="5760720" cy="1057911"/>
          </a:xfrm>
        </p:spPr>
        <p:txBody>
          <a:bodyPr anchor="b"/>
          <a:lstStyle>
            <a:lvl1pPr algn="l">
              <a:defRPr sz="2800" b="1"/>
            </a:lvl1pPr>
          </a:lstStyle>
          <a:p>
            <a:r>
              <a:rPr lang="ko-KR" altLang="en-US"/>
              <a:t>마스터 제목 스타일 편집</a:t>
            </a:r>
          </a:p>
        </p:txBody>
      </p:sp>
      <p:sp>
        <p:nvSpPr>
          <p:cNvPr id="3" name="그림 개체 틀 2"/>
          <p:cNvSpPr>
            <a:spLocks noGrp="1"/>
          </p:cNvSpPr>
          <p:nvPr>
            <p:ph type="pic" idx="1"/>
          </p:nvPr>
        </p:nvSpPr>
        <p:spPr>
          <a:xfrm>
            <a:off x="1881902" y="1143847"/>
            <a:ext cx="5760720" cy="7680960"/>
          </a:xfrm>
        </p:spPr>
        <p:txBody>
          <a:bodyPr/>
          <a:lstStyle>
            <a:lvl1pPr marL="0" indent="0">
              <a:buNone/>
              <a:defRPr sz="4500"/>
            </a:lvl1pPr>
            <a:lvl2pPr marL="639976" indent="0">
              <a:buNone/>
              <a:defRPr sz="3900"/>
            </a:lvl2pPr>
            <a:lvl3pPr marL="1279953" indent="0">
              <a:buNone/>
              <a:defRPr sz="3400"/>
            </a:lvl3pPr>
            <a:lvl4pPr marL="1919929" indent="0">
              <a:buNone/>
              <a:defRPr sz="2800"/>
            </a:lvl4pPr>
            <a:lvl5pPr marL="2559906" indent="0">
              <a:buNone/>
              <a:defRPr sz="2800"/>
            </a:lvl5pPr>
            <a:lvl6pPr marL="3199882" indent="0">
              <a:buNone/>
              <a:defRPr sz="2800"/>
            </a:lvl6pPr>
            <a:lvl7pPr marL="3839859" indent="0">
              <a:buNone/>
              <a:defRPr sz="2800"/>
            </a:lvl7pPr>
            <a:lvl8pPr marL="4479835" indent="0">
              <a:buNone/>
              <a:defRPr sz="2800"/>
            </a:lvl8pPr>
            <a:lvl9pPr marL="5119812" indent="0">
              <a:buNone/>
              <a:defRPr sz="2800"/>
            </a:lvl9pPr>
          </a:lstStyle>
          <a:p>
            <a:endParaRPr lang="ko-KR" altLang="en-US"/>
          </a:p>
        </p:txBody>
      </p:sp>
      <p:sp>
        <p:nvSpPr>
          <p:cNvPr id="4" name="텍스트 개체 틀 3"/>
          <p:cNvSpPr>
            <a:spLocks noGrp="1"/>
          </p:cNvSpPr>
          <p:nvPr>
            <p:ph type="body" sz="half" idx="2"/>
          </p:nvPr>
        </p:nvSpPr>
        <p:spPr>
          <a:xfrm>
            <a:off x="1881902" y="10019032"/>
            <a:ext cx="5760720" cy="1502409"/>
          </a:xfrm>
        </p:spPr>
        <p:txBody>
          <a:bodyPr/>
          <a:lstStyle>
            <a:lvl1pPr marL="0" indent="0">
              <a:buNone/>
              <a:defRPr sz="2000"/>
            </a:lvl1pPr>
            <a:lvl2pPr marL="639976" indent="0">
              <a:buNone/>
              <a:defRPr sz="1600"/>
            </a:lvl2pPr>
            <a:lvl3pPr marL="1279953" indent="0">
              <a:buNone/>
              <a:defRPr sz="1400"/>
            </a:lvl3pPr>
            <a:lvl4pPr marL="1919929" indent="0">
              <a:buNone/>
              <a:defRPr sz="1300"/>
            </a:lvl4pPr>
            <a:lvl5pPr marL="2559906" indent="0">
              <a:buNone/>
              <a:defRPr sz="1300"/>
            </a:lvl5pPr>
            <a:lvl6pPr marL="3199882" indent="0">
              <a:buNone/>
              <a:defRPr sz="1300"/>
            </a:lvl6pPr>
            <a:lvl7pPr marL="3839859" indent="0">
              <a:buNone/>
              <a:defRPr sz="1300"/>
            </a:lvl7pPr>
            <a:lvl8pPr marL="4479835" indent="0">
              <a:buNone/>
              <a:defRPr sz="1300"/>
            </a:lvl8pPr>
            <a:lvl9pPr marL="5119812" indent="0">
              <a:buNone/>
              <a:defRPr sz="1300"/>
            </a:lvl9pPr>
          </a:lstStyle>
          <a:p>
            <a:pPr lvl="0"/>
            <a:r>
              <a:rPr lang="ko-KR" altLang="en-US"/>
              <a:t>마스터 텍스트 스타일을 편집합니다</a:t>
            </a:r>
          </a:p>
        </p:txBody>
      </p:sp>
      <p:sp>
        <p:nvSpPr>
          <p:cNvPr id="5" name="날짜 개체 틀 4"/>
          <p:cNvSpPr>
            <a:spLocks noGrp="1"/>
          </p:cNvSpPr>
          <p:nvPr>
            <p:ph type="dt" sz="half" idx="10"/>
          </p:nvPr>
        </p:nvSpPr>
        <p:spPr/>
        <p:txBody>
          <a:bodyPr/>
          <a:lstStyle/>
          <a:p>
            <a:fld id="{FC75D36E-F5BB-47E1-8CF6-197642BF9C69}" type="datetimeFigureOut">
              <a:rPr lang="ko-KR" altLang="en-US" smtClean="0"/>
              <a:pPr/>
              <a:t>2024-12-11</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BFDFE31A-9D4B-4AD2-9F2E-CC153BB0E734}" type="slidenum">
              <a:rPr lang="ko-KR" altLang="en-US" smtClean="0"/>
              <a:pPr/>
              <a:t>‹#›</a:t>
            </a:fld>
            <a:endParaRPr lang="ko-KR" altLang="en-US"/>
          </a:p>
        </p:txBody>
      </p:sp>
    </p:spTree>
    <p:extLst>
      <p:ext uri="{BB962C8B-B14F-4D97-AF65-F5344CB8AC3E}">
        <p14:creationId xmlns:p14="http://schemas.microsoft.com/office/powerpoint/2010/main" val="135306800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p:cNvSpPr>
            <a:spLocks noGrp="1"/>
          </p:cNvSpPr>
          <p:nvPr>
            <p:ph type="title"/>
          </p:nvPr>
        </p:nvSpPr>
        <p:spPr>
          <a:xfrm>
            <a:off x="480060" y="512658"/>
            <a:ext cx="8641080" cy="2133600"/>
          </a:xfrm>
          <a:prstGeom prst="rect">
            <a:avLst/>
          </a:prstGeom>
        </p:spPr>
        <p:txBody>
          <a:bodyPr vert="horz" lIns="127995" tIns="63998" rIns="127995" bIns="63998" rtlCol="0" anchor="ctr">
            <a:normAutofit/>
          </a:bodyPr>
          <a:lstStyle/>
          <a:p>
            <a:r>
              <a:rPr lang="ko-KR" altLang="en-US"/>
              <a:t>마스터 제목 스타일 편집</a:t>
            </a:r>
          </a:p>
        </p:txBody>
      </p:sp>
      <p:sp>
        <p:nvSpPr>
          <p:cNvPr id="3" name="텍스트 개체 틀 2"/>
          <p:cNvSpPr>
            <a:spLocks noGrp="1"/>
          </p:cNvSpPr>
          <p:nvPr>
            <p:ph type="body" idx="1"/>
          </p:nvPr>
        </p:nvSpPr>
        <p:spPr>
          <a:xfrm>
            <a:off x="480060" y="2987043"/>
            <a:ext cx="8641080" cy="8448464"/>
          </a:xfrm>
          <a:prstGeom prst="rect">
            <a:avLst/>
          </a:prstGeom>
        </p:spPr>
        <p:txBody>
          <a:bodyPr vert="horz" lIns="127995" tIns="63998" rIns="127995" bIns="63998" rtlCol="0">
            <a:normAutofit/>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p:cNvSpPr>
            <a:spLocks noGrp="1"/>
          </p:cNvSpPr>
          <p:nvPr>
            <p:ph type="dt" sz="half" idx="2"/>
          </p:nvPr>
        </p:nvSpPr>
        <p:spPr>
          <a:xfrm>
            <a:off x="480061" y="11865188"/>
            <a:ext cx="2240280" cy="681566"/>
          </a:xfrm>
          <a:prstGeom prst="rect">
            <a:avLst/>
          </a:prstGeom>
        </p:spPr>
        <p:txBody>
          <a:bodyPr vert="horz" lIns="127995" tIns="63998" rIns="127995" bIns="63998" rtlCol="0" anchor="ctr"/>
          <a:lstStyle>
            <a:lvl1pPr algn="l">
              <a:defRPr sz="1600">
                <a:solidFill>
                  <a:schemeClr val="tx1">
                    <a:tint val="75000"/>
                  </a:schemeClr>
                </a:solidFill>
              </a:defRPr>
            </a:lvl1pPr>
          </a:lstStyle>
          <a:p>
            <a:fld id="{FC75D36E-F5BB-47E1-8CF6-197642BF9C69}" type="datetimeFigureOut">
              <a:rPr lang="ko-KR" altLang="en-US" smtClean="0"/>
              <a:pPr/>
              <a:t>2024-12-11</a:t>
            </a:fld>
            <a:endParaRPr lang="ko-KR" altLang="en-US"/>
          </a:p>
        </p:txBody>
      </p:sp>
      <p:sp>
        <p:nvSpPr>
          <p:cNvPr id="5" name="바닥글 개체 틀 4"/>
          <p:cNvSpPr>
            <a:spLocks noGrp="1"/>
          </p:cNvSpPr>
          <p:nvPr>
            <p:ph type="ftr" sz="quarter" idx="3"/>
          </p:nvPr>
        </p:nvSpPr>
        <p:spPr>
          <a:xfrm>
            <a:off x="3280411" y="11865188"/>
            <a:ext cx="3040380" cy="681566"/>
          </a:xfrm>
          <a:prstGeom prst="rect">
            <a:avLst/>
          </a:prstGeom>
        </p:spPr>
        <p:txBody>
          <a:bodyPr vert="horz" lIns="127995" tIns="63998" rIns="127995" bIns="63998" rtlCol="0" anchor="ctr"/>
          <a:lstStyle>
            <a:lvl1pPr algn="ctr">
              <a:defRPr sz="1600">
                <a:solidFill>
                  <a:schemeClr val="tx1">
                    <a:tint val="75000"/>
                  </a:schemeClr>
                </a:solidFill>
              </a:defRPr>
            </a:lvl1pPr>
          </a:lstStyle>
          <a:p>
            <a:endParaRPr lang="ko-KR" altLang="en-US"/>
          </a:p>
        </p:txBody>
      </p:sp>
      <p:sp>
        <p:nvSpPr>
          <p:cNvPr id="6" name="슬라이드 번호 개체 틀 5"/>
          <p:cNvSpPr>
            <a:spLocks noGrp="1"/>
          </p:cNvSpPr>
          <p:nvPr>
            <p:ph type="sldNum" sz="quarter" idx="4"/>
          </p:nvPr>
        </p:nvSpPr>
        <p:spPr>
          <a:xfrm>
            <a:off x="6880860" y="11865188"/>
            <a:ext cx="2240280" cy="681566"/>
          </a:xfrm>
          <a:prstGeom prst="rect">
            <a:avLst/>
          </a:prstGeom>
        </p:spPr>
        <p:txBody>
          <a:bodyPr vert="horz" lIns="127995" tIns="63998" rIns="127995" bIns="63998" rtlCol="0" anchor="ctr"/>
          <a:lstStyle>
            <a:lvl1pPr algn="r">
              <a:defRPr sz="1600">
                <a:solidFill>
                  <a:schemeClr val="tx1">
                    <a:tint val="75000"/>
                  </a:schemeClr>
                </a:solidFill>
              </a:defRPr>
            </a:lvl1pPr>
          </a:lstStyle>
          <a:p>
            <a:fld id="{BFDFE31A-9D4B-4AD2-9F2E-CC153BB0E734}" type="slidenum">
              <a:rPr lang="ko-KR" altLang="en-US" smtClean="0"/>
              <a:pPr/>
              <a:t>‹#›</a:t>
            </a:fld>
            <a:endParaRPr lang="ko-KR" altLang="en-US"/>
          </a:p>
        </p:txBody>
      </p:sp>
    </p:spTree>
    <p:extLst>
      <p:ext uri="{BB962C8B-B14F-4D97-AF65-F5344CB8AC3E}">
        <p14:creationId xmlns:p14="http://schemas.microsoft.com/office/powerpoint/2010/main" val="144605586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1279953" rtl="0" eaLnBrk="1" latinLnBrk="1" hangingPunct="1">
        <a:spcBef>
          <a:spcPct val="0"/>
        </a:spcBef>
        <a:buNone/>
        <a:defRPr sz="6200" kern="1200">
          <a:solidFill>
            <a:schemeClr val="tx1"/>
          </a:solidFill>
          <a:latin typeface="+mj-lt"/>
          <a:ea typeface="+mj-ea"/>
          <a:cs typeface="+mj-cs"/>
        </a:defRPr>
      </a:lvl1pPr>
    </p:titleStyle>
    <p:bodyStyle>
      <a:lvl1pPr marL="479982" indent="-479982" algn="l" defTabSz="1279953" rtl="0" eaLnBrk="1" latinLnBrk="1" hangingPunct="1">
        <a:spcBef>
          <a:spcPct val="20000"/>
        </a:spcBef>
        <a:buFont typeface="Arial" pitchFamily="34" charset="0"/>
        <a:buChar char="•"/>
        <a:defRPr sz="4500" kern="1200">
          <a:solidFill>
            <a:schemeClr val="tx1"/>
          </a:solidFill>
          <a:latin typeface="+mn-lt"/>
          <a:ea typeface="+mn-ea"/>
          <a:cs typeface="+mn-cs"/>
        </a:defRPr>
      </a:lvl1pPr>
      <a:lvl2pPr marL="1039962" indent="-399985" algn="l" defTabSz="1279953" rtl="0" eaLnBrk="1" latinLnBrk="1" hangingPunct="1">
        <a:spcBef>
          <a:spcPct val="20000"/>
        </a:spcBef>
        <a:buFont typeface="Arial" pitchFamily="34" charset="0"/>
        <a:buChar char="–"/>
        <a:defRPr sz="3900" kern="1200">
          <a:solidFill>
            <a:schemeClr val="tx1"/>
          </a:solidFill>
          <a:latin typeface="+mn-lt"/>
          <a:ea typeface="+mn-ea"/>
          <a:cs typeface="+mn-cs"/>
        </a:defRPr>
      </a:lvl2pPr>
      <a:lvl3pPr marL="1599942" indent="-319989" algn="l" defTabSz="1279953" rtl="0" eaLnBrk="1" latinLnBrk="1" hangingPunct="1">
        <a:spcBef>
          <a:spcPct val="20000"/>
        </a:spcBef>
        <a:buFont typeface="Arial" pitchFamily="34" charset="0"/>
        <a:buChar char="•"/>
        <a:defRPr sz="3400" kern="1200">
          <a:solidFill>
            <a:schemeClr val="tx1"/>
          </a:solidFill>
          <a:latin typeface="+mn-lt"/>
          <a:ea typeface="+mn-ea"/>
          <a:cs typeface="+mn-cs"/>
        </a:defRPr>
      </a:lvl3pPr>
      <a:lvl4pPr marL="2239918" indent="-319989" algn="l" defTabSz="1279953" rtl="0" eaLnBrk="1" latinLnBrk="1" hangingPunct="1">
        <a:spcBef>
          <a:spcPct val="20000"/>
        </a:spcBef>
        <a:buFont typeface="Arial" pitchFamily="34" charset="0"/>
        <a:buChar char="–"/>
        <a:defRPr sz="2800" kern="1200">
          <a:solidFill>
            <a:schemeClr val="tx1"/>
          </a:solidFill>
          <a:latin typeface="+mn-lt"/>
          <a:ea typeface="+mn-ea"/>
          <a:cs typeface="+mn-cs"/>
        </a:defRPr>
      </a:lvl4pPr>
      <a:lvl5pPr marL="2879895" indent="-319989" algn="l" defTabSz="1279953" rtl="0" eaLnBrk="1" latinLnBrk="1" hangingPunct="1">
        <a:spcBef>
          <a:spcPct val="20000"/>
        </a:spcBef>
        <a:buFont typeface="Arial" pitchFamily="34" charset="0"/>
        <a:buChar char="»"/>
        <a:defRPr sz="2800" kern="1200">
          <a:solidFill>
            <a:schemeClr val="tx1"/>
          </a:solidFill>
          <a:latin typeface="+mn-lt"/>
          <a:ea typeface="+mn-ea"/>
          <a:cs typeface="+mn-cs"/>
        </a:defRPr>
      </a:lvl5pPr>
      <a:lvl6pPr marL="3519871" indent="-319989" algn="l" defTabSz="1279953" rtl="0" eaLnBrk="1" latinLnBrk="1" hangingPunct="1">
        <a:spcBef>
          <a:spcPct val="20000"/>
        </a:spcBef>
        <a:buFont typeface="Arial" pitchFamily="34" charset="0"/>
        <a:buChar char="•"/>
        <a:defRPr sz="2800" kern="1200">
          <a:solidFill>
            <a:schemeClr val="tx1"/>
          </a:solidFill>
          <a:latin typeface="+mn-lt"/>
          <a:ea typeface="+mn-ea"/>
          <a:cs typeface="+mn-cs"/>
        </a:defRPr>
      </a:lvl6pPr>
      <a:lvl7pPr marL="4159848" indent="-319989" algn="l" defTabSz="1279953" rtl="0" eaLnBrk="1" latinLnBrk="1" hangingPunct="1">
        <a:spcBef>
          <a:spcPct val="20000"/>
        </a:spcBef>
        <a:buFont typeface="Arial" pitchFamily="34" charset="0"/>
        <a:buChar char="•"/>
        <a:defRPr sz="2800" kern="1200">
          <a:solidFill>
            <a:schemeClr val="tx1"/>
          </a:solidFill>
          <a:latin typeface="+mn-lt"/>
          <a:ea typeface="+mn-ea"/>
          <a:cs typeface="+mn-cs"/>
        </a:defRPr>
      </a:lvl7pPr>
      <a:lvl8pPr marL="4799824" indent="-319989" algn="l" defTabSz="1279953" rtl="0" eaLnBrk="1" latinLnBrk="1" hangingPunct="1">
        <a:spcBef>
          <a:spcPct val="20000"/>
        </a:spcBef>
        <a:buFont typeface="Arial" pitchFamily="34" charset="0"/>
        <a:buChar char="•"/>
        <a:defRPr sz="2800" kern="1200">
          <a:solidFill>
            <a:schemeClr val="tx1"/>
          </a:solidFill>
          <a:latin typeface="+mn-lt"/>
          <a:ea typeface="+mn-ea"/>
          <a:cs typeface="+mn-cs"/>
        </a:defRPr>
      </a:lvl8pPr>
      <a:lvl9pPr marL="5439800" indent="-319989" algn="l" defTabSz="1279953" rtl="0" eaLnBrk="1" latinLnBrk="1" hangingPunct="1">
        <a:spcBef>
          <a:spcPct val="20000"/>
        </a:spcBef>
        <a:buFont typeface="Arial" pitchFamily="34" charset="0"/>
        <a:buChar char="•"/>
        <a:defRPr sz="2800" kern="1200">
          <a:solidFill>
            <a:schemeClr val="tx1"/>
          </a:solidFill>
          <a:latin typeface="+mn-lt"/>
          <a:ea typeface="+mn-ea"/>
          <a:cs typeface="+mn-cs"/>
        </a:defRPr>
      </a:lvl9pPr>
    </p:bodyStyle>
    <p:otherStyle>
      <a:defPPr>
        <a:defRPr lang="ko-KR"/>
      </a:defPPr>
      <a:lvl1pPr marL="0" algn="l" defTabSz="1279953" rtl="0" eaLnBrk="1" latinLnBrk="1" hangingPunct="1">
        <a:defRPr sz="2500" kern="1200">
          <a:solidFill>
            <a:schemeClr val="tx1"/>
          </a:solidFill>
          <a:latin typeface="+mn-lt"/>
          <a:ea typeface="+mn-ea"/>
          <a:cs typeface="+mn-cs"/>
        </a:defRPr>
      </a:lvl1pPr>
      <a:lvl2pPr marL="639976" algn="l" defTabSz="1279953" rtl="0" eaLnBrk="1" latinLnBrk="1" hangingPunct="1">
        <a:defRPr sz="2500" kern="1200">
          <a:solidFill>
            <a:schemeClr val="tx1"/>
          </a:solidFill>
          <a:latin typeface="+mn-lt"/>
          <a:ea typeface="+mn-ea"/>
          <a:cs typeface="+mn-cs"/>
        </a:defRPr>
      </a:lvl2pPr>
      <a:lvl3pPr marL="1279953" algn="l" defTabSz="1279953" rtl="0" eaLnBrk="1" latinLnBrk="1" hangingPunct="1">
        <a:defRPr sz="2500" kern="1200">
          <a:solidFill>
            <a:schemeClr val="tx1"/>
          </a:solidFill>
          <a:latin typeface="+mn-lt"/>
          <a:ea typeface="+mn-ea"/>
          <a:cs typeface="+mn-cs"/>
        </a:defRPr>
      </a:lvl3pPr>
      <a:lvl4pPr marL="1919929" algn="l" defTabSz="1279953" rtl="0" eaLnBrk="1" latinLnBrk="1" hangingPunct="1">
        <a:defRPr sz="2500" kern="1200">
          <a:solidFill>
            <a:schemeClr val="tx1"/>
          </a:solidFill>
          <a:latin typeface="+mn-lt"/>
          <a:ea typeface="+mn-ea"/>
          <a:cs typeface="+mn-cs"/>
        </a:defRPr>
      </a:lvl4pPr>
      <a:lvl5pPr marL="2559906" algn="l" defTabSz="1279953" rtl="0" eaLnBrk="1" latinLnBrk="1" hangingPunct="1">
        <a:defRPr sz="2500" kern="1200">
          <a:solidFill>
            <a:schemeClr val="tx1"/>
          </a:solidFill>
          <a:latin typeface="+mn-lt"/>
          <a:ea typeface="+mn-ea"/>
          <a:cs typeface="+mn-cs"/>
        </a:defRPr>
      </a:lvl5pPr>
      <a:lvl6pPr marL="3199882" algn="l" defTabSz="1279953" rtl="0" eaLnBrk="1" latinLnBrk="1" hangingPunct="1">
        <a:defRPr sz="2500" kern="1200">
          <a:solidFill>
            <a:schemeClr val="tx1"/>
          </a:solidFill>
          <a:latin typeface="+mn-lt"/>
          <a:ea typeface="+mn-ea"/>
          <a:cs typeface="+mn-cs"/>
        </a:defRPr>
      </a:lvl6pPr>
      <a:lvl7pPr marL="3839859" algn="l" defTabSz="1279953" rtl="0" eaLnBrk="1" latinLnBrk="1" hangingPunct="1">
        <a:defRPr sz="2500" kern="1200">
          <a:solidFill>
            <a:schemeClr val="tx1"/>
          </a:solidFill>
          <a:latin typeface="+mn-lt"/>
          <a:ea typeface="+mn-ea"/>
          <a:cs typeface="+mn-cs"/>
        </a:defRPr>
      </a:lvl7pPr>
      <a:lvl8pPr marL="4479835" algn="l" defTabSz="1279953" rtl="0" eaLnBrk="1" latinLnBrk="1" hangingPunct="1">
        <a:defRPr sz="2500" kern="1200">
          <a:solidFill>
            <a:schemeClr val="tx1"/>
          </a:solidFill>
          <a:latin typeface="+mn-lt"/>
          <a:ea typeface="+mn-ea"/>
          <a:cs typeface="+mn-cs"/>
        </a:defRPr>
      </a:lvl8pPr>
      <a:lvl9pPr marL="5119812" algn="l" defTabSz="1279953" rtl="0" eaLnBrk="1" latinLnBrk="1" hangingPunct="1">
        <a:defRPr sz="25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p:cNvSpPr>
            <a:spLocks noGrp="1"/>
          </p:cNvSpPr>
          <p:nvPr>
            <p:ph type="title"/>
          </p:nvPr>
        </p:nvSpPr>
        <p:spPr>
          <a:xfrm>
            <a:off x="480060" y="512658"/>
            <a:ext cx="8641080" cy="2133600"/>
          </a:xfrm>
          <a:prstGeom prst="rect">
            <a:avLst/>
          </a:prstGeom>
        </p:spPr>
        <p:txBody>
          <a:bodyPr vert="horz" lIns="127995" tIns="63998" rIns="127995" bIns="63998" rtlCol="0" anchor="ctr">
            <a:normAutofit/>
          </a:bodyPr>
          <a:lstStyle/>
          <a:p>
            <a:r>
              <a:rPr lang="ko-KR" altLang="en-US"/>
              <a:t>마스터 제목 스타일 편집</a:t>
            </a:r>
          </a:p>
        </p:txBody>
      </p:sp>
      <p:sp>
        <p:nvSpPr>
          <p:cNvPr id="3" name="텍스트 개체 틀 2"/>
          <p:cNvSpPr>
            <a:spLocks noGrp="1"/>
          </p:cNvSpPr>
          <p:nvPr>
            <p:ph type="body" idx="1"/>
          </p:nvPr>
        </p:nvSpPr>
        <p:spPr>
          <a:xfrm>
            <a:off x="480060" y="2987043"/>
            <a:ext cx="8641080" cy="8448464"/>
          </a:xfrm>
          <a:prstGeom prst="rect">
            <a:avLst/>
          </a:prstGeom>
        </p:spPr>
        <p:txBody>
          <a:bodyPr vert="horz" lIns="127995" tIns="63998" rIns="127995" bIns="63998" rtlCol="0">
            <a:normAutofit/>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p:cNvSpPr>
            <a:spLocks noGrp="1"/>
          </p:cNvSpPr>
          <p:nvPr>
            <p:ph type="dt" sz="half" idx="2"/>
          </p:nvPr>
        </p:nvSpPr>
        <p:spPr>
          <a:xfrm>
            <a:off x="480061" y="11865188"/>
            <a:ext cx="2240280" cy="681566"/>
          </a:xfrm>
          <a:prstGeom prst="rect">
            <a:avLst/>
          </a:prstGeom>
        </p:spPr>
        <p:txBody>
          <a:bodyPr vert="horz" lIns="127995" tIns="63998" rIns="127995" bIns="63998" rtlCol="0" anchor="ctr"/>
          <a:lstStyle>
            <a:lvl1pPr algn="l">
              <a:defRPr sz="1600">
                <a:solidFill>
                  <a:schemeClr val="tx1">
                    <a:tint val="75000"/>
                  </a:schemeClr>
                </a:solidFill>
              </a:defRPr>
            </a:lvl1pPr>
          </a:lstStyle>
          <a:p>
            <a:fld id="{FC75D36E-F5BB-47E1-8CF6-197642BF9C69}" type="datetimeFigureOut">
              <a:rPr lang="ko-KR" altLang="en-US" smtClean="0"/>
              <a:pPr/>
              <a:t>2024-12-11</a:t>
            </a:fld>
            <a:endParaRPr lang="ko-KR" altLang="en-US"/>
          </a:p>
        </p:txBody>
      </p:sp>
      <p:sp>
        <p:nvSpPr>
          <p:cNvPr id="5" name="바닥글 개체 틀 4"/>
          <p:cNvSpPr>
            <a:spLocks noGrp="1"/>
          </p:cNvSpPr>
          <p:nvPr>
            <p:ph type="ftr" sz="quarter" idx="3"/>
          </p:nvPr>
        </p:nvSpPr>
        <p:spPr>
          <a:xfrm>
            <a:off x="3280411" y="11865188"/>
            <a:ext cx="3040380" cy="681566"/>
          </a:xfrm>
          <a:prstGeom prst="rect">
            <a:avLst/>
          </a:prstGeom>
        </p:spPr>
        <p:txBody>
          <a:bodyPr vert="horz" lIns="127995" tIns="63998" rIns="127995" bIns="63998" rtlCol="0" anchor="ctr"/>
          <a:lstStyle>
            <a:lvl1pPr algn="ctr">
              <a:defRPr sz="1600">
                <a:solidFill>
                  <a:schemeClr val="tx1">
                    <a:tint val="75000"/>
                  </a:schemeClr>
                </a:solidFill>
              </a:defRPr>
            </a:lvl1pPr>
          </a:lstStyle>
          <a:p>
            <a:endParaRPr lang="ko-KR" altLang="en-US"/>
          </a:p>
        </p:txBody>
      </p:sp>
      <p:sp>
        <p:nvSpPr>
          <p:cNvPr id="6" name="슬라이드 번호 개체 틀 5"/>
          <p:cNvSpPr>
            <a:spLocks noGrp="1"/>
          </p:cNvSpPr>
          <p:nvPr>
            <p:ph type="sldNum" sz="quarter" idx="4"/>
          </p:nvPr>
        </p:nvSpPr>
        <p:spPr>
          <a:xfrm>
            <a:off x="6880860" y="11865188"/>
            <a:ext cx="2240280" cy="681566"/>
          </a:xfrm>
          <a:prstGeom prst="rect">
            <a:avLst/>
          </a:prstGeom>
        </p:spPr>
        <p:txBody>
          <a:bodyPr vert="horz" lIns="127995" tIns="63998" rIns="127995" bIns="63998" rtlCol="0" anchor="ctr"/>
          <a:lstStyle>
            <a:lvl1pPr algn="r">
              <a:defRPr sz="1600">
                <a:solidFill>
                  <a:schemeClr val="tx1">
                    <a:tint val="75000"/>
                  </a:schemeClr>
                </a:solidFill>
              </a:defRPr>
            </a:lvl1pPr>
          </a:lstStyle>
          <a:p>
            <a:fld id="{BFDFE31A-9D4B-4AD2-9F2E-CC153BB0E734}" type="slidenum">
              <a:rPr lang="ko-KR" altLang="en-US" smtClean="0"/>
              <a:pPr/>
              <a:t>‹#›</a:t>
            </a:fld>
            <a:endParaRPr lang="ko-KR" altLang="en-US"/>
          </a:p>
        </p:txBody>
      </p:sp>
    </p:spTree>
    <p:extLst>
      <p:ext uri="{BB962C8B-B14F-4D97-AF65-F5344CB8AC3E}">
        <p14:creationId xmlns:p14="http://schemas.microsoft.com/office/powerpoint/2010/main" val="386342499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ctr" defTabSz="1279953" rtl="0" eaLnBrk="1" latinLnBrk="1" hangingPunct="1">
        <a:spcBef>
          <a:spcPct val="0"/>
        </a:spcBef>
        <a:buNone/>
        <a:defRPr sz="6200" kern="1200">
          <a:solidFill>
            <a:schemeClr val="tx1"/>
          </a:solidFill>
          <a:latin typeface="+mj-lt"/>
          <a:ea typeface="+mj-ea"/>
          <a:cs typeface="+mj-cs"/>
        </a:defRPr>
      </a:lvl1pPr>
    </p:titleStyle>
    <p:bodyStyle>
      <a:lvl1pPr marL="479982" indent="-479982" algn="l" defTabSz="1279953" rtl="0" eaLnBrk="1" latinLnBrk="1" hangingPunct="1">
        <a:spcBef>
          <a:spcPct val="20000"/>
        </a:spcBef>
        <a:buFont typeface="Arial" pitchFamily="34" charset="0"/>
        <a:buChar char="•"/>
        <a:defRPr sz="4500" kern="1200">
          <a:solidFill>
            <a:schemeClr val="tx1"/>
          </a:solidFill>
          <a:latin typeface="+mn-lt"/>
          <a:ea typeface="+mn-ea"/>
          <a:cs typeface="+mn-cs"/>
        </a:defRPr>
      </a:lvl1pPr>
      <a:lvl2pPr marL="1039962" indent="-399985" algn="l" defTabSz="1279953" rtl="0" eaLnBrk="1" latinLnBrk="1" hangingPunct="1">
        <a:spcBef>
          <a:spcPct val="20000"/>
        </a:spcBef>
        <a:buFont typeface="Arial" pitchFamily="34" charset="0"/>
        <a:buChar char="–"/>
        <a:defRPr sz="3900" kern="1200">
          <a:solidFill>
            <a:schemeClr val="tx1"/>
          </a:solidFill>
          <a:latin typeface="+mn-lt"/>
          <a:ea typeface="+mn-ea"/>
          <a:cs typeface="+mn-cs"/>
        </a:defRPr>
      </a:lvl2pPr>
      <a:lvl3pPr marL="1599942" indent="-319989" algn="l" defTabSz="1279953" rtl="0" eaLnBrk="1" latinLnBrk="1" hangingPunct="1">
        <a:spcBef>
          <a:spcPct val="20000"/>
        </a:spcBef>
        <a:buFont typeface="Arial" pitchFamily="34" charset="0"/>
        <a:buChar char="•"/>
        <a:defRPr sz="3400" kern="1200">
          <a:solidFill>
            <a:schemeClr val="tx1"/>
          </a:solidFill>
          <a:latin typeface="+mn-lt"/>
          <a:ea typeface="+mn-ea"/>
          <a:cs typeface="+mn-cs"/>
        </a:defRPr>
      </a:lvl3pPr>
      <a:lvl4pPr marL="2239918" indent="-319989" algn="l" defTabSz="1279953" rtl="0" eaLnBrk="1" latinLnBrk="1" hangingPunct="1">
        <a:spcBef>
          <a:spcPct val="20000"/>
        </a:spcBef>
        <a:buFont typeface="Arial" pitchFamily="34" charset="0"/>
        <a:buChar char="–"/>
        <a:defRPr sz="2800" kern="1200">
          <a:solidFill>
            <a:schemeClr val="tx1"/>
          </a:solidFill>
          <a:latin typeface="+mn-lt"/>
          <a:ea typeface="+mn-ea"/>
          <a:cs typeface="+mn-cs"/>
        </a:defRPr>
      </a:lvl4pPr>
      <a:lvl5pPr marL="2879895" indent="-319989" algn="l" defTabSz="1279953" rtl="0" eaLnBrk="1" latinLnBrk="1" hangingPunct="1">
        <a:spcBef>
          <a:spcPct val="20000"/>
        </a:spcBef>
        <a:buFont typeface="Arial" pitchFamily="34" charset="0"/>
        <a:buChar char="»"/>
        <a:defRPr sz="2800" kern="1200">
          <a:solidFill>
            <a:schemeClr val="tx1"/>
          </a:solidFill>
          <a:latin typeface="+mn-lt"/>
          <a:ea typeface="+mn-ea"/>
          <a:cs typeface="+mn-cs"/>
        </a:defRPr>
      </a:lvl5pPr>
      <a:lvl6pPr marL="3519871" indent="-319989" algn="l" defTabSz="1279953" rtl="0" eaLnBrk="1" latinLnBrk="1" hangingPunct="1">
        <a:spcBef>
          <a:spcPct val="20000"/>
        </a:spcBef>
        <a:buFont typeface="Arial" pitchFamily="34" charset="0"/>
        <a:buChar char="•"/>
        <a:defRPr sz="2800" kern="1200">
          <a:solidFill>
            <a:schemeClr val="tx1"/>
          </a:solidFill>
          <a:latin typeface="+mn-lt"/>
          <a:ea typeface="+mn-ea"/>
          <a:cs typeface="+mn-cs"/>
        </a:defRPr>
      </a:lvl6pPr>
      <a:lvl7pPr marL="4159848" indent="-319989" algn="l" defTabSz="1279953" rtl="0" eaLnBrk="1" latinLnBrk="1" hangingPunct="1">
        <a:spcBef>
          <a:spcPct val="20000"/>
        </a:spcBef>
        <a:buFont typeface="Arial" pitchFamily="34" charset="0"/>
        <a:buChar char="•"/>
        <a:defRPr sz="2800" kern="1200">
          <a:solidFill>
            <a:schemeClr val="tx1"/>
          </a:solidFill>
          <a:latin typeface="+mn-lt"/>
          <a:ea typeface="+mn-ea"/>
          <a:cs typeface="+mn-cs"/>
        </a:defRPr>
      </a:lvl7pPr>
      <a:lvl8pPr marL="4799824" indent="-319989" algn="l" defTabSz="1279953" rtl="0" eaLnBrk="1" latinLnBrk="1" hangingPunct="1">
        <a:spcBef>
          <a:spcPct val="20000"/>
        </a:spcBef>
        <a:buFont typeface="Arial" pitchFamily="34" charset="0"/>
        <a:buChar char="•"/>
        <a:defRPr sz="2800" kern="1200">
          <a:solidFill>
            <a:schemeClr val="tx1"/>
          </a:solidFill>
          <a:latin typeface="+mn-lt"/>
          <a:ea typeface="+mn-ea"/>
          <a:cs typeface="+mn-cs"/>
        </a:defRPr>
      </a:lvl8pPr>
      <a:lvl9pPr marL="5439800" indent="-319989" algn="l" defTabSz="1279953" rtl="0" eaLnBrk="1" latinLnBrk="1" hangingPunct="1">
        <a:spcBef>
          <a:spcPct val="20000"/>
        </a:spcBef>
        <a:buFont typeface="Arial" pitchFamily="34" charset="0"/>
        <a:buChar char="•"/>
        <a:defRPr sz="2800" kern="1200">
          <a:solidFill>
            <a:schemeClr val="tx1"/>
          </a:solidFill>
          <a:latin typeface="+mn-lt"/>
          <a:ea typeface="+mn-ea"/>
          <a:cs typeface="+mn-cs"/>
        </a:defRPr>
      </a:lvl9pPr>
    </p:bodyStyle>
    <p:otherStyle>
      <a:defPPr>
        <a:defRPr lang="ko-KR"/>
      </a:defPPr>
      <a:lvl1pPr marL="0" algn="l" defTabSz="1279953" rtl="0" eaLnBrk="1" latinLnBrk="1" hangingPunct="1">
        <a:defRPr sz="2500" kern="1200">
          <a:solidFill>
            <a:schemeClr val="tx1"/>
          </a:solidFill>
          <a:latin typeface="+mn-lt"/>
          <a:ea typeface="+mn-ea"/>
          <a:cs typeface="+mn-cs"/>
        </a:defRPr>
      </a:lvl1pPr>
      <a:lvl2pPr marL="639976" algn="l" defTabSz="1279953" rtl="0" eaLnBrk="1" latinLnBrk="1" hangingPunct="1">
        <a:defRPr sz="2500" kern="1200">
          <a:solidFill>
            <a:schemeClr val="tx1"/>
          </a:solidFill>
          <a:latin typeface="+mn-lt"/>
          <a:ea typeface="+mn-ea"/>
          <a:cs typeface="+mn-cs"/>
        </a:defRPr>
      </a:lvl2pPr>
      <a:lvl3pPr marL="1279953" algn="l" defTabSz="1279953" rtl="0" eaLnBrk="1" latinLnBrk="1" hangingPunct="1">
        <a:defRPr sz="2500" kern="1200">
          <a:solidFill>
            <a:schemeClr val="tx1"/>
          </a:solidFill>
          <a:latin typeface="+mn-lt"/>
          <a:ea typeface="+mn-ea"/>
          <a:cs typeface="+mn-cs"/>
        </a:defRPr>
      </a:lvl3pPr>
      <a:lvl4pPr marL="1919929" algn="l" defTabSz="1279953" rtl="0" eaLnBrk="1" latinLnBrk="1" hangingPunct="1">
        <a:defRPr sz="2500" kern="1200">
          <a:solidFill>
            <a:schemeClr val="tx1"/>
          </a:solidFill>
          <a:latin typeface="+mn-lt"/>
          <a:ea typeface="+mn-ea"/>
          <a:cs typeface="+mn-cs"/>
        </a:defRPr>
      </a:lvl4pPr>
      <a:lvl5pPr marL="2559906" algn="l" defTabSz="1279953" rtl="0" eaLnBrk="1" latinLnBrk="1" hangingPunct="1">
        <a:defRPr sz="2500" kern="1200">
          <a:solidFill>
            <a:schemeClr val="tx1"/>
          </a:solidFill>
          <a:latin typeface="+mn-lt"/>
          <a:ea typeface="+mn-ea"/>
          <a:cs typeface="+mn-cs"/>
        </a:defRPr>
      </a:lvl5pPr>
      <a:lvl6pPr marL="3199882" algn="l" defTabSz="1279953" rtl="0" eaLnBrk="1" latinLnBrk="1" hangingPunct="1">
        <a:defRPr sz="2500" kern="1200">
          <a:solidFill>
            <a:schemeClr val="tx1"/>
          </a:solidFill>
          <a:latin typeface="+mn-lt"/>
          <a:ea typeface="+mn-ea"/>
          <a:cs typeface="+mn-cs"/>
        </a:defRPr>
      </a:lvl6pPr>
      <a:lvl7pPr marL="3839859" algn="l" defTabSz="1279953" rtl="0" eaLnBrk="1" latinLnBrk="1" hangingPunct="1">
        <a:defRPr sz="2500" kern="1200">
          <a:solidFill>
            <a:schemeClr val="tx1"/>
          </a:solidFill>
          <a:latin typeface="+mn-lt"/>
          <a:ea typeface="+mn-ea"/>
          <a:cs typeface="+mn-cs"/>
        </a:defRPr>
      </a:lvl7pPr>
      <a:lvl8pPr marL="4479835" algn="l" defTabSz="1279953" rtl="0" eaLnBrk="1" latinLnBrk="1" hangingPunct="1">
        <a:defRPr sz="2500" kern="1200">
          <a:solidFill>
            <a:schemeClr val="tx1"/>
          </a:solidFill>
          <a:latin typeface="+mn-lt"/>
          <a:ea typeface="+mn-ea"/>
          <a:cs typeface="+mn-cs"/>
        </a:defRPr>
      </a:lvl8pPr>
      <a:lvl9pPr marL="5119812" algn="l" defTabSz="1279953" rtl="0" eaLnBrk="1" latinLnBrk="1" hangingPunct="1">
        <a:defRPr sz="25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microsoft.com/office/2007/relationships/hdphoto" Target="../media/hdphoto8.wdp"/><Relationship Id="rId2" Type="http://schemas.openxmlformats.org/officeDocument/2006/relationships/image" Target="../media/image11.png"/><Relationship Id="rId1" Type="http://schemas.openxmlformats.org/officeDocument/2006/relationships/slideLayout" Target="../slideLayouts/slideLayout13.xml"/><Relationship Id="rId5" Type="http://schemas.microsoft.com/office/2007/relationships/hdphoto" Target="../media/hdphoto9.wdp"/><Relationship Id="rId4" Type="http://schemas.openxmlformats.org/officeDocument/2006/relationships/image" Target="../media/image12.png"/></Relationships>
</file>

<file path=ppt/slides/_rels/slide11.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image" Target="../media/image13.png"/><Relationship Id="rId1" Type="http://schemas.openxmlformats.org/officeDocument/2006/relationships/slideLayout" Target="../slideLayouts/slideLayout13.xml"/></Relationships>
</file>

<file path=ppt/slides/_rels/slide12.xml.rels><?xml version="1.0" encoding="UTF-8" standalone="yes"?>
<Relationships xmlns="http://schemas.openxmlformats.org/package/2006/relationships"><Relationship Id="rId3" Type="http://schemas.microsoft.com/office/2007/relationships/hdphoto" Target="../media/hdphoto10.wdp"/><Relationship Id="rId2" Type="http://schemas.openxmlformats.org/officeDocument/2006/relationships/image" Target="../media/image15.png"/><Relationship Id="rId1" Type="http://schemas.openxmlformats.org/officeDocument/2006/relationships/slideLayout" Target="../slideLayouts/slideLayout13.xml"/><Relationship Id="rId5" Type="http://schemas.microsoft.com/office/2007/relationships/hdphoto" Target="../media/hdphoto11.wdp"/><Relationship Id="rId4" Type="http://schemas.openxmlformats.org/officeDocument/2006/relationships/image" Target="../media/image16.png"/></Relationships>
</file>

<file path=ppt/slides/_rels/slide13.xml.rels><?xml version="1.0" encoding="UTF-8" standalone="yes"?>
<Relationships xmlns="http://schemas.openxmlformats.org/package/2006/relationships"><Relationship Id="rId3" Type="http://schemas.microsoft.com/office/2007/relationships/hdphoto" Target="../media/hdphoto12.wdp"/><Relationship Id="rId2" Type="http://schemas.openxmlformats.org/officeDocument/2006/relationships/image" Target="../media/image17.png"/><Relationship Id="rId1" Type="http://schemas.openxmlformats.org/officeDocument/2006/relationships/slideLayout" Target="../slideLayouts/slideLayout13.xml"/><Relationship Id="rId5" Type="http://schemas.microsoft.com/office/2007/relationships/hdphoto" Target="../media/hdphoto13.wdp"/><Relationship Id="rId4" Type="http://schemas.openxmlformats.org/officeDocument/2006/relationships/image" Target="../media/image18.png"/></Relationships>
</file>

<file path=ppt/slides/_rels/slide14.xml.rels><?xml version="1.0" encoding="UTF-8" standalone="yes"?>
<Relationships xmlns="http://schemas.openxmlformats.org/package/2006/relationships"><Relationship Id="rId3" Type="http://schemas.microsoft.com/office/2007/relationships/hdphoto" Target="../media/hdphoto14.wdp"/><Relationship Id="rId2" Type="http://schemas.openxmlformats.org/officeDocument/2006/relationships/image" Target="../media/image19.png"/><Relationship Id="rId1" Type="http://schemas.openxmlformats.org/officeDocument/2006/relationships/slideLayout" Target="../slideLayouts/slideLayout13.xml"/><Relationship Id="rId5" Type="http://schemas.microsoft.com/office/2007/relationships/hdphoto" Target="../media/hdphoto15.wdp"/><Relationship Id="rId4" Type="http://schemas.openxmlformats.org/officeDocument/2006/relationships/image" Target="../media/image20.png"/></Relationships>
</file>

<file path=ppt/slides/_rels/slide15.xml.rels><?xml version="1.0" encoding="UTF-8" standalone="yes"?>
<Relationships xmlns="http://schemas.openxmlformats.org/package/2006/relationships"><Relationship Id="rId3" Type="http://schemas.microsoft.com/office/2007/relationships/hdphoto" Target="../media/hdphoto16.wdp"/><Relationship Id="rId2" Type="http://schemas.openxmlformats.org/officeDocument/2006/relationships/image" Target="../media/image21.png"/><Relationship Id="rId1" Type="http://schemas.openxmlformats.org/officeDocument/2006/relationships/slideLayout" Target="../slideLayouts/slideLayout13.xml"/><Relationship Id="rId5" Type="http://schemas.microsoft.com/office/2007/relationships/hdphoto" Target="../media/hdphoto17.wdp"/><Relationship Id="rId4" Type="http://schemas.openxmlformats.org/officeDocument/2006/relationships/image" Target="../media/image22.png"/></Relationships>
</file>

<file path=ppt/slides/_rels/slide16.xml.rels><?xml version="1.0" encoding="UTF-8" standalone="yes"?>
<Relationships xmlns="http://schemas.openxmlformats.org/package/2006/relationships"><Relationship Id="rId3" Type="http://schemas.microsoft.com/office/2007/relationships/hdphoto" Target="../media/hdphoto18.wdp"/><Relationship Id="rId2" Type="http://schemas.openxmlformats.org/officeDocument/2006/relationships/image" Target="../media/image23.png"/><Relationship Id="rId1" Type="http://schemas.openxmlformats.org/officeDocument/2006/relationships/slideLayout" Target="../slideLayouts/slideLayout13.xml"/><Relationship Id="rId5" Type="http://schemas.microsoft.com/office/2007/relationships/hdphoto" Target="../media/hdphoto19.wdp"/><Relationship Id="rId4" Type="http://schemas.openxmlformats.org/officeDocument/2006/relationships/image" Target="../media/image24.png"/></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7" Type="http://schemas.microsoft.com/office/2007/relationships/hdphoto" Target="../media/hdphoto2.wdp"/><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3.png"/><Relationship Id="rId5" Type="http://schemas.microsoft.com/office/2007/relationships/hdphoto" Target="../media/hdphoto1.wdp"/><Relationship Id="rId4" Type="http://schemas.openxmlformats.org/officeDocument/2006/relationships/image" Target="../media/image2.png"/></Relationships>
</file>

<file path=ppt/slides/_rels/slide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xml"/><Relationship Id="rId1" Type="http://schemas.openxmlformats.org/officeDocument/2006/relationships/slideLayout" Target="../slideLayouts/slideLayout1.xml"/><Relationship Id="rId5" Type="http://schemas.microsoft.com/office/2007/relationships/hdphoto" Target="../media/hdphoto3.wdp"/><Relationship Id="rId4" Type="http://schemas.openxmlformats.org/officeDocument/2006/relationships/image" Target="../media/image4.png"/></Relationships>
</file>

<file path=ppt/slides/_rels/slide4.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3.xml"/><Relationship Id="rId1" Type="http://schemas.openxmlformats.org/officeDocument/2006/relationships/slideLayout" Target="../slideLayouts/slideLayout1.xml"/><Relationship Id="rId5" Type="http://schemas.openxmlformats.org/officeDocument/2006/relationships/image" Target="../media/image6.png"/><Relationship Id="rId4" Type="http://schemas.openxmlformats.org/officeDocument/2006/relationships/image" Target="../media/image5.png"/></Relationships>
</file>

<file path=ppt/slides/_rels/slide5.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4.xml"/><Relationship Id="rId1" Type="http://schemas.openxmlformats.org/officeDocument/2006/relationships/slideLayout" Target="../slideLayouts/slideLayout1.xml"/><Relationship Id="rId5" Type="http://schemas.microsoft.com/office/2007/relationships/hdphoto" Target="../media/hdphoto4.wdp"/><Relationship Id="rId4" Type="http://schemas.openxmlformats.org/officeDocument/2006/relationships/image" Target="../media/image7.png"/></Relationships>
</file>

<file path=ppt/slides/_rels/slide6.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5.xml"/><Relationship Id="rId1" Type="http://schemas.openxmlformats.org/officeDocument/2006/relationships/slideLayout" Target="../slideLayouts/slideLayout1.xml"/><Relationship Id="rId5" Type="http://schemas.microsoft.com/office/2007/relationships/hdphoto" Target="../media/hdphoto5.wdp"/><Relationship Id="rId4" Type="http://schemas.openxmlformats.org/officeDocument/2006/relationships/image" Target="../media/image8.png"/></Relationships>
</file>

<file path=ppt/slides/_rels/slide7.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6.xml"/><Relationship Id="rId1" Type="http://schemas.openxmlformats.org/officeDocument/2006/relationships/slideLayout" Target="../slideLayouts/slideLayout1.xml"/><Relationship Id="rId5" Type="http://schemas.microsoft.com/office/2007/relationships/hdphoto" Target="../media/hdphoto6.wdp"/><Relationship Id="rId4" Type="http://schemas.openxmlformats.org/officeDocument/2006/relationships/image" Target="../media/image9.png"/></Relationships>
</file>

<file path=ppt/slides/_rels/slide8.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7.xml"/><Relationship Id="rId1" Type="http://schemas.openxmlformats.org/officeDocument/2006/relationships/slideLayout" Target="../slideLayouts/slideLayout1.xml"/><Relationship Id="rId5" Type="http://schemas.microsoft.com/office/2007/relationships/hdphoto" Target="../media/hdphoto7.wdp"/><Relationship Id="rId4" Type="http://schemas.openxmlformats.org/officeDocument/2006/relationships/image" Target="../media/image10.png"/></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1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제목 1"/>
          <p:cNvSpPr>
            <a:spLocks noGrp="1"/>
          </p:cNvSpPr>
          <p:nvPr>
            <p:ph type="ctrTitle"/>
          </p:nvPr>
        </p:nvSpPr>
        <p:spPr/>
        <p:txBody>
          <a:bodyPr>
            <a:noAutofit/>
          </a:bodyPr>
          <a:lstStyle/>
          <a:p>
            <a:r>
              <a:rPr lang="en-US" altLang="ko-KR" sz="8800" dirty="0">
                <a:solidFill>
                  <a:srgbClr val="01358B"/>
                </a:solidFill>
                <a:latin typeface="HY헤드라인M" pitchFamily="18" charset="-127"/>
                <a:ea typeface="HY헤드라인M" pitchFamily="18" charset="-127"/>
              </a:rPr>
              <a:t>Lower Back Exercises</a:t>
            </a:r>
            <a:endParaRPr lang="ko-KR" altLang="en-US" sz="8800" dirty="0">
              <a:solidFill>
                <a:srgbClr val="01358B"/>
              </a:solidFill>
              <a:latin typeface="HY헤드라인M" pitchFamily="18" charset="-127"/>
              <a:ea typeface="HY헤드라인M" pitchFamily="18" charset="-127"/>
            </a:endParaRPr>
          </a:p>
        </p:txBody>
      </p:sp>
      <p:sp>
        <p:nvSpPr>
          <p:cNvPr id="3" name="부제목 2"/>
          <p:cNvSpPr>
            <a:spLocks noGrp="1"/>
          </p:cNvSpPr>
          <p:nvPr>
            <p:ph type="subTitle" idx="1"/>
          </p:nvPr>
        </p:nvSpPr>
        <p:spPr>
          <a:xfrm>
            <a:off x="1440180" y="7254240"/>
            <a:ext cx="6720840" cy="946760"/>
          </a:xfrm>
        </p:spPr>
        <p:txBody>
          <a:bodyPr/>
          <a:lstStyle/>
          <a:p>
            <a:r>
              <a:rPr lang="en-US" altLang="ko-KR" dirty="0">
                <a:solidFill>
                  <a:srgbClr val="01358B"/>
                </a:solidFill>
                <a:latin typeface="HY헤드라인M" pitchFamily="18" charset="-127"/>
                <a:ea typeface="HY헤드라인M" pitchFamily="18" charset="-127"/>
              </a:rPr>
              <a:t>- Stage 1 -</a:t>
            </a:r>
            <a:endParaRPr lang="ko-KR" altLang="en-US" dirty="0">
              <a:solidFill>
                <a:srgbClr val="01358B"/>
              </a:solidFill>
              <a:latin typeface="HY헤드라인M" pitchFamily="18" charset="-127"/>
              <a:ea typeface="HY헤드라인M" pitchFamily="18" charset="-127"/>
            </a:endParaRPr>
          </a:p>
        </p:txBody>
      </p:sp>
      <p:pic>
        <p:nvPicPr>
          <p:cNvPr id="4" name="Picture 2"/>
          <p:cNvPicPr preferRelativeResize="0">
            <a:picLocks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6588008" y="12060000"/>
            <a:ext cx="2700000" cy="54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5" name="부제목 2"/>
          <p:cNvSpPr txBox="1">
            <a:spLocks/>
          </p:cNvSpPr>
          <p:nvPr/>
        </p:nvSpPr>
        <p:spPr>
          <a:xfrm>
            <a:off x="0" y="125448"/>
            <a:ext cx="8689032" cy="1450816"/>
          </a:xfrm>
          <a:prstGeom prst="rect">
            <a:avLst/>
          </a:prstGeom>
        </p:spPr>
        <p:txBody>
          <a:bodyPr vert="horz" lIns="127995" tIns="63998" rIns="127995" bIns="63998" rtlCol="0">
            <a:normAutofit fontScale="77500" lnSpcReduction="20000"/>
          </a:bodyPr>
          <a:lstStyle>
            <a:lvl1pPr marL="0" indent="0" algn="ctr" defTabSz="1279953" rtl="0" eaLnBrk="1" latinLnBrk="1" hangingPunct="1">
              <a:spcBef>
                <a:spcPct val="20000"/>
              </a:spcBef>
              <a:buFont typeface="Arial" pitchFamily="34" charset="0"/>
              <a:buNone/>
              <a:defRPr sz="4500" kern="1200">
                <a:solidFill>
                  <a:schemeClr val="tx1">
                    <a:tint val="75000"/>
                  </a:schemeClr>
                </a:solidFill>
                <a:latin typeface="+mn-lt"/>
                <a:ea typeface="+mn-ea"/>
                <a:cs typeface="+mn-cs"/>
              </a:defRPr>
            </a:lvl1pPr>
            <a:lvl2pPr marL="639976" indent="0" algn="ctr" defTabSz="1279953" rtl="0" eaLnBrk="1" latinLnBrk="1" hangingPunct="1">
              <a:spcBef>
                <a:spcPct val="20000"/>
              </a:spcBef>
              <a:buFont typeface="Arial" pitchFamily="34" charset="0"/>
              <a:buNone/>
              <a:defRPr sz="3900" kern="1200">
                <a:solidFill>
                  <a:schemeClr val="tx1">
                    <a:tint val="75000"/>
                  </a:schemeClr>
                </a:solidFill>
                <a:latin typeface="+mn-lt"/>
                <a:ea typeface="+mn-ea"/>
                <a:cs typeface="+mn-cs"/>
              </a:defRPr>
            </a:lvl2pPr>
            <a:lvl3pPr marL="1279953" indent="0" algn="ctr" defTabSz="1279953" rtl="0" eaLnBrk="1" latinLnBrk="1" hangingPunct="1">
              <a:spcBef>
                <a:spcPct val="20000"/>
              </a:spcBef>
              <a:buFont typeface="Arial" pitchFamily="34" charset="0"/>
              <a:buNone/>
              <a:defRPr sz="3400" kern="1200">
                <a:solidFill>
                  <a:schemeClr val="tx1">
                    <a:tint val="75000"/>
                  </a:schemeClr>
                </a:solidFill>
                <a:latin typeface="+mn-lt"/>
                <a:ea typeface="+mn-ea"/>
                <a:cs typeface="+mn-cs"/>
              </a:defRPr>
            </a:lvl3pPr>
            <a:lvl4pPr marL="1919929" indent="0" algn="ctr" defTabSz="1279953" rtl="0" eaLnBrk="1" latinLnBrk="1" hangingPunct="1">
              <a:spcBef>
                <a:spcPct val="20000"/>
              </a:spcBef>
              <a:buFont typeface="Arial" pitchFamily="34" charset="0"/>
              <a:buNone/>
              <a:defRPr sz="2800" kern="1200">
                <a:solidFill>
                  <a:schemeClr val="tx1">
                    <a:tint val="75000"/>
                  </a:schemeClr>
                </a:solidFill>
                <a:latin typeface="+mn-lt"/>
                <a:ea typeface="+mn-ea"/>
                <a:cs typeface="+mn-cs"/>
              </a:defRPr>
            </a:lvl4pPr>
            <a:lvl5pPr marL="2559906" indent="0" algn="ctr" defTabSz="1279953" rtl="0" eaLnBrk="1" latinLnBrk="1" hangingPunct="1">
              <a:spcBef>
                <a:spcPct val="20000"/>
              </a:spcBef>
              <a:buFont typeface="Arial" pitchFamily="34" charset="0"/>
              <a:buNone/>
              <a:defRPr sz="2800" kern="1200">
                <a:solidFill>
                  <a:schemeClr val="tx1">
                    <a:tint val="75000"/>
                  </a:schemeClr>
                </a:solidFill>
                <a:latin typeface="+mn-lt"/>
                <a:ea typeface="+mn-ea"/>
                <a:cs typeface="+mn-cs"/>
              </a:defRPr>
            </a:lvl5pPr>
            <a:lvl6pPr marL="3199882" indent="0" algn="ctr" defTabSz="1279953" rtl="0" eaLnBrk="1" latinLnBrk="1" hangingPunct="1">
              <a:spcBef>
                <a:spcPct val="20000"/>
              </a:spcBef>
              <a:buFont typeface="Arial" pitchFamily="34" charset="0"/>
              <a:buNone/>
              <a:defRPr sz="2800" kern="1200">
                <a:solidFill>
                  <a:schemeClr val="tx1">
                    <a:tint val="75000"/>
                  </a:schemeClr>
                </a:solidFill>
                <a:latin typeface="+mn-lt"/>
                <a:ea typeface="+mn-ea"/>
                <a:cs typeface="+mn-cs"/>
              </a:defRPr>
            </a:lvl6pPr>
            <a:lvl7pPr marL="3839859" indent="0" algn="ctr" defTabSz="1279953" rtl="0" eaLnBrk="1" latinLnBrk="1" hangingPunct="1">
              <a:spcBef>
                <a:spcPct val="20000"/>
              </a:spcBef>
              <a:buFont typeface="Arial" pitchFamily="34" charset="0"/>
              <a:buNone/>
              <a:defRPr sz="2800" kern="1200">
                <a:solidFill>
                  <a:schemeClr val="tx1">
                    <a:tint val="75000"/>
                  </a:schemeClr>
                </a:solidFill>
                <a:latin typeface="+mn-lt"/>
                <a:ea typeface="+mn-ea"/>
                <a:cs typeface="+mn-cs"/>
              </a:defRPr>
            </a:lvl7pPr>
            <a:lvl8pPr marL="4479835" indent="0" algn="ctr" defTabSz="1279953" rtl="0" eaLnBrk="1" latinLnBrk="1" hangingPunct="1">
              <a:spcBef>
                <a:spcPct val="20000"/>
              </a:spcBef>
              <a:buFont typeface="Arial" pitchFamily="34" charset="0"/>
              <a:buNone/>
              <a:defRPr sz="2800" kern="1200">
                <a:solidFill>
                  <a:schemeClr val="tx1">
                    <a:tint val="75000"/>
                  </a:schemeClr>
                </a:solidFill>
                <a:latin typeface="+mn-lt"/>
                <a:ea typeface="+mn-ea"/>
                <a:cs typeface="+mn-cs"/>
              </a:defRPr>
            </a:lvl8pPr>
            <a:lvl9pPr marL="5119812" indent="0" algn="ctr" defTabSz="1279953" rtl="0" eaLnBrk="1" latinLnBrk="1" hangingPunct="1">
              <a:spcBef>
                <a:spcPct val="20000"/>
              </a:spcBef>
              <a:buFont typeface="Arial" pitchFamily="34" charset="0"/>
              <a:buNone/>
              <a:defRPr sz="2800" kern="1200">
                <a:solidFill>
                  <a:schemeClr val="tx1">
                    <a:tint val="75000"/>
                  </a:schemeClr>
                </a:solidFill>
                <a:latin typeface="+mn-lt"/>
                <a:ea typeface="+mn-ea"/>
                <a:cs typeface="+mn-cs"/>
              </a:defRPr>
            </a:lvl9pPr>
          </a:lstStyle>
          <a:p>
            <a:pPr algn="l"/>
            <a:r>
              <a:rPr lang="en-US" altLang="ko-KR" dirty="0">
                <a:solidFill>
                  <a:srgbClr val="01358B"/>
                </a:solidFill>
                <a:latin typeface="HY헤드라인M" pitchFamily="18" charset="-127"/>
                <a:ea typeface="HY헤드라인M" pitchFamily="18" charset="-127"/>
              </a:rPr>
              <a:t>Physical Therapy Room</a:t>
            </a:r>
            <a:endParaRPr lang="ko-KR" altLang="en-US" dirty="0">
              <a:solidFill>
                <a:srgbClr val="01358B"/>
              </a:solidFill>
              <a:latin typeface="HY헤드라인M" pitchFamily="18" charset="-127"/>
              <a:ea typeface="HY헤드라인M" pitchFamily="18" charset="-127"/>
            </a:endParaRPr>
          </a:p>
          <a:p>
            <a:pPr algn="l"/>
            <a:r>
              <a:rPr lang="en-US" altLang="ko-KR" dirty="0">
                <a:solidFill>
                  <a:srgbClr val="01358B"/>
                </a:solidFill>
                <a:latin typeface="HY헤드라인M" pitchFamily="18" charset="-127"/>
                <a:ea typeface="HY헤드라인M" pitchFamily="18" charset="-127"/>
              </a:rPr>
              <a:t>Department of Rehabilitation Medicine</a:t>
            </a:r>
            <a:endParaRPr lang="ko-KR" altLang="en-US" dirty="0">
              <a:solidFill>
                <a:srgbClr val="01358B"/>
              </a:solidFill>
              <a:latin typeface="HY헤드라인M" pitchFamily="18" charset="-127"/>
              <a:ea typeface="HY헤드라인M" pitchFamily="18" charset="-127"/>
            </a:endParaRPr>
          </a:p>
        </p:txBody>
      </p:sp>
    </p:spTree>
    <p:extLst>
      <p:ext uri="{BB962C8B-B14F-4D97-AF65-F5344CB8AC3E}">
        <p14:creationId xmlns:p14="http://schemas.microsoft.com/office/powerpoint/2010/main" val="153447669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2" name="모서리가 둥근 직사각형 21"/>
          <p:cNvSpPr/>
          <p:nvPr/>
        </p:nvSpPr>
        <p:spPr>
          <a:xfrm>
            <a:off x="336104" y="3055078"/>
            <a:ext cx="3600000" cy="5217850"/>
          </a:xfrm>
          <a:prstGeom prst="roundRect">
            <a:avLst/>
          </a:prstGeom>
          <a:noFill/>
          <a:ln w="50800">
            <a:solidFill>
              <a:srgbClr val="689E1D"/>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79953" rtl="0" eaLnBrk="1" fontAlgn="auto" latinLnBrk="1" hangingPunct="1">
              <a:lnSpc>
                <a:spcPct val="100000"/>
              </a:lnSpc>
              <a:spcBef>
                <a:spcPts val="0"/>
              </a:spcBef>
              <a:spcAft>
                <a:spcPts val="0"/>
              </a:spcAft>
              <a:buClrTx/>
              <a:buSzTx/>
              <a:buFontTx/>
              <a:buNone/>
              <a:tabLst/>
              <a:defRPr/>
            </a:pPr>
            <a:endParaRPr kumimoji="0" lang="ko-KR" altLang="en-US" sz="2500" b="0" i="0" u="none" strike="noStrike" kern="1200" cap="none" spc="0" normalizeH="0" baseline="0" noProof="0">
              <a:ln>
                <a:noFill/>
              </a:ln>
              <a:solidFill>
                <a:prstClr val="white"/>
              </a:solidFill>
              <a:effectLst/>
              <a:uLnTx/>
              <a:uFillTx/>
              <a:latin typeface="맑은 고딕"/>
              <a:ea typeface="맑은 고딕" panose="020B0503020000020004" pitchFamily="50" charset="-127"/>
              <a:cs typeface="+mn-cs"/>
            </a:endParaRPr>
          </a:p>
        </p:txBody>
      </p:sp>
      <p:sp>
        <p:nvSpPr>
          <p:cNvPr id="25" name="모서리가 둥근 직사각형 24"/>
          <p:cNvSpPr/>
          <p:nvPr/>
        </p:nvSpPr>
        <p:spPr>
          <a:xfrm>
            <a:off x="4800600" y="3055078"/>
            <a:ext cx="3600000" cy="5217850"/>
          </a:xfrm>
          <a:prstGeom prst="roundRect">
            <a:avLst/>
          </a:prstGeom>
          <a:noFill/>
          <a:ln w="50800">
            <a:solidFill>
              <a:srgbClr val="689E1D"/>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79953" rtl="0" eaLnBrk="1" fontAlgn="auto" latinLnBrk="1" hangingPunct="1">
              <a:lnSpc>
                <a:spcPct val="100000"/>
              </a:lnSpc>
              <a:spcBef>
                <a:spcPts val="0"/>
              </a:spcBef>
              <a:spcAft>
                <a:spcPts val="0"/>
              </a:spcAft>
              <a:buClrTx/>
              <a:buSzTx/>
              <a:buFontTx/>
              <a:buNone/>
              <a:tabLst/>
              <a:defRPr/>
            </a:pPr>
            <a:endParaRPr kumimoji="0" lang="ko-KR" altLang="en-US" sz="2500" b="0" i="0" u="none" strike="noStrike" kern="1200" cap="none" spc="0" normalizeH="0" baseline="0" noProof="0">
              <a:ln>
                <a:noFill/>
              </a:ln>
              <a:solidFill>
                <a:prstClr val="white"/>
              </a:solidFill>
              <a:effectLst/>
              <a:uLnTx/>
              <a:uFillTx/>
              <a:latin typeface="맑은 고딕"/>
              <a:ea typeface="맑은 고딕" panose="020B0503020000020004" pitchFamily="50" charset="-127"/>
              <a:cs typeface="+mn-cs"/>
            </a:endParaRPr>
          </a:p>
        </p:txBody>
      </p:sp>
      <p:sp>
        <p:nvSpPr>
          <p:cNvPr id="37" name="직사각형 36"/>
          <p:cNvSpPr/>
          <p:nvPr/>
        </p:nvSpPr>
        <p:spPr>
          <a:xfrm>
            <a:off x="108000" y="8488832"/>
            <a:ext cx="8941072" cy="396064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457200" marR="0" lvl="0" indent="-457200" algn="just" defTabSz="1279953" rtl="0" eaLnBrk="1" fontAlgn="auto" latinLnBrk="1" hangingPunct="1">
              <a:lnSpc>
                <a:spcPct val="100000"/>
              </a:lnSpc>
              <a:spcBef>
                <a:spcPts val="0"/>
              </a:spcBef>
              <a:spcAft>
                <a:spcPts val="0"/>
              </a:spcAft>
              <a:buClrTx/>
              <a:buSzTx/>
              <a:buFontTx/>
              <a:buAutoNum type="arabicPeriod"/>
              <a:tabLst/>
              <a:defRPr/>
            </a:pPr>
            <a:r>
              <a:rPr kumimoji="0" lang="en-US" altLang="ko-KR" sz="2400" b="0" i="0" u="none" strike="noStrike" kern="1200" cap="none" spc="-150" normalizeH="0" baseline="0" noProof="0" dirty="0">
                <a:ln>
                  <a:noFill/>
                </a:ln>
                <a:solidFill>
                  <a:prstClr val="black">
                    <a:lumMod val="75000"/>
                    <a:lumOff val="25000"/>
                  </a:prstClr>
                </a:solidFill>
                <a:effectLst/>
                <a:uLnTx/>
                <a:uFillTx/>
                <a:latin typeface="HY헤드라인M" pitchFamily="18" charset="-127"/>
                <a:ea typeface="HY헤드라인M" pitchFamily="18" charset="-127"/>
                <a:cs typeface="+mn-cs"/>
              </a:rPr>
              <a:t>Kneel with your knees apart at the same distance as your shoulders and position yourself as shown in the photo on the left.</a:t>
            </a:r>
          </a:p>
          <a:p>
            <a:pPr marL="457200" marR="0" lvl="0" indent="-457200" algn="just" defTabSz="1279953" rtl="0" eaLnBrk="1" fontAlgn="auto" latinLnBrk="1" hangingPunct="1">
              <a:lnSpc>
                <a:spcPct val="100000"/>
              </a:lnSpc>
              <a:spcBef>
                <a:spcPts val="0"/>
              </a:spcBef>
              <a:spcAft>
                <a:spcPts val="0"/>
              </a:spcAft>
              <a:buClrTx/>
              <a:buSzTx/>
              <a:buFontTx/>
              <a:buAutoNum type="arabicPeriod"/>
              <a:tabLst/>
              <a:defRPr/>
            </a:pPr>
            <a:endParaRPr kumimoji="0" lang="en-US" altLang="ko-KR" sz="1600" b="0" i="0" u="none" strike="noStrike" kern="1200" cap="none" spc="-150" normalizeH="0" baseline="0" noProof="0" dirty="0">
              <a:ln>
                <a:noFill/>
              </a:ln>
              <a:solidFill>
                <a:prstClr val="black">
                  <a:lumMod val="75000"/>
                  <a:lumOff val="25000"/>
                </a:prstClr>
              </a:solidFill>
              <a:effectLst/>
              <a:uLnTx/>
              <a:uFillTx/>
              <a:latin typeface="HY헤드라인M" pitchFamily="18" charset="-127"/>
              <a:ea typeface="HY헤드라인M" pitchFamily="18" charset="-127"/>
              <a:cs typeface="+mn-cs"/>
            </a:endParaRPr>
          </a:p>
          <a:p>
            <a:pPr marL="457200" marR="0" lvl="0" indent="-457200" algn="just" defTabSz="1279953" rtl="0" eaLnBrk="1" fontAlgn="auto" latinLnBrk="1" hangingPunct="1">
              <a:lnSpc>
                <a:spcPct val="100000"/>
              </a:lnSpc>
              <a:spcBef>
                <a:spcPts val="0"/>
              </a:spcBef>
              <a:spcAft>
                <a:spcPts val="0"/>
              </a:spcAft>
              <a:buClrTx/>
              <a:buSzTx/>
              <a:buFontTx/>
              <a:buAutoNum type="arabicPeriod"/>
              <a:tabLst/>
              <a:defRPr/>
            </a:pPr>
            <a:r>
              <a:rPr kumimoji="0" lang="en-US" altLang="ko-KR" sz="2400" b="0" i="0" u="none" strike="noStrike" kern="1200" cap="none" spc="-150" normalizeH="0" baseline="0" noProof="0" dirty="0">
                <a:ln>
                  <a:noFill/>
                </a:ln>
                <a:solidFill>
                  <a:prstClr val="black">
                    <a:lumMod val="75000"/>
                    <a:lumOff val="25000"/>
                  </a:prstClr>
                </a:solidFill>
                <a:effectLst/>
                <a:uLnTx/>
                <a:uFillTx/>
                <a:latin typeface="HY헤드라인M" pitchFamily="18" charset="-127"/>
                <a:ea typeface="HY헤드라인M" pitchFamily="18" charset="-127"/>
                <a:cs typeface="+mn-cs"/>
              </a:rPr>
              <a:t>Lean your torso forward while maintaining your back’s natural curve, making sure your back doesn’t bend backwards. Keep your abdomen braced.</a:t>
            </a:r>
          </a:p>
          <a:p>
            <a:pPr marL="457200" marR="0" lvl="0" indent="-457200" algn="just" defTabSz="1279953" rtl="0" eaLnBrk="1" fontAlgn="auto" latinLnBrk="1" hangingPunct="1">
              <a:lnSpc>
                <a:spcPct val="100000"/>
              </a:lnSpc>
              <a:spcBef>
                <a:spcPts val="0"/>
              </a:spcBef>
              <a:spcAft>
                <a:spcPts val="0"/>
              </a:spcAft>
              <a:buClrTx/>
              <a:buSzTx/>
              <a:buFontTx/>
              <a:buAutoNum type="arabicPeriod"/>
              <a:tabLst/>
              <a:defRPr/>
            </a:pPr>
            <a:endParaRPr kumimoji="0" lang="en-US" altLang="ko-KR" sz="1600" b="0" i="0" u="none" strike="noStrike" kern="1200" cap="none" spc="-150" normalizeH="0" baseline="0" noProof="0" dirty="0">
              <a:ln>
                <a:noFill/>
              </a:ln>
              <a:solidFill>
                <a:prstClr val="black">
                  <a:lumMod val="75000"/>
                  <a:lumOff val="25000"/>
                </a:prstClr>
              </a:solidFill>
              <a:effectLst/>
              <a:uLnTx/>
              <a:uFillTx/>
              <a:latin typeface="HY헤드라인M" pitchFamily="18" charset="-127"/>
              <a:ea typeface="HY헤드라인M" pitchFamily="18" charset="-127"/>
              <a:cs typeface="+mn-cs"/>
            </a:endParaRPr>
          </a:p>
          <a:p>
            <a:pPr marL="457200" marR="0" lvl="0" indent="-457200" algn="just" defTabSz="1279953" rtl="0" eaLnBrk="1" fontAlgn="auto" latinLnBrk="1" hangingPunct="1">
              <a:lnSpc>
                <a:spcPct val="100000"/>
              </a:lnSpc>
              <a:spcBef>
                <a:spcPts val="0"/>
              </a:spcBef>
              <a:spcAft>
                <a:spcPts val="0"/>
              </a:spcAft>
              <a:buClrTx/>
              <a:buSzTx/>
              <a:buFontTx/>
              <a:buAutoNum type="arabicPeriod"/>
              <a:tabLst/>
              <a:defRPr/>
            </a:pPr>
            <a:r>
              <a:rPr kumimoji="0" lang="en-US" altLang="ko-KR" sz="2400" b="0" i="0" u="none" strike="noStrike" kern="1200" cap="none" spc="-150" normalizeH="0" baseline="0" noProof="0" dirty="0">
                <a:ln>
                  <a:noFill/>
                </a:ln>
                <a:solidFill>
                  <a:prstClr val="black">
                    <a:lumMod val="75000"/>
                    <a:lumOff val="25000"/>
                  </a:prstClr>
                </a:solidFill>
                <a:effectLst/>
                <a:uLnTx/>
                <a:uFillTx/>
                <a:latin typeface="HY헤드라인M" pitchFamily="18" charset="-127"/>
                <a:ea typeface="HY헤드라인M" pitchFamily="18" charset="-127"/>
                <a:cs typeface="+mn-cs"/>
              </a:rPr>
              <a:t>Keeping the curve of your back, push your hip backwards and sit down slowly.</a:t>
            </a:r>
          </a:p>
          <a:p>
            <a:pPr marL="457200" marR="0" lvl="0" indent="-457200" algn="just" defTabSz="1279953" rtl="0" eaLnBrk="1" fontAlgn="auto" latinLnBrk="1" hangingPunct="1">
              <a:lnSpc>
                <a:spcPct val="100000"/>
              </a:lnSpc>
              <a:spcBef>
                <a:spcPts val="0"/>
              </a:spcBef>
              <a:spcAft>
                <a:spcPts val="0"/>
              </a:spcAft>
              <a:buClrTx/>
              <a:buSzTx/>
              <a:buFontTx/>
              <a:buAutoNum type="arabicPeriod"/>
              <a:tabLst/>
              <a:defRPr/>
            </a:pPr>
            <a:endParaRPr kumimoji="0" lang="en-US" altLang="ko-KR" sz="1600" b="0" i="0" u="none" strike="noStrike" kern="1200" cap="none" spc="-150" normalizeH="0" baseline="0" noProof="0" dirty="0">
              <a:ln>
                <a:noFill/>
              </a:ln>
              <a:solidFill>
                <a:prstClr val="black">
                  <a:lumMod val="75000"/>
                  <a:lumOff val="25000"/>
                </a:prstClr>
              </a:solidFill>
              <a:effectLst/>
              <a:uLnTx/>
              <a:uFillTx/>
              <a:latin typeface="HY헤드라인M" pitchFamily="18" charset="-127"/>
              <a:ea typeface="HY헤드라인M" pitchFamily="18" charset="-127"/>
              <a:cs typeface="+mn-cs"/>
            </a:endParaRPr>
          </a:p>
          <a:p>
            <a:pPr marL="457200" marR="0" lvl="0" indent="-457200" algn="just" defTabSz="1279953" rtl="0" eaLnBrk="1" fontAlgn="auto" latinLnBrk="1" hangingPunct="1">
              <a:lnSpc>
                <a:spcPct val="100000"/>
              </a:lnSpc>
              <a:spcBef>
                <a:spcPts val="0"/>
              </a:spcBef>
              <a:spcAft>
                <a:spcPts val="0"/>
              </a:spcAft>
              <a:buClrTx/>
              <a:buSzTx/>
              <a:buFontTx/>
              <a:buAutoNum type="arabicPeriod"/>
              <a:tabLst/>
              <a:defRPr/>
            </a:pPr>
            <a:r>
              <a:rPr kumimoji="0" lang="en-US" altLang="ko-KR" sz="2400" b="0" i="0" u="none" strike="noStrike" kern="1200" cap="none" spc="-150" normalizeH="0" baseline="0" noProof="0" dirty="0">
                <a:ln>
                  <a:noFill/>
                </a:ln>
                <a:solidFill>
                  <a:prstClr val="black">
                    <a:lumMod val="75000"/>
                    <a:lumOff val="25000"/>
                  </a:prstClr>
                </a:solidFill>
                <a:effectLst/>
                <a:uLnTx/>
                <a:uFillTx/>
                <a:latin typeface="HY헤드라인M" pitchFamily="18" charset="-127"/>
                <a:ea typeface="HY헤드라인M" pitchFamily="18" charset="-127"/>
                <a:cs typeface="+mn-cs"/>
              </a:rPr>
              <a:t>Return to your first position.    </a:t>
            </a:r>
          </a:p>
        </p:txBody>
      </p:sp>
      <p:sp>
        <p:nvSpPr>
          <p:cNvPr id="40" name="직사각형 39"/>
          <p:cNvSpPr/>
          <p:nvPr/>
        </p:nvSpPr>
        <p:spPr>
          <a:xfrm>
            <a:off x="876104" y="2136073"/>
            <a:ext cx="2520000" cy="720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79953" rtl="0" eaLnBrk="1" fontAlgn="auto" latinLnBrk="1" hangingPunct="1">
              <a:lnSpc>
                <a:spcPct val="100000"/>
              </a:lnSpc>
              <a:spcBef>
                <a:spcPts val="0"/>
              </a:spcBef>
              <a:spcAft>
                <a:spcPts val="0"/>
              </a:spcAft>
              <a:buClrTx/>
              <a:buSzTx/>
              <a:buFontTx/>
              <a:buNone/>
              <a:tabLst/>
              <a:defRPr/>
            </a:pPr>
            <a:r>
              <a:rPr kumimoji="0" lang="en-US" altLang="ko-KR" sz="2500" b="0" i="0" u="none" strike="noStrike" kern="1200" cap="none" spc="0" normalizeH="0" baseline="0" noProof="0" dirty="0">
                <a:ln>
                  <a:noFill/>
                </a:ln>
                <a:solidFill>
                  <a:prstClr val="black"/>
                </a:solidFill>
                <a:effectLst/>
                <a:uLnTx/>
                <a:uFillTx/>
                <a:latin typeface="HY헤드라인M" pitchFamily="18" charset="-127"/>
                <a:ea typeface="HY헤드라인M" pitchFamily="18" charset="-127"/>
                <a:cs typeface="+mn-cs"/>
              </a:rPr>
              <a:t>Preparation</a:t>
            </a:r>
            <a:endParaRPr kumimoji="0" lang="ko-KR" altLang="en-US" sz="2500" b="0" i="0" u="none" strike="noStrike" kern="1200" cap="none" spc="0" normalizeH="0" baseline="0" noProof="0" dirty="0">
              <a:ln>
                <a:noFill/>
              </a:ln>
              <a:solidFill>
                <a:prstClr val="black"/>
              </a:solidFill>
              <a:effectLst/>
              <a:uLnTx/>
              <a:uFillTx/>
              <a:latin typeface="HY헤드라인M" pitchFamily="18" charset="-127"/>
              <a:ea typeface="HY헤드라인M" pitchFamily="18" charset="-127"/>
              <a:cs typeface="+mn-cs"/>
            </a:endParaRPr>
          </a:p>
        </p:txBody>
      </p:sp>
      <p:sp>
        <p:nvSpPr>
          <p:cNvPr id="41" name="직사각형 40"/>
          <p:cNvSpPr/>
          <p:nvPr/>
        </p:nvSpPr>
        <p:spPr>
          <a:xfrm>
            <a:off x="5340600" y="2136073"/>
            <a:ext cx="2520000" cy="720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79953" rtl="0" eaLnBrk="1" fontAlgn="auto" latinLnBrk="1" hangingPunct="1">
              <a:lnSpc>
                <a:spcPct val="100000"/>
              </a:lnSpc>
              <a:spcBef>
                <a:spcPts val="0"/>
              </a:spcBef>
              <a:spcAft>
                <a:spcPts val="0"/>
              </a:spcAft>
              <a:buClrTx/>
              <a:buSzTx/>
              <a:buFontTx/>
              <a:buNone/>
              <a:tabLst/>
              <a:defRPr/>
            </a:pPr>
            <a:r>
              <a:rPr kumimoji="0" lang="en-US" altLang="ko-KR" sz="2500" b="0" i="0" u="none" strike="noStrike" kern="1200" cap="none" spc="0" normalizeH="0" baseline="0" noProof="0" dirty="0">
                <a:ln>
                  <a:noFill/>
                </a:ln>
                <a:solidFill>
                  <a:prstClr val="black"/>
                </a:solidFill>
                <a:effectLst/>
                <a:uLnTx/>
                <a:uFillTx/>
                <a:latin typeface="HY헤드라인M" pitchFamily="18" charset="-127"/>
                <a:ea typeface="HY헤드라인M" pitchFamily="18" charset="-127"/>
                <a:cs typeface="+mn-cs"/>
              </a:rPr>
              <a:t>Exercise</a:t>
            </a:r>
            <a:endParaRPr kumimoji="0" lang="ko-KR" altLang="en-US" sz="2500" b="0" i="0" u="none" strike="noStrike" kern="1200" cap="none" spc="0" normalizeH="0" baseline="0" noProof="0" dirty="0">
              <a:ln>
                <a:noFill/>
              </a:ln>
              <a:solidFill>
                <a:prstClr val="black"/>
              </a:solidFill>
              <a:effectLst/>
              <a:uLnTx/>
              <a:uFillTx/>
              <a:latin typeface="HY헤드라인M" pitchFamily="18" charset="-127"/>
              <a:ea typeface="HY헤드라인M" pitchFamily="18" charset="-127"/>
              <a:cs typeface="+mn-cs"/>
            </a:endParaRPr>
          </a:p>
        </p:txBody>
      </p:sp>
      <p:sp>
        <p:nvSpPr>
          <p:cNvPr id="42" name="직사각형 41"/>
          <p:cNvSpPr/>
          <p:nvPr/>
        </p:nvSpPr>
        <p:spPr>
          <a:xfrm>
            <a:off x="336104" y="1432248"/>
            <a:ext cx="8573896" cy="720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79953" rtl="0" eaLnBrk="1" fontAlgn="auto" latinLnBrk="1" hangingPunct="1">
              <a:lnSpc>
                <a:spcPct val="100000"/>
              </a:lnSpc>
              <a:spcBef>
                <a:spcPts val="0"/>
              </a:spcBef>
              <a:spcAft>
                <a:spcPts val="0"/>
              </a:spcAft>
              <a:buClrTx/>
              <a:buSzTx/>
              <a:buFontTx/>
              <a:buNone/>
              <a:tabLst/>
              <a:defRPr/>
            </a:pPr>
            <a:r>
              <a:rPr kumimoji="0" lang="en-US" altLang="ko-KR" sz="2400" b="0" i="0" u="none" strike="noStrike" kern="1200" cap="none" spc="0" normalizeH="0" baseline="0" noProof="0" dirty="0">
                <a:ln>
                  <a:noFill/>
                </a:ln>
                <a:solidFill>
                  <a:prstClr val="black"/>
                </a:solidFill>
                <a:effectLst/>
                <a:uLnTx/>
                <a:uFillTx/>
                <a:latin typeface="HY헤드라인M" pitchFamily="18" charset="-127"/>
                <a:ea typeface="HY헤드라인M" pitchFamily="18" charset="-127"/>
                <a:cs typeface="+mn-cs"/>
              </a:rPr>
              <a:t>1st Set (   times) -&gt;  2nd Set (  times) -&gt;  3rd Set (  times)</a:t>
            </a:r>
            <a:endParaRPr kumimoji="0" lang="ko-KR" altLang="en-US" sz="2400" b="0" i="0" u="none" strike="noStrike" kern="1200" cap="none" spc="0" normalizeH="0" baseline="0" noProof="0" dirty="0">
              <a:ln>
                <a:noFill/>
              </a:ln>
              <a:solidFill>
                <a:prstClr val="black"/>
              </a:solidFill>
              <a:effectLst/>
              <a:uLnTx/>
              <a:uFillTx/>
              <a:latin typeface="HY헤드라인M" pitchFamily="18" charset="-127"/>
              <a:ea typeface="HY헤드라인M" pitchFamily="18" charset="-127"/>
              <a:cs typeface="+mn-cs"/>
            </a:endParaRPr>
          </a:p>
        </p:txBody>
      </p:sp>
      <p:sp>
        <p:nvSpPr>
          <p:cNvPr id="2" name="직사각형 1"/>
          <p:cNvSpPr/>
          <p:nvPr/>
        </p:nvSpPr>
        <p:spPr>
          <a:xfrm>
            <a:off x="-23936" y="0"/>
            <a:ext cx="9433248" cy="1432248"/>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79953" rtl="0" eaLnBrk="1" fontAlgn="auto" latinLnBrk="1" hangingPunct="1">
              <a:lnSpc>
                <a:spcPct val="100000"/>
              </a:lnSpc>
              <a:spcBef>
                <a:spcPts val="0"/>
              </a:spcBef>
              <a:spcAft>
                <a:spcPts val="0"/>
              </a:spcAft>
              <a:buClrTx/>
              <a:buSzTx/>
              <a:buFontTx/>
              <a:buNone/>
              <a:tabLst/>
              <a:defRPr/>
            </a:pPr>
            <a:r>
              <a:rPr kumimoji="0" lang="en-US" altLang="ko-KR" sz="4800" b="0" i="0" u="none" strike="noStrike" kern="1200" cap="none" spc="0" normalizeH="0" baseline="0" noProof="0" dirty="0">
                <a:ln>
                  <a:noFill/>
                </a:ln>
                <a:solidFill>
                  <a:srgbClr val="689E1D"/>
                </a:solidFill>
                <a:effectLst/>
                <a:uLnTx/>
                <a:uFillTx/>
                <a:latin typeface="HY헤드라인M" pitchFamily="18" charset="-127"/>
                <a:ea typeface="HY헤드라인M" pitchFamily="18" charset="-127"/>
                <a:cs typeface="+mn-cs"/>
              </a:rPr>
              <a:t>Hip Hinge – Kneeling </a:t>
            </a:r>
            <a:r>
              <a:rPr kumimoji="0" lang="en-US" altLang="ko-KR" sz="4800" b="0" i="0" u="none" strike="noStrike" kern="1200" cap="none" spc="0" normalizeH="0" baseline="0" noProof="0" dirty="0">
                <a:ln>
                  <a:noFill/>
                </a:ln>
                <a:solidFill>
                  <a:srgbClr val="9BBB59">
                    <a:lumMod val="75000"/>
                  </a:srgbClr>
                </a:solidFill>
                <a:effectLst/>
                <a:uLnTx/>
                <a:uFillTx/>
                <a:latin typeface="HY헤드라인M" pitchFamily="18" charset="-127"/>
                <a:ea typeface="HY헤드라인M" pitchFamily="18" charset="-127"/>
                <a:cs typeface="+mn-cs"/>
              </a:rPr>
              <a:t>P</a:t>
            </a:r>
            <a:r>
              <a:rPr kumimoji="0" lang="en-US" altLang="ko-KR" sz="4800" b="0" i="0" u="none" strike="noStrike" kern="1200" cap="none" spc="0" normalizeH="0" baseline="0" noProof="0" dirty="0">
                <a:ln>
                  <a:noFill/>
                </a:ln>
                <a:solidFill>
                  <a:srgbClr val="689E1D"/>
                </a:solidFill>
                <a:effectLst/>
                <a:uLnTx/>
                <a:uFillTx/>
                <a:latin typeface="HY헤드라인M" pitchFamily="18" charset="-127"/>
                <a:ea typeface="HY헤드라인M" pitchFamily="18" charset="-127"/>
                <a:cs typeface="+mn-cs"/>
              </a:rPr>
              <a:t>osture</a:t>
            </a:r>
          </a:p>
        </p:txBody>
      </p:sp>
      <p:pic>
        <p:nvPicPr>
          <p:cNvPr id="3" name="그림 2"/>
          <p:cNvPicPr>
            <a:picLocks noChangeAspect="1"/>
          </p:cNvPicPr>
          <p:nvPr/>
        </p:nvPicPr>
        <p:blipFill>
          <a:blip r:embed="rId2">
            <a:extLst>
              <a:ext uri="{BEBA8EAE-BF5A-486C-A8C5-ECC9F3942E4B}">
                <a14:imgProps xmlns:a14="http://schemas.microsoft.com/office/drawing/2010/main">
                  <a14:imgLayer r:embed="rId3">
                    <a14:imgEffect>
                      <a14:backgroundRemoval t="0" b="100000" l="0" r="100000">
                        <a14:backgroundMark x1="83654" y1="39316" x2="83654" y2="39316"/>
                        <a14:backgroundMark x1="68269" y1="64672" x2="68269" y2="64672"/>
                        <a14:backgroundMark x1="71154" y1="50997" x2="71154" y2="50997"/>
                        <a14:backgroundMark x1="59615" y1="39886" x2="59615" y2="39886"/>
                        <a14:backgroundMark x1="62500" y1="37322" x2="62500" y2="37322"/>
                        <a14:backgroundMark x1="65385" y1="37322" x2="65385" y2="37322"/>
                        <a14:backgroundMark x1="69712" y1="39316" x2="72596" y2="40741"/>
                        <a14:backgroundMark x1="9135" y1="30769" x2="9135" y2="30769"/>
                        <a14:backgroundMark x1="10096" y1="49573" x2="10096" y2="49573"/>
                        <a14:backgroundMark x1="12500" y1="61538" x2="12500" y2="61538"/>
                        <a14:backgroundMark x1="12019" y1="69231" x2="12019" y2="69231"/>
                        <a14:backgroundMark x1="12500" y1="75783" x2="12500" y2="75783"/>
                        <a14:backgroundMark x1="48077" y1="17379" x2="48077" y2="17379"/>
                        <a14:backgroundMark x1="60096" y1="43305" x2="60096" y2="43305"/>
                        <a14:backgroundMark x1="9135" y1="40456" x2="9135" y2="40456"/>
                        <a14:backgroundMark x1="10577" y1="58974" x2="10577" y2="58974"/>
                        <a14:backgroundMark x1="73558" y1="56125" x2="73558" y2="56125"/>
                        <a14:backgroundMark x1="41827" y1="19373" x2="41827" y2="19373"/>
                        <a14:backgroundMark x1="42788" y1="17949" x2="42788" y2="17949"/>
                        <a14:backgroundMark x1="44231" y1="16239" x2="44231" y2="16239"/>
                        <a14:backgroundMark x1="45192" y1="15670" x2="45192" y2="15670"/>
                        <a14:backgroundMark x1="69712" y1="47009" x2="69712" y2="47009"/>
                        <a14:backgroundMark x1="68269" y1="56695" x2="68269" y2="56695"/>
                      </a14:backgroundRemoval>
                    </a14:imgEffect>
                  </a14:imgLayer>
                </a14:imgProps>
              </a:ext>
              <a:ext uri="{28A0092B-C50C-407E-A947-70E740481C1C}">
                <a14:useLocalDpi xmlns:a14="http://schemas.microsoft.com/office/drawing/2010/main" val="0"/>
              </a:ext>
            </a:extLst>
          </a:blip>
          <a:stretch>
            <a:fillRect/>
          </a:stretch>
        </p:blipFill>
        <p:spPr>
          <a:xfrm>
            <a:off x="620165" y="3055078"/>
            <a:ext cx="3288104" cy="5548677"/>
          </a:xfrm>
          <a:prstGeom prst="rect">
            <a:avLst/>
          </a:prstGeom>
        </p:spPr>
      </p:pic>
      <p:pic>
        <p:nvPicPr>
          <p:cNvPr id="4" name="그림 3"/>
          <p:cNvPicPr>
            <a:picLocks noChangeAspect="1"/>
          </p:cNvPicPr>
          <p:nvPr/>
        </p:nvPicPr>
        <p:blipFill>
          <a:blip r:embed="rId4">
            <a:extLst>
              <a:ext uri="{BEBA8EAE-BF5A-486C-A8C5-ECC9F3942E4B}">
                <a14:imgProps xmlns:a14="http://schemas.microsoft.com/office/drawing/2010/main">
                  <a14:imgLayer r:embed="rId5">
                    <a14:imgEffect>
                      <a14:backgroundRemoval t="0" b="100000" l="0" r="100000">
                        <a14:foregroundMark x1="17073" y1="18466" x2="17073" y2="18466"/>
                        <a14:foregroundMark x1="17073" y1="17898" x2="17073" y2="17898"/>
                        <a14:foregroundMark x1="17073" y1="17330" x2="17073" y2="17330"/>
                        <a14:foregroundMark x1="17073" y1="17330" x2="17073" y2="17330"/>
                        <a14:foregroundMark x1="18049" y1="16761" x2="18049" y2="16761"/>
                        <a14:foregroundMark x1="18049" y1="16761" x2="18049" y2="16761"/>
                        <a14:foregroundMark x1="18049" y1="16477" x2="18049" y2="16477"/>
                        <a14:foregroundMark x1="18049" y1="16477" x2="18049" y2="16477"/>
                        <a14:foregroundMark x1="18049" y1="16477" x2="18049" y2="16193"/>
                        <a14:foregroundMark x1="18537" y1="15625" x2="18537" y2="15625"/>
                        <a14:foregroundMark x1="18537" y1="15625" x2="18537" y2="15625"/>
                        <a14:foregroundMark x1="18537" y1="15625" x2="18537" y2="15625"/>
                        <a14:foregroundMark x1="17561" y1="14489" x2="17561" y2="14489"/>
                        <a14:foregroundMark x1="17561" y1="14489" x2="17561" y2="14489"/>
                        <a14:foregroundMark x1="17561" y1="14489" x2="17561" y2="14205"/>
                        <a14:foregroundMark x1="17561" y1="13920" x2="17561" y2="13636"/>
                        <a14:foregroundMark x1="17561" y1="13636" x2="18049" y2="13352"/>
                        <a14:foregroundMark x1="18049" y1="12784" x2="18049" y2="12784"/>
                        <a14:foregroundMark x1="18049" y1="12784" x2="18049" y2="12784"/>
                        <a14:foregroundMark x1="18049" y1="14773" x2="18537" y2="16193"/>
                        <a14:foregroundMark x1="18537" y1="16193" x2="18537" y2="16193"/>
                        <a14:foregroundMark x1="18049" y1="16761" x2="18049" y2="16761"/>
                        <a14:foregroundMark x1="17561" y1="17330" x2="17561" y2="17330"/>
                        <a14:foregroundMark x1="17561" y1="17614" x2="17561" y2="17614"/>
                        <a14:foregroundMark x1="17073" y1="17898" x2="17073" y2="17898"/>
                        <a14:foregroundMark x1="17073" y1="17898" x2="17073" y2="17898"/>
                        <a14:foregroundMark x1="17073" y1="18182" x2="16585" y2="18466"/>
                        <a14:foregroundMark x1="16098" y1="18182" x2="16098" y2="18182"/>
                        <a14:foregroundMark x1="16098" y1="18182" x2="16098" y2="18182"/>
                        <a14:foregroundMark x1="16098" y1="18182" x2="16098" y2="18182"/>
                        <a14:foregroundMark x1="16098" y1="18182" x2="16098" y2="18182"/>
                        <a14:foregroundMark x1="16098" y1="18182" x2="16098" y2="18182"/>
                        <a14:foregroundMark x1="16098" y1="18182" x2="16098" y2="18182"/>
                        <a14:foregroundMark x1="16098" y1="18182" x2="16098" y2="18182"/>
                        <a14:foregroundMark x1="16098" y1="18466" x2="16098" y2="18466"/>
                        <a14:foregroundMark x1="16098" y1="18750" x2="16098" y2="18750"/>
                        <a14:foregroundMark x1="16098" y1="18750" x2="16098" y2="18750"/>
                        <a14:foregroundMark x1="16098" y1="18750" x2="16098" y2="18750"/>
                        <a14:foregroundMark x1="16098" y1="18466" x2="16098" y2="18466"/>
                        <a14:foregroundMark x1="15610" y1="18466" x2="15610" y2="18466"/>
                        <a14:foregroundMark x1="15610" y1="18466" x2="15610" y2="18466"/>
                        <a14:foregroundMark x1="15610" y1="18466" x2="15610" y2="18466"/>
                        <a14:foregroundMark x1="15610" y1="18182" x2="15610" y2="18182"/>
                        <a14:foregroundMark x1="16098" y1="17898" x2="16098" y2="17898"/>
                        <a14:foregroundMark x1="16098" y1="17898" x2="16098" y2="17898"/>
                        <a14:foregroundMark x1="16585" y1="17614" x2="16585" y2="17614"/>
                        <a14:foregroundMark x1="16585" y1="17614" x2="16585" y2="17614"/>
                        <a14:foregroundMark x1="17561" y1="17614" x2="17561" y2="17614"/>
                        <a14:foregroundMark x1="17561" y1="17614" x2="17561" y2="17614"/>
                        <a14:foregroundMark x1="18049" y1="17614" x2="18049" y2="17614"/>
                        <a14:backgroundMark x1="81463" y1="27557" x2="81463" y2="27557"/>
                        <a14:backgroundMark x1="68293" y1="31534" x2="68293" y2="31534"/>
                        <a14:backgroundMark x1="58049" y1="21307" x2="58049" y2="21307"/>
                        <a14:backgroundMark x1="78537" y1="49716" x2="78537" y2="49716"/>
                        <a14:backgroundMark x1="82439" y1="41193" x2="82439" y2="41193"/>
                        <a14:backgroundMark x1="82439" y1="41193" x2="82439" y2="41193"/>
                        <a14:backgroundMark x1="82439" y1="41193" x2="82439" y2="41193"/>
                        <a14:backgroundMark x1="82439" y1="41193" x2="82439" y2="41193"/>
                        <a14:backgroundMark x1="82439" y1="46023" x2="82439" y2="46023"/>
                        <a14:backgroundMark x1="71707" y1="43466" x2="71707" y2="43466"/>
                        <a14:backgroundMark x1="20488" y1="45739" x2="20488" y2="45739"/>
                        <a14:backgroundMark x1="20488" y1="45739" x2="20488" y2="45739"/>
                        <a14:backgroundMark x1="15122" y1="36648" x2="15122" y2="36648"/>
                        <a14:backgroundMark x1="15122" y1="36648" x2="15122" y2="36648"/>
                        <a14:backgroundMark x1="9756" y1="30114" x2="9756" y2="30114"/>
                        <a14:backgroundMark x1="9756" y1="28409" x2="9756" y2="28409"/>
                        <a14:backgroundMark x1="9756" y1="40057" x2="9756" y2="40057"/>
                        <a14:backgroundMark x1="9756" y1="46023" x2="9756" y2="46023"/>
                        <a14:backgroundMark x1="11707" y1="49432" x2="12195" y2="50568"/>
                        <a14:backgroundMark x1="12683" y1="51705" x2="12683" y2="55114"/>
                        <a14:backgroundMark x1="12683" y1="58239" x2="12683" y2="58239"/>
                        <a14:backgroundMark x1="12683" y1="59943" x2="12683" y2="59943"/>
                        <a14:backgroundMark x1="38049" y1="62500" x2="38049" y2="62500"/>
                        <a14:backgroundMark x1="43415" y1="13068" x2="43415" y2="13068"/>
                        <a14:backgroundMark x1="43902" y1="11648" x2="43902" y2="11648"/>
                        <a14:backgroundMark x1="41463" y1="9943" x2="41463" y2="9943"/>
                        <a14:backgroundMark x1="40488" y1="9659" x2="40488" y2="9659"/>
                        <a14:backgroundMark x1="50244" y1="12216" x2="51220" y2="13352"/>
                        <a14:backgroundMark x1="62439" y1="27273" x2="64390" y2="29545"/>
                        <a14:backgroundMark x1="68780" y1="37784" x2="69268" y2="38068"/>
                        <a14:backgroundMark x1="70244" y1="38920" x2="70244" y2="38920"/>
                      </a14:backgroundRemoval>
                    </a14:imgEffect>
                  </a14:imgLayer>
                </a14:imgProps>
              </a:ext>
              <a:ext uri="{28A0092B-C50C-407E-A947-70E740481C1C}">
                <a14:useLocalDpi xmlns:a14="http://schemas.microsoft.com/office/drawing/2010/main" val="0"/>
              </a:ext>
            </a:extLst>
          </a:blip>
          <a:stretch>
            <a:fillRect/>
          </a:stretch>
        </p:blipFill>
        <p:spPr>
          <a:xfrm>
            <a:off x="5088633" y="3055078"/>
            <a:ext cx="3271848" cy="5618001"/>
          </a:xfrm>
          <a:prstGeom prst="rect">
            <a:avLst/>
          </a:prstGeom>
        </p:spPr>
      </p:pic>
    </p:spTree>
    <p:extLst>
      <p:ext uri="{BB962C8B-B14F-4D97-AF65-F5344CB8AC3E}">
        <p14:creationId xmlns:p14="http://schemas.microsoft.com/office/powerpoint/2010/main" val="340573824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2" name="모서리가 둥근 직사각형 21"/>
          <p:cNvSpPr/>
          <p:nvPr/>
        </p:nvSpPr>
        <p:spPr>
          <a:xfrm>
            <a:off x="336104" y="2806289"/>
            <a:ext cx="3600000" cy="5217850"/>
          </a:xfrm>
          <a:prstGeom prst="roundRect">
            <a:avLst/>
          </a:prstGeom>
          <a:noFill/>
          <a:ln w="50800">
            <a:solidFill>
              <a:srgbClr val="689E1D"/>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79953" rtl="0" eaLnBrk="1" fontAlgn="auto" latinLnBrk="1" hangingPunct="1">
              <a:lnSpc>
                <a:spcPct val="100000"/>
              </a:lnSpc>
              <a:spcBef>
                <a:spcPts val="0"/>
              </a:spcBef>
              <a:spcAft>
                <a:spcPts val="0"/>
              </a:spcAft>
              <a:buClrTx/>
              <a:buSzTx/>
              <a:buFontTx/>
              <a:buNone/>
              <a:tabLst/>
              <a:defRPr/>
            </a:pPr>
            <a:endParaRPr kumimoji="0" lang="ko-KR" altLang="en-US" sz="2500" b="0" i="0" u="none" strike="noStrike" kern="1200" cap="none" spc="0" normalizeH="0" baseline="0" noProof="0">
              <a:ln>
                <a:noFill/>
              </a:ln>
              <a:solidFill>
                <a:prstClr val="white"/>
              </a:solidFill>
              <a:effectLst/>
              <a:uLnTx/>
              <a:uFillTx/>
              <a:latin typeface="맑은 고딕"/>
              <a:ea typeface="맑은 고딕" panose="020B0503020000020004" pitchFamily="50" charset="-127"/>
              <a:cs typeface="+mn-cs"/>
            </a:endParaRPr>
          </a:p>
        </p:txBody>
      </p:sp>
      <p:sp>
        <p:nvSpPr>
          <p:cNvPr id="25" name="모서리가 둥근 직사각형 24"/>
          <p:cNvSpPr/>
          <p:nvPr/>
        </p:nvSpPr>
        <p:spPr>
          <a:xfrm>
            <a:off x="4800600" y="2806289"/>
            <a:ext cx="3600000" cy="5217850"/>
          </a:xfrm>
          <a:prstGeom prst="roundRect">
            <a:avLst/>
          </a:prstGeom>
          <a:noFill/>
          <a:ln w="50800">
            <a:solidFill>
              <a:srgbClr val="689E1D"/>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79953" rtl="0" eaLnBrk="1" fontAlgn="auto" latinLnBrk="1" hangingPunct="1">
              <a:lnSpc>
                <a:spcPct val="100000"/>
              </a:lnSpc>
              <a:spcBef>
                <a:spcPts val="0"/>
              </a:spcBef>
              <a:spcAft>
                <a:spcPts val="0"/>
              </a:spcAft>
              <a:buClrTx/>
              <a:buSzTx/>
              <a:buFontTx/>
              <a:buNone/>
              <a:tabLst/>
              <a:defRPr/>
            </a:pPr>
            <a:endParaRPr kumimoji="0" lang="ko-KR" altLang="en-US" sz="2500" b="0" i="0" u="none" strike="noStrike" kern="1200" cap="none" spc="0" normalizeH="0" baseline="0" noProof="0">
              <a:ln>
                <a:noFill/>
              </a:ln>
              <a:solidFill>
                <a:prstClr val="white"/>
              </a:solidFill>
              <a:effectLst/>
              <a:uLnTx/>
              <a:uFillTx/>
              <a:latin typeface="맑은 고딕"/>
              <a:ea typeface="맑은 고딕" panose="020B0503020000020004" pitchFamily="50" charset="-127"/>
              <a:cs typeface="+mn-cs"/>
            </a:endParaRPr>
          </a:p>
        </p:txBody>
      </p:sp>
      <p:sp>
        <p:nvSpPr>
          <p:cNvPr id="37" name="직사각형 36"/>
          <p:cNvSpPr/>
          <p:nvPr/>
        </p:nvSpPr>
        <p:spPr>
          <a:xfrm>
            <a:off x="108000" y="8273008"/>
            <a:ext cx="8802000" cy="432048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457200" marR="0" lvl="0" indent="-457200" algn="just" defTabSz="1279953" rtl="0" eaLnBrk="1" fontAlgn="auto" latinLnBrk="1" hangingPunct="1">
              <a:lnSpc>
                <a:spcPct val="100000"/>
              </a:lnSpc>
              <a:spcBef>
                <a:spcPts val="0"/>
              </a:spcBef>
              <a:spcAft>
                <a:spcPts val="0"/>
              </a:spcAft>
              <a:buClrTx/>
              <a:buSzTx/>
              <a:buFontTx/>
              <a:buAutoNum type="arabicPeriod"/>
              <a:tabLst/>
              <a:defRPr/>
            </a:pPr>
            <a:r>
              <a:rPr kumimoji="0" lang="en-US" altLang="ko-KR" sz="2400" b="0" i="0" u="none" strike="noStrike" kern="1200" cap="none" spc="-150" normalizeH="0" baseline="0" noProof="0" dirty="0">
                <a:ln>
                  <a:noFill/>
                </a:ln>
                <a:solidFill>
                  <a:prstClr val="black">
                    <a:lumMod val="75000"/>
                    <a:lumOff val="25000"/>
                  </a:prstClr>
                </a:solidFill>
                <a:effectLst/>
                <a:uLnTx/>
                <a:uFillTx/>
                <a:latin typeface="HY헤드라인M" pitchFamily="18" charset="-127"/>
                <a:ea typeface="HY헤드라인M" pitchFamily="18" charset="-127"/>
                <a:cs typeface="+mn-cs"/>
              </a:rPr>
              <a:t>Spread your legs at the same distance as your shoulders and make sure your feet are pointed forward.</a:t>
            </a:r>
          </a:p>
          <a:p>
            <a:pPr marL="457200" marR="0" lvl="0" indent="-457200" algn="just" defTabSz="1279953" rtl="0" eaLnBrk="1" fontAlgn="auto" latinLnBrk="1" hangingPunct="1">
              <a:lnSpc>
                <a:spcPct val="100000"/>
              </a:lnSpc>
              <a:spcBef>
                <a:spcPts val="0"/>
              </a:spcBef>
              <a:spcAft>
                <a:spcPts val="0"/>
              </a:spcAft>
              <a:buClrTx/>
              <a:buSzTx/>
              <a:buFontTx/>
              <a:buAutoNum type="arabicPeriod"/>
              <a:tabLst/>
              <a:defRPr/>
            </a:pPr>
            <a:endParaRPr kumimoji="0" lang="en-US" altLang="ko-KR" sz="2400" b="0" i="0" u="none" strike="noStrike" kern="1200" cap="none" spc="-150" normalizeH="0" baseline="0" noProof="0" dirty="0">
              <a:ln>
                <a:noFill/>
              </a:ln>
              <a:solidFill>
                <a:prstClr val="black">
                  <a:lumMod val="75000"/>
                  <a:lumOff val="25000"/>
                </a:prstClr>
              </a:solidFill>
              <a:effectLst/>
              <a:uLnTx/>
              <a:uFillTx/>
              <a:latin typeface="HY헤드라인M" pitchFamily="18" charset="-127"/>
              <a:ea typeface="HY헤드라인M" pitchFamily="18" charset="-127"/>
              <a:cs typeface="+mn-cs"/>
            </a:endParaRPr>
          </a:p>
          <a:p>
            <a:pPr marL="457200" marR="0" lvl="0" indent="-457200" algn="just" defTabSz="1279953" rtl="0" eaLnBrk="1" fontAlgn="auto" latinLnBrk="1" hangingPunct="1">
              <a:lnSpc>
                <a:spcPct val="100000"/>
              </a:lnSpc>
              <a:spcBef>
                <a:spcPts val="0"/>
              </a:spcBef>
              <a:spcAft>
                <a:spcPts val="0"/>
              </a:spcAft>
              <a:buClrTx/>
              <a:buSzTx/>
              <a:buFontTx/>
              <a:buAutoNum type="arabicPeriod"/>
              <a:tabLst/>
              <a:defRPr/>
            </a:pPr>
            <a:r>
              <a:rPr kumimoji="0" lang="en-US" altLang="ko-KR" sz="2400" b="0" i="0" u="none" strike="noStrike" kern="1200" cap="none" spc="-150" normalizeH="0" baseline="0" noProof="0" dirty="0">
                <a:ln>
                  <a:noFill/>
                </a:ln>
                <a:solidFill>
                  <a:prstClr val="black">
                    <a:lumMod val="75000"/>
                    <a:lumOff val="25000"/>
                  </a:prstClr>
                </a:solidFill>
                <a:effectLst/>
                <a:uLnTx/>
                <a:uFillTx/>
                <a:latin typeface="HY헤드라인M" pitchFamily="18" charset="-127"/>
                <a:ea typeface="HY헤드라인M" pitchFamily="18" charset="-127"/>
                <a:cs typeface="+mn-cs"/>
              </a:rPr>
              <a:t>Keeping your back straight, brace your abdomen and buttocks. Bend your hips and knees, and push back your buttocks.</a:t>
            </a:r>
          </a:p>
          <a:p>
            <a:pPr marL="457200" marR="0" lvl="0" indent="-457200" algn="just" defTabSz="1279953" rtl="0" eaLnBrk="1" fontAlgn="auto" latinLnBrk="1" hangingPunct="1">
              <a:lnSpc>
                <a:spcPct val="100000"/>
              </a:lnSpc>
              <a:spcBef>
                <a:spcPts val="0"/>
              </a:spcBef>
              <a:spcAft>
                <a:spcPts val="0"/>
              </a:spcAft>
              <a:buClrTx/>
              <a:buSzTx/>
              <a:buFontTx/>
              <a:buAutoNum type="arabicPeriod"/>
              <a:tabLst/>
              <a:defRPr/>
            </a:pPr>
            <a:endParaRPr kumimoji="0" lang="en-US" altLang="ko-KR" sz="2400" b="0" i="0" u="none" strike="noStrike" kern="1200" cap="none" spc="-150" normalizeH="0" baseline="0" noProof="0" dirty="0">
              <a:ln>
                <a:noFill/>
              </a:ln>
              <a:solidFill>
                <a:prstClr val="black">
                  <a:lumMod val="75000"/>
                  <a:lumOff val="25000"/>
                </a:prstClr>
              </a:solidFill>
              <a:effectLst/>
              <a:uLnTx/>
              <a:uFillTx/>
              <a:latin typeface="HY헤드라인M" pitchFamily="18" charset="-127"/>
              <a:ea typeface="HY헤드라인M" pitchFamily="18" charset="-127"/>
              <a:cs typeface="+mn-cs"/>
            </a:endParaRPr>
          </a:p>
          <a:p>
            <a:pPr marL="457200" marR="0" lvl="0" indent="-457200" algn="just" defTabSz="1279953" rtl="0" eaLnBrk="1" fontAlgn="auto" latinLnBrk="1" hangingPunct="1">
              <a:lnSpc>
                <a:spcPct val="100000"/>
              </a:lnSpc>
              <a:spcBef>
                <a:spcPts val="0"/>
              </a:spcBef>
              <a:spcAft>
                <a:spcPts val="0"/>
              </a:spcAft>
              <a:buClrTx/>
              <a:buSzTx/>
              <a:buFontTx/>
              <a:buAutoNum type="arabicPeriod"/>
              <a:tabLst/>
              <a:defRPr/>
            </a:pPr>
            <a:r>
              <a:rPr kumimoji="0" lang="en-US" altLang="ko-KR" sz="2400" b="0" i="0" u="none" strike="noStrike" kern="1200" cap="none" spc="-150" normalizeH="0" baseline="0" noProof="0" dirty="0">
                <a:ln>
                  <a:noFill/>
                </a:ln>
                <a:solidFill>
                  <a:prstClr val="black">
                    <a:lumMod val="75000"/>
                    <a:lumOff val="25000"/>
                  </a:prstClr>
                </a:solidFill>
                <a:effectLst/>
                <a:uLnTx/>
                <a:uFillTx/>
                <a:latin typeface="HY헤드라인M" pitchFamily="18" charset="-127"/>
                <a:ea typeface="HY헤드라인M" pitchFamily="18" charset="-127"/>
                <a:cs typeface="+mn-cs"/>
              </a:rPr>
              <a:t>While sitting down, make sure your knees don’t stick out farther than the end of your feet. Bring your arms together in front.</a:t>
            </a:r>
          </a:p>
          <a:p>
            <a:pPr marL="457200" marR="0" lvl="0" indent="-457200" algn="just" defTabSz="1279953" rtl="0" eaLnBrk="1" fontAlgn="auto" latinLnBrk="1" hangingPunct="1">
              <a:lnSpc>
                <a:spcPct val="100000"/>
              </a:lnSpc>
              <a:spcBef>
                <a:spcPts val="0"/>
              </a:spcBef>
              <a:spcAft>
                <a:spcPts val="0"/>
              </a:spcAft>
              <a:buClrTx/>
              <a:buSzTx/>
              <a:buFontTx/>
              <a:buAutoNum type="arabicPeriod"/>
              <a:tabLst/>
              <a:defRPr/>
            </a:pPr>
            <a:endParaRPr kumimoji="0" lang="en-US" altLang="ko-KR" sz="2400" b="0" i="0" u="none" strike="noStrike" kern="1200" cap="none" spc="-150" normalizeH="0" baseline="0" noProof="0" dirty="0">
              <a:ln>
                <a:noFill/>
              </a:ln>
              <a:solidFill>
                <a:prstClr val="black">
                  <a:lumMod val="75000"/>
                  <a:lumOff val="25000"/>
                </a:prstClr>
              </a:solidFill>
              <a:effectLst/>
              <a:uLnTx/>
              <a:uFillTx/>
              <a:latin typeface="HY헤드라인M" pitchFamily="18" charset="-127"/>
              <a:ea typeface="HY헤드라인M" pitchFamily="18" charset="-127"/>
              <a:cs typeface="+mn-cs"/>
            </a:endParaRPr>
          </a:p>
          <a:p>
            <a:pPr marL="457200" marR="0" lvl="0" indent="-457200" algn="just" defTabSz="1279953" rtl="0" eaLnBrk="1" fontAlgn="auto" latinLnBrk="1" hangingPunct="1">
              <a:lnSpc>
                <a:spcPct val="100000"/>
              </a:lnSpc>
              <a:spcBef>
                <a:spcPts val="0"/>
              </a:spcBef>
              <a:spcAft>
                <a:spcPts val="0"/>
              </a:spcAft>
              <a:buClrTx/>
              <a:buSzTx/>
              <a:buFontTx/>
              <a:buAutoNum type="arabicPeriod"/>
              <a:tabLst/>
              <a:defRPr/>
            </a:pPr>
            <a:r>
              <a:rPr kumimoji="0" lang="en-US" altLang="ko-KR" sz="2400" b="0" i="0" u="none" strike="noStrike" kern="1200" cap="none" spc="-150" normalizeH="0" baseline="0" noProof="0" dirty="0">
                <a:ln>
                  <a:noFill/>
                </a:ln>
                <a:solidFill>
                  <a:prstClr val="black">
                    <a:lumMod val="75000"/>
                    <a:lumOff val="25000"/>
                  </a:prstClr>
                </a:solidFill>
                <a:effectLst/>
                <a:uLnTx/>
                <a:uFillTx/>
                <a:latin typeface="HY헤드라인M" pitchFamily="18" charset="-127"/>
                <a:ea typeface="HY헤드라인M" pitchFamily="18" charset="-127"/>
                <a:cs typeface="+mn-cs"/>
              </a:rPr>
              <a:t>Return to your first position while standing, and spread your arms to your sides.</a:t>
            </a:r>
          </a:p>
        </p:txBody>
      </p:sp>
      <p:sp>
        <p:nvSpPr>
          <p:cNvPr id="40" name="직사각형 39"/>
          <p:cNvSpPr/>
          <p:nvPr/>
        </p:nvSpPr>
        <p:spPr>
          <a:xfrm>
            <a:off x="876104" y="2136073"/>
            <a:ext cx="2520000" cy="720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79953" rtl="0" eaLnBrk="1" fontAlgn="auto" latinLnBrk="1" hangingPunct="1">
              <a:lnSpc>
                <a:spcPct val="100000"/>
              </a:lnSpc>
              <a:spcBef>
                <a:spcPts val="0"/>
              </a:spcBef>
              <a:spcAft>
                <a:spcPts val="0"/>
              </a:spcAft>
              <a:buClrTx/>
              <a:buSzTx/>
              <a:buFontTx/>
              <a:buNone/>
              <a:tabLst/>
              <a:defRPr/>
            </a:pPr>
            <a:r>
              <a:rPr kumimoji="0" lang="en-US" altLang="ko-KR" sz="2500" b="0" i="0" u="none" strike="noStrike" kern="1200" cap="none" spc="0" normalizeH="0" baseline="0" noProof="0" dirty="0">
                <a:ln>
                  <a:noFill/>
                </a:ln>
                <a:solidFill>
                  <a:prstClr val="black"/>
                </a:solidFill>
                <a:effectLst/>
                <a:uLnTx/>
                <a:uFillTx/>
                <a:latin typeface="HY헤드라인M" pitchFamily="18" charset="-127"/>
                <a:ea typeface="HY헤드라인M" pitchFamily="18" charset="-127"/>
                <a:cs typeface="+mn-cs"/>
              </a:rPr>
              <a:t>Preparation</a:t>
            </a:r>
            <a:endParaRPr kumimoji="0" lang="ko-KR" altLang="en-US" sz="2500" b="0" i="0" u="none" strike="noStrike" kern="1200" cap="none" spc="0" normalizeH="0" baseline="0" noProof="0" dirty="0">
              <a:ln>
                <a:noFill/>
              </a:ln>
              <a:solidFill>
                <a:prstClr val="black"/>
              </a:solidFill>
              <a:effectLst/>
              <a:uLnTx/>
              <a:uFillTx/>
              <a:latin typeface="HY헤드라인M" pitchFamily="18" charset="-127"/>
              <a:ea typeface="HY헤드라인M" pitchFamily="18" charset="-127"/>
              <a:cs typeface="+mn-cs"/>
            </a:endParaRPr>
          </a:p>
        </p:txBody>
      </p:sp>
      <p:sp>
        <p:nvSpPr>
          <p:cNvPr id="41" name="직사각형 40"/>
          <p:cNvSpPr/>
          <p:nvPr/>
        </p:nvSpPr>
        <p:spPr>
          <a:xfrm>
            <a:off x="5340600" y="2136073"/>
            <a:ext cx="2520000" cy="720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79953" rtl="0" eaLnBrk="1" fontAlgn="auto" latinLnBrk="1" hangingPunct="1">
              <a:lnSpc>
                <a:spcPct val="100000"/>
              </a:lnSpc>
              <a:spcBef>
                <a:spcPts val="0"/>
              </a:spcBef>
              <a:spcAft>
                <a:spcPts val="0"/>
              </a:spcAft>
              <a:buClrTx/>
              <a:buSzTx/>
              <a:buFontTx/>
              <a:buNone/>
              <a:tabLst/>
              <a:defRPr/>
            </a:pPr>
            <a:r>
              <a:rPr kumimoji="0" lang="en-US" altLang="ko-KR" sz="2500" b="0" i="0" u="none" strike="noStrike" kern="1200" cap="none" spc="0" normalizeH="0" baseline="0" noProof="0" dirty="0">
                <a:ln>
                  <a:noFill/>
                </a:ln>
                <a:solidFill>
                  <a:prstClr val="black"/>
                </a:solidFill>
                <a:effectLst/>
                <a:uLnTx/>
                <a:uFillTx/>
                <a:latin typeface="HY헤드라인M" pitchFamily="18" charset="-127"/>
                <a:ea typeface="HY헤드라인M" pitchFamily="18" charset="-127"/>
                <a:cs typeface="+mn-cs"/>
              </a:rPr>
              <a:t>Exercise</a:t>
            </a:r>
            <a:endParaRPr kumimoji="0" lang="ko-KR" altLang="en-US" sz="2500" b="0" i="0" u="none" strike="noStrike" kern="1200" cap="none" spc="0" normalizeH="0" baseline="0" noProof="0" dirty="0">
              <a:ln>
                <a:noFill/>
              </a:ln>
              <a:solidFill>
                <a:prstClr val="black"/>
              </a:solidFill>
              <a:effectLst/>
              <a:uLnTx/>
              <a:uFillTx/>
              <a:latin typeface="HY헤드라인M" pitchFamily="18" charset="-127"/>
              <a:ea typeface="HY헤드라인M" pitchFamily="18" charset="-127"/>
              <a:cs typeface="+mn-cs"/>
            </a:endParaRPr>
          </a:p>
        </p:txBody>
      </p:sp>
      <p:sp>
        <p:nvSpPr>
          <p:cNvPr id="2" name="직사각형 1"/>
          <p:cNvSpPr/>
          <p:nvPr/>
        </p:nvSpPr>
        <p:spPr>
          <a:xfrm>
            <a:off x="0" y="0"/>
            <a:ext cx="9601200" cy="1432248"/>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79953" rtl="0" eaLnBrk="1" fontAlgn="auto" latinLnBrk="1" hangingPunct="1">
              <a:lnSpc>
                <a:spcPct val="100000"/>
              </a:lnSpc>
              <a:spcBef>
                <a:spcPts val="0"/>
              </a:spcBef>
              <a:spcAft>
                <a:spcPts val="0"/>
              </a:spcAft>
              <a:buClrTx/>
              <a:buSzTx/>
              <a:buFontTx/>
              <a:buNone/>
              <a:tabLst/>
              <a:defRPr/>
            </a:pPr>
            <a:r>
              <a:rPr kumimoji="0" lang="en-US" altLang="ko-KR" sz="5000" b="0" i="0" u="none" strike="noStrike" kern="1200" cap="none" spc="0" normalizeH="0" baseline="0" noProof="0" dirty="0">
                <a:ln>
                  <a:noFill/>
                </a:ln>
                <a:solidFill>
                  <a:srgbClr val="689E1D"/>
                </a:solidFill>
                <a:effectLst/>
                <a:uLnTx/>
                <a:uFillTx/>
                <a:latin typeface="HY헤드라인M" pitchFamily="18" charset="-127"/>
                <a:ea typeface="HY헤드라인M" pitchFamily="18" charset="-127"/>
                <a:cs typeface="+mn-cs"/>
              </a:rPr>
              <a:t>Potty Squat</a:t>
            </a:r>
          </a:p>
        </p:txBody>
      </p:sp>
      <p:pic>
        <p:nvPicPr>
          <p:cNvPr id="1026"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20080" y="2728392"/>
            <a:ext cx="3669629" cy="522333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7"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5188362" y="2825339"/>
            <a:ext cx="3653149" cy="502944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2" name="직사각형 11"/>
          <p:cNvSpPr/>
          <p:nvPr/>
        </p:nvSpPr>
        <p:spPr>
          <a:xfrm>
            <a:off x="336104" y="1432248"/>
            <a:ext cx="8573896" cy="720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79953" rtl="0" eaLnBrk="1" fontAlgn="auto" latinLnBrk="1" hangingPunct="1">
              <a:lnSpc>
                <a:spcPct val="100000"/>
              </a:lnSpc>
              <a:spcBef>
                <a:spcPts val="0"/>
              </a:spcBef>
              <a:spcAft>
                <a:spcPts val="0"/>
              </a:spcAft>
              <a:buClrTx/>
              <a:buSzTx/>
              <a:buFontTx/>
              <a:buNone/>
              <a:tabLst/>
              <a:defRPr/>
            </a:pPr>
            <a:r>
              <a:rPr kumimoji="0" lang="en-US" altLang="ko-KR" sz="2400" b="0" i="0" u="none" strike="noStrike" kern="1200" cap="none" spc="0" normalizeH="0" baseline="0" noProof="0" dirty="0">
                <a:ln>
                  <a:noFill/>
                </a:ln>
                <a:solidFill>
                  <a:prstClr val="black"/>
                </a:solidFill>
                <a:effectLst/>
                <a:uLnTx/>
                <a:uFillTx/>
                <a:latin typeface="HY헤드라인M" pitchFamily="18" charset="-127"/>
                <a:ea typeface="HY헤드라인M" pitchFamily="18" charset="-127"/>
                <a:cs typeface="+mn-cs"/>
              </a:rPr>
              <a:t>1st Set (   times) -&gt;  2nd Set (  times) -&gt;  3rd Set (  times)</a:t>
            </a:r>
            <a:endParaRPr kumimoji="0" lang="ko-KR" altLang="en-US" sz="2400" b="0" i="0" u="none" strike="noStrike" kern="1200" cap="none" spc="0" normalizeH="0" baseline="0" noProof="0" dirty="0">
              <a:ln>
                <a:noFill/>
              </a:ln>
              <a:solidFill>
                <a:prstClr val="black"/>
              </a:solidFill>
              <a:effectLst/>
              <a:uLnTx/>
              <a:uFillTx/>
              <a:latin typeface="HY헤드라인M" pitchFamily="18" charset="-127"/>
              <a:ea typeface="HY헤드라인M" pitchFamily="18" charset="-127"/>
              <a:cs typeface="+mn-cs"/>
            </a:endParaRPr>
          </a:p>
        </p:txBody>
      </p:sp>
    </p:spTree>
    <p:extLst>
      <p:ext uri="{BB962C8B-B14F-4D97-AF65-F5344CB8AC3E}">
        <p14:creationId xmlns:p14="http://schemas.microsoft.com/office/powerpoint/2010/main" val="31822038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2" name="모서리가 둥근 직사각형 21"/>
          <p:cNvSpPr/>
          <p:nvPr/>
        </p:nvSpPr>
        <p:spPr>
          <a:xfrm>
            <a:off x="311905" y="2627801"/>
            <a:ext cx="8100216" cy="2608925"/>
          </a:xfrm>
          <a:prstGeom prst="roundRect">
            <a:avLst/>
          </a:prstGeom>
          <a:noFill/>
          <a:ln w="50800">
            <a:solidFill>
              <a:srgbClr val="689E1D"/>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79953" rtl="0" eaLnBrk="1" fontAlgn="auto" latinLnBrk="1" hangingPunct="1">
              <a:lnSpc>
                <a:spcPct val="100000"/>
              </a:lnSpc>
              <a:spcBef>
                <a:spcPts val="0"/>
              </a:spcBef>
              <a:spcAft>
                <a:spcPts val="0"/>
              </a:spcAft>
              <a:buClrTx/>
              <a:buSzTx/>
              <a:buFontTx/>
              <a:buNone/>
              <a:tabLst/>
              <a:defRPr/>
            </a:pPr>
            <a:endParaRPr kumimoji="0" lang="ko-KR" altLang="en-US" sz="2500" b="0" i="0" u="none" strike="noStrike" kern="1200" cap="none" spc="0" normalizeH="0" baseline="0" noProof="0">
              <a:ln>
                <a:noFill/>
              </a:ln>
              <a:solidFill>
                <a:prstClr val="white"/>
              </a:solidFill>
              <a:effectLst/>
              <a:uLnTx/>
              <a:uFillTx/>
              <a:latin typeface="맑은 고딕"/>
              <a:ea typeface="맑은 고딕" panose="020B0503020000020004" pitchFamily="50" charset="-127"/>
              <a:cs typeface="+mn-cs"/>
            </a:endParaRPr>
          </a:p>
        </p:txBody>
      </p:sp>
      <p:sp>
        <p:nvSpPr>
          <p:cNvPr id="37" name="직사각형 36"/>
          <p:cNvSpPr/>
          <p:nvPr/>
        </p:nvSpPr>
        <p:spPr>
          <a:xfrm>
            <a:off x="108000" y="8488832"/>
            <a:ext cx="8802000" cy="3312568"/>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457200" marR="0" lvl="0" indent="-457200" algn="l" defTabSz="1279953" rtl="0" eaLnBrk="1" fontAlgn="auto" latinLnBrk="1" hangingPunct="1">
              <a:lnSpc>
                <a:spcPct val="100000"/>
              </a:lnSpc>
              <a:spcBef>
                <a:spcPts val="0"/>
              </a:spcBef>
              <a:spcAft>
                <a:spcPts val="0"/>
              </a:spcAft>
              <a:buClrTx/>
              <a:buSzTx/>
              <a:buFontTx/>
              <a:buAutoNum type="arabicPeriod"/>
              <a:tabLst/>
              <a:defRPr/>
            </a:pPr>
            <a:r>
              <a:rPr kumimoji="0" lang="en-US" altLang="ko-KR" sz="2400" b="0" i="0" u="none" strike="noStrike" kern="1200" cap="none" spc="-150" normalizeH="0" baseline="0" noProof="0" dirty="0">
                <a:ln>
                  <a:noFill/>
                </a:ln>
                <a:solidFill>
                  <a:prstClr val="black">
                    <a:lumMod val="75000"/>
                    <a:lumOff val="25000"/>
                  </a:prstClr>
                </a:solidFill>
                <a:effectLst/>
                <a:uLnTx/>
                <a:uFillTx/>
                <a:latin typeface="HY헤드라인M" pitchFamily="18" charset="-127"/>
                <a:ea typeface="HY헤드라인M" pitchFamily="18" charset="-127"/>
                <a:cs typeface="+mn-cs"/>
              </a:rPr>
              <a:t>Lie on your back and put both your hands under your back to support its natural curve.</a:t>
            </a:r>
          </a:p>
          <a:p>
            <a:pPr marL="457200" marR="0" lvl="0" indent="-457200" algn="l" defTabSz="1279953" rtl="0" eaLnBrk="1" fontAlgn="auto" latinLnBrk="1" hangingPunct="1">
              <a:lnSpc>
                <a:spcPct val="100000"/>
              </a:lnSpc>
              <a:spcBef>
                <a:spcPts val="0"/>
              </a:spcBef>
              <a:spcAft>
                <a:spcPts val="0"/>
              </a:spcAft>
              <a:buClrTx/>
              <a:buSzTx/>
              <a:buFontTx/>
              <a:buAutoNum type="arabicPeriod"/>
              <a:tabLst/>
              <a:defRPr/>
            </a:pPr>
            <a:endParaRPr kumimoji="0" lang="en-US" altLang="ko-KR" sz="2400" b="0" i="0" u="none" strike="noStrike" kern="1200" cap="none" spc="-150" normalizeH="0" baseline="0" noProof="0" dirty="0">
              <a:ln>
                <a:noFill/>
              </a:ln>
              <a:solidFill>
                <a:prstClr val="black">
                  <a:lumMod val="75000"/>
                  <a:lumOff val="25000"/>
                </a:prstClr>
              </a:solidFill>
              <a:effectLst/>
              <a:uLnTx/>
              <a:uFillTx/>
              <a:latin typeface="HY헤드라인M" pitchFamily="18" charset="-127"/>
              <a:ea typeface="HY헤드라인M" pitchFamily="18" charset="-127"/>
              <a:cs typeface="+mn-cs"/>
            </a:endParaRPr>
          </a:p>
          <a:p>
            <a:pPr marL="457200" marR="0" lvl="0" indent="-457200" algn="l" defTabSz="1279953" rtl="0" eaLnBrk="1" fontAlgn="auto" latinLnBrk="1" hangingPunct="1">
              <a:lnSpc>
                <a:spcPct val="100000"/>
              </a:lnSpc>
              <a:spcBef>
                <a:spcPts val="0"/>
              </a:spcBef>
              <a:spcAft>
                <a:spcPts val="0"/>
              </a:spcAft>
              <a:buClrTx/>
              <a:buSzTx/>
              <a:buFontTx/>
              <a:buAutoNum type="arabicPeriod"/>
              <a:tabLst/>
              <a:defRPr/>
            </a:pPr>
            <a:r>
              <a:rPr kumimoji="0" lang="en-US" altLang="ko-KR" sz="2400" b="0" i="0" u="none" strike="noStrike" kern="1200" cap="none" spc="-150" normalizeH="0" baseline="0" noProof="0" dirty="0">
                <a:ln>
                  <a:noFill/>
                </a:ln>
                <a:solidFill>
                  <a:prstClr val="black">
                    <a:lumMod val="75000"/>
                    <a:lumOff val="25000"/>
                  </a:prstClr>
                </a:solidFill>
                <a:effectLst/>
                <a:uLnTx/>
                <a:uFillTx/>
                <a:latin typeface="HY헤드라인M" pitchFamily="18" charset="-127"/>
                <a:ea typeface="HY헤드라인M" pitchFamily="18" charset="-127"/>
                <a:cs typeface="+mn-cs"/>
              </a:rPr>
              <a:t>Bend one knee at 90 degrees and leave your other leg relaxed on the floor.</a:t>
            </a:r>
          </a:p>
          <a:p>
            <a:pPr marL="457200" marR="0" lvl="0" indent="-457200" algn="l" defTabSz="1279953" rtl="0" eaLnBrk="1" fontAlgn="auto" latinLnBrk="1" hangingPunct="1">
              <a:lnSpc>
                <a:spcPct val="100000"/>
              </a:lnSpc>
              <a:spcBef>
                <a:spcPts val="0"/>
              </a:spcBef>
              <a:spcAft>
                <a:spcPts val="0"/>
              </a:spcAft>
              <a:buClrTx/>
              <a:buSzTx/>
              <a:buFontTx/>
              <a:buAutoNum type="arabicPeriod"/>
              <a:tabLst/>
              <a:defRPr/>
            </a:pPr>
            <a:endParaRPr kumimoji="0" lang="en-US" altLang="ko-KR" sz="2400" b="0" i="0" u="none" strike="noStrike" kern="1200" cap="none" spc="-150" normalizeH="0" baseline="0" noProof="0" dirty="0">
              <a:ln>
                <a:noFill/>
              </a:ln>
              <a:solidFill>
                <a:prstClr val="black">
                  <a:lumMod val="75000"/>
                  <a:lumOff val="25000"/>
                </a:prstClr>
              </a:solidFill>
              <a:effectLst/>
              <a:uLnTx/>
              <a:uFillTx/>
              <a:latin typeface="HY헤드라인M" pitchFamily="18" charset="-127"/>
              <a:ea typeface="HY헤드라인M" pitchFamily="18" charset="-127"/>
              <a:cs typeface="+mn-cs"/>
            </a:endParaRPr>
          </a:p>
          <a:p>
            <a:pPr marL="457200" marR="0" lvl="0" indent="-457200" algn="l" defTabSz="1279953" rtl="0" eaLnBrk="1" fontAlgn="auto" latinLnBrk="1" hangingPunct="1">
              <a:lnSpc>
                <a:spcPct val="100000"/>
              </a:lnSpc>
              <a:spcBef>
                <a:spcPts val="0"/>
              </a:spcBef>
              <a:spcAft>
                <a:spcPts val="0"/>
              </a:spcAft>
              <a:buClrTx/>
              <a:buSzTx/>
              <a:buFontTx/>
              <a:buAutoNum type="arabicPeriod"/>
              <a:tabLst/>
              <a:defRPr/>
            </a:pPr>
            <a:r>
              <a:rPr kumimoji="0" lang="en-US" altLang="ko-KR" sz="2400" b="0" i="0" u="none" strike="noStrike" kern="1200" cap="none" spc="-150" normalizeH="0" baseline="0" noProof="0" dirty="0">
                <a:ln>
                  <a:noFill/>
                </a:ln>
                <a:solidFill>
                  <a:prstClr val="black">
                    <a:lumMod val="75000"/>
                    <a:lumOff val="25000"/>
                  </a:prstClr>
                </a:solidFill>
                <a:effectLst/>
                <a:uLnTx/>
                <a:uFillTx/>
                <a:latin typeface="HY헤드라인M" pitchFamily="18" charset="-127"/>
                <a:ea typeface="HY헤드라인M" pitchFamily="18" charset="-127"/>
                <a:cs typeface="+mn-cs"/>
              </a:rPr>
              <a:t>Slight lift your torso until your scapulae are not touching the floor. Tighten your abdominal muscles, hold the position for 3-5 seconds, and then return to the floor.</a:t>
            </a:r>
          </a:p>
        </p:txBody>
      </p:sp>
      <p:sp>
        <p:nvSpPr>
          <p:cNvPr id="40" name="직사각형 39"/>
          <p:cNvSpPr/>
          <p:nvPr/>
        </p:nvSpPr>
        <p:spPr>
          <a:xfrm>
            <a:off x="876104" y="2080320"/>
            <a:ext cx="2520000" cy="720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79953" rtl="0" eaLnBrk="1" fontAlgn="auto" latinLnBrk="1" hangingPunct="1">
              <a:lnSpc>
                <a:spcPct val="100000"/>
              </a:lnSpc>
              <a:spcBef>
                <a:spcPts val="0"/>
              </a:spcBef>
              <a:spcAft>
                <a:spcPts val="0"/>
              </a:spcAft>
              <a:buClrTx/>
              <a:buSzTx/>
              <a:buFontTx/>
              <a:buNone/>
              <a:tabLst/>
              <a:defRPr/>
            </a:pPr>
            <a:r>
              <a:rPr kumimoji="0" lang="en-US" altLang="ko-KR" sz="2500" b="0" i="0" u="none" strike="noStrike" kern="1200" cap="none" spc="0" normalizeH="0" baseline="0" noProof="0" dirty="0">
                <a:ln>
                  <a:noFill/>
                </a:ln>
                <a:solidFill>
                  <a:prstClr val="black"/>
                </a:solidFill>
                <a:effectLst/>
                <a:uLnTx/>
                <a:uFillTx/>
                <a:latin typeface="HY헤드라인M" pitchFamily="18" charset="-127"/>
                <a:ea typeface="HY헤드라인M" pitchFamily="18" charset="-127"/>
                <a:cs typeface="+mn-cs"/>
              </a:rPr>
              <a:t>Preparation</a:t>
            </a:r>
            <a:endParaRPr kumimoji="0" lang="ko-KR" altLang="en-US" sz="2500" b="0" i="0" u="none" strike="noStrike" kern="1200" cap="none" spc="0" normalizeH="0" baseline="0" noProof="0" dirty="0">
              <a:ln>
                <a:noFill/>
              </a:ln>
              <a:solidFill>
                <a:prstClr val="black"/>
              </a:solidFill>
              <a:effectLst/>
              <a:uLnTx/>
              <a:uFillTx/>
              <a:latin typeface="HY헤드라인M" pitchFamily="18" charset="-127"/>
              <a:ea typeface="HY헤드라인M" pitchFamily="18" charset="-127"/>
              <a:cs typeface="+mn-cs"/>
            </a:endParaRPr>
          </a:p>
        </p:txBody>
      </p:sp>
      <p:sp>
        <p:nvSpPr>
          <p:cNvPr id="2" name="직사각형 1"/>
          <p:cNvSpPr/>
          <p:nvPr/>
        </p:nvSpPr>
        <p:spPr>
          <a:xfrm>
            <a:off x="0" y="0"/>
            <a:ext cx="9601200" cy="1432248"/>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79953" rtl="0" eaLnBrk="1" fontAlgn="auto" latinLnBrk="1" hangingPunct="1">
              <a:lnSpc>
                <a:spcPct val="100000"/>
              </a:lnSpc>
              <a:spcBef>
                <a:spcPts val="0"/>
              </a:spcBef>
              <a:spcAft>
                <a:spcPts val="0"/>
              </a:spcAft>
              <a:buClrTx/>
              <a:buSzTx/>
              <a:buFontTx/>
              <a:buNone/>
              <a:tabLst/>
              <a:defRPr/>
            </a:pPr>
            <a:r>
              <a:rPr kumimoji="0" lang="en-US" altLang="ko-KR" sz="5000" b="0" i="0" u="none" strike="noStrike" kern="1200" cap="none" spc="0" normalizeH="0" baseline="0" noProof="0" dirty="0">
                <a:ln>
                  <a:noFill/>
                </a:ln>
                <a:solidFill>
                  <a:srgbClr val="9BBB59">
                    <a:lumMod val="75000"/>
                  </a:srgbClr>
                </a:solidFill>
                <a:effectLst/>
                <a:uLnTx/>
                <a:uFillTx/>
                <a:latin typeface="HY헤드라인M" pitchFamily="18" charset="-127"/>
                <a:ea typeface="HY헤드라인M" pitchFamily="18" charset="-127"/>
                <a:cs typeface="+mn-cs"/>
              </a:rPr>
              <a:t>Curl-up (</a:t>
            </a:r>
            <a:r>
              <a:rPr kumimoji="0" lang="en-US" altLang="ko-KR" sz="5000" b="0" i="0" u="none" strike="noStrike" kern="1200" cap="none" spc="0" normalizeH="0" baseline="0" noProof="0" dirty="0">
                <a:ln>
                  <a:noFill/>
                </a:ln>
                <a:solidFill>
                  <a:srgbClr val="689E1D"/>
                </a:solidFill>
                <a:effectLst/>
                <a:uLnTx/>
                <a:uFillTx/>
                <a:latin typeface="HY헤드라인M" pitchFamily="18" charset="-127"/>
                <a:ea typeface="HY헤드라인M" pitchFamily="18" charset="-127"/>
                <a:cs typeface="+mn-cs"/>
              </a:rPr>
              <a:t>Beginner)</a:t>
            </a:r>
          </a:p>
        </p:txBody>
      </p:sp>
      <p:sp>
        <p:nvSpPr>
          <p:cNvPr id="12" name="모서리가 둥근 직사각형 11"/>
          <p:cNvSpPr/>
          <p:nvPr/>
        </p:nvSpPr>
        <p:spPr>
          <a:xfrm>
            <a:off x="336104" y="5680720"/>
            <a:ext cx="8100216" cy="2608925"/>
          </a:xfrm>
          <a:prstGeom prst="roundRect">
            <a:avLst/>
          </a:prstGeom>
          <a:noFill/>
          <a:ln w="50800">
            <a:solidFill>
              <a:srgbClr val="689E1D"/>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79953" rtl="0" eaLnBrk="1" fontAlgn="auto" latinLnBrk="1" hangingPunct="1">
              <a:lnSpc>
                <a:spcPct val="100000"/>
              </a:lnSpc>
              <a:spcBef>
                <a:spcPts val="0"/>
              </a:spcBef>
              <a:spcAft>
                <a:spcPts val="0"/>
              </a:spcAft>
              <a:buClrTx/>
              <a:buSzTx/>
              <a:buFontTx/>
              <a:buNone/>
              <a:tabLst/>
              <a:defRPr/>
            </a:pPr>
            <a:endParaRPr kumimoji="0" lang="ko-KR" altLang="en-US" sz="2500" b="0" i="0" u="none" strike="noStrike" kern="1200" cap="none" spc="0" normalizeH="0" baseline="0" noProof="0">
              <a:ln>
                <a:noFill/>
              </a:ln>
              <a:solidFill>
                <a:prstClr val="white"/>
              </a:solidFill>
              <a:effectLst/>
              <a:uLnTx/>
              <a:uFillTx/>
              <a:latin typeface="맑은 고딕"/>
              <a:ea typeface="맑은 고딕" panose="020B0503020000020004" pitchFamily="50" charset="-127"/>
              <a:cs typeface="+mn-cs"/>
            </a:endParaRPr>
          </a:p>
        </p:txBody>
      </p:sp>
      <p:sp>
        <p:nvSpPr>
          <p:cNvPr id="14" name="직사각형 13"/>
          <p:cNvSpPr/>
          <p:nvPr/>
        </p:nvSpPr>
        <p:spPr>
          <a:xfrm>
            <a:off x="876104" y="5104656"/>
            <a:ext cx="2520000" cy="720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79953" rtl="0" eaLnBrk="1" fontAlgn="auto" latinLnBrk="1" hangingPunct="1">
              <a:lnSpc>
                <a:spcPct val="100000"/>
              </a:lnSpc>
              <a:spcBef>
                <a:spcPts val="0"/>
              </a:spcBef>
              <a:spcAft>
                <a:spcPts val="0"/>
              </a:spcAft>
              <a:buClrTx/>
              <a:buSzTx/>
              <a:buFontTx/>
              <a:buNone/>
              <a:tabLst/>
              <a:defRPr/>
            </a:pPr>
            <a:r>
              <a:rPr kumimoji="0" lang="en-US" altLang="ko-KR" sz="2500" b="0" i="0" u="none" strike="noStrike" kern="1200" cap="none" spc="0" normalizeH="0" baseline="0" noProof="0" dirty="0">
                <a:ln>
                  <a:noFill/>
                </a:ln>
                <a:solidFill>
                  <a:prstClr val="black"/>
                </a:solidFill>
                <a:effectLst/>
                <a:uLnTx/>
                <a:uFillTx/>
                <a:latin typeface="HY헤드라인M" pitchFamily="18" charset="-127"/>
                <a:ea typeface="HY헤드라인M" pitchFamily="18" charset="-127"/>
                <a:cs typeface="+mn-cs"/>
              </a:rPr>
              <a:t>Exercise</a:t>
            </a:r>
            <a:endParaRPr kumimoji="0" lang="ko-KR" altLang="en-US" sz="2500" b="0" i="0" u="none" strike="noStrike" kern="1200" cap="none" spc="0" normalizeH="0" baseline="0" noProof="0" dirty="0">
              <a:ln>
                <a:noFill/>
              </a:ln>
              <a:solidFill>
                <a:prstClr val="black"/>
              </a:solidFill>
              <a:effectLst/>
              <a:uLnTx/>
              <a:uFillTx/>
              <a:latin typeface="HY헤드라인M" pitchFamily="18" charset="-127"/>
              <a:ea typeface="HY헤드라인M" pitchFamily="18" charset="-127"/>
              <a:cs typeface="+mn-cs"/>
            </a:endParaRPr>
          </a:p>
        </p:txBody>
      </p:sp>
      <p:sp>
        <p:nvSpPr>
          <p:cNvPr id="15" name="직사각형 14"/>
          <p:cNvSpPr/>
          <p:nvPr/>
        </p:nvSpPr>
        <p:spPr>
          <a:xfrm>
            <a:off x="270000" y="11801400"/>
            <a:ext cx="9000000" cy="853622"/>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l" defTabSz="1279953" rtl="0" eaLnBrk="1" fontAlgn="base" latinLnBrk="1" hangingPunct="1">
              <a:lnSpc>
                <a:spcPct val="100000"/>
              </a:lnSpc>
              <a:spcBef>
                <a:spcPts val="0"/>
              </a:spcBef>
              <a:spcAft>
                <a:spcPts val="0"/>
              </a:spcAft>
              <a:buClrTx/>
              <a:buSzTx/>
              <a:buFontTx/>
              <a:buNone/>
              <a:tabLst/>
              <a:defRPr/>
            </a:pPr>
            <a:r>
              <a:rPr kumimoji="0" lang="en-US" altLang="ko-KR" sz="1800" b="1" i="0" u="none" strike="noStrike" kern="1200" cap="none" spc="0" normalizeH="0" baseline="0" noProof="0" dirty="0">
                <a:ln>
                  <a:noFill/>
                </a:ln>
                <a:solidFill>
                  <a:srgbClr val="363636"/>
                </a:solidFill>
                <a:effectLst/>
                <a:uLnTx/>
                <a:uFillTx/>
                <a:latin typeface="HY헤드라인M" pitchFamily="18" charset="-127"/>
                <a:ea typeface="HY헤드라인M" pitchFamily="18" charset="-127"/>
                <a:cs typeface="+mn-cs"/>
              </a:rPr>
              <a:t>Caution</a:t>
            </a:r>
          </a:p>
          <a:p>
            <a:pPr marL="0" marR="0" lvl="0" indent="0" algn="l" defTabSz="1279953" rtl="0" eaLnBrk="1" fontAlgn="base" latinLnBrk="1" hangingPunct="1">
              <a:lnSpc>
                <a:spcPct val="100000"/>
              </a:lnSpc>
              <a:spcBef>
                <a:spcPts val="0"/>
              </a:spcBef>
              <a:spcAft>
                <a:spcPts val="0"/>
              </a:spcAft>
              <a:buClrTx/>
              <a:buSzTx/>
              <a:buFontTx/>
              <a:buNone/>
              <a:tabLst/>
              <a:defRPr/>
            </a:pPr>
            <a:r>
              <a:rPr kumimoji="0" lang="en-US" altLang="ko-KR" sz="1800" b="1" i="0" u="none" strike="noStrike" kern="1200" cap="none" spc="0" normalizeH="0" baseline="0" noProof="0" dirty="0">
                <a:ln>
                  <a:noFill/>
                </a:ln>
                <a:solidFill>
                  <a:srgbClr val="363636"/>
                </a:solidFill>
                <a:effectLst/>
                <a:uLnTx/>
                <a:uFillTx/>
                <a:latin typeface="HY헤드라인M" pitchFamily="18" charset="-127"/>
                <a:ea typeface="HY헤드라인M" pitchFamily="18" charset="-127"/>
                <a:cs typeface="+mn-cs"/>
              </a:rPr>
              <a:t>Try not to bend your head and </a:t>
            </a:r>
            <a:r>
              <a:rPr kumimoji="0" lang="en-US" altLang="ko-KR" sz="1800" b="1" i="0" u="none" strike="noStrike" kern="1200" cap="none" spc="0" normalizeH="0" baseline="0" noProof="0" dirty="0">
                <a:ln>
                  <a:noFill/>
                </a:ln>
                <a:solidFill>
                  <a:prstClr val="black">
                    <a:lumMod val="75000"/>
                    <a:lumOff val="25000"/>
                  </a:prstClr>
                </a:solidFill>
                <a:effectLst/>
                <a:uLnTx/>
                <a:uFillTx/>
                <a:latin typeface="HY헤드라인M" pitchFamily="18" charset="-127"/>
                <a:ea typeface="HY헤드라인M" pitchFamily="18" charset="-127"/>
                <a:cs typeface="+mn-cs"/>
              </a:rPr>
              <a:t>neck too much.</a:t>
            </a:r>
          </a:p>
        </p:txBody>
      </p:sp>
      <p:pic>
        <p:nvPicPr>
          <p:cNvPr id="3" name="그림 2"/>
          <p:cNvPicPr>
            <a:picLocks noChangeAspect="1"/>
          </p:cNvPicPr>
          <p:nvPr/>
        </p:nvPicPr>
        <p:blipFill>
          <a:blip r:embed="rId2">
            <a:extLst>
              <a:ext uri="{BEBA8EAE-BF5A-486C-A8C5-ECC9F3942E4B}">
                <a14:imgProps xmlns:a14="http://schemas.microsoft.com/office/drawing/2010/main">
                  <a14:imgLayer r:embed="rId3">
                    <a14:imgEffect>
                      <a14:backgroundRemoval t="0" b="100000" l="0" r="100000">
                        <a14:foregroundMark x1="9490" y1="86802" x2="9490" y2="86802"/>
                        <a14:foregroundMark x1="4042" y1="85279" x2="4042" y2="85279"/>
                        <a14:foregroundMark x1="3339" y1="75127" x2="3339" y2="75127"/>
                        <a14:foregroundMark x1="3163" y1="63959" x2="3163" y2="63959"/>
                        <a14:foregroundMark x1="19332" y1="83249" x2="19332" y2="83249"/>
                        <a14:foregroundMark x1="27417" y1="85787" x2="27417" y2="85787"/>
                        <a14:foregroundMark x1="37610" y1="86802" x2="37610" y2="86802"/>
                        <a14:foregroundMark x1="39895" y1="88832" x2="39895" y2="88832"/>
                        <a14:foregroundMark x1="43585" y1="88832" x2="43585" y2="88832"/>
                        <a14:foregroundMark x1="60105" y1="88832" x2="60105" y2="88832"/>
                        <a14:foregroundMark x1="69420" y1="92386" x2="69420" y2="92386"/>
                        <a14:foregroundMark x1="70299" y1="92386" x2="71529" y2="92386"/>
                        <a14:foregroundMark x1="74692" y1="92386" x2="74692" y2="92386"/>
                        <a14:foregroundMark x1="77504" y1="89340" x2="77504" y2="89340"/>
                        <a14:foregroundMark x1="78207" y1="87817" x2="78207" y2="87817"/>
                        <a14:foregroundMark x1="78207" y1="85279" x2="78207" y2="85279"/>
                        <a14:foregroundMark x1="77504" y1="81218" x2="77504" y2="81218"/>
                        <a14:foregroundMark x1="76098" y1="79695" x2="76098" y2="79695"/>
                        <a14:foregroundMark x1="75395" y1="79695" x2="75395" y2="79695"/>
                        <a14:foregroundMark x1="72759" y1="79695" x2="72759" y2="79695"/>
                        <a14:foregroundMark x1="71529" y1="79695" x2="71529" y2="79695"/>
                        <a14:foregroundMark x1="71529" y1="79695" x2="71529" y2="79695"/>
                        <a14:foregroundMark x1="71002" y1="78173" x2="71002" y2="78173"/>
                        <a14:foregroundMark x1="72935" y1="75127" x2="72935" y2="75127"/>
                        <a14:foregroundMark x1="72935" y1="73096" x2="72935" y2="73096"/>
                        <a14:foregroundMark x1="73989" y1="70051" x2="73989" y2="70051"/>
                        <a14:foregroundMark x1="78383" y1="66497" x2="78383" y2="66497"/>
                        <a14:foregroundMark x1="82074" y1="63959" x2="82777" y2="62944"/>
                        <a14:foregroundMark x1="83304" y1="61929" x2="85062" y2="60406"/>
                        <a14:foregroundMark x1="87522" y1="58883" x2="87522" y2="58883"/>
                        <a14:foregroundMark x1="89279" y1="57868" x2="89279" y2="57868"/>
                        <a14:foregroundMark x1="94200" y1="68528" x2="94200" y2="68528"/>
                        <a14:foregroundMark x1="95606" y1="77665" x2="95606" y2="77665"/>
                        <a14:foregroundMark x1="95606" y1="79695" x2="95606" y2="79695"/>
                        <a14:foregroundMark x1="95255" y1="81218" x2="95255" y2="81218"/>
                        <a14:foregroundMark x1="89631" y1="84772" x2="89631" y2="84772"/>
                        <a14:foregroundMark x1="82074" y1="62944" x2="82074" y2="62944"/>
                        <a14:foregroundMark x1="82250" y1="56853" x2="82250" y2="56853"/>
                        <a14:foregroundMark x1="90861" y1="64467" x2="90861" y2="64467"/>
                        <a14:foregroundMark x1="90685" y1="56345" x2="90685" y2="56345"/>
                        <a14:foregroundMark x1="90685" y1="56345" x2="90685" y2="56345"/>
                        <a14:foregroundMark x1="90685" y1="56345" x2="90685" y2="56345"/>
                        <a14:foregroundMark x1="90685" y1="56345" x2="90685" y2="56345"/>
                        <a14:foregroundMark x1="90685" y1="56345" x2="90685" y2="56345"/>
                        <a14:foregroundMark x1="90861" y1="52284" x2="90861" y2="52284"/>
                        <a14:foregroundMark x1="91388" y1="47208" x2="91388" y2="47208"/>
                        <a14:foregroundMark x1="91564" y1="44670" x2="91564" y2="44670"/>
                        <a14:foregroundMark x1="91740" y1="52284" x2="91740" y2="52284"/>
                        <a14:foregroundMark x1="91388" y1="55330" x2="91388" y2="55330"/>
                        <a14:foregroundMark x1="90510" y1="60406" x2="90510" y2="60406"/>
                        <a14:foregroundMark x1="90685" y1="65990" x2="90685" y2="66497"/>
                        <a14:foregroundMark x1="83831" y1="60914" x2="83831" y2="60914"/>
                        <a14:foregroundMark x1="83480" y1="55330" x2="83480" y2="55330"/>
                        <a14:foregroundMark x1="81898" y1="56345" x2="81195" y2="56345"/>
                        <a14:foregroundMark x1="81019" y1="56853" x2="80668" y2="57360"/>
                        <a14:foregroundMark x1="79262" y1="57360" x2="79262" y2="57360"/>
                        <a14:backgroundMark x1="39192" y1="28934" x2="39192" y2="28934"/>
                        <a14:backgroundMark x1="27241" y1="22335" x2="27241" y2="22335"/>
                        <a14:backgroundMark x1="67838" y1="8629" x2="67838" y2="8629"/>
                        <a14:backgroundMark x1="78383" y1="27411" x2="78383" y2="27411"/>
                        <a14:backgroundMark x1="61336" y1="45685" x2="61336" y2="45685"/>
                        <a14:backgroundMark x1="4218" y1="44162" x2="4218" y2="44162"/>
                        <a14:backgroundMark x1="32513" y1="24873" x2="32513" y2="24873"/>
                      </a14:backgroundRemoval>
                    </a14:imgEffect>
                  </a14:imgLayer>
                </a14:imgProps>
              </a:ext>
              <a:ext uri="{28A0092B-C50C-407E-A947-70E740481C1C}">
                <a14:useLocalDpi xmlns:a14="http://schemas.microsoft.com/office/drawing/2010/main" val="0"/>
              </a:ext>
            </a:extLst>
          </a:blip>
          <a:stretch>
            <a:fillRect/>
          </a:stretch>
        </p:blipFill>
        <p:spPr>
          <a:xfrm>
            <a:off x="747746" y="2683484"/>
            <a:ext cx="7374592" cy="2553242"/>
          </a:xfrm>
          <a:prstGeom prst="rect">
            <a:avLst/>
          </a:prstGeom>
        </p:spPr>
      </p:pic>
      <p:pic>
        <p:nvPicPr>
          <p:cNvPr id="4" name="그림 3"/>
          <p:cNvPicPr>
            <a:picLocks noChangeAspect="1"/>
          </p:cNvPicPr>
          <p:nvPr/>
        </p:nvPicPr>
        <p:blipFill>
          <a:blip r:embed="rId4">
            <a:extLst>
              <a:ext uri="{BEBA8EAE-BF5A-486C-A8C5-ECC9F3942E4B}">
                <a14:imgProps xmlns:a14="http://schemas.microsoft.com/office/drawing/2010/main">
                  <a14:imgLayer r:embed="rId5">
                    <a14:imgEffect>
                      <a14:backgroundRemoval t="0" b="100000" l="0" r="100000">
                        <a14:foregroundMark x1="16226" y1="84974" x2="16226" y2="84974"/>
                        <a14:foregroundMark x1="6173" y1="86528" x2="6173" y2="86528"/>
                        <a14:foregroundMark x1="2469" y1="77720" x2="2469" y2="77720"/>
                        <a14:foregroundMark x1="2822" y1="69430" x2="2822" y2="69430"/>
                        <a14:foregroundMark x1="23280" y1="92228" x2="23280" y2="92228"/>
                        <a14:foregroundMark x1="40212" y1="92746" x2="40212" y2="92746"/>
                        <a14:foregroundMark x1="54850" y1="91710" x2="54850" y2="91710"/>
                        <a14:foregroundMark x1="62610" y1="91710" x2="62610" y2="91710"/>
                        <a14:foregroundMark x1="65079" y1="91710" x2="65961" y2="91710"/>
                        <a14:foregroundMark x1="68254" y1="90674" x2="68254" y2="90674"/>
                        <a14:foregroundMark x1="70723" y1="80311" x2="70723" y2="80311"/>
                        <a14:foregroundMark x1="72487" y1="79275" x2="72487" y2="79275"/>
                        <a14:foregroundMark x1="73369" y1="78756" x2="74074" y2="78756"/>
                        <a14:foregroundMark x1="77954" y1="76166" x2="78483" y2="76166"/>
                        <a14:foregroundMark x1="82011" y1="75648" x2="82716" y2="74611"/>
                        <a14:foregroundMark x1="88889" y1="71503" x2="88889" y2="71503"/>
                        <a14:foregroundMark x1="90829" y1="67358" x2="90829" y2="67358"/>
                        <a14:foregroundMark x1="90829" y1="67358" x2="90829" y2="67358"/>
                        <a14:foregroundMark x1="91182" y1="66321" x2="91182" y2="66321"/>
                        <a14:foregroundMark x1="94180" y1="68912" x2="94180" y2="68912"/>
                        <a14:foregroundMark x1="95238" y1="69948" x2="95238" y2="69948"/>
                        <a14:foregroundMark x1="96296" y1="76166" x2="96296" y2="76166"/>
                        <a14:foregroundMark x1="95944" y1="80311" x2="95944" y2="80311"/>
                        <a14:foregroundMark x1="93298" y1="85492" x2="92063" y2="85492"/>
                        <a14:foregroundMark x1="91358" y1="86010" x2="91358" y2="86010"/>
                        <a14:foregroundMark x1="84832" y1="86528" x2="84832" y2="86528"/>
                        <a14:foregroundMark x1="82540" y1="85492" x2="82540" y2="85492"/>
                        <a14:foregroundMark x1="80776" y1="61140" x2="80776" y2="61140"/>
                        <a14:foregroundMark x1="86067" y1="61658" x2="86067" y2="61658"/>
                        <a14:foregroundMark x1="86949" y1="62176" x2="86949" y2="62176"/>
                        <a14:foregroundMark x1="88536" y1="62694" x2="88536" y2="62694"/>
                        <a14:foregroundMark x1="92240" y1="55959" x2="92240" y2="55959"/>
                        <a14:foregroundMark x1="92240" y1="52332" x2="92240" y2="52332"/>
                        <a14:foregroundMark x1="92240" y1="50259" x2="92240" y2="50259"/>
                        <a14:foregroundMark x1="91182" y1="65285" x2="91182" y2="65285"/>
                        <a14:foregroundMark x1="91182" y1="66321" x2="91711" y2="70984"/>
                        <a14:foregroundMark x1="96825" y1="72539" x2="96825" y2="72539"/>
                        <a14:foregroundMark x1="95767" y1="77720" x2="95591" y2="79275"/>
                        <a14:foregroundMark x1="92240" y1="84974" x2="92240" y2="84974"/>
                        <a14:foregroundMark x1="14991" y1="39378" x2="14991" y2="39378"/>
                        <a14:foregroundMark x1="14991" y1="39378" x2="14991" y2="39378"/>
                        <a14:foregroundMark x1="14991" y1="39378" x2="14991" y2="39378"/>
                        <a14:foregroundMark x1="15168" y1="39378" x2="15168" y2="39378"/>
                        <a14:foregroundMark x1="15168" y1="39378" x2="15168" y2="39378"/>
                        <a14:foregroundMark x1="15168" y1="39378" x2="15168" y2="39378"/>
                        <a14:foregroundMark x1="15168" y1="39896" x2="15168" y2="39896"/>
                        <a14:foregroundMark x1="15168" y1="39896" x2="15168" y2="39896"/>
                        <a14:foregroundMark x1="15168" y1="39896" x2="15168" y2="39896"/>
                        <a14:foregroundMark x1="15168" y1="39896" x2="15168" y2="39896"/>
                        <a14:foregroundMark x1="15168" y1="39378" x2="15168" y2="39378"/>
                        <a14:foregroundMark x1="15168" y1="39378" x2="15168" y2="39378"/>
                        <a14:foregroundMark x1="15168" y1="38860" x2="15168" y2="38860"/>
                        <a14:foregroundMark x1="15168" y1="38860" x2="15168" y2="38860"/>
                        <a14:foregroundMark x1="15168" y1="38860" x2="15168" y2="38860"/>
                        <a14:foregroundMark x1="15168" y1="38860" x2="15168" y2="38860"/>
                        <a14:foregroundMark x1="15168" y1="38860" x2="15168" y2="38860"/>
                        <a14:foregroundMark x1="15168" y1="38860" x2="15168" y2="38860"/>
                        <a14:foregroundMark x1="15168" y1="38860" x2="15168" y2="38860"/>
                        <a14:foregroundMark x1="15168" y1="38860" x2="15168" y2="38860"/>
                        <a14:foregroundMark x1="15168" y1="38860" x2="15168" y2="38860"/>
                        <a14:foregroundMark x1="15168" y1="38860" x2="15168" y2="38860"/>
                        <a14:foregroundMark x1="15168" y1="38860" x2="15168" y2="38860"/>
                        <a14:foregroundMark x1="15168" y1="38860" x2="15168" y2="38860"/>
                        <a14:foregroundMark x1="15520" y1="43005" x2="15520" y2="43005"/>
                        <a14:foregroundMark x1="16578" y1="44041" x2="16578" y2="44041"/>
                        <a14:foregroundMark x1="17108" y1="44560" x2="17108" y2="44560"/>
                        <a14:foregroundMark x1="17989" y1="44560" x2="17989" y2="44560"/>
                        <a14:foregroundMark x1="17989" y1="45078" x2="18166" y2="45596"/>
                        <a14:foregroundMark x1="18695" y1="47150" x2="18695" y2="47150"/>
                        <a14:foregroundMark x1="19048" y1="49741" x2="19048" y2="50777"/>
                        <a14:foregroundMark x1="19224" y1="52850" x2="19224" y2="52850"/>
                        <a14:foregroundMark x1="18695" y1="54922" x2="18342" y2="55440"/>
                        <a14:foregroundMark x1="17460" y1="54922" x2="17460" y2="54922"/>
                        <a14:foregroundMark x1="16931" y1="53886" x2="16578" y2="52332"/>
                        <a14:foregroundMark x1="15344" y1="37824" x2="15344" y2="37824"/>
                        <a14:foregroundMark x1="15344" y1="39378" x2="15344" y2="39378"/>
                        <a14:foregroundMark x1="15344" y1="39378" x2="15344" y2="39378"/>
                        <a14:foregroundMark x1="15168" y1="39378" x2="15168" y2="39378"/>
                        <a14:backgroundMark x1="31217" y1="27979" x2="31217" y2="27979"/>
                        <a14:backgroundMark x1="13404" y1="10363" x2="13404" y2="10363"/>
                        <a14:backgroundMark x1="7231" y1="3109" x2="7231" y2="3109"/>
                        <a14:backgroundMark x1="31393" y1="11399" x2="31393" y2="11399"/>
                        <a14:backgroundMark x1="41623" y1="14508" x2="41623" y2="14508"/>
                        <a14:backgroundMark x1="44974" y1="15544" x2="44974" y2="15544"/>
                        <a14:backgroundMark x1="50265" y1="15544" x2="50265" y2="15544"/>
                        <a14:backgroundMark x1="70018" y1="17098" x2="70018" y2="17098"/>
                        <a14:backgroundMark x1="72134" y1="17098" x2="72134" y2="17098"/>
                        <a14:backgroundMark x1="72134" y1="17098" x2="72134" y2="17098"/>
                        <a14:backgroundMark x1="73545" y1="23834" x2="73545" y2="23834"/>
                        <a14:backgroundMark x1="76367" y1="25907" x2="76367" y2="25907"/>
                        <a14:backgroundMark x1="77425" y1="24352" x2="77425" y2="24352"/>
                        <a14:backgroundMark x1="78131" y1="21244" x2="78131" y2="21244"/>
                        <a14:backgroundMark x1="42328" y1="26943" x2="42328" y2="26943"/>
                        <a14:backgroundMark x1="42328" y1="26943" x2="42328" y2="26943"/>
                        <a14:backgroundMark x1="37213" y1="25907" x2="37213" y2="25907"/>
                        <a14:backgroundMark x1="61552" y1="49223" x2="61552" y2="49223"/>
                        <a14:backgroundMark x1="2469" y1="43523" x2="2469" y2="43523"/>
                        <a14:backgroundMark x1="3351" y1="47668" x2="3351" y2="47668"/>
                        <a14:backgroundMark x1="4056" y1="32124" x2="4056" y2="32124"/>
                        <a14:backgroundMark x1="19400" y1="19171" x2="19400" y2="19171"/>
                        <a14:backgroundMark x1="27866" y1="20207" x2="28395" y2="20725"/>
                        <a14:backgroundMark x1="32275" y1="23834" x2="32275" y2="23834"/>
                        <a14:backgroundMark x1="33510" y1="26425" x2="33510" y2="26425"/>
                      </a14:backgroundRemoval>
                    </a14:imgEffect>
                  </a14:imgLayer>
                </a14:imgProps>
              </a:ext>
              <a:ext uri="{28A0092B-C50C-407E-A947-70E740481C1C}">
                <a14:useLocalDpi xmlns:a14="http://schemas.microsoft.com/office/drawing/2010/main" val="0"/>
              </a:ext>
            </a:extLst>
          </a:blip>
          <a:stretch>
            <a:fillRect/>
          </a:stretch>
        </p:blipFill>
        <p:spPr>
          <a:xfrm>
            <a:off x="747746" y="5779422"/>
            <a:ext cx="7374592" cy="2510223"/>
          </a:xfrm>
          <a:prstGeom prst="rect">
            <a:avLst/>
          </a:prstGeom>
        </p:spPr>
      </p:pic>
      <p:sp>
        <p:nvSpPr>
          <p:cNvPr id="13" name="직사각형 12"/>
          <p:cNvSpPr/>
          <p:nvPr/>
        </p:nvSpPr>
        <p:spPr>
          <a:xfrm>
            <a:off x="336104" y="1432248"/>
            <a:ext cx="8573896" cy="720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79953" rtl="0" eaLnBrk="1" fontAlgn="auto" latinLnBrk="1" hangingPunct="1">
              <a:lnSpc>
                <a:spcPct val="100000"/>
              </a:lnSpc>
              <a:spcBef>
                <a:spcPts val="0"/>
              </a:spcBef>
              <a:spcAft>
                <a:spcPts val="0"/>
              </a:spcAft>
              <a:buClrTx/>
              <a:buSzTx/>
              <a:buFontTx/>
              <a:buNone/>
              <a:tabLst/>
              <a:defRPr/>
            </a:pPr>
            <a:r>
              <a:rPr kumimoji="0" lang="en-US" altLang="ko-KR" sz="2400" b="0" i="0" u="none" strike="noStrike" kern="1200" cap="none" spc="0" normalizeH="0" baseline="0" noProof="0" dirty="0">
                <a:ln>
                  <a:noFill/>
                </a:ln>
                <a:solidFill>
                  <a:prstClr val="black"/>
                </a:solidFill>
                <a:effectLst/>
                <a:uLnTx/>
                <a:uFillTx/>
                <a:latin typeface="HY헤드라인M" pitchFamily="18" charset="-127"/>
                <a:ea typeface="HY헤드라인M" pitchFamily="18" charset="-127"/>
                <a:cs typeface="+mn-cs"/>
              </a:rPr>
              <a:t>1st Set (   times) -&gt;  2nd Set (  times) -&gt;  3rd Set (  times)</a:t>
            </a:r>
            <a:endParaRPr kumimoji="0" lang="ko-KR" altLang="en-US" sz="2400" b="0" i="0" u="none" strike="noStrike" kern="1200" cap="none" spc="0" normalizeH="0" baseline="0" noProof="0" dirty="0">
              <a:ln>
                <a:noFill/>
              </a:ln>
              <a:solidFill>
                <a:prstClr val="black"/>
              </a:solidFill>
              <a:effectLst/>
              <a:uLnTx/>
              <a:uFillTx/>
              <a:latin typeface="HY헤드라인M" pitchFamily="18" charset="-127"/>
              <a:ea typeface="HY헤드라인M" pitchFamily="18" charset="-127"/>
              <a:cs typeface="+mn-cs"/>
            </a:endParaRPr>
          </a:p>
        </p:txBody>
      </p:sp>
    </p:spTree>
    <p:extLst>
      <p:ext uri="{BB962C8B-B14F-4D97-AF65-F5344CB8AC3E}">
        <p14:creationId xmlns:p14="http://schemas.microsoft.com/office/powerpoint/2010/main" val="2784179235"/>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2" name="모서리가 둥근 직사각형 21"/>
          <p:cNvSpPr/>
          <p:nvPr/>
        </p:nvSpPr>
        <p:spPr>
          <a:xfrm>
            <a:off x="311905" y="2627801"/>
            <a:ext cx="8100216" cy="2608925"/>
          </a:xfrm>
          <a:prstGeom prst="roundRect">
            <a:avLst/>
          </a:prstGeom>
          <a:noFill/>
          <a:ln w="50800">
            <a:solidFill>
              <a:srgbClr val="689E1D"/>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79953" rtl="0" eaLnBrk="1" fontAlgn="auto" latinLnBrk="1" hangingPunct="1">
              <a:lnSpc>
                <a:spcPct val="100000"/>
              </a:lnSpc>
              <a:spcBef>
                <a:spcPts val="0"/>
              </a:spcBef>
              <a:spcAft>
                <a:spcPts val="0"/>
              </a:spcAft>
              <a:buClrTx/>
              <a:buSzTx/>
              <a:buFontTx/>
              <a:buNone/>
              <a:tabLst/>
              <a:defRPr/>
            </a:pPr>
            <a:endParaRPr kumimoji="0" lang="ko-KR" altLang="en-US" sz="2500" b="0" i="0" u="none" strike="noStrike" kern="1200" cap="none" spc="0" normalizeH="0" baseline="0" noProof="0">
              <a:ln>
                <a:noFill/>
              </a:ln>
              <a:solidFill>
                <a:prstClr val="white"/>
              </a:solidFill>
              <a:effectLst/>
              <a:uLnTx/>
              <a:uFillTx/>
              <a:latin typeface="맑은 고딕"/>
              <a:ea typeface="맑은 고딕" panose="020B0503020000020004" pitchFamily="50" charset="-127"/>
              <a:cs typeface="+mn-cs"/>
            </a:endParaRPr>
          </a:p>
        </p:txBody>
      </p:sp>
      <p:sp>
        <p:nvSpPr>
          <p:cNvPr id="37" name="직사각형 36"/>
          <p:cNvSpPr/>
          <p:nvPr/>
        </p:nvSpPr>
        <p:spPr>
          <a:xfrm>
            <a:off x="108000" y="8488832"/>
            <a:ext cx="8328320" cy="3312568"/>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457200" marR="0" lvl="0" indent="-457200" algn="l" defTabSz="1279953" rtl="0" eaLnBrk="1" fontAlgn="auto" latinLnBrk="1" hangingPunct="1">
              <a:lnSpc>
                <a:spcPct val="100000"/>
              </a:lnSpc>
              <a:spcBef>
                <a:spcPts val="0"/>
              </a:spcBef>
              <a:spcAft>
                <a:spcPts val="0"/>
              </a:spcAft>
              <a:buClrTx/>
              <a:buSzTx/>
              <a:buFontTx/>
              <a:buAutoNum type="arabicPeriod"/>
              <a:tabLst/>
              <a:defRPr/>
            </a:pPr>
            <a:r>
              <a:rPr kumimoji="0" lang="en-US" altLang="ko-KR" sz="2400" b="0" i="0" u="none" strike="noStrike" kern="1200" cap="none" spc="-150" normalizeH="0" baseline="0" noProof="0" dirty="0">
                <a:ln>
                  <a:noFill/>
                </a:ln>
                <a:solidFill>
                  <a:prstClr val="black">
                    <a:lumMod val="75000"/>
                    <a:lumOff val="25000"/>
                  </a:prstClr>
                </a:solidFill>
                <a:effectLst/>
                <a:uLnTx/>
                <a:uFillTx/>
                <a:latin typeface="HY헤드라인M" pitchFamily="18" charset="-127"/>
                <a:ea typeface="HY헤드라인M" pitchFamily="18" charset="-127"/>
                <a:cs typeface="+mn-cs"/>
              </a:rPr>
              <a:t>Lie on your back with your knees bent and your hands relaxed on your sides. </a:t>
            </a:r>
          </a:p>
          <a:p>
            <a:pPr marL="457200" marR="0" lvl="0" indent="-457200" algn="l" defTabSz="1279953" rtl="0" eaLnBrk="1" fontAlgn="auto" latinLnBrk="1" hangingPunct="1">
              <a:lnSpc>
                <a:spcPct val="100000"/>
              </a:lnSpc>
              <a:spcBef>
                <a:spcPts val="0"/>
              </a:spcBef>
              <a:spcAft>
                <a:spcPts val="0"/>
              </a:spcAft>
              <a:buClrTx/>
              <a:buSzTx/>
              <a:buFontTx/>
              <a:buAutoNum type="arabicPeriod"/>
              <a:tabLst/>
              <a:defRPr/>
            </a:pPr>
            <a:endParaRPr kumimoji="0" lang="en-US" altLang="ko-KR" sz="2400" b="0" i="0" u="none" strike="noStrike" kern="1200" cap="none" spc="-150" normalizeH="0" baseline="0" noProof="0" dirty="0">
              <a:ln>
                <a:noFill/>
              </a:ln>
              <a:solidFill>
                <a:prstClr val="black">
                  <a:lumMod val="75000"/>
                  <a:lumOff val="25000"/>
                </a:prstClr>
              </a:solidFill>
              <a:effectLst/>
              <a:uLnTx/>
              <a:uFillTx/>
              <a:latin typeface="HY헤드라인M" pitchFamily="18" charset="-127"/>
              <a:ea typeface="HY헤드라인M" pitchFamily="18" charset="-127"/>
              <a:cs typeface="+mn-cs"/>
            </a:endParaRPr>
          </a:p>
          <a:p>
            <a:pPr marL="457200" marR="0" lvl="0" indent="-457200" algn="l" defTabSz="1279953" rtl="0" eaLnBrk="1" fontAlgn="auto" latinLnBrk="1" hangingPunct="1">
              <a:lnSpc>
                <a:spcPct val="100000"/>
              </a:lnSpc>
              <a:spcBef>
                <a:spcPts val="0"/>
              </a:spcBef>
              <a:spcAft>
                <a:spcPts val="0"/>
              </a:spcAft>
              <a:buClrTx/>
              <a:buSzTx/>
              <a:buFontTx/>
              <a:buAutoNum type="arabicPeriod"/>
              <a:tabLst/>
              <a:defRPr/>
            </a:pPr>
            <a:r>
              <a:rPr kumimoji="0" lang="en-US" altLang="ko-KR" sz="2400" b="0" i="0" u="none" strike="noStrike" kern="1200" cap="none" spc="-150" normalizeH="0" baseline="0" noProof="0" dirty="0">
                <a:ln>
                  <a:noFill/>
                </a:ln>
                <a:solidFill>
                  <a:prstClr val="black">
                    <a:lumMod val="75000"/>
                    <a:lumOff val="25000"/>
                  </a:prstClr>
                </a:solidFill>
                <a:effectLst/>
                <a:uLnTx/>
                <a:uFillTx/>
                <a:latin typeface="HY헤드라인M" pitchFamily="18" charset="-127"/>
                <a:ea typeface="HY헤드라인M" pitchFamily="18" charset="-127"/>
                <a:cs typeface="+mn-cs"/>
              </a:rPr>
              <a:t>Begin by tightening your buttocks, without lifting your pelvis. </a:t>
            </a:r>
          </a:p>
          <a:p>
            <a:pPr marL="457200" marR="0" lvl="0" indent="-457200" algn="l" defTabSz="1279953" rtl="0" eaLnBrk="1" fontAlgn="auto" latinLnBrk="1" hangingPunct="1">
              <a:lnSpc>
                <a:spcPct val="100000"/>
              </a:lnSpc>
              <a:spcBef>
                <a:spcPts val="0"/>
              </a:spcBef>
              <a:spcAft>
                <a:spcPts val="0"/>
              </a:spcAft>
              <a:buClrTx/>
              <a:buSzTx/>
              <a:buFontTx/>
              <a:buAutoNum type="arabicPeriod"/>
              <a:tabLst/>
              <a:defRPr/>
            </a:pPr>
            <a:endParaRPr kumimoji="0" lang="en-US" altLang="ko-KR" sz="2400" b="0" i="0" u="none" strike="noStrike" kern="1200" cap="none" spc="-150" normalizeH="0" baseline="0" noProof="0" dirty="0">
              <a:ln>
                <a:noFill/>
              </a:ln>
              <a:solidFill>
                <a:prstClr val="black">
                  <a:lumMod val="75000"/>
                  <a:lumOff val="25000"/>
                </a:prstClr>
              </a:solidFill>
              <a:effectLst/>
              <a:uLnTx/>
              <a:uFillTx/>
              <a:latin typeface="HY헤드라인M" pitchFamily="18" charset="-127"/>
              <a:ea typeface="HY헤드라인M" pitchFamily="18" charset="-127"/>
              <a:cs typeface="+mn-cs"/>
            </a:endParaRPr>
          </a:p>
          <a:p>
            <a:pPr marL="457200" marR="0" lvl="0" indent="-457200" algn="l" defTabSz="1279953" rtl="0" eaLnBrk="1" fontAlgn="auto" latinLnBrk="1" hangingPunct="1">
              <a:lnSpc>
                <a:spcPct val="100000"/>
              </a:lnSpc>
              <a:spcBef>
                <a:spcPts val="0"/>
              </a:spcBef>
              <a:spcAft>
                <a:spcPts val="0"/>
              </a:spcAft>
              <a:buClrTx/>
              <a:buSzTx/>
              <a:buFontTx/>
              <a:buAutoNum type="arabicPeriod"/>
              <a:tabLst/>
              <a:defRPr/>
            </a:pPr>
            <a:r>
              <a:rPr kumimoji="0" lang="en-US" altLang="ko-KR" sz="2400" b="0" i="0" u="none" strike="noStrike" kern="1200" cap="none" spc="-150" normalizeH="0" baseline="0" noProof="0" dirty="0">
                <a:ln>
                  <a:noFill/>
                </a:ln>
                <a:solidFill>
                  <a:prstClr val="black">
                    <a:lumMod val="75000"/>
                    <a:lumOff val="25000"/>
                  </a:prstClr>
                </a:solidFill>
                <a:effectLst/>
                <a:uLnTx/>
                <a:uFillTx/>
                <a:latin typeface="HY헤드라인M" pitchFamily="18" charset="-127"/>
                <a:ea typeface="HY헤드라인M" pitchFamily="18" charset="-127"/>
                <a:cs typeface="+mn-cs"/>
              </a:rPr>
              <a:t>Tighten your buttocks and slowly lift your pelvis from the floor.</a:t>
            </a:r>
          </a:p>
        </p:txBody>
      </p:sp>
      <p:sp>
        <p:nvSpPr>
          <p:cNvPr id="40" name="직사각형 39"/>
          <p:cNvSpPr/>
          <p:nvPr/>
        </p:nvSpPr>
        <p:spPr>
          <a:xfrm>
            <a:off x="876104" y="2080320"/>
            <a:ext cx="2520000" cy="720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79953" rtl="0" eaLnBrk="1" fontAlgn="auto" latinLnBrk="1" hangingPunct="1">
              <a:lnSpc>
                <a:spcPct val="100000"/>
              </a:lnSpc>
              <a:spcBef>
                <a:spcPts val="0"/>
              </a:spcBef>
              <a:spcAft>
                <a:spcPts val="0"/>
              </a:spcAft>
              <a:buClrTx/>
              <a:buSzTx/>
              <a:buFontTx/>
              <a:buNone/>
              <a:tabLst/>
              <a:defRPr/>
            </a:pPr>
            <a:r>
              <a:rPr kumimoji="0" lang="en-US" altLang="ko-KR" sz="2500" b="0" i="0" u="none" strike="noStrike" kern="1200" cap="none" spc="0" normalizeH="0" baseline="0" noProof="0" dirty="0">
                <a:ln>
                  <a:noFill/>
                </a:ln>
                <a:solidFill>
                  <a:prstClr val="black"/>
                </a:solidFill>
                <a:effectLst/>
                <a:uLnTx/>
                <a:uFillTx/>
                <a:latin typeface="HY헤드라인M" pitchFamily="18" charset="-127"/>
                <a:ea typeface="HY헤드라인M" pitchFamily="18" charset="-127"/>
                <a:cs typeface="+mn-cs"/>
              </a:rPr>
              <a:t>Preparation</a:t>
            </a:r>
            <a:endParaRPr kumimoji="0" lang="ko-KR" altLang="en-US" sz="2500" b="0" i="0" u="none" strike="noStrike" kern="1200" cap="none" spc="0" normalizeH="0" baseline="0" noProof="0" dirty="0">
              <a:ln>
                <a:noFill/>
              </a:ln>
              <a:solidFill>
                <a:prstClr val="black"/>
              </a:solidFill>
              <a:effectLst/>
              <a:uLnTx/>
              <a:uFillTx/>
              <a:latin typeface="HY헤드라인M" pitchFamily="18" charset="-127"/>
              <a:ea typeface="HY헤드라인M" pitchFamily="18" charset="-127"/>
              <a:cs typeface="+mn-cs"/>
            </a:endParaRPr>
          </a:p>
        </p:txBody>
      </p:sp>
      <p:sp>
        <p:nvSpPr>
          <p:cNvPr id="2" name="직사각형 1"/>
          <p:cNvSpPr/>
          <p:nvPr/>
        </p:nvSpPr>
        <p:spPr>
          <a:xfrm>
            <a:off x="0" y="0"/>
            <a:ext cx="9601200" cy="1432248"/>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79953" rtl="0" eaLnBrk="1" fontAlgn="auto" latinLnBrk="1" hangingPunct="1">
              <a:lnSpc>
                <a:spcPct val="100000"/>
              </a:lnSpc>
              <a:spcBef>
                <a:spcPts val="0"/>
              </a:spcBef>
              <a:spcAft>
                <a:spcPts val="0"/>
              </a:spcAft>
              <a:buClrTx/>
              <a:buSzTx/>
              <a:buFontTx/>
              <a:buNone/>
              <a:tabLst/>
              <a:defRPr/>
            </a:pPr>
            <a:r>
              <a:rPr kumimoji="0" lang="en-US" altLang="ko-KR" sz="5000" b="0" i="0" u="none" strike="noStrike" kern="1200" cap="none" spc="0" normalizeH="0" baseline="0" noProof="0" dirty="0">
                <a:ln>
                  <a:noFill/>
                </a:ln>
                <a:solidFill>
                  <a:srgbClr val="689E1D"/>
                </a:solidFill>
                <a:effectLst/>
                <a:uLnTx/>
                <a:uFillTx/>
                <a:latin typeface="HY헤드라인M" pitchFamily="18" charset="-127"/>
                <a:ea typeface="HY헤드라인M" pitchFamily="18" charset="-127"/>
                <a:cs typeface="+mn-cs"/>
              </a:rPr>
              <a:t>Bridge </a:t>
            </a:r>
            <a:r>
              <a:rPr kumimoji="0" lang="en-US" altLang="ko-KR" sz="5000" b="0" i="0" u="none" strike="noStrike" kern="1200" cap="none" spc="0" normalizeH="0" baseline="0" noProof="0" dirty="0">
                <a:ln>
                  <a:noFill/>
                </a:ln>
                <a:solidFill>
                  <a:srgbClr val="9BBB59">
                    <a:lumMod val="75000"/>
                  </a:srgbClr>
                </a:solidFill>
                <a:effectLst/>
                <a:uLnTx/>
                <a:uFillTx/>
                <a:latin typeface="HY헤드라인M" pitchFamily="18" charset="-127"/>
                <a:ea typeface="HY헤드라인M" pitchFamily="18" charset="-127"/>
                <a:cs typeface="+mn-cs"/>
              </a:rPr>
              <a:t>E</a:t>
            </a:r>
            <a:r>
              <a:rPr kumimoji="0" lang="en-US" altLang="ko-KR" sz="5000" b="0" i="0" u="none" strike="noStrike" kern="1200" cap="none" spc="0" normalizeH="0" baseline="0" noProof="0" dirty="0">
                <a:ln>
                  <a:noFill/>
                </a:ln>
                <a:solidFill>
                  <a:srgbClr val="689E1D"/>
                </a:solidFill>
                <a:effectLst/>
                <a:uLnTx/>
                <a:uFillTx/>
                <a:latin typeface="HY헤드라인M" pitchFamily="18" charset="-127"/>
                <a:ea typeface="HY헤드라인M" pitchFamily="18" charset="-127"/>
                <a:cs typeface="+mn-cs"/>
              </a:rPr>
              <a:t>xercise </a:t>
            </a:r>
          </a:p>
          <a:p>
            <a:pPr marL="0" marR="0" lvl="0" indent="0" algn="ctr" defTabSz="1279953" rtl="0" eaLnBrk="1" fontAlgn="auto" latinLnBrk="1" hangingPunct="1">
              <a:lnSpc>
                <a:spcPct val="100000"/>
              </a:lnSpc>
              <a:spcBef>
                <a:spcPts val="0"/>
              </a:spcBef>
              <a:spcAft>
                <a:spcPts val="0"/>
              </a:spcAft>
              <a:buClrTx/>
              <a:buSzTx/>
              <a:buFontTx/>
              <a:buNone/>
              <a:tabLst/>
              <a:defRPr/>
            </a:pPr>
            <a:r>
              <a:rPr kumimoji="0" lang="en-US" altLang="ko-KR" sz="5000" b="0" i="0" u="none" strike="noStrike" kern="1200" cap="none" spc="0" normalizeH="0" baseline="0" noProof="0" dirty="0">
                <a:ln>
                  <a:noFill/>
                </a:ln>
                <a:solidFill>
                  <a:srgbClr val="689E1D"/>
                </a:solidFill>
                <a:effectLst/>
                <a:uLnTx/>
                <a:uFillTx/>
                <a:latin typeface="HY헤드라인M" pitchFamily="18" charset="-127"/>
                <a:ea typeface="HY헤드라인M" pitchFamily="18" charset="-127"/>
                <a:cs typeface="+mn-cs"/>
              </a:rPr>
              <a:t>– </a:t>
            </a:r>
            <a:r>
              <a:rPr kumimoji="0" lang="en-US" altLang="ko-KR" sz="4000" b="0" i="0" u="none" strike="noStrike" kern="1200" cap="none" spc="0" normalizeH="0" baseline="0" noProof="0" dirty="0">
                <a:ln>
                  <a:noFill/>
                </a:ln>
                <a:solidFill>
                  <a:srgbClr val="689E1D"/>
                </a:solidFill>
                <a:effectLst/>
                <a:uLnTx/>
                <a:uFillTx/>
                <a:latin typeface="HY헤드라인M" pitchFamily="18" charset="-127"/>
                <a:ea typeface="HY헤드라인M" pitchFamily="18" charset="-127"/>
                <a:cs typeface="+mn-cs"/>
              </a:rPr>
              <a:t>Gluteus Maximus </a:t>
            </a:r>
            <a:r>
              <a:rPr kumimoji="0" lang="en-US" altLang="ko-KR" sz="4000" b="0" i="0" u="none" strike="noStrike" kern="1200" cap="none" spc="0" normalizeH="0" baseline="0" noProof="0" dirty="0">
                <a:ln>
                  <a:noFill/>
                </a:ln>
                <a:solidFill>
                  <a:srgbClr val="FF0000"/>
                </a:solidFill>
                <a:effectLst/>
                <a:uLnTx/>
                <a:uFillTx/>
                <a:latin typeface="HY헤드라인M" pitchFamily="18" charset="-127"/>
                <a:ea typeface="HY헤드라인M" pitchFamily="18" charset="-127"/>
                <a:cs typeface="+mn-cs"/>
              </a:rPr>
              <a:t>-</a:t>
            </a:r>
            <a:endParaRPr kumimoji="0" lang="ko-KR" altLang="en-US" sz="4000" b="0" i="0" u="none" strike="noStrike" kern="1200" cap="none" spc="0" normalizeH="0" baseline="0" noProof="0" dirty="0">
              <a:ln>
                <a:noFill/>
              </a:ln>
              <a:solidFill>
                <a:srgbClr val="689E1D"/>
              </a:solidFill>
              <a:effectLst/>
              <a:uLnTx/>
              <a:uFillTx/>
              <a:latin typeface="HY헤드라인M" pitchFamily="18" charset="-127"/>
              <a:ea typeface="HY헤드라인M" pitchFamily="18" charset="-127"/>
              <a:cs typeface="+mn-cs"/>
            </a:endParaRPr>
          </a:p>
        </p:txBody>
      </p:sp>
      <p:sp>
        <p:nvSpPr>
          <p:cNvPr id="12" name="모서리가 둥근 직사각형 11"/>
          <p:cNvSpPr/>
          <p:nvPr/>
        </p:nvSpPr>
        <p:spPr>
          <a:xfrm>
            <a:off x="336104" y="5680720"/>
            <a:ext cx="8100216" cy="2608925"/>
          </a:xfrm>
          <a:prstGeom prst="roundRect">
            <a:avLst/>
          </a:prstGeom>
          <a:noFill/>
          <a:ln w="50800">
            <a:solidFill>
              <a:srgbClr val="689E1D"/>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79953" rtl="0" eaLnBrk="1" fontAlgn="auto" latinLnBrk="1" hangingPunct="1">
              <a:lnSpc>
                <a:spcPct val="100000"/>
              </a:lnSpc>
              <a:spcBef>
                <a:spcPts val="0"/>
              </a:spcBef>
              <a:spcAft>
                <a:spcPts val="0"/>
              </a:spcAft>
              <a:buClrTx/>
              <a:buSzTx/>
              <a:buFontTx/>
              <a:buNone/>
              <a:tabLst/>
              <a:defRPr/>
            </a:pPr>
            <a:endParaRPr kumimoji="0" lang="ko-KR" altLang="en-US" sz="2500" b="0" i="0" u="none" strike="noStrike" kern="1200" cap="none" spc="0" normalizeH="0" baseline="0" noProof="0">
              <a:ln>
                <a:noFill/>
              </a:ln>
              <a:solidFill>
                <a:prstClr val="white"/>
              </a:solidFill>
              <a:effectLst/>
              <a:uLnTx/>
              <a:uFillTx/>
              <a:latin typeface="맑은 고딕"/>
              <a:ea typeface="맑은 고딕" panose="020B0503020000020004" pitchFamily="50" charset="-127"/>
              <a:cs typeface="+mn-cs"/>
            </a:endParaRPr>
          </a:p>
        </p:txBody>
      </p:sp>
      <p:sp>
        <p:nvSpPr>
          <p:cNvPr id="14" name="직사각형 13"/>
          <p:cNvSpPr/>
          <p:nvPr/>
        </p:nvSpPr>
        <p:spPr>
          <a:xfrm>
            <a:off x="876104" y="5104656"/>
            <a:ext cx="2520000" cy="720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79953" rtl="0" eaLnBrk="1" fontAlgn="auto" latinLnBrk="1" hangingPunct="1">
              <a:lnSpc>
                <a:spcPct val="100000"/>
              </a:lnSpc>
              <a:spcBef>
                <a:spcPts val="0"/>
              </a:spcBef>
              <a:spcAft>
                <a:spcPts val="0"/>
              </a:spcAft>
              <a:buClrTx/>
              <a:buSzTx/>
              <a:buFontTx/>
              <a:buNone/>
              <a:tabLst/>
              <a:defRPr/>
            </a:pPr>
            <a:r>
              <a:rPr kumimoji="0" lang="en-US" altLang="ko-KR" sz="2500" b="0" i="0" u="none" strike="noStrike" kern="1200" cap="none" spc="0" normalizeH="0" baseline="0" noProof="0" dirty="0">
                <a:ln>
                  <a:noFill/>
                </a:ln>
                <a:solidFill>
                  <a:prstClr val="black"/>
                </a:solidFill>
                <a:effectLst/>
                <a:uLnTx/>
                <a:uFillTx/>
                <a:latin typeface="HY헤드라인M" pitchFamily="18" charset="-127"/>
                <a:ea typeface="HY헤드라인M" pitchFamily="18" charset="-127"/>
                <a:cs typeface="+mn-cs"/>
              </a:rPr>
              <a:t>Exercise</a:t>
            </a:r>
            <a:endParaRPr kumimoji="0" lang="ko-KR" altLang="en-US" sz="2500" b="0" i="0" u="none" strike="noStrike" kern="1200" cap="none" spc="0" normalizeH="0" baseline="0" noProof="0" dirty="0">
              <a:ln>
                <a:noFill/>
              </a:ln>
              <a:solidFill>
                <a:prstClr val="black"/>
              </a:solidFill>
              <a:effectLst/>
              <a:uLnTx/>
              <a:uFillTx/>
              <a:latin typeface="HY헤드라인M" pitchFamily="18" charset="-127"/>
              <a:ea typeface="HY헤드라인M" pitchFamily="18" charset="-127"/>
              <a:cs typeface="+mn-cs"/>
            </a:endParaRPr>
          </a:p>
        </p:txBody>
      </p:sp>
      <p:sp>
        <p:nvSpPr>
          <p:cNvPr id="15" name="직사각형 14"/>
          <p:cNvSpPr/>
          <p:nvPr/>
        </p:nvSpPr>
        <p:spPr>
          <a:xfrm>
            <a:off x="270000" y="11801400"/>
            <a:ext cx="9000000" cy="853622"/>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l" defTabSz="1279953" rtl="0" eaLnBrk="1" fontAlgn="base" latinLnBrk="1" hangingPunct="1">
              <a:lnSpc>
                <a:spcPct val="100000"/>
              </a:lnSpc>
              <a:spcBef>
                <a:spcPts val="0"/>
              </a:spcBef>
              <a:spcAft>
                <a:spcPts val="0"/>
              </a:spcAft>
              <a:buClrTx/>
              <a:buSzTx/>
              <a:buFontTx/>
              <a:buNone/>
              <a:tabLst/>
              <a:defRPr/>
            </a:pPr>
            <a:r>
              <a:rPr kumimoji="0" lang="en-US" altLang="ko-KR" sz="1800" b="1" i="0" u="none" strike="noStrike" kern="1200" cap="none" spc="0" normalizeH="0" baseline="0" noProof="0" dirty="0">
                <a:ln>
                  <a:noFill/>
                </a:ln>
                <a:solidFill>
                  <a:srgbClr val="363636"/>
                </a:solidFill>
                <a:effectLst/>
                <a:uLnTx/>
                <a:uFillTx/>
                <a:latin typeface="HY헤드라인M" pitchFamily="18" charset="-127"/>
                <a:ea typeface="HY헤드라인M" pitchFamily="18" charset="-127"/>
                <a:cs typeface="+mn-cs"/>
              </a:rPr>
              <a:t>Caution</a:t>
            </a:r>
          </a:p>
          <a:p>
            <a:pPr marL="0" marR="0" lvl="0" indent="0" algn="l" defTabSz="1279953" rtl="0" eaLnBrk="1" fontAlgn="base" latinLnBrk="1" hangingPunct="1">
              <a:lnSpc>
                <a:spcPct val="100000"/>
              </a:lnSpc>
              <a:spcBef>
                <a:spcPts val="0"/>
              </a:spcBef>
              <a:spcAft>
                <a:spcPts val="0"/>
              </a:spcAft>
              <a:buClrTx/>
              <a:buSzTx/>
              <a:buFontTx/>
              <a:buNone/>
              <a:tabLst/>
              <a:defRPr/>
            </a:pPr>
            <a:r>
              <a:rPr kumimoji="0" lang="en-US" altLang="ko-KR" sz="1800" b="1" i="0" u="none" strike="noStrike" kern="1200" cap="none" spc="0" normalizeH="0" baseline="0" noProof="0" dirty="0">
                <a:ln>
                  <a:noFill/>
                </a:ln>
                <a:solidFill>
                  <a:srgbClr val="363636"/>
                </a:solidFill>
                <a:effectLst/>
                <a:uLnTx/>
                <a:uFillTx/>
                <a:latin typeface="HY헤드라인M" pitchFamily="18" charset="-127"/>
                <a:ea typeface="HY헤드라인M" pitchFamily="18" charset="-127"/>
                <a:cs typeface="+mn-cs"/>
              </a:rPr>
              <a:t>When </a:t>
            </a:r>
            <a:r>
              <a:rPr kumimoji="0" lang="en-US" altLang="ko-KR" sz="1800" b="1" i="0" u="none" strike="noStrike" kern="1200" cap="none" spc="0" normalizeH="0" baseline="0" noProof="0" dirty="0">
                <a:ln>
                  <a:noFill/>
                </a:ln>
                <a:solidFill>
                  <a:prstClr val="black">
                    <a:lumMod val="75000"/>
                    <a:lumOff val="25000"/>
                  </a:prstClr>
                </a:solidFill>
                <a:effectLst/>
                <a:uLnTx/>
                <a:uFillTx/>
                <a:latin typeface="HY헤드라인M" pitchFamily="18" charset="-127"/>
                <a:ea typeface="HY헤드라인M" pitchFamily="18" charset="-127"/>
                <a:cs typeface="+mn-cs"/>
              </a:rPr>
              <a:t>lifting your pelvis, try not to strain any muscle below your thighs</a:t>
            </a:r>
            <a:r>
              <a:rPr kumimoji="0" lang="en-US" altLang="ko-KR" sz="1800" b="1" i="0" u="none" strike="noStrike" kern="1200" cap="none" spc="0" normalizeH="0" baseline="0" noProof="0" dirty="0">
                <a:ln>
                  <a:noFill/>
                </a:ln>
                <a:solidFill>
                  <a:srgbClr val="363636"/>
                </a:solidFill>
                <a:effectLst/>
                <a:uLnTx/>
                <a:uFillTx/>
                <a:latin typeface="HY헤드라인M" pitchFamily="18" charset="-127"/>
                <a:ea typeface="HY헤드라인M" pitchFamily="18" charset="-127"/>
                <a:cs typeface="+mn-cs"/>
              </a:rPr>
              <a:t>.</a:t>
            </a:r>
          </a:p>
        </p:txBody>
      </p:sp>
      <p:pic>
        <p:nvPicPr>
          <p:cNvPr id="5" name="그림 4"/>
          <p:cNvPicPr>
            <a:picLocks noChangeAspect="1"/>
          </p:cNvPicPr>
          <p:nvPr/>
        </p:nvPicPr>
        <p:blipFill>
          <a:blip r:embed="rId2">
            <a:extLst>
              <a:ext uri="{BEBA8EAE-BF5A-486C-A8C5-ECC9F3942E4B}">
                <a14:imgProps xmlns:a14="http://schemas.microsoft.com/office/drawing/2010/main">
                  <a14:imgLayer r:embed="rId3">
                    <a14:imgEffect>
                      <a14:backgroundRemoval t="0" b="100000" l="0" r="100000">
                        <a14:foregroundMark x1="3515" y1="84127" x2="3515" y2="84127"/>
                        <a14:foregroundMark x1="15466" y1="91534" x2="15466" y2="91534"/>
                        <a14:foregroundMark x1="63269" y1="76720" x2="63269" y2="76720"/>
                        <a14:foregroundMark x1="96661" y1="76720" x2="96661" y2="76720"/>
                        <a14:foregroundMark x1="92091" y1="66138" x2="92091" y2="66138"/>
                        <a14:foregroundMark x1="69772" y1="88360" x2="69772" y2="88360"/>
                        <a14:foregroundMark x1="66081" y1="67725" x2="66081" y2="67725"/>
                        <a14:foregroundMark x1="67663" y1="86243" x2="67663" y2="86243"/>
                        <a14:foregroundMark x1="68893" y1="76190" x2="68893" y2="76190"/>
                        <a14:foregroundMark x1="86116" y1="88360" x2="86116" y2="88360"/>
                        <a14:foregroundMark x1="89455" y1="70370" x2="89455" y2="70370"/>
                        <a14:foregroundMark x1="95606" y1="64550" x2="95606" y2="64550"/>
                        <a14:foregroundMark x1="4218" y1="68254" x2="4218" y2="68254"/>
                        <a14:backgroundMark x1="44991" y1="22222" x2="44991" y2="22222"/>
                        <a14:backgroundMark x1="66081" y1="55556" x2="66081" y2="55556"/>
                        <a14:backgroundMark x1="30053" y1="29630" x2="30053" y2="29630"/>
                        <a14:backgroundMark x1="6151" y1="47090" x2="6151" y2="47090"/>
                        <a14:backgroundMark x1="20211" y1="49206" x2="20211" y2="49206"/>
                        <a14:backgroundMark x1="20035" y1="50794" x2="20035" y2="50794"/>
                        <a14:backgroundMark x1="20211" y1="51852" x2="20211" y2="51852"/>
                        <a14:backgroundMark x1="31986" y1="33862" x2="31986" y2="33862"/>
                        <a14:backgroundMark x1="35501" y1="20106" x2="35501" y2="20106"/>
                        <a14:backgroundMark x1="56415" y1="20106" x2="56415" y2="20106"/>
                      </a14:backgroundRemoval>
                    </a14:imgEffect>
                  </a14:imgLayer>
                </a14:imgProps>
              </a:ext>
              <a:ext uri="{28A0092B-C50C-407E-A947-70E740481C1C}">
                <a14:useLocalDpi xmlns:a14="http://schemas.microsoft.com/office/drawing/2010/main" val="0"/>
              </a:ext>
            </a:extLst>
          </a:blip>
          <a:stretch>
            <a:fillRect/>
          </a:stretch>
        </p:blipFill>
        <p:spPr>
          <a:xfrm>
            <a:off x="561921" y="2712236"/>
            <a:ext cx="7600183" cy="2524490"/>
          </a:xfrm>
          <a:prstGeom prst="rect">
            <a:avLst/>
          </a:prstGeom>
        </p:spPr>
      </p:pic>
      <p:pic>
        <p:nvPicPr>
          <p:cNvPr id="7" name="그림 6"/>
          <p:cNvPicPr>
            <a:picLocks noChangeAspect="1"/>
          </p:cNvPicPr>
          <p:nvPr/>
        </p:nvPicPr>
        <p:blipFill>
          <a:blip r:embed="rId4">
            <a:extLst>
              <a:ext uri="{BEBA8EAE-BF5A-486C-A8C5-ECC9F3942E4B}">
                <a14:imgProps xmlns:a14="http://schemas.microsoft.com/office/drawing/2010/main">
                  <a14:imgLayer r:embed="rId5">
                    <a14:imgEffect>
                      <a14:backgroundRemoval t="0" b="100000" l="0" r="100000">
                        <a14:foregroundMark x1="4912" y1="72632" x2="4912" y2="72632"/>
                        <a14:foregroundMark x1="15088" y1="90000" x2="15088" y2="90000"/>
                        <a14:foregroundMark x1="2105" y1="66316" x2="2105" y2="66316"/>
                        <a14:foregroundMark x1="66316" y1="83684" x2="66316" y2="83684"/>
                        <a14:foregroundMark x1="70351" y1="72632" x2="70351" y2="72632"/>
                        <a14:foregroundMark x1="62982" y1="74211" x2="62982" y2="74211"/>
                        <a14:foregroundMark x1="66842" y1="69474" x2="66842" y2="69474"/>
                        <a14:foregroundMark x1="91053" y1="74737" x2="91053" y2="74737"/>
                        <a14:foregroundMark x1="87719" y1="81579" x2="87719" y2="81579"/>
                        <a14:foregroundMark x1="90175" y1="73158" x2="90175" y2="73158"/>
                        <a14:foregroundMark x1="93509" y1="68947" x2="93509" y2="68947"/>
                        <a14:backgroundMark x1="40526" y1="33684" x2="40526" y2="33684"/>
                        <a14:backgroundMark x1="70351" y1="53158" x2="70351" y2="53158"/>
                        <a14:backgroundMark x1="82281" y1="15789" x2="82281" y2="15789"/>
                      </a14:backgroundRemoval>
                    </a14:imgEffect>
                  </a14:imgLayer>
                </a14:imgProps>
              </a:ext>
              <a:ext uri="{28A0092B-C50C-407E-A947-70E740481C1C}">
                <a14:useLocalDpi xmlns:a14="http://schemas.microsoft.com/office/drawing/2010/main" val="0"/>
              </a:ext>
            </a:extLst>
          </a:blip>
          <a:stretch>
            <a:fillRect/>
          </a:stretch>
        </p:blipFill>
        <p:spPr>
          <a:xfrm>
            <a:off x="593022" y="5760852"/>
            <a:ext cx="7586380" cy="2528793"/>
          </a:xfrm>
          <a:prstGeom prst="rect">
            <a:avLst/>
          </a:prstGeom>
        </p:spPr>
      </p:pic>
      <p:sp>
        <p:nvSpPr>
          <p:cNvPr id="13" name="직사각형 12"/>
          <p:cNvSpPr/>
          <p:nvPr/>
        </p:nvSpPr>
        <p:spPr>
          <a:xfrm>
            <a:off x="336104" y="1504336"/>
            <a:ext cx="8573896" cy="720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79953" rtl="0" eaLnBrk="1" fontAlgn="auto" latinLnBrk="1" hangingPunct="1">
              <a:lnSpc>
                <a:spcPct val="100000"/>
              </a:lnSpc>
              <a:spcBef>
                <a:spcPts val="0"/>
              </a:spcBef>
              <a:spcAft>
                <a:spcPts val="0"/>
              </a:spcAft>
              <a:buClrTx/>
              <a:buSzTx/>
              <a:buFontTx/>
              <a:buNone/>
              <a:tabLst/>
              <a:defRPr/>
            </a:pPr>
            <a:r>
              <a:rPr kumimoji="0" lang="en-US" altLang="ko-KR" sz="2400" b="0" i="0" u="none" strike="noStrike" kern="1200" cap="none" spc="0" normalizeH="0" baseline="0" noProof="0" dirty="0">
                <a:ln>
                  <a:noFill/>
                </a:ln>
                <a:solidFill>
                  <a:prstClr val="black"/>
                </a:solidFill>
                <a:effectLst/>
                <a:uLnTx/>
                <a:uFillTx/>
                <a:latin typeface="HY헤드라인M" pitchFamily="18" charset="-127"/>
                <a:ea typeface="HY헤드라인M" pitchFamily="18" charset="-127"/>
                <a:cs typeface="+mn-cs"/>
              </a:rPr>
              <a:t>1st Set (   times) -&gt;  2nd Set (  times) -&gt;  3rd Set (  times)</a:t>
            </a:r>
            <a:endParaRPr kumimoji="0" lang="ko-KR" altLang="en-US" sz="2400" b="0" i="0" u="none" strike="noStrike" kern="1200" cap="none" spc="0" normalizeH="0" baseline="0" noProof="0" dirty="0">
              <a:ln>
                <a:noFill/>
              </a:ln>
              <a:solidFill>
                <a:prstClr val="black"/>
              </a:solidFill>
              <a:effectLst/>
              <a:uLnTx/>
              <a:uFillTx/>
              <a:latin typeface="HY헤드라인M" pitchFamily="18" charset="-127"/>
              <a:ea typeface="HY헤드라인M" pitchFamily="18" charset="-127"/>
              <a:cs typeface="+mn-cs"/>
            </a:endParaRPr>
          </a:p>
        </p:txBody>
      </p:sp>
    </p:spTree>
    <p:extLst>
      <p:ext uri="{BB962C8B-B14F-4D97-AF65-F5344CB8AC3E}">
        <p14:creationId xmlns:p14="http://schemas.microsoft.com/office/powerpoint/2010/main" val="189857761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2" name="모서리가 둥근 직사각형 21"/>
          <p:cNvSpPr/>
          <p:nvPr/>
        </p:nvSpPr>
        <p:spPr>
          <a:xfrm>
            <a:off x="311905" y="2627801"/>
            <a:ext cx="8100216" cy="2608925"/>
          </a:xfrm>
          <a:prstGeom prst="roundRect">
            <a:avLst/>
          </a:prstGeom>
          <a:noFill/>
          <a:ln w="50800">
            <a:solidFill>
              <a:srgbClr val="689E1D"/>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79953" rtl="0" eaLnBrk="1" fontAlgn="auto" latinLnBrk="1" hangingPunct="1">
              <a:lnSpc>
                <a:spcPct val="100000"/>
              </a:lnSpc>
              <a:spcBef>
                <a:spcPts val="0"/>
              </a:spcBef>
              <a:spcAft>
                <a:spcPts val="0"/>
              </a:spcAft>
              <a:buClrTx/>
              <a:buSzTx/>
              <a:buFontTx/>
              <a:buNone/>
              <a:tabLst/>
              <a:defRPr/>
            </a:pPr>
            <a:endParaRPr kumimoji="0" lang="ko-KR" altLang="en-US" sz="2500" b="0" i="0" u="none" strike="noStrike" kern="1200" cap="none" spc="0" normalizeH="0" baseline="0" noProof="0">
              <a:ln>
                <a:noFill/>
              </a:ln>
              <a:solidFill>
                <a:prstClr val="white"/>
              </a:solidFill>
              <a:effectLst/>
              <a:uLnTx/>
              <a:uFillTx/>
              <a:latin typeface="맑은 고딕"/>
              <a:ea typeface="맑은 고딕" panose="020B0503020000020004" pitchFamily="50" charset="-127"/>
              <a:cs typeface="+mn-cs"/>
            </a:endParaRPr>
          </a:p>
        </p:txBody>
      </p:sp>
      <p:sp>
        <p:nvSpPr>
          <p:cNvPr id="37" name="직사각형 36"/>
          <p:cNvSpPr/>
          <p:nvPr/>
        </p:nvSpPr>
        <p:spPr>
          <a:xfrm>
            <a:off x="108000" y="8488832"/>
            <a:ext cx="8802000" cy="4176664"/>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457200" marR="0" lvl="0" indent="-457200" algn="l" defTabSz="1279953" rtl="0" eaLnBrk="1" fontAlgn="auto" latinLnBrk="1" hangingPunct="1">
              <a:lnSpc>
                <a:spcPct val="100000"/>
              </a:lnSpc>
              <a:spcBef>
                <a:spcPts val="0"/>
              </a:spcBef>
              <a:spcAft>
                <a:spcPts val="0"/>
              </a:spcAft>
              <a:buClrTx/>
              <a:buSzTx/>
              <a:buFontTx/>
              <a:buAutoNum type="arabicPeriod"/>
              <a:tabLst/>
              <a:defRPr/>
            </a:pPr>
            <a:r>
              <a:rPr kumimoji="0" lang="en-US" altLang="ko-KR" sz="2400" b="0" i="0" u="none" strike="noStrike" kern="1200" cap="none" spc="-150" normalizeH="0" baseline="0" noProof="0" dirty="0">
                <a:ln>
                  <a:noFill/>
                </a:ln>
                <a:solidFill>
                  <a:prstClr val="black">
                    <a:lumMod val="75000"/>
                    <a:lumOff val="25000"/>
                  </a:prstClr>
                </a:solidFill>
                <a:effectLst/>
                <a:uLnTx/>
                <a:uFillTx/>
                <a:latin typeface="HY헤드라인M" pitchFamily="18" charset="-127"/>
                <a:ea typeface="HY헤드라인M" pitchFamily="18" charset="-127"/>
                <a:cs typeface="+mn-cs"/>
              </a:rPr>
              <a:t>Spread your hands and knees at the same distance as your shoulders, and position yourself as shown in the photo. Pushing your hands against the floor, slightly lift your back. Then lower it and keep your torso stable.</a:t>
            </a:r>
          </a:p>
          <a:p>
            <a:pPr marL="457200" marR="0" lvl="0" indent="-457200" algn="l" defTabSz="1279953" rtl="0" eaLnBrk="1" fontAlgn="auto" latinLnBrk="1" hangingPunct="1">
              <a:lnSpc>
                <a:spcPct val="100000"/>
              </a:lnSpc>
              <a:spcBef>
                <a:spcPts val="0"/>
              </a:spcBef>
              <a:spcAft>
                <a:spcPts val="0"/>
              </a:spcAft>
              <a:buClrTx/>
              <a:buSzTx/>
              <a:buFontTx/>
              <a:buAutoNum type="arabicPeriod"/>
              <a:tabLst/>
              <a:defRPr/>
            </a:pPr>
            <a:endParaRPr kumimoji="0" lang="en-US" altLang="ko-KR" sz="2400" b="0" i="0" u="none" strike="noStrike" kern="1200" cap="none" spc="-150" normalizeH="0" baseline="0" noProof="0" dirty="0">
              <a:ln>
                <a:noFill/>
              </a:ln>
              <a:solidFill>
                <a:prstClr val="black">
                  <a:lumMod val="75000"/>
                  <a:lumOff val="25000"/>
                </a:prstClr>
              </a:solidFill>
              <a:effectLst/>
              <a:uLnTx/>
              <a:uFillTx/>
              <a:latin typeface="HY헤드라인M" pitchFamily="18" charset="-127"/>
              <a:ea typeface="HY헤드라인M" pitchFamily="18" charset="-127"/>
              <a:cs typeface="+mn-cs"/>
            </a:endParaRPr>
          </a:p>
          <a:p>
            <a:pPr marL="457200" marR="0" lvl="0" indent="-457200" algn="l" defTabSz="1279953" rtl="0" eaLnBrk="1" fontAlgn="auto" latinLnBrk="1" hangingPunct="1">
              <a:lnSpc>
                <a:spcPct val="100000"/>
              </a:lnSpc>
              <a:spcBef>
                <a:spcPts val="0"/>
              </a:spcBef>
              <a:spcAft>
                <a:spcPts val="0"/>
              </a:spcAft>
              <a:buClrTx/>
              <a:buSzTx/>
              <a:buFontTx/>
              <a:buAutoNum type="arabicPeriod"/>
              <a:tabLst/>
              <a:defRPr/>
            </a:pPr>
            <a:r>
              <a:rPr kumimoji="0" lang="en-US" altLang="ko-KR" sz="2400" b="0" i="0" u="none" strike="noStrike" kern="1200" cap="none" spc="-150" normalizeH="0" baseline="0" noProof="0" dirty="0">
                <a:ln>
                  <a:noFill/>
                </a:ln>
                <a:solidFill>
                  <a:prstClr val="black">
                    <a:lumMod val="75000"/>
                    <a:lumOff val="25000"/>
                  </a:prstClr>
                </a:solidFill>
                <a:effectLst/>
                <a:uLnTx/>
                <a:uFillTx/>
                <a:latin typeface="HY헤드라인M" pitchFamily="18" charset="-127"/>
                <a:ea typeface="HY헤드라인M" pitchFamily="18" charset="-127"/>
                <a:cs typeface="+mn-cs"/>
              </a:rPr>
              <a:t>Lift one hand or knee 2-3 cm from the floor and check for any back pain.</a:t>
            </a:r>
          </a:p>
          <a:p>
            <a:pPr marL="457200" marR="0" lvl="0" indent="-457200" algn="l" defTabSz="1279953" rtl="0" eaLnBrk="1" fontAlgn="auto" latinLnBrk="1" hangingPunct="1">
              <a:lnSpc>
                <a:spcPct val="100000"/>
              </a:lnSpc>
              <a:spcBef>
                <a:spcPts val="0"/>
              </a:spcBef>
              <a:spcAft>
                <a:spcPts val="0"/>
              </a:spcAft>
              <a:buClrTx/>
              <a:buSzTx/>
              <a:buFontTx/>
              <a:buAutoNum type="arabicPeriod"/>
              <a:tabLst/>
              <a:defRPr/>
            </a:pPr>
            <a:endParaRPr kumimoji="0" lang="en-US" altLang="ko-KR" sz="2400" b="0" i="0" u="none" strike="noStrike" kern="1200" cap="none" spc="-150" normalizeH="0" baseline="0" noProof="0" dirty="0">
              <a:ln>
                <a:noFill/>
              </a:ln>
              <a:solidFill>
                <a:prstClr val="black">
                  <a:lumMod val="75000"/>
                  <a:lumOff val="25000"/>
                </a:prstClr>
              </a:solidFill>
              <a:effectLst/>
              <a:uLnTx/>
              <a:uFillTx/>
              <a:latin typeface="HY헤드라인M" pitchFamily="18" charset="-127"/>
              <a:ea typeface="HY헤드라인M" pitchFamily="18" charset="-127"/>
              <a:cs typeface="+mn-cs"/>
            </a:endParaRPr>
          </a:p>
          <a:p>
            <a:pPr marL="457200" marR="0" lvl="0" indent="-457200" algn="l" defTabSz="1279953" rtl="0" eaLnBrk="1" fontAlgn="auto" latinLnBrk="1" hangingPunct="1">
              <a:lnSpc>
                <a:spcPct val="100000"/>
              </a:lnSpc>
              <a:spcBef>
                <a:spcPts val="0"/>
              </a:spcBef>
              <a:spcAft>
                <a:spcPts val="0"/>
              </a:spcAft>
              <a:buClrTx/>
              <a:buSzTx/>
              <a:buFontTx/>
              <a:buAutoNum type="arabicPeriod"/>
              <a:tabLst/>
              <a:defRPr/>
            </a:pPr>
            <a:r>
              <a:rPr kumimoji="0" lang="en-US" altLang="ko-KR" sz="2400" b="0" i="0" u="none" strike="noStrike" kern="1200" cap="none" spc="-150" normalizeH="0" baseline="0" noProof="0" dirty="0">
                <a:ln>
                  <a:noFill/>
                </a:ln>
                <a:solidFill>
                  <a:prstClr val="black">
                    <a:lumMod val="75000"/>
                    <a:lumOff val="25000"/>
                  </a:prstClr>
                </a:solidFill>
                <a:effectLst/>
                <a:uLnTx/>
                <a:uFillTx/>
                <a:latin typeface="HY헤드라인M" pitchFamily="18" charset="-127"/>
                <a:ea typeface="HY헤드라인M" pitchFamily="18" charset="-127"/>
                <a:cs typeface="+mn-cs"/>
              </a:rPr>
              <a:t>If there is no pain, lift one leg parallel to the floor and hold it for 3-5 seconds. Your pelvis should stay in place during </a:t>
            </a:r>
            <a:r>
              <a:rPr kumimoji="0" lang="en-US" altLang="ko-KR" sz="2400" b="0" i="0" u="none" strike="noStrike" kern="1200" cap="none" spc="-150" normalizeH="0" baseline="0" noProof="0" dirty="0">
                <a:ln>
                  <a:noFill/>
                </a:ln>
                <a:solidFill>
                  <a:srgbClr val="363636"/>
                </a:solidFill>
                <a:effectLst/>
                <a:uLnTx/>
                <a:uFillTx/>
                <a:latin typeface="HY헤드라인M" pitchFamily="18" charset="-127"/>
                <a:ea typeface="HY헤드라인M" pitchFamily="18" charset="-127"/>
                <a:cs typeface="+mn-cs"/>
              </a:rPr>
              <a:t>the exercise. </a:t>
            </a:r>
          </a:p>
        </p:txBody>
      </p:sp>
      <p:sp>
        <p:nvSpPr>
          <p:cNvPr id="40" name="직사각형 39"/>
          <p:cNvSpPr/>
          <p:nvPr/>
        </p:nvSpPr>
        <p:spPr>
          <a:xfrm>
            <a:off x="876104" y="2080320"/>
            <a:ext cx="2520000" cy="720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79953" rtl="0" eaLnBrk="1" fontAlgn="auto" latinLnBrk="1" hangingPunct="1">
              <a:lnSpc>
                <a:spcPct val="100000"/>
              </a:lnSpc>
              <a:spcBef>
                <a:spcPts val="0"/>
              </a:spcBef>
              <a:spcAft>
                <a:spcPts val="0"/>
              </a:spcAft>
              <a:buClrTx/>
              <a:buSzTx/>
              <a:buFontTx/>
              <a:buNone/>
              <a:tabLst/>
              <a:defRPr/>
            </a:pPr>
            <a:r>
              <a:rPr kumimoji="0" lang="en-US" altLang="ko-KR" sz="2500" b="0" i="0" u="none" strike="noStrike" kern="1200" cap="none" spc="0" normalizeH="0" baseline="0" noProof="0" dirty="0">
                <a:ln>
                  <a:noFill/>
                </a:ln>
                <a:solidFill>
                  <a:prstClr val="black"/>
                </a:solidFill>
                <a:effectLst/>
                <a:uLnTx/>
                <a:uFillTx/>
                <a:latin typeface="HY헤드라인M" pitchFamily="18" charset="-127"/>
                <a:ea typeface="HY헤드라인M" pitchFamily="18" charset="-127"/>
                <a:cs typeface="+mn-cs"/>
              </a:rPr>
              <a:t>Preparation</a:t>
            </a:r>
            <a:endParaRPr kumimoji="0" lang="ko-KR" altLang="en-US" sz="2500" b="0" i="0" u="none" strike="noStrike" kern="1200" cap="none" spc="0" normalizeH="0" baseline="0" noProof="0" dirty="0">
              <a:ln>
                <a:noFill/>
              </a:ln>
              <a:solidFill>
                <a:prstClr val="black"/>
              </a:solidFill>
              <a:effectLst/>
              <a:uLnTx/>
              <a:uFillTx/>
              <a:latin typeface="HY헤드라인M" pitchFamily="18" charset="-127"/>
              <a:ea typeface="HY헤드라인M" pitchFamily="18" charset="-127"/>
              <a:cs typeface="+mn-cs"/>
            </a:endParaRPr>
          </a:p>
        </p:txBody>
      </p:sp>
      <p:sp>
        <p:nvSpPr>
          <p:cNvPr id="2" name="직사각형 1"/>
          <p:cNvSpPr/>
          <p:nvPr/>
        </p:nvSpPr>
        <p:spPr>
          <a:xfrm>
            <a:off x="0" y="0"/>
            <a:ext cx="9601200" cy="1432248"/>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79953" rtl="0" eaLnBrk="1" fontAlgn="auto" latinLnBrk="1" hangingPunct="1">
              <a:lnSpc>
                <a:spcPct val="100000"/>
              </a:lnSpc>
              <a:spcBef>
                <a:spcPts val="0"/>
              </a:spcBef>
              <a:spcAft>
                <a:spcPts val="0"/>
              </a:spcAft>
              <a:buClrTx/>
              <a:buSzTx/>
              <a:buFontTx/>
              <a:buNone/>
              <a:tabLst/>
              <a:defRPr/>
            </a:pPr>
            <a:r>
              <a:rPr kumimoji="0" lang="en-US" altLang="ko-KR" sz="5000" b="0" i="0" u="none" strike="noStrike" kern="1200" cap="none" spc="0" normalizeH="0" baseline="0" noProof="0" dirty="0">
                <a:ln>
                  <a:noFill/>
                </a:ln>
                <a:solidFill>
                  <a:srgbClr val="689E1D"/>
                </a:solidFill>
                <a:effectLst/>
                <a:uLnTx/>
                <a:uFillTx/>
                <a:latin typeface="HY헤드라인M" pitchFamily="18" charset="-127"/>
                <a:ea typeface="HY헤드라인M" pitchFamily="18" charset="-127"/>
                <a:cs typeface="+mn-cs"/>
              </a:rPr>
              <a:t>Bird – Dog (Beginner)</a:t>
            </a:r>
          </a:p>
        </p:txBody>
      </p:sp>
      <p:sp>
        <p:nvSpPr>
          <p:cNvPr id="12" name="모서리가 둥근 직사각형 11"/>
          <p:cNvSpPr/>
          <p:nvPr/>
        </p:nvSpPr>
        <p:spPr>
          <a:xfrm>
            <a:off x="336104" y="5680720"/>
            <a:ext cx="8100216" cy="2608925"/>
          </a:xfrm>
          <a:prstGeom prst="roundRect">
            <a:avLst/>
          </a:prstGeom>
          <a:noFill/>
          <a:ln w="50800">
            <a:solidFill>
              <a:srgbClr val="689E1D"/>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79953" rtl="0" eaLnBrk="1" fontAlgn="auto" latinLnBrk="1" hangingPunct="1">
              <a:lnSpc>
                <a:spcPct val="100000"/>
              </a:lnSpc>
              <a:spcBef>
                <a:spcPts val="0"/>
              </a:spcBef>
              <a:spcAft>
                <a:spcPts val="0"/>
              </a:spcAft>
              <a:buClrTx/>
              <a:buSzTx/>
              <a:buFontTx/>
              <a:buNone/>
              <a:tabLst/>
              <a:defRPr/>
            </a:pPr>
            <a:endParaRPr kumimoji="0" lang="ko-KR" altLang="en-US" sz="2500" b="0" i="0" u="none" strike="noStrike" kern="1200" cap="none" spc="0" normalizeH="0" baseline="0" noProof="0">
              <a:ln>
                <a:noFill/>
              </a:ln>
              <a:solidFill>
                <a:prstClr val="white"/>
              </a:solidFill>
              <a:effectLst/>
              <a:uLnTx/>
              <a:uFillTx/>
              <a:latin typeface="맑은 고딕"/>
              <a:ea typeface="맑은 고딕" panose="020B0503020000020004" pitchFamily="50" charset="-127"/>
              <a:cs typeface="+mn-cs"/>
            </a:endParaRPr>
          </a:p>
        </p:txBody>
      </p:sp>
      <p:sp>
        <p:nvSpPr>
          <p:cNvPr id="14" name="직사각형 13"/>
          <p:cNvSpPr/>
          <p:nvPr/>
        </p:nvSpPr>
        <p:spPr>
          <a:xfrm>
            <a:off x="876104" y="5104656"/>
            <a:ext cx="2520000" cy="720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79953" rtl="0" eaLnBrk="1" fontAlgn="auto" latinLnBrk="1" hangingPunct="1">
              <a:lnSpc>
                <a:spcPct val="100000"/>
              </a:lnSpc>
              <a:spcBef>
                <a:spcPts val="0"/>
              </a:spcBef>
              <a:spcAft>
                <a:spcPts val="0"/>
              </a:spcAft>
              <a:buClrTx/>
              <a:buSzTx/>
              <a:buFontTx/>
              <a:buNone/>
              <a:tabLst/>
              <a:defRPr/>
            </a:pPr>
            <a:r>
              <a:rPr kumimoji="0" lang="en-US" altLang="ko-KR" sz="2500" b="0" i="0" u="none" strike="noStrike" kern="1200" cap="none" spc="0" normalizeH="0" baseline="0" noProof="0" dirty="0">
                <a:ln>
                  <a:noFill/>
                </a:ln>
                <a:solidFill>
                  <a:prstClr val="black"/>
                </a:solidFill>
                <a:effectLst/>
                <a:uLnTx/>
                <a:uFillTx/>
                <a:latin typeface="HY헤드라인M" pitchFamily="18" charset="-127"/>
                <a:ea typeface="HY헤드라인M" pitchFamily="18" charset="-127"/>
                <a:cs typeface="+mn-cs"/>
              </a:rPr>
              <a:t>Exercise</a:t>
            </a:r>
            <a:endParaRPr kumimoji="0" lang="ko-KR" altLang="en-US" sz="2500" b="0" i="0" u="none" strike="noStrike" kern="1200" cap="none" spc="0" normalizeH="0" baseline="0" noProof="0" dirty="0">
              <a:ln>
                <a:noFill/>
              </a:ln>
              <a:solidFill>
                <a:prstClr val="black"/>
              </a:solidFill>
              <a:effectLst/>
              <a:uLnTx/>
              <a:uFillTx/>
              <a:latin typeface="HY헤드라인M" pitchFamily="18" charset="-127"/>
              <a:ea typeface="HY헤드라인M" pitchFamily="18" charset="-127"/>
              <a:cs typeface="+mn-cs"/>
            </a:endParaRPr>
          </a:p>
        </p:txBody>
      </p:sp>
      <p:pic>
        <p:nvPicPr>
          <p:cNvPr id="3" name="그림 2"/>
          <p:cNvPicPr>
            <a:picLocks noChangeAspect="1"/>
          </p:cNvPicPr>
          <p:nvPr/>
        </p:nvPicPr>
        <p:blipFill>
          <a:blip r:embed="rId2">
            <a:extLst>
              <a:ext uri="{BEBA8EAE-BF5A-486C-A8C5-ECC9F3942E4B}">
                <a14:imgProps xmlns:a14="http://schemas.microsoft.com/office/drawing/2010/main">
                  <a14:imgLayer r:embed="rId3">
                    <a14:imgEffect>
                      <a14:backgroundRemoval t="0" b="100000" l="0" r="100000">
                        <a14:foregroundMark x1="19343" y1="23383" x2="19343" y2="23383"/>
                        <a14:foregroundMark x1="22445" y1="17413" x2="22445" y2="17413"/>
                        <a14:foregroundMark x1="17883" y1="17910" x2="17883" y2="17910"/>
                        <a14:foregroundMark x1="29927" y1="45771" x2="29927" y2="45771"/>
                        <a14:foregroundMark x1="27737" y1="65672" x2="27737" y2="65672"/>
                        <a14:foregroundMark x1="28102" y1="47264" x2="28102" y2="47264"/>
                        <a14:foregroundMark x1="27555" y1="67164" x2="27555" y2="67164"/>
                        <a14:foregroundMark x1="28650" y1="61692" x2="28650" y2="61692"/>
                        <a14:foregroundMark x1="29015" y1="52239" x2="29015" y2="52239"/>
                        <a14:foregroundMark x1="28285" y1="44279" x2="28285" y2="44279"/>
                        <a14:foregroundMark x1="27190" y1="38806" x2="27190" y2="38806"/>
                        <a14:foregroundMark x1="27555" y1="31841" x2="27555" y2="31841"/>
                        <a14:foregroundMark x1="27737" y1="31343" x2="27737" y2="31343"/>
                        <a14:foregroundMark x1="28285" y1="27861" x2="28285" y2="27861"/>
                        <a14:foregroundMark x1="28285" y1="25871" x2="28285" y2="25871"/>
                        <a14:foregroundMark x1="28650" y1="43781" x2="28832" y2="45771"/>
                        <a14:foregroundMark x1="29015" y1="52239" x2="29197" y2="53731"/>
                        <a14:foregroundMark x1="29380" y1="59204" x2="29380" y2="59204"/>
                        <a14:foregroundMark x1="29380" y1="63682" x2="29380" y2="65672"/>
                        <a14:foregroundMark x1="29380" y1="69652" x2="29380" y2="70647"/>
                        <a14:foregroundMark x1="29197" y1="72139" x2="29197" y2="72139"/>
                        <a14:foregroundMark x1="28832" y1="75124" x2="28832" y2="75124"/>
                        <a14:foregroundMark x1="28102" y1="78109" x2="27920" y2="79602"/>
                        <a14:foregroundMark x1="27920" y1="80597" x2="27555" y2="81592"/>
                        <a14:foregroundMark x1="27555" y1="82090" x2="27372" y2="83085"/>
                        <a14:foregroundMark x1="27372" y1="84577" x2="27372" y2="84577"/>
                        <a14:foregroundMark x1="27007" y1="86567" x2="26642" y2="88060"/>
                        <a14:foregroundMark x1="26277" y1="90050" x2="26277" y2="90050"/>
                        <a14:foregroundMark x1="23540" y1="94030" x2="23540" y2="94030"/>
                        <a14:foregroundMark x1="22445" y1="94030" x2="22445" y2="94030"/>
                        <a14:foregroundMark x1="20803" y1="95025" x2="20803" y2="95025"/>
                        <a14:foregroundMark x1="30657" y1="85572" x2="30657" y2="85572"/>
                        <a14:foregroundMark x1="24270" y1="85075" x2="24270" y2="85075"/>
                        <a14:foregroundMark x1="33212" y1="70647" x2="33212" y2="70647"/>
                        <a14:foregroundMark x1="33029" y1="56716" x2="33029" y2="55721"/>
                        <a14:foregroundMark x1="32664" y1="44279" x2="32664" y2="43284"/>
                        <a14:foregroundMark x1="32664" y1="39801" x2="32847" y2="38308"/>
                        <a14:foregroundMark x1="32847" y1="36318" x2="32847" y2="36318"/>
                        <a14:foregroundMark x1="82299" y1="81095" x2="82299" y2="81095"/>
                        <a14:foregroundMark x1="83029" y1="80100" x2="83029" y2="80100"/>
                        <a14:foregroundMark x1="83029" y1="80100" x2="83029" y2="80100"/>
                        <a14:foregroundMark x1="83759" y1="80100" x2="83759" y2="80100"/>
                        <a14:foregroundMark x1="83942" y1="80597" x2="83942" y2="80597"/>
                        <a14:foregroundMark x1="85766" y1="86070" x2="85766" y2="86070"/>
                        <a14:foregroundMark x1="85766" y1="79104" x2="85766" y2="79104"/>
                        <a14:foregroundMark x1="84854" y1="76617" x2="84854" y2="76617"/>
                        <a14:foregroundMark x1="86861" y1="83582" x2="86861" y2="83582"/>
                        <a14:foregroundMark x1="88686" y1="87065" x2="88686" y2="87065"/>
                        <a14:foregroundMark x1="88869" y1="88060" x2="88869" y2="88060"/>
                        <a14:foregroundMark x1="89234" y1="89055" x2="89234" y2="89055"/>
                        <a14:foregroundMark x1="89234" y1="89055" x2="89234" y2="89055"/>
                        <a14:foregroundMark x1="87226" y1="86567" x2="87226" y2="86567"/>
                        <a14:foregroundMark x1="86679" y1="85572" x2="86679" y2="85572"/>
                        <a14:foregroundMark x1="85766" y1="83582" x2="85766" y2="83582"/>
                        <a14:foregroundMark x1="79562" y1="71642" x2="79562" y2="71642"/>
                        <a14:foregroundMark x1="78832" y1="73134" x2="78832" y2="73134"/>
                        <a14:foregroundMark x1="77372" y1="74129" x2="77372" y2="74129"/>
                        <a14:foregroundMark x1="77190" y1="74129" x2="77190" y2="74129"/>
                        <a14:foregroundMark x1="81204" y1="74627" x2="81204" y2="74627"/>
                        <a14:foregroundMark x1="78832" y1="69652" x2="78832" y2="69652"/>
                        <a14:foregroundMark x1="96533" y1="83582" x2="96533" y2="83582"/>
                        <a14:foregroundMark x1="96533" y1="83582" x2="96533" y2="83582"/>
                        <a14:foregroundMark x1="96168" y1="81095" x2="96168" y2="81095"/>
                        <a14:foregroundMark x1="94891" y1="81095" x2="94526" y2="80597"/>
                        <a14:foregroundMark x1="92701" y1="79104" x2="92701" y2="79104"/>
                        <a14:foregroundMark x1="90146" y1="77612" x2="90146" y2="77612"/>
                        <a14:foregroundMark x1="88686" y1="77612" x2="88686" y2="77612"/>
                        <a14:foregroundMark x1="87956" y1="78109" x2="87956" y2="78109"/>
                        <a14:foregroundMark x1="86861" y1="82587" x2="79745" y2="84080"/>
                        <a14:foregroundMark x1="77007" y1="84080" x2="77007" y2="84080"/>
                        <a14:foregroundMark x1="74270" y1="85572" x2="73905" y2="85572"/>
                        <a14:foregroundMark x1="70985" y1="86567" x2="69343" y2="87065"/>
                        <a14:foregroundMark x1="65146" y1="88557" x2="64416" y2="89055"/>
                        <a14:foregroundMark x1="59307" y1="89552" x2="58394" y2="90050"/>
                        <a14:foregroundMark x1="52920" y1="90050" x2="51460" y2="90050"/>
                        <a14:foregroundMark x1="45620" y1="90050" x2="45620" y2="90050"/>
                        <a14:foregroundMark x1="44161" y1="89055" x2="44161" y2="89055"/>
                        <a14:foregroundMark x1="43431" y1="85075" x2="43431" y2="85075"/>
                        <a14:foregroundMark x1="41971" y1="84080" x2="41971" y2="84080"/>
                        <a14:foregroundMark x1="41606" y1="81592" x2="41606" y2="81592"/>
                        <a14:foregroundMark x1="44708" y1="76617" x2="44708" y2="76617"/>
                        <a14:foregroundMark x1="45803" y1="76617" x2="46350" y2="76617"/>
                        <a14:foregroundMark x1="50365" y1="78607" x2="50182" y2="80597"/>
                        <a14:foregroundMark x1="42518" y1="82090" x2="42153" y2="82090"/>
                        <a14:foregroundMark x1="39599" y1="82090" x2="39599" y2="82090"/>
                        <a14:foregroundMark x1="37409" y1="80597" x2="37409" y2="80597"/>
                        <a14:foregroundMark x1="33212" y1="81592" x2="32117" y2="82090"/>
                        <a14:foregroundMark x1="26642" y1="82587" x2="26095" y2="83085"/>
                        <a14:foregroundMark x1="18613" y1="83085" x2="18066" y2="83085"/>
                        <a14:foregroundMark x1="12956" y1="83582" x2="12409" y2="83582"/>
                        <a14:foregroundMark x1="10584" y1="83582" x2="9307" y2="83582"/>
                        <a14:foregroundMark x1="6204" y1="83582" x2="6204" y2="83582"/>
                        <a14:foregroundMark x1="5839" y1="83582" x2="5839" y2="83582"/>
                        <a14:foregroundMark x1="4745" y1="81592" x2="4745" y2="81592"/>
                        <a14:foregroundMark x1="4197" y1="79602" x2="4197" y2="79602"/>
                        <a14:foregroundMark x1="3832" y1="75622" x2="3832" y2="75622"/>
                        <a14:foregroundMark x1="3832" y1="75622" x2="3832" y2="75622"/>
                        <a14:foregroundMark x1="4745" y1="76119" x2="5657" y2="76617"/>
                        <a14:foregroundMark x1="11131" y1="78109" x2="11496" y2="78109"/>
                        <a14:foregroundMark x1="13139" y1="78109" x2="13139" y2="78109"/>
                        <a14:foregroundMark x1="14416" y1="80100" x2="14599" y2="81095"/>
                        <a14:foregroundMark x1="14599" y1="82587" x2="14599" y2="82587"/>
                        <a14:foregroundMark x1="17153" y1="85572" x2="23358" y2="86567"/>
                        <a14:foregroundMark x1="24818" y1="86567" x2="26642" y2="86567"/>
                        <a14:foregroundMark x1="31022" y1="84080" x2="31934" y2="84080"/>
                        <a14:foregroundMark x1="33577" y1="84577" x2="34854" y2="85075"/>
                        <a14:foregroundMark x1="38686" y1="85572" x2="38686" y2="85572"/>
                        <a14:backgroundMark x1="77737" y1="34328" x2="77737" y2="34328"/>
                        <a14:backgroundMark x1="77737" y1="34328" x2="77737" y2="34328"/>
                        <a14:backgroundMark x1="80109" y1="22886" x2="80109" y2="22886"/>
                        <a14:backgroundMark x1="80109" y1="22886" x2="80109" y2="22886"/>
                        <a14:backgroundMark x1="72628" y1="13930" x2="72628" y2="13930"/>
                        <a14:backgroundMark x1="69708" y1="11443" x2="69708" y2="11443"/>
                        <a14:backgroundMark x1="46715" y1="62189" x2="46715" y2="62189"/>
                        <a14:backgroundMark x1="46715" y1="62189" x2="46715" y2="62189"/>
                        <a14:backgroundMark x1="20438" y1="45274" x2="20438" y2="45274"/>
                        <a14:backgroundMark x1="33029" y1="10945" x2="33029" y2="10945"/>
                      </a14:backgroundRemoval>
                    </a14:imgEffect>
                  </a14:imgLayer>
                </a14:imgProps>
              </a:ext>
              <a:ext uri="{28A0092B-C50C-407E-A947-70E740481C1C}">
                <a14:useLocalDpi xmlns:a14="http://schemas.microsoft.com/office/drawing/2010/main" val="0"/>
              </a:ext>
            </a:extLst>
          </a:blip>
          <a:stretch>
            <a:fillRect/>
          </a:stretch>
        </p:blipFill>
        <p:spPr>
          <a:xfrm>
            <a:off x="876104" y="2653673"/>
            <a:ext cx="7092849" cy="2601574"/>
          </a:xfrm>
          <a:prstGeom prst="rect">
            <a:avLst/>
          </a:prstGeom>
        </p:spPr>
      </p:pic>
      <p:pic>
        <p:nvPicPr>
          <p:cNvPr id="4" name="그림 3"/>
          <p:cNvPicPr>
            <a:picLocks noChangeAspect="1"/>
          </p:cNvPicPr>
          <p:nvPr/>
        </p:nvPicPr>
        <p:blipFill>
          <a:blip r:embed="rId4">
            <a:extLst>
              <a:ext uri="{BEBA8EAE-BF5A-486C-A8C5-ECC9F3942E4B}">
                <a14:imgProps xmlns:a14="http://schemas.microsoft.com/office/drawing/2010/main">
                  <a14:imgLayer r:embed="rId5">
                    <a14:imgEffect>
                      <a14:backgroundRemoval t="0" b="100000" l="0" r="100000">
                        <a14:foregroundMark x1="13661" y1="85784" x2="13661" y2="85784"/>
                        <a14:foregroundMark x1="6011" y1="77941" x2="6011" y2="77941"/>
                        <a14:foregroundMark x1="44262" y1="87255" x2="44262" y2="87255"/>
                        <a14:foregroundMark x1="45355" y1="77941" x2="45719" y2="77941"/>
                        <a14:foregroundMark x1="48634" y1="78431" x2="51913" y2="78431"/>
                        <a14:foregroundMark x1="54098" y1="78431" x2="57559" y2="79412"/>
                        <a14:foregroundMark x1="58106" y1="79412" x2="60109" y2="81373"/>
                        <a14:foregroundMark x1="66302" y1="81373" x2="67577" y2="81373"/>
                        <a14:foregroundMark x1="69217" y1="80882" x2="69945" y2="79412"/>
                        <a14:foregroundMark x1="74317" y1="74020" x2="74317" y2="74020"/>
                        <a14:foregroundMark x1="74681" y1="73039" x2="74681" y2="73039"/>
                        <a14:foregroundMark x1="77049" y1="75000" x2="77960" y2="75000"/>
                        <a14:foregroundMark x1="89435" y1="75000" x2="90164" y2="76961"/>
                        <a14:foregroundMark x1="93078" y1="78922" x2="93443" y2="79412"/>
                        <a14:foregroundMark x1="94353" y1="80882" x2="94353" y2="80882"/>
                        <a14:foregroundMark x1="94353" y1="82843" x2="94171" y2="84804"/>
                        <a14:foregroundMark x1="92896" y1="87255" x2="86521" y2="87745"/>
                        <a14:foregroundMark x1="84335" y1="87745" x2="84335" y2="87745"/>
                        <a14:foregroundMark x1="80692" y1="84314" x2="80692" y2="84314"/>
                        <a14:foregroundMark x1="79964" y1="83333" x2="79964" y2="83333"/>
                        <a14:foregroundMark x1="79599" y1="82843" x2="79599" y2="82843"/>
                        <a14:foregroundMark x1="67031" y1="83333" x2="65574" y2="83333"/>
                        <a14:foregroundMark x1="20583" y1="85294" x2="19672" y2="85784"/>
                        <a14:foregroundMark x1="4554" y1="85784" x2="4554" y2="85784"/>
                        <a14:foregroundMark x1="10747" y1="83824" x2="11111" y2="83824"/>
                        <a14:foregroundMark x1="17486" y1="82843" x2="17486" y2="82843"/>
                        <a14:foregroundMark x1="91257" y1="43627" x2="91257" y2="43627"/>
                        <a14:foregroundMark x1="91985" y1="50980" x2="91985" y2="50980"/>
                        <a14:foregroundMark x1="92714" y1="54902" x2="92714" y2="54902"/>
                        <a14:foregroundMark x1="94536" y1="59804" x2="94536" y2="59804"/>
                        <a14:foregroundMark x1="92896" y1="54412" x2="92896" y2="54412"/>
                        <a14:foregroundMark x1="92350" y1="49510" x2="92350" y2="49510"/>
                        <a14:foregroundMark x1="70674" y1="46078" x2="70674" y2="46078"/>
                        <a14:foregroundMark x1="54281" y1="36765" x2="54281" y2="36765"/>
                        <a14:foregroundMark x1="51184" y1="36275" x2="50638" y2="35294"/>
                        <a14:foregroundMark x1="46630" y1="33333" x2="44627" y2="30882"/>
                        <a14:foregroundMark x1="41712" y1="29412" x2="41348" y2="29412"/>
                        <a14:foregroundMark x1="35155" y1="27941" x2="35155" y2="27941"/>
                        <a14:foregroundMark x1="32240" y1="25490" x2="31694" y2="25490"/>
                        <a14:foregroundMark x1="27140" y1="24510" x2="24954" y2="24510"/>
                        <a14:foregroundMark x1="24408" y1="24510" x2="21858" y2="24510"/>
                        <a14:foregroundMark x1="16029" y1="24510" x2="16029" y2="24510"/>
                        <a14:foregroundMark x1="14390" y1="24510" x2="14026" y2="24020"/>
                        <a14:foregroundMark x1="25137" y1="53431" x2="25137" y2="53431"/>
                        <a14:foregroundMark x1="25865" y1="56863" x2="25865" y2="56863"/>
                        <a14:foregroundMark x1="25865" y1="57843" x2="25865" y2="58824"/>
                        <a14:foregroundMark x1="25865" y1="60294" x2="25865" y2="61275"/>
                        <a14:foregroundMark x1="25865" y1="62255" x2="25865" y2="63235"/>
                        <a14:foregroundMark x1="25865" y1="66176" x2="25865" y2="66176"/>
                        <a14:foregroundMark x1="25865" y1="67647" x2="25865" y2="67647"/>
                        <a14:foregroundMark x1="26047" y1="68137" x2="26047" y2="68137"/>
                        <a14:foregroundMark x1="26047" y1="68627" x2="26047" y2="69608"/>
                        <a14:foregroundMark x1="26230" y1="72059" x2="26230" y2="72059"/>
                        <a14:foregroundMark x1="94536" y1="81373" x2="94536" y2="81373"/>
                        <a14:foregroundMark x1="94900" y1="78922" x2="94900" y2="78922"/>
                        <a14:foregroundMark x1="95993" y1="76471" x2="95993" y2="76471"/>
                        <a14:foregroundMark x1="95993" y1="76471" x2="95993" y2="76471"/>
                        <a14:foregroundMark x1="96175" y1="75980" x2="96175" y2="75980"/>
                        <a14:foregroundMark x1="96357" y1="74020" x2="96357" y2="74020"/>
                        <a14:backgroundMark x1="3279" y1="22549" x2="3279" y2="22549"/>
                        <a14:backgroundMark x1="5647" y1="35294" x2="5647" y2="37255"/>
                        <a14:backgroundMark x1="6922" y1="44118" x2="6922" y2="45098"/>
                        <a14:backgroundMark x1="6922" y1="48039" x2="6922" y2="48039"/>
                        <a14:backgroundMark x1="20583" y1="50000" x2="20583" y2="50000"/>
                        <a14:backgroundMark x1="18397" y1="38235" x2="18397" y2="38235"/>
                        <a14:backgroundMark x1="22040" y1="43137" x2="22040" y2="43137"/>
                        <a14:backgroundMark x1="22040" y1="51471" x2="22040" y2="51471"/>
                        <a14:backgroundMark x1="22222" y1="55392" x2="22222" y2="57843"/>
                        <a14:backgroundMark x1="22222" y1="57843" x2="22404" y2="58824"/>
                        <a14:backgroundMark x1="34244" y1="5392" x2="34244" y2="5392"/>
                        <a14:backgroundMark x1="34791" y1="4902" x2="34791" y2="4902"/>
                        <a14:backgroundMark x1="37705" y1="1961" x2="38069" y2="1961"/>
                        <a14:backgroundMark x1="40619" y1="3431" x2="40984" y2="3431"/>
                        <a14:backgroundMark x1="43169" y1="3431" x2="43534" y2="3922"/>
                        <a14:backgroundMark x1="45902" y1="4412" x2="46266" y2="4902"/>
                        <a14:backgroundMark x1="48816" y1="4902" x2="51730" y2="4902"/>
                        <a14:backgroundMark x1="54463" y1="4902" x2="56102" y2="4902"/>
                        <a14:backgroundMark x1="60291" y1="6863" x2="61202" y2="7843"/>
                        <a14:backgroundMark x1="63752" y1="9314" x2="63752" y2="9314"/>
                        <a14:backgroundMark x1="38980" y1="54902" x2="38980" y2="54902"/>
                        <a14:backgroundMark x1="41712" y1="60294" x2="41712" y2="60294"/>
                        <a14:backgroundMark x1="41712" y1="60294" x2="41712" y2="60294"/>
                        <a14:backgroundMark x1="65027" y1="61765" x2="65027" y2="61765"/>
                        <a14:backgroundMark x1="71403" y1="61275" x2="71403" y2="61275"/>
                        <a14:backgroundMark x1="24408" y1="62745" x2="24408" y2="62745"/>
                        <a14:backgroundMark x1="24408" y1="61765" x2="24408" y2="61765"/>
                        <a14:backgroundMark x1="24408" y1="60294" x2="24408" y2="59314"/>
                        <a14:backgroundMark x1="24408" y1="58333" x2="24408" y2="57353"/>
                        <a14:backgroundMark x1="24226" y1="56863" x2="24226" y2="56373"/>
                        <a14:backgroundMark x1="24044" y1="55392" x2="24044" y2="54412"/>
                        <a14:backgroundMark x1="24044" y1="54412" x2="24044" y2="54412"/>
                        <a14:backgroundMark x1="24044" y1="58824" x2="24044" y2="60294"/>
                        <a14:backgroundMark x1="24226" y1="61765" x2="24226" y2="63235"/>
                        <a14:backgroundMark x1="24408" y1="63725" x2="24408" y2="63725"/>
                        <a14:backgroundMark x1="24408" y1="64706" x2="24408" y2="64706"/>
                        <a14:backgroundMark x1="24408" y1="64706" x2="24408" y2="64706"/>
                        <a14:backgroundMark x1="24408" y1="65686" x2="24408" y2="65686"/>
                        <a14:backgroundMark x1="24408" y1="65686" x2="24408" y2="65686"/>
                        <a14:backgroundMark x1="24408" y1="65686" x2="24408" y2="65686"/>
                        <a14:backgroundMark x1="24408" y1="66176" x2="24408" y2="66667"/>
                        <a14:backgroundMark x1="24408" y1="66667" x2="24408" y2="66667"/>
                        <a14:backgroundMark x1="24408" y1="66667" x2="24408" y2="66667"/>
                        <a14:backgroundMark x1="24408" y1="66667" x2="24408" y2="66667"/>
                        <a14:backgroundMark x1="24408" y1="66667" x2="24408" y2="66667"/>
                        <a14:backgroundMark x1="24408" y1="66667" x2="24408" y2="66667"/>
                      </a14:backgroundRemoval>
                    </a14:imgEffect>
                  </a14:imgLayer>
                </a14:imgProps>
              </a:ext>
              <a:ext uri="{28A0092B-C50C-407E-A947-70E740481C1C}">
                <a14:useLocalDpi xmlns:a14="http://schemas.microsoft.com/office/drawing/2010/main" val="0"/>
              </a:ext>
            </a:extLst>
          </a:blip>
          <a:stretch>
            <a:fillRect/>
          </a:stretch>
        </p:blipFill>
        <p:spPr>
          <a:xfrm>
            <a:off x="876105" y="5723259"/>
            <a:ext cx="7092848" cy="2635593"/>
          </a:xfrm>
          <a:prstGeom prst="rect">
            <a:avLst/>
          </a:prstGeom>
        </p:spPr>
      </p:pic>
      <p:sp>
        <p:nvSpPr>
          <p:cNvPr id="13" name="직사각형 12"/>
          <p:cNvSpPr/>
          <p:nvPr/>
        </p:nvSpPr>
        <p:spPr>
          <a:xfrm>
            <a:off x="336104" y="1432248"/>
            <a:ext cx="8573896" cy="720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79953" rtl="0" eaLnBrk="1" fontAlgn="auto" latinLnBrk="1" hangingPunct="1">
              <a:lnSpc>
                <a:spcPct val="100000"/>
              </a:lnSpc>
              <a:spcBef>
                <a:spcPts val="0"/>
              </a:spcBef>
              <a:spcAft>
                <a:spcPts val="0"/>
              </a:spcAft>
              <a:buClrTx/>
              <a:buSzTx/>
              <a:buFontTx/>
              <a:buNone/>
              <a:tabLst/>
              <a:defRPr/>
            </a:pPr>
            <a:r>
              <a:rPr kumimoji="0" lang="en-US" altLang="ko-KR" sz="2400" b="0" i="0" u="none" strike="noStrike" kern="1200" cap="none" spc="0" normalizeH="0" baseline="0" noProof="0" dirty="0">
                <a:ln>
                  <a:noFill/>
                </a:ln>
                <a:solidFill>
                  <a:prstClr val="black"/>
                </a:solidFill>
                <a:effectLst/>
                <a:uLnTx/>
                <a:uFillTx/>
                <a:latin typeface="HY헤드라인M" pitchFamily="18" charset="-127"/>
                <a:ea typeface="HY헤드라인M" pitchFamily="18" charset="-127"/>
                <a:cs typeface="+mn-cs"/>
              </a:rPr>
              <a:t>1st Set (   times) -&gt;  2nd Set (  times) -&gt;  3rd Set (  times)</a:t>
            </a:r>
            <a:endParaRPr kumimoji="0" lang="ko-KR" altLang="en-US" sz="2400" b="0" i="0" u="none" strike="noStrike" kern="1200" cap="none" spc="0" normalizeH="0" baseline="0" noProof="0" dirty="0">
              <a:ln>
                <a:noFill/>
              </a:ln>
              <a:solidFill>
                <a:prstClr val="black"/>
              </a:solidFill>
              <a:effectLst/>
              <a:uLnTx/>
              <a:uFillTx/>
              <a:latin typeface="HY헤드라인M" pitchFamily="18" charset="-127"/>
              <a:ea typeface="HY헤드라인M" pitchFamily="18" charset="-127"/>
              <a:cs typeface="+mn-cs"/>
            </a:endParaRPr>
          </a:p>
        </p:txBody>
      </p:sp>
    </p:spTree>
    <p:extLst>
      <p:ext uri="{BB962C8B-B14F-4D97-AF65-F5344CB8AC3E}">
        <p14:creationId xmlns:p14="http://schemas.microsoft.com/office/powerpoint/2010/main" val="3778053970"/>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2" name="모서리가 둥근 직사각형 21"/>
          <p:cNvSpPr/>
          <p:nvPr/>
        </p:nvSpPr>
        <p:spPr>
          <a:xfrm>
            <a:off x="311905" y="2627801"/>
            <a:ext cx="8100216" cy="2608925"/>
          </a:xfrm>
          <a:prstGeom prst="roundRect">
            <a:avLst/>
          </a:prstGeom>
          <a:noFill/>
          <a:ln w="50800">
            <a:solidFill>
              <a:srgbClr val="689E1D"/>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79953" rtl="0" eaLnBrk="1" fontAlgn="auto" latinLnBrk="1" hangingPunct="1">
              <a:lnSpc>
                <a:spcPct val="100000"/>
              </a:lnSpc>
              <a:spcBef>
                <a:spcPts val="0"/>
              </a:spcBef>
              <a:spcAft>
                <a:spcPts val="0"/>
              </a:spcAft>
              <a:buClrTx/>
              <a:buSzTx/>
              <a:buFontTx/>
              <a:buNone/>
              <a:tabLst/>
              <a:defRPr/>
            </a:pPr>
            <a:endParaRPr kumimoji="0" lang="ko-KR" altLang="en-US" sz="2500" b="0" i="0" u="none" strike="noStrike" kern="1200" cap="none" spc="0" normalizeH="0" baseline="0" noProof="0">
              <a:ln>
                <a:noFill/>
              </a:ln>
              <a:solidFill>
                <a:prstClr val="white"/>
              </a:solidFill>
              <a:effectLst/>
              <a:uLnTx/>
              <a:uFillTx/>
              <a:latin typeface="맑은 고딕"/>
              <a:ea typeface="맑은 고딕" panose="020B0503020000020004" pitchFamily="50" charset="-127"/>
              <a:cs typeface="+mn-cs"/>
            </a:endParaRPr>
          </a:p>
        </p:txBody>
      </p:sp>
      <p:sp>
        <p:nvSpPr>
          <p:cNvPr id="37" name="직사각형 36"/>
          <p:cNvSpPr/>
          <p:nvPr/>
        </p:nvSpPr>
        <p:spPr>
          <a:xfrm>
            <a:off x="108000" y="8488832"/>
            <a:ext cx="8802000" cy="4176664"/>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457200" marR="0" lvl="0" indent="-457200" algn="l" defTabSz="1279953" rtl="0" eaLnBrk="1" fontAlgn="auto" latinLnBrk="1" hangingPunct="1">
              <a:lnSpc>
                <a:spcPct val="100000"/>
              </a:lnSpc>
              <a:spcBef>
                <a:spcPts val="0"/>
              </a:spcBef>
              <a:spcAft>
                <a:spcPts val="0"/>
              </a:spcAft>
              <a:buClrTx/>
              <a:buSzTx/>
              <a:buFontTx/>
              <a:buAutoNum type="arabicPeriod"/>
              <a:tabLst/>
              <a:defRPr/>
            </a:pPr>
            <a:r>
              <a:rPr kumimoji="0" lang="en-US" altLang="ko-KR" sz="2400" b="0" i="0" u="none" strike="noStrike" kern="1200" cap="none" spc="-150" normalizeH="0" baseline="0" noProof="0" dirty="0">
                <a:ln>
                  <a:noFill/>
                </a:ln>
                <a:solidFill>
                  <a:prstClr val="black">
                    <a:lumMod val="75000"/>
                    <a:lumOff val="25000"/>
                  </a:prstClr>
                </a:solidFill>
                <a:effectLst/>
                <a:uLnTx/>
                <a:uFillTx/>
                <a:latin typeface="HY헤드라인M" pitchFamily="18" charset="-127"/>
                <a:ea typeface="HY헤드라인M" pitchFamily="18" charset="-127"/>
                <a:cs typeface="+mn-cs"/>
              </a:rPr>
              <a:t>Lie on your side and put  your thumb on the protrusion on the upper front part of your pelvis and your palm on your side. Try to feel your muscles during these exercises. </a:t>
            </a:r>
          </a:p>
          <a:p>
            <a:pPr marL="457200" marR="0" lvl="0" indent="-457200" algn="l" defTabSz="1279953" rtl="0" eaLnBrk="1" fontAlgn="auto" latinLnBrk="1" hangingPunct="1">
              <a:lnSpc>
                <a:spcPct val="100000"/>
              </a:lnSpc>
              <a:spcBef>
                <a:spcPts val="0"/>
              </a:spcBef>
              <a:spcAft>
                <a:spcPts val="0"/>
              </a:spcAft>
              <a:buClrTx/>
              <a:buSzTx/>
              <a:buFontTx/>
              <a:buAutoNum type="arabicPeriod"/>
              <a:tabLst/>
              <a:defRPr/>
            </a:pPr>
            <a:endParaRPr kumimoji="0" lang="en-US" altLang="ko-KR" sz="2400" b="0" i="0" u="none" strike="noStrike" kern="1200" cap="none" spc="-150" normalizeH="0" baseline="0" noProof="0" dirty="0">
              <a:ln>
                <a:noFill/>
              </a:ln>
              <a:solidFill>
                <a:prstClr val="black">
                  <a:lumMod val="75000"/>
                  <a:lumOff val="25000"/>
                </a:prstClr>
              </a:solidFill>
              <a:effectLst/>
              <a:uLnTx/>
              <a:uFillTx/>
              <a:latin typeface="HY헤드라인M" pitchFamily="18" charset="-127"/>
              <a:ea typeface="HY헤드라인M" pitchFamily="18" charset="-127"/>
              <a:cs typeface="+mn-cs"/>
            </a:endParaRPr>
          </a:p>
          <a:p>
            <a:pPr marL="457200" marR="0" lvl="0" indent="-457200" algn="l" defTabSz="1279953" rtl="0" eaLnBrk="1" fontAlgn="auto" latinLnBrk="1" hangingPunct="1">
              <a:lnSpc>
                <a:spcPct val="100000"/>
              </a:lnSpc>
              <a:spcBef>
                <a:spcPts val="0"/>
              </a:spcBef>
              <a:spcAft>
                <a:spcPts val="0"/>
              </a:spcAft>
              <a:buClrTx/>
              <a:buSzTx/>
              <a:buFontTx/>
              <a:buAutoNum type="arabicPeriod"/>
              <a:tabLst/>
              <a:defRPr/>
            </a:pPr>
            <a:r>
              <a:rPr kumimoji="0" lang="en-US" altLang="ko-KR" sz="2400" b="0" i="0" u="none" strike="noStrike" kern="1200" cap="none" spc="-150" normalizeH="0" baseline="0" noProof="0" dirty="0">
                <a:ln>
                  <a:noFill/>
                </a:ln>
                <a:solidFill>
                  <a:prstClr val="black">
                    <a:lumMod val="75000"/>
                    <a:lumOff val="25000"/>
                  </a:prstClr>
                </a:solidFill>
                <a:effectLst/>
                <a:uLnTx/>
                <a:uFillTx/>
                <a:latin typeface="HY헤드라인M" pitchFamily="18" charset="-127"/>
                <a:ea typeface="HY헤드라인M" pitchFamily="18" charset="-127"/>
                <a:cs typeface="+mn-cs"/>
              </a:rPr>
              <a:t>Bend your knees to form a &lt; shape. Spread your legs by lifting your upper knee like a clam while keeping your feet together.</a:t>
            </a:r>
          </a:p>
          <a:p>
            <a:pPr marL="457200" marR="0" lvl="0" indent="-457200" algn="l" defTabSz="1279953" rtl="0" eaLnBrk="1" fontAlgn="auto" latinLnBrk="1" hangingPunct="1">
              <a:lnSpc>
                <a:spcPct val="100000"/>
              </a:lnSpc>
              <a:spcBef>
                <a:spcPts val="0"/>
              </a:spcBef>
              <a:spcAft>
                <a:spcPts val="0"/>
              </a:spcAft>
              <a:buClrTx/>
              <a:buSzTx/>
              <a:buFontTx/>
              <a:buAutoNum type="arabicPeriod"/>
              <a:tabLst/>
              <a:defRPr/>
            </a:pPr>
            <a:endParaRPr kumimoji="0" lang="en-US" altLang="ko-KR" sz="2400" b="0" i="0" u="none" strike="noStrike" kern="1200" cap="none" spc="-150" normalizeH="0" baseline="0" noProof="0" dirty="0">
              <a:ln>
                <a:noFill/>
              </a:ln>
              <a:solidFill>
                <a:prstClr val="black">
                  <a:lumMod val="75000"/>
                  <a:lumOff val="25000"/>
                </a:prstClr>
              </a:solidFill>
              <a:effectLst/>
              <a:uLnTx/>
              <a:uFillTx/>
              <a:latin typeface="HY헤드라인M" pitchFamily="18" charset="-127"/>
              <a:ea typeface="HY헤드라인M" pitchFamily="18" charset="-127"/>
              <a:cs typeface="+mn-cs"/>
            </a:endParaRPr>
          </a:p>
          <a:p>
            <a:pPr marL="457200" marR="0" lvl="0" indent="-457200" algn="l" defTabSz="1279953" rtl="0" eaLnBrk="1" fontAlgn="auto" latinLnBrk="1" hangingPunct="1">
              <a:lnSpc>
                <a:spcPct val="100000"/>
              </a:lnSpc>
              <a:spcBef>
                <a:spcPts val="0"/>
              </a:spcBef>
              <a:spcAft>
                <a:spcPts val="0"/>
              </a:spcAft>
              <a:buClrTx/>
              <a:buSzTx/>
              <a:buFontTx/>
              <a:buAutoNum type="arabicPeriod"/>
              <a:tabLst/>
              <a:defRPr/>
            </a:pPr>
            <a:r>
              <a:rPr kumimoji="0" lang="en-US" altLang="ko-KR" sz="2400" b="0" i="0" u="none" strike="noStrike" kern="1200" cap="none" spc="-150" normalizeH="0" baseline="0" noProof="0" dirty="0">
                <a:ln>
                  <a:noFill/>
                </a:ln>
                <a:solidFill>
                  <a:prstClr val="black">
                    <a:lumMod val="75000"/>
                    <a:lumOff val="25000"/>
                  </a:prstClr>
                </a:solidFill>
                <a:effectLst/>
                <a:uLnTx/>
                <a:uFillTx/>
                <a:latin typeface="HY헤드라인M" pitchFamily="18" charset="-127"/>
                <a:ea typeface="HY헤드라인M" pitchFamily="18" charset="-127"/>
                <a:cs typeface="+mn-cs"/>
              </a:rPr>
              <a:t>When spreading your legs, try to keep your pelvis from moving backwards. It is preferable to spread your legs while tightening your gluteus muscles. </a:t>
            </a:r>
          </a:p>
        </p:txBody>
      </p:sp>
      <p:sp>
        <p:nvSpPr>
          <p:cNvPr id="40" name="직사각형 39"/>
          <p:cNvSpPr/>
          <p:nvPr/>
        </p:nvSpPr>
        <p:spPr>
          <a:xfrm>
            <a:off x="876104" y="2080320"/>
            <a:ext cx="2520000" cy="720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79953" rtl="0" eaLnBrk="1" fontAlgn="auto" latinLnBrk="1" hangingPunct="1">
              <a:lnSpc>
                <a:spcPct val="100000"/>
              </a:lnSpc>
              <a:spcBef>
                <a:spcPts val="0"/>
              </a:spcBef>
              <a:spcAft>
                <a:spcPts val="0"/>
              </a:spcAft>
              <a:buClrTx/>
              <a:buSzTx/>
              <a:buFontTx/>
              <a:buNone/>
              <a:tabLst/>
              <a:defRPr/>
            </a:pPr>
            <a:r>
              <a:rPr kumimoji="0" lang="en-US" altLang="ko-KR" sz="2500" b="0" i="0" u="none" strike="noStrike" kern="1200" cap="none" spc="0" normalizeH="0" baseline="0" noProof="0" dirty="0">
                <a:ln>
                  <a:noFill/>
                </a:ln>
                <a:solidFill>
                  <a:prstClr val="black"/>
                </a:solidFill>
                <a:effectLst/>
                <a:uLnTx/>
                <a:uFillTx/>
                <a:latin typeface="HY헤드라인M" pitchFamily="18" charset="-127"/>
                <a:ea typeface="HY헤드라인M" pitchFamily="18" charset="-127"/>
                <a:cs typeface="+mn-cs"/>
              </a:rPr>
              <a:t>Preparation</a:t>
            </a:r>
            <a:endParaRPr kumimoji="0" lang="ko-KR" altLang="en-US" sz="2500" b="0" i="0" u="none" strike="noStrike" kern="1200" cap="none" spc="0" normalizeH="0" baseline="0" noProof="0" dirty="0">
              <a:ln>
                <a:noFill/>
              </a:ln>
              <a:solidFill>
                <a:prstClr val="black"/>
              </a:solidFill>
              <a:effectLst/>
              <a:uLnTx/>
              <a:uFillTx/>
              <a:latin typeface="HY헤드라인M" pitchFamily="18" charset="-127"/>
              <a:ea typeface="HY헤드라인M" pitchFamily="18" charset="-127"/>
              <a:cs typeface="+mn-cs"/>
            </a:endParaRPr>
          </a:p>
        </p:txBody>
      </p:sp>
      <p:sp>
        <p:nvSpPr>
          <p:cNvPr id="2" name="직사각형 1"/>
          <p:cNvSpPr/>
          <p:nvPr/>
        </p:nvSpPr>
        <p:spPr>
          <a:xfrm>
            <a:off x="0" y="0"/>
            <a:ext cx="9601200" cy="1432248"/>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79953" rtl="0" eaLnBrk="1" fontAlgn="auto" latinLnBrk="1" hangingPunct="1">
              <a:lnSpc>
                <a:spcPct val="100000"/>
              </a:lnSpc>
              <a:spcBef>
                <a:spcPts val="0"/>
              </a:spcBef>
              <a:spcAft>
                <a:spcPts val="0"/>
              </a:spcAft>
              <a:buClrTx/>
              <a:buSzTx/>
              <a:buFontTx/>
              <a:buNone/>
              <a:tabLst/>
              <a:defRPr/>
            </a:pPr>
            <a:r>
              <a:rPr kumimoji="0" lang="en-US" altLang="ko-KR" sz="5000" b="0" i="0" u="none" strike="noStrike" kern="1200" cap="none" spc="0" normalizeH="0" baseline="0" noProof="0" dirty="0">
                <a:ln>
                  <a:noFill/>
                </a:ln>
                <a:solidFill>
                  <a:srgbClr val="689E1D"/>
                </a:solidFill>
                <a:effectLst/>
                <a:uLnTx/>
                <a:uFillTx/>
                <a:latin typeface="HY헤드라인M" pitchFamily="18" charset="-127"/>
                <a:ea typeface="HY헤드라인M" pitchFamily="18" charset="-127"/>
                <a:cs typeface="+mn-cs"/>
              </a:rPr>
              <a:t>Knee Clam Exercise </a:t>
            </a:r>
          </a:p>
          <a:p>
            <a:pPr marL="0" marR="0" lvl="0" indent="0" algn="ctr" defTabSz="1279953" rtl="0" eaLnBrk="1" fontAlgn="auto" latinLnBrk="1" hangingPunct="1">
              <a:lnSpc>
                <a:spcPct val="100000"/>
              </a:lnSpc>
              <a:spcBef>
                <a:spcPts val="0"/>
              </a:spcBef>
              <a:spcAft>
                <a:spcPts val="0"/>
              </a:spcAft>
              <a:buClrTx/>
              <a:buSzTx/>
              <a:buFontTx/>
              <a:buNone/>
              <a:tabLst/>
              <a:defRPr/>
            </a:pPr>
            <a:r>
              <a:rPr kumimoji="0" lang="en-US" altLang="ko-KR" sz="4000" b="0" i="0" u="none" strike="noStrike" kern="1200" cap="none" spc="0" normalizeH="0" baseline="0" noProof="0" dirty="0">
                <a:ln>
                  <a:noFill/>
                </a:ln>
                <a:solidFill>
                  <a:srgbClr val="689E1D"/>
                </a:solidFill>
                <a:effectLst/>
                <a:uLnTx/>
                <a:uFillTx/>
                <a:latin typeface="HY헤드라인M" pitchFamily="18" charset="-127"/>
                <a:ea typeface="HY헤드라인M" pitchFamily="18" charset="-127"/>
                <a:cs typeface="+mn-cs"/>
              </a:rPr>
              <a:t>– Gluteus </a:t>
            </a:r>
            <a:r>
              <a:rPr kumimoji="0" lang="en-US" altLang="ko-KR" sz="4000" b="0" i="0" u="none" strike="noStrike" kern="1200" cap="none" spc="0" normalizeH="0" baseline="0" noProof="0" dirty="0" err="1">
                <a:ln>
                  <a:noFill/>
                </a:ln>
                <a:solidFill>
                  <a:srgbClr val="9BBB59">
                    <a:lumMod val="75000"/>
                  </a:srgbClr>
                </a:solidFill>
                <a:effectLst/>
                <a:uLnTx/>
                <a:uFillTx/>
                <a:latin typeface="HY헤드라인M" pitchFamily="18" charset="-127"/>
                <a:ea typeface="HY헤드라인M" pitchFamily="18" charset="-127"/>
                <a:cs typeface="+mn-cs"/>
              </a:rPr>
              <a:t>Medius</a:t>
            </a:r>
            <a:r>
              <a:rPr kumimoji="0" lang="en-US" altLang="ko-KR" sz="4000" b="0" i="0" u="none" strike="noStrike" kern="1200" cap="none" spc="0" normalizeH="0" baseline="0" noProof="0" dirty="0">
                <a:ln>
                  <a:noFill/>
                </a:ln>
                <a:solidFill>
                  <a:srgbClr val="9BBB59">
                    <a:lumMod val="75000"/>
                  </a:srgbClr>
                </a:solidFill>
                <a:effectLst/>
                <a:uLnTx/>
                <a:uFillTx/>
                <a:latin typeface="HY헤드라인M" pitchFamily="18" charset="-127"/>
                <a:ea typeface="HY헤드라인M" pitchFamily="18" charset="-127"/>
                <a:cs typeface="+mn-cs"/>
              </a:rPr>
              <a:t> -</a:t>
            </a:r>
          </a:p>
        </p:txBody>
      </p:sp>
      <p:sp>
        <p:nvSpPr>
          <p:cNvPr id="12" name="모서리가 둥근 직사각형 11"/>
          <p:cNvSpPr/>
          <p:nvPr/>
        </p:nvSpPr>
        <p:spPr>
          <a:xfrm>
            <a:off x="336104" y="5680720"/>
            <a:ext cx="8100216" cy="2608925"/>
          </a:xfrm>
          <a:prstGeom prst="roundRect">
            <a:avLst/>
          </a:prstGeom>
          <a:noFill/>
          <a:ln w="50800">
            <a:solidFill>
              <a:srgbClr val="689E1D"/>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79953" rtl="0" eaLnBrk="1" fontAlgn="auto" latinLnBrk="1" hangingPunct="1">
              <a:lnSpc>
                <a:spcPct val="100000"/>
              </a:lnSpc>
              <a:spcBef>
                <a:spcPts val="0"/>
              </a:spcBef>
              <a:spcAft>
                <a:spcPts val="0"/>
              </a:spcAft>
              <a:buClrTx/>
              <a:buSzTx/>
              <a:buFontTx/>
              <a:buNone/>
              <a:tabLst/>
              <a:defRPr/>
            </a:pPr>
            <a:endParaRPr kumimoji="0" lang="ko-KR" altLang="en-US" sz="2500" b="0" i="0" u="none" strike="noStrike" kern="1200" cap="none" spc="0" normalizeH="0" baseline="0" noProof="0">
              <a:ln>
                <a:noFill/>
              </a:ln>
              <a:solidFill>
                <a:prstClr val="white"/>
              </a:solidFill>
              <a:effectLst/>
              <a:uLnTx/>
              <a:uFillTx/>
              <a:latin typeface="맑은 고딕"/>
              <a:ea typeface="맑은 고딕" panose="020B0503020000020004" pitchFamily="50" charset="-127"/>
              <a:cs typeface="+mn-cs"/>
            </a:endParaRPr>
          </a:p>
        </p:txBody>
      </p:sp>
      <p:sp>
        <p:nvSpPr>
          <p:cNvPr id="14" name="직사각형 13"/>
          <p:cNvSpPr/>
          <p:nvPr/>
        </p:nvSpPr>
        <p:spPr>
          <a:xfrm>
            <a:off x="876104" y="5104656"/>
            <a:ext cx="2520000" cy="720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79953" rtl="0" eaLnBrk="1" fontAlgn="auto" latinLnBrk="1" hangingPunct="1">
              <a:lnSpc>
                <a:spcPct val="100000"/>
              </a:lnSpc>
              <a:spcBef>
                <a:spcPts val="0"/>
              </a:spcBef>
              <a:spcAft>
                <a:spcPts val="0"/>
              </a:spcAft>
              <a:buClrTx/>
              <a:buSzTx/>
              <a:buFontTx/>
              <a:buNone/>
              <a:tabLst/>
              <a:defRPr/>
            </a:pPr>
            <a:r>
              <a:rPr kumimoji="0" lang="en-US" altLang="ko-KR" sz="2500" b="0" i="0" u="none" strike="noStrike" kern="1200" cap="none" spc="0" normalizeH="0" baseline="0" noProof="0" dirty="0">
                <a:ln>
                  <a:noFill/>
                </a:ln>
                <a:solidFill>
                  <a:prstClr val="black"/>
                </a:solidFill>
                <a:effectLst/>
                <a:uLnTx/>
                <a:uFillTx/>
                <a:latin typeface="HY헤드라인M" pitchFamily="18" charset="-127"/>
                <a:ea typeface="HY헤드라인M" pitchFamily="18" charset="-127"/>
                <a:cs typeface="+mn-cs"/>
              </a:rPr>
              <a:t>Exercise</a:t>
            </a:r>
            <a:endParaRPr kumimoji="0" lang="ko-KR" altLang="en-US" sz="2500" b="0" i="0" u="none" strike="noStrike" kern="1200" cap="none" spc="0" normalizeH="0" baseline="0" noProof="0" dirty="0">
              <a:ln>
                <a:noFill/>
              </a:ln>
              <a:solidFill>
                <a:prstClr val="black"/>
              </a:solidFill>
              <a:effectLst/>
              <a:uLnTx/>
              <a:uFillTx/>
              <a:latin typeface="HY헤드라인M" pitchFamily="18" charset="-127"/>
              <a:ea typeface="HY헤드라인M" pitchFamily="18" charset="-127"/>
              <a:cs typeface="+mn-cs"/>
            </a:endParaRPr>
          </a:p>
        </p:txBody>
      </p:sp>
      <p:pic>
        <p:nvPicPr>
          <p:cNvPr id="5" name="그림 4"/>
          <p:cNvPicPr>
            <a:picLocks noChangeAspect="1"/>
          </p:cNvPicPr>
          <p:nvPr/>
        </p:nvPicPr>
        <p:blipFill>
          <a:blip r:embed="rId2">
            <a:extLst>
              <a:ext uri="{BEBA8EAE-BF5A-486C-A8C5-ECC9F3942E4B}">
                <a14:imgProps xmlns:a14="http://schemas.microsoft.com/office/drawing/2010/main">
                  <a14:imgLayer r:embed="rId3">
                    <a14:imgEffect>
                      <a14:backgroundRemoval t="0" b="100000" l="0" r="100000">
                        <a14:foregroundMark x1="37143" y1="19681" x2="37143" y2="19681"/>
                        <a14:foregroundMark x1="43810" y1="20745" x2="43810" y2="20745"/>
                        <a14:foregroundMark x1="49841" y1="19681" x2="49841" y2="19681"/>
                        <a14:foregroundMark x1="52857" y1="22872" x2="52857" y2="22872"/>
                        <a14:foregroundMark x1="55873" y1="26596" x2="55873" y2="26596"/>
                        <a14:foregroundMark x1="52540" y1="39362" x2="51429" y2="40426"/>
                        <a14:foregroundMark x1="23333" y1="48404" x2="23333" y2="48404"/>
                        <a14:foregroundMark x1="8889" y1="77128" x2="8889" y2="77128"/>
                        <a14:foregroundMark x1="8571" y1="76596" x2="8571" y2="76596"/>
                        <a14:foregroundMark x1="3651" y1="64894" x2="3651" y2="64894"/>
                        <a14:foregroundMark x1="16984" y1="59043" x2="16984" y2="59043"/>
                        <a14:foregroundMark x1="19524" y1="56915" x2="22857" y2="57447"/>
                        <a14:foregroundMark x1="25873" y1="57447" x2="25873" y2="57447"/>
                        <a14:foregroundMark x1="29841" y1="19681" x2="29841" y2="19681"/>
                        <a14:foregroundMark x1="30000" y1="20213" x2="31429" y2="21809"/>
                        <a14:foregroundMark x1="32857" y1="19681" x2="33333" y2="19681"/>
                        <a14:foregroundMark x1="35079" y1="18617" x2="35079" y2="18617"/>
                        <a14:foregroundMark x1="36190" y1="18617" x2="36190" y2="18617"/>
                        <a14:foregroundMark x1="36349" y1="19149" x2="36349" y2="19149"/>
                        <a14:foregroundMark x1="36508" y1="19149" x2="36508" y2="19149"/>
                        <a14:foregroundMark x1="37619" y1="19149" x2="37937" y2="19149"/>
                        <a14:foregroundMark x1="39365" y1="19149" x2="39365" y2="19149"/>
                        <a14:foregroundMark x1="39524" y1="19149" x2="39524" y2="19149"/>
                        <a14:foregroundMark x1="39524" y1="19149" x2="39524" y2="19149"/>
                        <a14:foregroundMark x1="34921" y1="19149" x2="34921" y2="19149"/>
                        <a14:foregroundMark x1="33968" y1="19149" x2="32540" y2="17553"/>
                        <a14:foregroundMark x1="30476" y1="16489" x2="30476" y2="16489"/>
                        <a14:foregroundMark x1="29365" y1="13830" x2="29365" y2="13830"/>
                        <a14:foregroundMark x1="30317" y1="14894" x2="31746" y2="15426"/>
                        <a14:foregroundMark x1="33651" y1="14894" x2="33651" y2="14894"/>
                        <a14:foregroundMark x1="34444" y1="14894" x2="34444" y2="14894"/>
                        <a14:foregroundMark x1="34762" y1="14894" x2="34762" y2="14894"/>
                        <a14:foregroundMark x1="36825" y1="15957" x2="37619" y2="16489"/>
                        <a14:foregroundMark x1="38571" y1="16489" x2="38571" y2="16489"/>
                        <a14:foregroundMark x1="38571" y1="16489" x2="38571" y2="16489"/>
                        <a14:foregroundMark x1="39048" y1="17021" x2="39365" y2="17021"/>
                        <a14:foregroundMark x1="39841" y1="17021" x2="40317" y2="17021"/>
                        <a14:foregroundMark x1="41587" y1="16489" x2="41587" y2="16489"/>
                        <a14:foregroundMark x1="42381" y1="16489" x2="42381" y2="16489"/>
                        <a14:foregroundMark x1="42540" y1="16489" x2="42698" y2="16489"/>
                        <a14:foregroundMark x1="43016" y1="16489" x2="43333" y2="16489"/>
                        <a14:foregroundMark x1="45238" y1="17021" x2="45238" y2="17021"/>
                        <a14:foregroundMark x1="45238" y1="17021" x2="45238" y2="17021"/>
                        <a14:foregroundMark x1="45397" y1="17021" x2="45397" y2="17021"/>
                        <a14:foregroundMark x1="47619" y1="17553" x2="47619" y2="17553"/>
                        <a14:foregroundMark x1="48413" y1="17553" x2="48413" y2="17553"/>
                        <a14:foregroundMark x1="48889" y1="17553" x2="48889" y2="17553"/>
                        <a14:foregroundMark x1="49048" y1="17553" x2="49048" y2="17553"/>
                        <a14:foregroundMark x1="49048" y1="17553" x2="49048" y2="17553"/>
                        <a14:foregroundMark x1="49048" y1="17553" x2="49048" y2="17553"/>
                        <a14:foregroundMark x1="50000" y1="18617" x2="50000" y2="18617"/>
                        <a14:foregroundMark x1="50159" y1="17553" x2="50159" y2="17553"/>
                        <a14:foregroundMark x1="50159" y1="17553" x2="50159" y2="17553"/>
                        <a14:foregroundMark x1="50159" y1="17553" x2="50159" y2="17553"/>
                        <a14:foregroundMark x1="50159" y1="17553" x2="50159" y2="17553"/>
                        <a14:foregroundMark x1="50159" y1="17553" x2="50159" y2="17553"/>
                        <a14:foregroundMark x1="50159" y1="17553" x2="50159" y2="17553"/>
                        <a14:foregroundMark x1="49524" y1="17553" x2="49524" y2="17553"/>
                        <a14:foregroundMark x1="51905" y1="17553" x2="51905" y2="17553"/>
                        <a14:foregroundMark x1="51905" y1="17553" x2="51905" y2="17553"/>
                        <a14:foregroundMark x1="51905" y1="17553" x2="51905" y2="17553"/>
                        <a14:foregroundMark x1="51905" y1="17553" x2="51905" y2="17553"/>
                        <a14:foregroundMark x1="51905" y1="17553" x2="52222" y2="17553"/>
                        <a14:foregroundMark x1="53175" y1="18085" x2="53175" y2="18085"/>
                        <a14:foregroundMark x1="53492" y1="20745" x2="53492" y2="20745"/>
                        <a14:foregroundMark x1="53810" y1="21809" x2="53968" y2="21809"/>
                        <a14:foregroundMark x1="54286" y1="22340" x2="55079" y2="22340"/>
                        <a14:foregroundMark x1="55556" y1="22872" x2="55556" y2="22872"/>
                        <a14:foregroundMark x1="55556" y1="22872" x2="55556" y2="22872"/>
                        <a14:foregroundMark x1="55556" y1="22872" x2="55556" y2="22872"/>
                        <a14:foregroundMark x1="55873" y1="22872" x2="55873" y2="22872"/>
                        <a14:foregroundMark x1="55873" y1="22872" x2="54127" y2="20213"/>
                        <a14:foregroundMark x1="53651" y1="19681" x2="53333" y2="19149"/>
                        <a14:foregroundMark x1="53175" y1="19149" x2="53175" y2="19149"/>
                        <a14:foregroundMark x1="53175" y1="19149" x2="53175" y2="19149"/>
                        <a14:foregroundMark x1="52857" y1="19149" x2="52857" y2="19149"/>
                        <a14:foregroundMark x1="51746" y1="18617" x2="51746" y2="18617"/>
                        <a14:foregroundMark x1="51746" y1="18617" x2="51746" y2="18617"/>
                        <a14:foregroundMark x1="51111" y1="18617" x2="51111" y2="18617"/>
                        <a14:foregroundMark x1="51111" y1="18617" x2="51111" y2="18617"/>
                        <a14:foregroundMark x1="51111" y1="18617" x2="51905" y2="18617"/>
                        <a14:foregroundMark x1="52222" y1="18617" x2="53175" y2="19149"/>
                        <a14:foregroundMark x1="55714" y1="20213" x2="55714" y2="20213"/>
                        <a14:foregroundMark x1="55873" y1="20213" x2="56190" y2="21809"/>
                        <a14:foregroundMark x1="56508" y1="22340" x2="56508" y2="22340"/>
                        <a14:foregroundMark x1="56508" y1="22872" x2="56825" y2="23936"/>
                        <a14:foregroundMark x1="56984" y1="25532" x2="56984" y2="26064"/>
                        <a14:foregroundMark x1="57143" y1="27128" x2="57143" y2="28191"/>
                        <a14:foregroundMark x1="57143" y1="29255" x2="57143" y2="29255"/>
                        <a14:foregroundMark x1="57302" y1="30319" x2="57460" y2="33511"/>
                        <a14:foregroundMark x1="7619" y1="85638" x2="7619" y2="85638"/>
                        <a14:foregroundMark x1="7302" y1="84574" x2="7302" y2="84574"/>
                        <a14:foregroundMark x1="6190" y1="80851" x2="6190" y2="80851"/>
                        <a14:foregroundMark x1="5079" y1="75000" x2="4762" y2="72340"/>
                        <a14:foregroundMark x1="4603" y1="71809" x2="4603" y2="71809"/>
                        <a14:foregroundMark x1="4603" y1="70213" x2="4603" y2="70213"/>
                      </a14:backgroundRemoval>
                    </a14:imgEffect>
                  </a14:imgLayer>
                </a14:imgProps>
              </a:ext>
              <a:ext uri="{28A0092B-C50C-407E-A947-70E740481C1C}">
                <a14:useLocalDpi xmlns:a14="http://schemas.microsoft.com/office/drawing/2010/main" val="0"/>
              </a:ext>
            </a:extLst>
          </a:blip>
          <a:stretch>
            <a:fillRect/>
          </a:stretch>
        </p:blipFill>
        <p:spPr>
          <a:xfrm>
            <a:off x="648000" y="2802162"/>
            <a:ext cx="7574084" cy="2260202"/>
          </a:xfrm>
          <a:prstGeom prst="rect">
            <a:avLst/>
          </a:prstGeom>
        </p:spPr>
      </p:pic>
      <p:pic>
        <p:nvPicPr>
          <p:cNvPr id="6" name="그림 5"/>
          <p:cNvPicPr>
            <a:picLocks noChangeAspect="1"/>
          </p:cNvPicPr>
          <p:nvPr/>
        </p:nvPicPr>
        <p:blipFill>
          <a:blip r:embed="rId4">
            <a:extLst>
              <a:ext uri="{BEBA8EAE-BF5A-486C-A8C5-ECC9F3942E4B}">
                <a14:imgProps xmlns:a14="http://schemas.microsoft.com/office/drawing/2010/main">
                  <a14:imgLayer r:embed="rId5">
                    <a14:imgEffect>
                      <a14:backgroundRemoval t="0" b="100000" l="0" r="100000">
                        <a14:foregroundMark x1="8903" y1="77436" x2="8903" y2="77436"/>
                        <a14:foregroundMark x1="3816" y1="73333" x2="3816" y2="73333"/>
                        <a14:foregroundMark x1="27663" y1="77949" x2="27663" y2="77949"/>
                        <a14:foregroundMark x1="29730" y1="75897" x2="30048" y2="64615"/>
                        <a14:foregroundMark x1="29730" y1="57436" x2="29730" y2="52308"/>
                        <a14:foregroundMark x1="29730" y1="40513" x2="29730" y2="40513"/>
                        <a14:foregroundMark x1="30366" y1="18974" x2="30366" y2="18974"/>
                        <a14:foregroundMark x1="30843" y1="18462" x2="31161" y2="17949"/>
                        <a14:foregroundMark x1="35135" y1="14359" x2="35135" y2="14359"/>
                        <a14:foregroundMark x1="35294" y1="14359" x2="35294" y2="14359"/>
                        <a14:foregroundMark x1="35453" y1="14359" x2="35453" y2="14359"/>
                        <a14:foregroundMark x1="35453" y1="14359" x2="35453" y2="14359"/>
                        <a14:foregroundMark x1="35453" y1="14359" x2="35453" y2="14359"/>
                        <a14:foregroundMark x1="34658" y1="14359" x2="34658" y2="14359"/>
                        <a14:foregroundMark x1="33227" y1="15385" x2="33227" y2="15385"/>
                        <a14:foregroundMark x1="32750" y1="16410" x2="32750" y2="16410"/>
                        <a14:foregroundMark x1="32750" y1="16410" x2="32750" y2="16410"/>
                        <a14:foregroundMark x1="32750" y1="16410" x2="32750" y2="16410"/>
                        <a14:foregroundMark x1="32750" y1="16410" x2="33068" y2="15385"/>
                        <a14:foregroundMark x1="33545" y1="14359" x2="33545" y2="14359"/>
                        <a14:foregroundMark x1="34181" y1="12821" x2="34181" y2="12821"/>
                        <a14:foregroundMark x1="34181" y1="12821" x2="34181" y2="12821"/>
                        <a14:foregroundMark x1="36407" y1="13333" x2="36407" y2="13333"/>
                        <a14:foregroundMark x1="37202" y1="13846" x2="38156" y2="14872"/>
                        <a14:foregroundMark x1="39110" y1="15385" x2="39587" y2="16410"/>
                        <a14:foregroundMark x1="41335" y1="18974" x2="41812" y2="18974"/>
                        <a14:foregroundMark x1="45151" y1="20000" x2="45151" y2="20000"/>
                        <a14:foregroundMark x1="45310" y1="20513" x2="45310" y2="20513"/>
                        <a14:foregroundMark x1="45946" y1="20513" x2="45946" y2="20513"/>
                        <a14:foregroundMark x1="46105" y1="21026" x2="46105" y2="21026"/>
                        <a14:foregroundMark x1="46741" y1="21538" x2="46741" y2="21538"/>
                        <a14:foregroundMark x1="46741" y1="21538" x2="46741" y2="21538"/>
                        <a14:foregroundMark x1="48331" y1="24103" x2="48331" y2="24103"/>
                        <a14:foregroundMark x1="48331" y1="24103" x2="48331" y2="24103"/>
                        <a14:foregroundMark x1="48331" y1="24103" x2="48331" y2="24103"/>
                        <a14:foregroundMark x1="48331" y1="24103" x2="48331" y2="24103"/>
                        <a14:foregroundMark x1="48331" y1="24103" x2="48331" y2="24103"/>
                        <a14:foregroundMark x1="48331" y1="24103" x2="48331" y2="24103"/>
                        <a14:foregroundMark x1="48331" y1="24103" x2="48649" y2="24103"/>
                        <a14:foregroundMark x1="50397" y1="22564" x2="50397" y2="22564"/>
                        <a14:foregroundMark x1="50556" y1="22564" x2="50556" y2="22564"/>
                        <a14:foregroundMark x1="50556" y1="22564" x2="50556" y2="22564"/>
                        <a14:foregroundMark x1="50556" y1="22564" x2="50556" y2="22564"/>
                        <a14:foregroundMark x1="51351" y1="23077" x2="51351" y2="23077"/>
                        <a14:foregroundMark x1="51351" y1="23077" x2="51351" y2="23077"/>
                        <a14:foregroundMark x1="51510" y1="23077" x2="51828" y2="23077"/>
                        <a14:foregroundMark x1="52941" y1="23590" x2="52941" y2="23590"/>
                        <a14:foregroundMark x1="53259" y1="23590" x2="53259" y2="23590"/>
                        <a14:foregroundMark x1="53418" y1="23590" x2="53418" y2="23590"/>
                        <a14:foregroundMark x1="53736" y1="24103" x2="53736" y2="24103"/>
                        <a14:foregroundMark x1="54372" y1="24103" x2="54372" y2="24103"/>
                        <a14:foregroundMark x1="54690" y1="24103" x2="54690" y2="24103"/>
                        <a14:foregroundMark x1="55008" y1="24103" x2="55008" y2="24103"/>
                        <a14:foregroundMark x1="55326" y1="24103" x2="55326" y2="24103"/>
                        <a14:foregroundMark x1="55326" y1="24103" x2="55326" y2="24103"/>
                        <a14:foregroundMark x1="55326" y1="24103" x2="54372" y2="24615"/>
                        <a14:foregroundMark x1="53736" y1="24615" x2="53418" y2="24615"/>
                        <a14:foregroundMark x1="52305" y1="23077" x2="52305" y2="23077"/>
                        <a14:foregroundMark x1="52305" y1="23077" x2="52305" y2="23077"/>
                        <a14:foregroundMark x1="52146" y1="23077" x2="52146" y2="23077"/>
                        <a14:foregroundMark x1="52146" y1="23077" x2="52146" y2="23077"/>
                        <a14:foregroundMark x1="52146" y1="23077" x2="52146" y2="23077"/>
                        <a14:foregroundMark x1="52146" y1="23077" x2="52146" y2="23077"/>
                        <a14:foregroundMark x1="34658" y1="18974" x2="34340" y2="18974"/>
                        <a14:foregroundMark x1="33227" y1="17436" x2="33227" y2="17436"/>
                        <a14:foregroundMark x1="33227" y1="16923" x2="33227" y2="16923"/>
                        <a14:foregroundMark x1="33068" y1="15385" x2="33068" y2="13333"/>
                        <a14:foregroundMark x1="33227" y1="11795" x2="33227" y2="11795"/>
                        <a14:foregroundMark x1="33227" y1="10769" x2="33227" y2="10769"/>
                        <a14:foregroundMark x1="33068" y1="10769" x2="33068" y2="10769"/>
                        <a14:foregroundMark x1="32432" y1="12308" x2="32432" y2="12308"/>
                        <a14:foregroundMark x1="31955" y1="13333" x2="31955" y2="13333"/>
                        <a14:foregroundMark x1="31955" y1="13333" x2="31638" y2="14359"/>
                        <a14:foregroundMark x1="31161" y1="15385" x2="31161" y2="15385"/>
                        <a14:foregroundMark x1="30366" y1="17436" x2="30048" y2="20000"/>
                        <a14:foregroundMark x1="29253" y1="22564" x2="29094" y2="24103"/>
                        <a14:foregroundMark x1="28935" y1="27692" x2="28617" y2="28718"/>
                        <a14:foregroundMark x1="28617" y1="27692" x2="29412" y2="23590"/>
                        <a14:foregroundMark x1="30048" y1="21538" x2="30366" y2="18974"/>
                        <a14:foregroundMark x1="31002" y1="15385" x2="31002" y2="15385"/>
                        <a14:foregroundMark x1="31161" y1="14359" x2="31161" y2="14359"/>
                        <a14:foregroundMark x1="31797" y1="13846" x2="31797" y2="13846"/>
                        <a14:foregroundMark x1="31797" y1="13846" x2="31797" y2="13846"/>
                        <a14:foregroundMark x1="31955" y1="13846" x2="31955" y2="13846"/>
                        <a14:foregroundMark x1="31955" y1="13846" x2="31955" y2="13846"/>
                        <a14:foregroundMark x1="31955" y1="13846" x2="31955" y2="13846"/>
                        <a14:foregroundMark x1="31955" y1="13846" x2="31955" y2="13846"/>
                        <a14:foregroundMark x1="32114" y1="13333" x2="32114" y2="13333"/>
                        <a14:foregroundMark x1="32114" y1="13333" x2="31797" y2="13846"/>
                        <a14:foregroundMark x1="31479" y1="14359" x2="31479" y2="14359"/>
                        <a14:foregroundMark x1="30684" y1="15897" x2="30684" y2="15897"/>
                        <a14:foregroundMark x1="30207" y1="17949" x2="29889" y2="20513"/>
                        <a14:foregroundMark x1="29412" y1="26154" x2="29412" y2="32308"/>
                        <a14:foregroundMark x1="29730" y1="36923" x2="29889" y2="41026"/>
                        <a14:foregroundMark x1="29889" y1="46154" x2="30048" y2="51282"/>
                        <a14:foregroundMark x1="29730" y1="54359" x2="29253" y2="57436"/>
                        <a14:foregroundMark x1="28617" y1="63077" x2="28299" y2="65641"/>
                        <a14:foregroundMark x1="19555" y1="87692" x2="19237" y2="87179"/>
                        <a14:foregroundMark x1="14785" y1="87179" x2="14308" y2="87179"/>
                        <a14:foregroundMark x1="8903" y1="85641" x2="8585" y2="86154"/>
                        <a14:foregroundMark x1="8108" y1="85128" x2="6836" y2="81538"/>
                        <a14:foregroundMark x1="4769" y1="76410" x2="4769" y2="76410"/>
                        <a14:foregroundMark x1="4610" y1="73333" x2="4452" y2="67179"/>
                        <a14:foregroundMark x1="4293" y1="66667" x2="4293" y2="66667"/>
                        <a14:foregroundMark x1="4452" y1="65641" x2="12719" y2="64103"/>
                        <a14:foregroundMark x1="13037" y1="63590" x2="13672" y2="63590"/>
                        <a14:foregroundMark x1="17170" y1="63077" x2="17647" y2="62051"/>
                        <a14:foregroundMark x1="21622" y1="61538" x2="25914" y2="62051"/>
                        <a14:foregroundMark x1="29571" y1="62051" x2="34022" y2="62051"/>
                        <a14:foregroundMark x1="36089" y1="61538" x2="41335" y2="57436"/>
                        <a14:foregroundMark x1="46105" y1="53333" x2="47536" y2="50256"/>
                        <a14:foregroundMark x1="48649" y1="45128" x2="49762" y2="38462"/>
                        <a14:foregroundMark x1="49762" y1="35385" x2="49762" y2="34359"/>
                        <a14:foregroundMark x1="49762" y1="31795" x2="49762" y2="30769"/>
                        <a14:foregroundMark x1="49762" y1="29744" x2="49762" y2="28718"/>
                        <a14:foregroundMark x1="49762" y1="27692" x2="49762" y2="27692"/>
                        <a14:foregroundMark x1="49444" y1="25641" x2="49444" y2="25641"/>
                        <a14:foregroundMark x1="49444" y1="25128" x2="49444" y2="25128"/>
                        <a14:foregroundMark x1="48967" y1="24615" x2="48967" y2="24615"/>
                        <a14:foregroundMark x1="48967" y1="24103" x2="48967" y2="24103"/>
                        <a14:foregroundMark x1="48967" y1="23077" x2="48967" y2="23077"/>
                        <a14:foregroundMark x1="48967" y1="22051" x2="48967" y2="22051"/>
                        <a14:foregroundMark x1="50556" y1="22564" x2="50556" y2="22564"/>
                        <a14:foregroundMark x1="50556" y1="22564" x2="50556" y2="22564"/>
                        <a14:foregroundMark x1="52146" y1="23077" x2="52146" y2="23077"/>
                        <a14:foregroundMark x1="52146" y1="23077" x2="52146" y2="23077"/>
                        <a14:foregroundMark x1="52623" y1="24103" x2="53259" y2="26154"/>
                        <a14:foregroundMark x1="53577" y1="26667" x2="53577" y2="26667"/>
                        <a14:foregroundMark x1="54690" y1="31282" x2="55326" y2="34872"/>
                        <a14:foregroundMark x1="57711" y1="35385" x2="58824" y2="33333"/>
                        <a14:foregroundMark x1="59300" y1="32308" x2="61526" y2="30769"/>
                        <a14:foregroundMark x1="62321" y1="29231" x2="63116" y2="28205"/>
                        <a14:foregroundMark x1="63593" y1="27692" x2="66614" y2="26154"/>
                        <a14:foregroundMark x1="68680" y1="25641" x2="69634" y2="25641"/>
                        <a14:foregroundMark x1="71065" y1="25641" x2="71065" y2="25641"/>
                        <a14:foregroundMark x1="71065" y1="25641" x2="71065" y2="25641"/>
                        <a14:foregroundMark x1="85692" y1="61026" x2="85692" y2="61026"/>
                        <a14:foregroundMark x1="83625" y1="60513" x2="80604" y2="60513"/>
                        <a14:foregroundMark x1="75517" y1="60000" x2="75199" y2="60513"/>
                        <a14:foregroundMark x1="72973" y1="58974" x2="70747" y2="58974"/>
                        <a14:foregroundMark x1="68362" y1="56410" x2="72496" y2="52308"/>
                        <a14:foregroundMark x1="73768" y1="52308" x2="74245" y2="52308"/>
                        <a14:foregroundMark x1="76789" y1="52308" x2="77742" y2="52308"/>
                        <a14:foregroundMark x1="81240" y1="52308" x2="81240" y2="52308"/>
                        <a14:foregroundMark x1="81240" y1="52308" x2="81240" y2="52308"/>
                        <a14:foregroundMark x1="64865" y1="55385" x2="64865" y2="55385"/>
                        <a14:foregroundMark x1="63911" y1="55385" x2="63911" y2="55385"/>
                        <a14:foregroundMark x1="65342" y1="52821" x2="65342" y2="52821"/>
                        <a14:foregroundMark x1="67568" y1="52821" x2="67568" y2="52821"/>
                        <a14:foregroundMark x1="70906" y1="52821" x2="82194" y2="53846"/>
                        <a14:foregroundMark x1="83943" y1="54359" x2="84261" y2="54359"/>
                        <a14:foregroundMark x1="86486" y1="54359" x2="86963" y2="54359"/>
                        <a14:foregroundMark x1="87281" y1="54359" x2="87599" y2="54359"/>
                        <a14:foregroundMark x1="87917" y1="54359" x2="88235" y2="54359"/>
                        <a14:foregroundMark x1="89984" y1="52821" x2="90302" y2="53333"/>
                        <a14:foregroundMark x1="92210" y1="54872" x2="93164" y2="55897"/>
                        <a14:foregroundMark x1="95707" y1="56410" x2="95707" y2="56410"/>
                        <a14:foregroundMark x1="95866" y1="56923" x2="95390" y2="55897"/>
                        <a14:foregroundMark x1="93323" y1="54872" x2="93323" y2="54872"/>
                        <a14:foregroundMark x1="92528" y1="53333" x2="92528" y2="53333"/>
                        <a14:foregroundMark x1="91733" y1="52308" x2="91415" y2="51282"/>
                        <a14:foregroundMark x1="90938" y1="50256" x2="90938" y2="50256"/>
                        <a14:foregroundMark x1="90938" y1="50256" x2="90938" y2="50256"/>
                        <a14:foregroundMark x1="90779" y1="49744" x2="90779" y2="49744"/>
                        <a14:foregroundMark x1="89984" y1="48205" x2="89984" y2="48205"/>
                        <a14:foregroundMark x1="89984" y1="48205" x2="89984" y2="48205"/>
                        <a14:foregroundMark x1="89189" y1="48718" x2="89189" y2="48718"/>
                        <a14:foregroundMark x1="88394" y1="48718" x2="88394" y2="48718"/>
                        <a14:foregroundMark x1="88076" y1="49231" x2="87758" y2="51282"/>
                        <a14:foregroundMark x1="86486" y1="56923" x2="85851" y2="60513"/>
                        <a14:foregroundMark x1="52464" y1="22564" x2="52464" y2="22564"/>
                        <a14:foregroundMark x1="53895" y1="22564" x2="53895" y2="22564"/>
                        <a14:foregroundMark x1="54690" y1="24103" x2="54690" y2="24103"/>
                        <a14:foregroundMark x1="54372" y1="22564" x2="54372" y2="22564"/>
                        <a14:foregroundMark x1="54690" y1="22564" x2="54690" y2="22564"/>
                        <a14:foregroundMark x1="55326" y1="24103" x2="55326" y2="24103"/>
                      </a14:backgroundRemoval>
                    </a14:imgEffect>
                  </a14:imgLayer>
                </a14:imgProps>
              </a:ext>
              <a:ext uri="{28A0092B-C50C-407E-A947-70E740481C1C}">
                <a14:useLocalDpi xmlns:a14="http://schemas.microsoft.com/office/drawing/2010/main" val="0"/>
              </a:ext>
            </a:extLst>
          </a:blip>
          <a:stretch>
            <a:fillRect/>
          </a:stretch>
        </p:blipFill>
        <p:spPr>
          <a:xfrm>
            <a:off x="648000" y="5861634"/>
            <a:ext cx="7574083" cy="2348087"/>
          </a:xfrm>
          <a:prstGeom prst="rect">
            <a:avLst/>
          </a:prstGeom>
        </p:spPr>
      </p:pic>
      <p:sp>
        <p:nvSpPr>
          <p:cNvPr id="13" name="직사각형 12"/>
          <p:cNvSpPr/>
          <p:nvPr/>
        </p:nvSpPr>
        <p:spPr>
          <a:xfrm>
            <a:off x="336104" y="1432248"/>
            <a:ext cx="8573896" cy="720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79953" rtl="0" eaLnBrk="1" fontAlgn="auto" latinLnBrk="1" hangingPunct="1">
              <a:lnSpc>
                <a:spcPct val="100000"/>
              </a:lnSpc>
              <a:spcBef>
                <a:spcPts val="0"/>
              </a:spcBef>
              <a:spcAft>
                <a:spcPts val="0"/>
              </a:spcAft>
              <a:buClrTx/>
              <a:buSzTx/>
              <a:buFontTx/>
              <a:buNone/>
              <a:tabLst/>
              <a:defRPr/>
            </a:pPr>
            <a:r>
              <a:rPr kumimoji="0" lang="en-US" altLang="ko-KR" sz="2400" b="0" i="0" u="none" strike="noStrike" kern="1200" cap="none" spc="0" normalizeH="0" baseline="0" noProof="0" dirty="0">
                <a:ln>
                  <a:noFill/>
                </a:ln>
                <a:solidFill>
                  <a:prstClr val="black"/>
                </a:solidFill>
                <a:effectLst/>
                <a:uLnTx/>
                <a:uFillTx/>
                <a:latin typeface="HY헤드라인M" pitchFamily="18" charset="-127"/>
                <a:ea typeface="HY헤드라인M" pitchFamily="18" charset="-127"/>
                <a:cs typeface="+mn-cs"/>
              </a:rPr>
              <a:t>1st Set (   times) -&gt;  2nd Set (  times) -&gt;  3rd Set (  times)</a:t>
            </a:r>
            <a:endParaRPr kumimoji="0" lang="ko-KR" altLang="en-US" sz="2400" b="0" i="0" u="none" strike="noStrike" kern="1200" cap="none" spc="0" normalizeH="0" baseline="0" noProof="0" dirty="0">
              <a:ln>
                <a:noFill/>
              </a:ln>
              <a:solidFill>
                <a:prstClr val="black"/>
              </a:solidFill>
              <a:effectLst/>
              <a:uLnTx/>
              <a:uFillTx/>
              <a:latin typeface="HY헤드라인M" pitchFamily="18" charset="-127"/>
              <a:ea typeface="HY헤드라인M" pitchFamily="18" charset="-127"/>
              <a:cs typeface="+mn-cs"/>
            </a:endParaRPr>
          </a:p>
        </p:txBody>
      </p:sp>
    </p:spTree>
    <p:extLst>
      <p:ext uri="{BB962C8B-B14F-4D97-AF65-F5344CB8AC3E}">
        <p14:creationId xmlns:p14="http://schemas.microsoft.com/office/powerpoint/2010/main" val="3960066850"/>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2" name="모서리가 둥근 직사각형 21"/>
          <p:cNvSpPr/>
          <p:nvPr/>
        </p:nvSpPr>
        <p:spPr>
          <a:xfrm>
            <a:off x="311905" y="2627801"/>
            <a:ext cx="8100216" cy="2608925"/>
          </a:xfrm>
          <a:prstGeom prst="roundRect">
            <a:avLst/>
          </a:prstGeom>
          <a:noFill/>
          <a:ln w="50800">
            <a:solidFill>
              <a:srgbClr val="689E1D"/>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79953" rtl="0" eaLnBrk="1" fontAlgn="auto" latinLnBrk="1" hangingPunct="1">
              <a:lnSpc>
                <a:spcPct val="100000"/>
              </a:lnSpc>
              <a:spcBef>
                <a:spcPts val="0"/>
              </a:spcBef>
              <a:spcAft>
                <a:spcPts val="0"/>
              </a:spcAft>
              <a:buClrTx/>
              <a:buSzTx/>
              <a:buFontTx/>
              <a:buNone/>
              <a:tabLst/>
              <a:defRPr/>
            </a:pPr>
            <a:endParaRPr kumimoji="0" lang="ko-KR" altLang="en-US" sz="2500" b="0" i="0" u="none" strike="noStrike" kern="1200" cap="none" spc="0" normalizeH="0" baseline="0" noProof="0">
              <a:ln>
                <a:noFill/>
              </a:ln>
              <a:solidFill>
                <a:prstClr val="white"/>
              </a:solidFill>
              <a:effectLst/>
              <a:uLnTx/>
              <a:uFillTx/>
              <a:latin typeface="맑은 고딕"/>
              <a:ea typeface="맑은 고딕" panose="020B0503020000020004" pitchFamily="50" charset="-127"/>
              <a:cs typeface="+mn-cs"/>
            </a:endParaRPr>
          </a:p>
        </p:txBody>
      </p:sp>
      <p:sp>
        <p:nvSpPr>
          <p:cNvPr id="37" name="직사각형 36"/>
          <p:cNvSpPr/>
          <p:nvPr/>
        </p:nvSpPr>
        <p:spPr>
          <a:xfrm>
            <a:off x="108000" y="8488832"/>
            <a:ext cx="8802000" cy="4176664"/>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457200" marR="0" lvl="0" indent="-457200" algn="l" defTabSz="1279953" rtl="0" eaLnBrk="1" fontAlgn="auto" latinLnBrk="1" hangingPunct="1">
              <a:lnSpc>
                <a:spcPct val="100000"/>
              </a:lnSpc>
              <a:spcBef>
                <a:spcPts val="0"/>
              </a:spcBef>
              <a:spcAft>
                <a:spcPts val="0"/>
              </a:spcAft>
              <a:buClrTx/>
              <a:buSzTx/>
              <a:buFontTx/>
              <a:buAutoNum type="arabicPeriod"/>
              <a:tabLst/>
              <a:defRPr/>
            </a:pPr>
            <a:r>
              <a:rPr kumimoji="0" lang="en-US" altLang="ko-KR" sz="2400" b="0" i="0" u="none" strike="noStrike" kern="1200" cap="none" spc="-150" normalizeH="0" baseline="0" noProof="0" dirty="0">
                <a:ln>
                  <a:noFill/>
                </a:ln>
                <a:solidFill>
                  <a:prstClr val="black">
                    <a:lumMod val="75000"/>
                    <a:lumOff val="25000"/>
                  </a:prstClr>
                </a:solidFill>
                <a:effectLst/>
                <a:uLnTx/>
                <a:uFillTx/>
                <a:latin typeface="HY헤드라인M" pitchFamily="18" charset="-127"/>
                <a:ea typeface="HY헤드라인M" pitchFamily="18" charset="-127"/>
                <a:cs typeface="+mn-cs"/>
              </a:rPr>
              <a:t>Lie on your side with your knees bent at 45 degrees and your elbow supporting your torso.</a:t>
            </a:r>
          </a:p>
          <a:p>
            <a:pPr marL="457200" marR="0" lvl="0" indent="-457200" algn="l" defTabSz="1279953" rtl="0" eaLnBrk="1" fontAlgn="auto" latinLnBrk="1" hangingPunct="1">
              <a:lnSpc>
                <a:spcPct val="100000"/>
              </a:lnSpc>
              <a:spcBef>
                <a:spcPts val="0"/>
              </a:spcBef>
              <a:spcAft>
                <a:spcPts val="0"/>
              </a:spcAft>
              <a:buClrTx/>
              <a:buSzTx/>
              <a:buFontTx/>
              <a:buAutoNum type="arabicPeriod"/>
              <a:tabLst/>
              <a:defRPr/>
            </a:pPr>
            <a:endParaRPr kumimoji="0" lang="en-US" altLang="ko-KR" sz="2400" b="0" i="0" u="none" strike="noStrike" kern="1200" cap="none" spc="-150" normalizeH="0" baseline="0" noProof="0" dirty="0">
              <a:ln>
                <a:noFill/>
              </a:ln>
              <a:solidFill>
                <a:prstClr val="black">
                  <a:lumMod val="75000"/>
                  <a:lumOff val="25000"/>
                </a:prstClr>
              </a:solidFill>
              <a:effectLst/>
              <a:uLnTx/>
              <a:uFillTx/>
              <a:latin typeface="HY헤드라인M" pitchFamily="18" charset="-127"/>
              <a:ea typeface="HY헤드라인M" pitchFamily="18" charset="-127"/>
              <a:cs typeface="+mn-cs"/>
            </a:endParaRPr>
          </a:p>
          <a:p>
            <a:pPr marL="457200" marR="0" lvl="0" indent="-457200" algn="l" defTabSz="1279953" rtl="0" eaLnBrk="1" fontAlgn="auto" latinLnBrk="1" hangingPunct="1">
              <a:lnSpc>
                <a:spcPct val="100000"/>
              </a:lnSpc>
              <a:spcBef>
                <a:spcPts val="0"/>
              </a:spcBef>
              <a:spcAft>
                <a:spcPts val="0"/>
              </a:spcAft>
              <a:buClrTx/>
              <a:buSzTx/>
              <a:buFontTx/>
              <a:buAutoNum type="arabicPeriod"/>
              <a:tabLst/>
              <a:defRPr/>
            </a:pPr>
            <a:r>
              <a:rPr kumimoji="0" lang="en-US" altLang="ko-KR" sz="2400" b="0" i="0" u="none" strike="noStrike" kern="1200" cap="none" spc="-150" normalizeH="0" baseline="0" noProof="0" dirty="0">
                <a:ln>
                  <a:noFill/>
                </a:ln>
                <a:solidFill>
                  <a:prstClr val="black">
                    <a:lumMod val="75000"/>
                    <a:lumOff val="25000"/>
                  </a:prstClr>
                </a:solidFill>
                <a:effectLst/>
                <a:uLnTx/>
                <a:uFillTx/>
                <a:latin typeface="HY헤드라인M" pitchFamily="18" charset="-127"/>
                <a:ea typeface="HY헤드라인M" pitchFamily="18" charset="-127"/>
                <a:cs typeface="+mn-cs"/>
              </a:rPr>
              <a:t>Straighten your back and brace your abdomen. Then lift your pelvis from the floor and push it forward. Try to keep your knees stable and your head and torso in a straight line. </a:t>
            </a:r>
          </a:p>
          <a:p>
            <a:pPr marL="457200" marR="0" lvl="0" indent="-457200" algn="l" defTabSz="1279953" rtl="0" eaLnBrk="1" fontAlgn="auto" latinLnBrk="1" hangingPunct="1">
              <a:lnSpc>
                <a:spcPct val="100000"/>
              </a:lnSpc>
              <a:spcBef>
                <a:spcPts val="0"/>
              </a:spcBef>
              <a:spcAft>
                <a:spcPts val="0"/>
              </a:spcAft>
              <a:buClrTx/>
              <a:buSzTx/>
              <a:buFontTx/>
              <a:buAutoNum type="arabicPeriod"/>
              <a:tabLst/>
              <a:defRPr/>
            </a:pPr>
            <a:endParaRPr kumimoji="0" lang="en-US" altLang="ko-KR" sz="2400" b="0" i="0" u="none" strike="noStrike" kern="1200" cap="none" spc="-150" normalizeH="0" baseline="0" noProof="0" dirty="0">
              <a:ln>
                <a:noFill/>
              </a:ln>
              <a:solidFill>
                <a:prstClr val="black">
                  <a:lumMod val="75000"/>
                  <a:lumOff val="25000"/>
                </a:prstClr>
              </a:solidFill>
              <a:effectLst/>
              <a:uLnTx/>
              <a:uFillTx/>
              <a:latin typeface="HY헤드라인M" pitchFamily="18" charset="-127"/>
              <a:ea typeface="HY헤드라인M" pitchFamily="18" charset="-127"/>
              <a:cs typeface="+mn-cs"/>
            </a:endParaRPr>
          </a:p>
          <a:p>
            <a:pPr marL="457200" marR="0" lvl="0" indent="-457200" algn="l" defTabSz="1279953" rtl="0" eaLnBrk="1" fontAlgn="auto" latinLnBrk="1" hangingPunct="1">
              <a:lnSpc>
                <a:spcPct val="100000"/>
              </a:lnSpc>
              <a:spcBef>
                <a:spcPts val="0"/>
              </a:spcBef>
              <a:spcAft>
                <a:spcPts val="0"/>
              </a:spcAft>
              <a:buClrTx/>
              <a:buSzTx/>
              <a:buFontTx/>
              <a:buAutoNum type="arabicPeriod"/>
              <a:tabLst/>
              <a:defRPr/>
            </a:pPr>
            <a:r>
              <a:rPr kumimoji="0" lang="en-US" altLang="ko-KR" sz="2400" b="0" i="0" u="none" strike="noStrike" kern="1200" cap="none" spc="-150" normalizeH="0" baseline="0" noProof="0" dirty="0">
                <a:ln>
                  <a:noFill/>
                </a:ln>
                <a:solidFill>
                  <a:prstClr val="black">
                    <a:lumMod val="75000"/>
                    <a:lumOff val="25000"/>
                  </a:prstClr>
                </a:solidFill>
                <a:effectLst/>
                <a:uLnTx/>
                <a:uFillTx/>
                <a:latin typeface="HY헤드라인M" pitchFamily="18" charset="-127"/>
                <a:ea typeface="HY헤드라인M" pitchFamily="18" charset="-127"/>
                <a:cs typeface="+mn-cs"/>
              </a:rPr>
              <a:t>Once your torso is in a straight line, return to your first position. </a:t>
            </a:r>
          </a:p>
          <a:p>
            <a:pPr marL="457200" marR="0" lvl="0" indent="-457200" algn="l" defTabSz="1279953" rtl="0" eaLnBrk="1" fontAlgn="auto" latinLnBrk="1" hangingPunct="1">
              <a:lnSpc>
                <a:spcPct val="100000"/>
              </a:lnSpc>
              <a:spcBef>
                <a:spcPts val="0"/>
              </a:spcBef>
              <a:spcAft>
                <a:spcPts val="0"/>
              </a:spcAft>
              <a:buClrTx/>
              <a:buSzTx/>
              <a:buFontTx/>
              <a:buAutoNum type="arabicPeriod"/>
              <a:tabLst/>
              <a:defRPr/>
            </a:pPr>
            <a:endParaRPr kumimoji="0" lang="en-US" altLang="ko-KR" sz="2400" b="0" i="0" u="none" strike="noStrike" kern="1200" cap="none" spc="-150" normalizeH="0" baseline="0" noProof="0" dirty="0">
              <a:ln>
                <a:noFill/>
              </a:ln>
              <a:solidFill>
                <a:prstClr val="black">
                  <a:lumMod val="75000"/>
                  <a:lumOff val="25000"/>
                </a:prstClr>
              </a:solidFill>
              <a:effectLst/>
              <a:uLnTx/>
              <a:uFillTx/>
              <a:latin typeface="HY헤드라인M" pitchFamily="18" charset="-127"/>
              <a:ea typeface="HY헤드라인M" pitchFamily="18" charset="-127"/>
              <a:cs typeface="+mn-cs"/>
            </a:endParaRPr>
          </a:p>
          <a:p>
            <a:pPr marL="457200" marR="0" lvl="0" indent="-457200" algn="l" defTabSz="1279953" rtl="0" eaLnBrk="1" fontAlgn="auto" latinLnBrk="1" hangingPunct="1">
              <a:lnSpc>
                <a:spcPct val="100000"/>
              </a:lnSpc>
              <a:spcBef>
                <a:spcPts val="0"/>
              </a:spcBef>
              <a:spcAft>
                <a:spcPts val="0"/>
              </a:spcAft>
              <a:buClrTx/>
              <a:buSzTx/>
              <a:buFontTx/>
              <a:buAutoNum type="arabicPeriod"/>
              <a:tabLst/>
              <a:defRPr/>
            </a:pPr>
            <a:r>
              <a:rPr kumimoji="0" lang="en-US" altLang="ko-KR" sz="2400" b="0" i="0" u="none" strike="noStrike" kern="1200" cap="none" spc="-150" normalizeH="0" baseline="0" noProof="0" dirty="0">
                <a:ln>
                  <a:noFill/>
                </a:ln>
                <a:solidFill>
                  <a:prstClr val="black">
                    <a:lumMod val="75000"/>
                    <a:lumOff val="25000"/>
                  </a:prstClr>
                </a:solidFill>
                <a:effectLst/>
                <a:uLnTx/>
                <a:uFillTx/>
                <a:latin typeface="HY헤드라인M" pitchFamily="18" charset="-127"/>
                <a:ea typeface="HY헤드라인M" pitchFamily="18" charset="-127"/>
                <a:cs typeface="+mn-cs"/>
              </a:rPr>
              <a:t>Perform 3 sets consecutively. Then shift to the other side and repeat the exercise.</a:t>
            </a:r>
          </a:p>
        </p:txBody>
      </p:sp>
      <p:sp>
        <p:nvSpPr>
          <p:cNvPr id="40" name="직사각형 39"/>
          <p:cNvSpPr/>
          <p:nvPr/>
        </p:nvSpPr>
        <p:spPr>
          <a:xfrm>
            <a:off x="876104" y="2080320"/>
            <a:ext cx="2520000" cy="720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79953" rtl="0" eaLnBrk="1" fontAlgn="auto" latinLnBrk="1" hangingPunct="1">
              <a:lnSpc>
                <a:spcPct val="100000"/>
              </a:lnSpc>
              <a:spcBef>
                <a:spcPts val="0"/>
              </a:spcBef>
              <a:spcAft>
                <a:spcPts val="0"/>
              </a:spcAft>
              <a:buClrTx/>
              <a:buSzTx/>
              <a:buFontTx/>
              <a:buNone/>
              <a:tabLst/>
              <a:defRPr/>
            </a:pPr>
            <a:r>
              <a:rPr kumimoji="0" lang="en-US" altLang="ko-KR" sz="2500" b="0" i="0" u="none" strike="noStrike" kern="1200" cap="none" spc="0" normalizeH="0" baseline="0" noProof="0" dirty="0">
                <a:ln>
                  <a:noFill/>
                </a:ln>
                <a:solidFill>
                  <a:prstClr val="black"/>
                </a:solidFill>
                <a:effectLst/>
                <a:uLnTx/>
                <a:uFillTx/>
                <a:latin typeface="HY헤드라인M" pitchFamily="18" charset="-127"/>
                <a:ea typeface="HY헤드라인M" pitchFamily="18" charset="-127"/>
                <a:cs typeface="+mn-cs"/>
              </a:rPr>
              <a:t>Preparation</a:t>
            </a:r>
            <a:endParaRPr kumimoji="0" lang="ko-KR" altLang="en-US" sz="2500" b="0" i="0" u="none" strike="noStrike" kern="1200" cap="none" spc="0" normalizeH="0" baseline="0" noProof="0" dirty="0">
              <a:ln>
                <a:noFill/>
              </a:ln>
              <a:solidFill>
                <a:prstClr val="black"/>
              </a:solidFill>
              <a:effectLst/>
              <a:uLnTx/>
              <a:uFillTx/>
              <a:latin typeface="HY헤드라인M" pitchFamily="18" charset="-127"/>
              <a:ea typeface="HY헤드라인M" pitchFamily="18" charset="-127"/>
              <a:cs typeface="+mn-cs"/>
            </a:endParaRPr>
          </a:p>
        </p:txBody>
      </p:sp>
      <p:sp>
        <p:nvSpPr>
          <p:cNvPr id="2" name="직사각형 1"/>
          <p:cNvSpPr/>
          <p:nvPr/>
        </p:nvSpPr>
        <p:spPr>
          <a:xfrm>
            <a:off x="0" y="0"/>
            <a:ext cx="9601200" cy="1432248"/>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79953" rtl="0" eaLnBrk="1" fontAlgn="auto" latinLnBrk="1" hangingPunct="1">
              <a:lnSpc>
                <a:spcPct val="100000"/>
              </a:lnSpc>
              <a:spcBef>
                <a:spcPts val="0"/>
              </a:spcBef>
              <a:spcAft>
                <a:spcPts val="0"/>
              </a:spcAft>
              <a:buClrTx/>
              <a:buSzTx/>
              <a:buFontTx/>
              <a:buNone/>
              <a:tabLst/>
              <a:defRPr/>
            </a:pPr>
            <a:r>
              <a:rPr kumimoji="0" lang="en-US" altLang="ko-KR" sz="5000" b="0" i="0" u="none" strike="noStrike" kern="1200" cap="none" spc="0" normalizeH="0" baseline="0" noProof="0" dirty="0">
                <a:ln>
                  <a:noFill/>
                </a:ln>
                <a:solidFill>
                  <a:srgbClr val="689E1D"/>
                </a:solidFill>
                <a:effectLst/>
                <a:uLnTx/>
                <a:uFillTx/>
                <a:latin typeface="HY헤드라인M" pitchFamily="18" charset="-127"/>
                <a:ea typeface="HY헤드라인M" pitchFamily="18" charset="-127"/>
                <a:cs typeface="+mn-cs"/>
              </a:rPr>
              <a:t>Side Bridge Exercise</a:t>
            </a:r>
          </a:p>
        </p:txBody>
      </p:sp>
      <p:sp>
        <p:nvSpPr>
          <p:cNvPr id="12" name="모서리가 둥근 직사각형 11"/>
          <p:cNvSpPr/>
          <p:nvPr/>
        </p:nvSpPr>
        <p:spPr>
          <a:xfrm>
            <a:off x="336104" y="5680720"/>
            <a:ext cx="8100216" cy="2608925"/>
          </a:xfrm>
          <a:prstGeom prst="roundRect">
            <a:avLst/>
          </a:prstGeom>
          <a:noFill/>
          <a:ln w="50800">
            <a:solidFill>
              <a:srgbClr val="689E1D"/>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79953" rtl="0" eaLnBrk="1" fontAlgn="auto" latinLnBrk="1" hangingPunct="1">
              <a:lnSpc>
                <a:spcPct val="100000"/>
              </a:lnSpc>
              <a:spcBef>
                <a:spcPts val="0"/>
              </a:spcBef>
              <a:spcAft>
                <a:spcPts val="0"/>
              </a:spcAft>
              <a:buClrTx/>
              <a:buSzTx/>
              <a:buFontTx/>
              <a:buNone/>
              <a:tabLst/>
              <a:defRPr/>
            </a:pPr>
            <a:endParaRPr kumimoji="0" lang="ko-KR" altLang="en-US" sz="2500" b="0" i="0" u="none" strike="noStrike" kern="1200" cap="none" spc="0" normalizeH="0" baseline="0" noProof="0">
              <a:ln>
                <a:noFill/>
              </a:ln>
              <a:solidFill>
                <a:prstClr val="white"/>
              </a:solidFill>
              <a:effectLst/>
              <a:uLnTx/>
              <a:uFillTx/>
              <a:latin typeface="맑은 고딕"/>
              <a:ea typeface="맑은 고딕" panose="020B0503020000020004" pitchFamily="50" charset="-127"/>
              <a:cs typeface="+mn-cs"/>
            </a:endParaRPr>
          </a:p>
        </p:txBody>
      </p:sp>
      <p:sp>
        <p:nvSpPr>
          <p:cNvPr id="14" name="직사각형 13"/>
          <p:cNvSpPr/>
          <p:nvPr/>
        </p:nvSpPr>
        <p:spPr>
          <a:xfrm>
            <a:off x="876104" y="5104656"/>
            <a:ext cx="2520000" cy="720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79953" rtl="0" eaLnBrk="1" fontAlgn="auto" latinLnBrk="1" hangingPunct="1">
              <a:lnSpc>
                <a:spcPct val="100000"/>
              </a:lnSpc>
              <a:spcBef>
                <a:spcPts val="0"/>
              </a:spcBef>
              <a:spcAft>
                <a:spcPts val="0"/>
              </a:spcAft>
              <a:buClrTx/>
              <a:buSzTx/>
              <a:buFontTx/>
              <a:buNone/>
              <a:tabLst/>
              <a:defRPr/>
            </a:pPr>
            <a:r>
              <a:rPr kumimoji="0" lang="en-US" altLang="ko-KR" sz="2500" b="0" i="0" u="none" strike="noStrike" kern="1200" cap="none" spc="0" normalizeH="0" baseline="0" noProof="0" dirty="0">
                <a:ln>
                  <a:noFill/>
                </a:ln>
                <a:solidFill>
                  <a:prstClr val="black"/>
                </a:solidFill>
                <a:effectLst/>
                <a:uLnTx/>
                <a:uFillTx/>
                <a:latin typeface="HY헤드라인M" pitchFamily="18" charset="-127"/>
                <a:ea typeface="HY헤드라인M" pitchFamily="18" charset="-127"/>
                <a:cs typeface="+mn-cs"/>
              </a:rPr>
              <a:t>Exercise</a:t>
            </a:r>
            <a:endParaRPr kumimoji="0" lang="ko-KR" altLang="en-US" sz="2500" b="0" i="0" u="none" strike="noStrike" kern="1200" cap="none" spc="0" normalizeH="0" baseline="0" noProof="0" dirty="0">
              <a:ln>
                <a:noFill/>
              </a:ln>
              <a:solidFill>
                <a:prstClr val="black"/>
              </a:solidFill>
              <a:effectLst/>
              <a:uLnTx/>
              <a:uFillTx/>
              <a:latin typeface="HY헤드라인M" pitchFamily="18" charset="-127"/>
              <a:ea typeface="HY헤드라인M" pitchFamily="18" charset="-127"/>
              <a:cs typeface="+mn-cs"/>
            </a:endParaRPr>
          </a:p>
        </p:txBody>
      </p:sp>
      <p:pic>
        <p:nvPicPr>
          <p:cNvPr id="3" name="그림 2"/>
          <p:cNvPicPr>
            <a:picLocks noChangeAspect="1"/>
          </p:cNvPicPr>
          <p:nvPr/>
        </p:nvPicPr>
        <p:blipFill>
          <a:blip r:embed="rId2">
            <a:extLst>
              <a:ext uri="{BEBA8EAE-BF5A-486C-A8C5-ECC9F3942E4B}">
                <a14:imgProps xmlns:a14="http://schemas.microsoft.com/office/drawing/2010/main">
                  <a14:imgLayer r:embed="rId3">
                    <a14:imgEffect>
                      <a14:backgroundRemoval t="0" b="100000" l="0" r="100000">
                        <a14:foregroundMark x1="8071" y1="82403" x2="8071" y2="82403"/>
                        <a14:foregroundMark x1="15157" y1="83691" x2="15157" y2="83691"/>
                        <a14:foregroundMark x1="20079" y1="83691" x2="22638" y2="84979"/>
                        <a14:foregroundMark x1="26575" y1="86266" x2="28740" y2="86266"/>
                        <a14:foregroundMark x1="33465" y1="86266" x2="37402" y2="87554"/>
                        <a14:foregroundMark x1="39370" y1="87554" x2="40354" y2="87554"/>
                        <a14:foregroundMark x1="44094" y1="87983" x2="50591" y2="88841"/>
                        <a14:foregroundMark x1="55315" y1="88841" x2="58465" y2="89270"/>
                        <a14:foregroundMark x1="64764" y1="90558" x2="74409" y2="90987"/>
                        <a14:foregroundMark x1="89173" y1="90987" x2="91732" y2="91845"/>
                        <a14:foregroundMark x1="99409" y1="90987" x2="99409" y2="90987"/>
                        <a14:foregroundMark x1="93504" y1="83691" x2="93110" y2="82403"/>
                        <a14:foregroundMark x1="88976" y1="77682" x2="88976" y2="77682"/>
                        <a14:foregroundMark x1="87992" y1="77253" x2="87992" y2="77253"/>
                        <a14:foregroundMark x1="87992" y1="77682" x2="87992" y2="77682"/>
                        <a14:foregroundMark x1="87992" y1="77682" x2="87992" y2="77682"/>
                        <a14:foregroundMark x1="87992" y1="76824" x2="87992" y2="76824"/>
                        <a14:foregroundMark x1="87992" y1="75536" x2="87992" y2="75536"/>
                        <a14:foregroundMark x1="88189" y1="74249" x2="88189" y2="74249"/>
                        <a14:foregroundMark x1="88976" y1="74249" x2="88976" y2="74249"/>
                        <a14:foregroundMark x1="89173" y1="74249" x2="89173" y2="74249"/>
                        <a14:foregroundMark x1="89173" y1="74249" x2="89764" y2="74249"/>
                        <a14:foregroundMark x1="89961" y1="75107" x2="91732" y2="77682"/>
                        <a14:foregroundMark x1="96260" y1="77682" x2="96063" y2="78541"/>
                        <a14:foregroundMark x1="96063" y1="78541" x2="96063" y2="78541"/>
                        <a14:foregroundMark x1="96063" y1="76824" x2="96654" y2="79399"/>
                        <a14:foregroundMark x1="97638" y1="84120" x2="97638" y2="84120"/>
                        <a14:foregroundMark x1="83268" y1="85408" x2="70866" y2="86266"/>
                        <a14:foregroundMark x1="45079" y1="86266" x2="31496" y2="83262"/>
                        <a14:foregroundMark x1="14173" y1="80258" x2="9449" y2="80687"/>
                        <a14:foregroundMark x1="5906" y1="78970" x2="5906" y2="78970"/>
                        <a14:foregroundMark x1="5709" y1="78541" x2="7283" y2="77682"/>
                        <a14:foregroundMark x1="8465" y1="77682" x2="8465" y2="77682"/>
                        <a14:foregroundMark x1="8661" y1="77682" x2="8661" y2="77682"/>
                        <a14:foregroundMark x1="15748" y1="77682" x2="15748" y2="77682"/>
                        <a14:foregroundMark x1="15945" y1="77682" x2="16929" y2="76824"/>
                        <a14:backgroundMark x1="12402" y1="45923" x2="12402" y2="45923"/>
                        <a14:backgroundMark x1="29724" y1="66524" x2="29724" y2="66524"/>
                        <a14:backgroundMark x1="25787" y1="9871" x2="25787" y2="9871"/>
                        <a14:backgroundMark x1="59843" y1="16738" x2="59843" y2="16738"/>
                      </a14:backgroundRemoval>
                    </a14:imgEffect>
                  </a14:imgLayer>
                </a14:imgProps>
              </a:ext>
              <a:ext uri="{28A0092B-C50C-407E-A947-70E740481C1C}">
                <a14:useLocalDpi xmlns:a14="http://schemas.microsoft.com/office/drawing/2010/main" val="0"/>
              </a:ext>
            </a:extLst>
          </a:blip>
          <a:stretch>
            <a:fillRect/>
          </a:stretch>
        </p:blipFill>
        <p:spPr>
          <a:xfrm>
            <a:off x="1560240" y="2688410"/>
            <a:ext cx="5460354" cy="2504454"/>
          </a:xfrm>
          <a:prstGeom prst="rect">
            <a:avLst/>
          </a:prstGeom>
        </p:spPr>
      </p:pic>
      <p:pic>
        <p:nvPicPr>
          <p:cNvPr id="4" name="그림 3"/>
          <p:cNvPicPr>
            <a:picLocks noChangeAspect="1"/>
          </p:cNvPicPr>
          <p:nvPr/>
        </p:nvPicPr>
        <p:blipFill>
          <a:blip r:embed="rId4">
            <a:extLst>
              <a:ext uri="{BEBA8EAE-BF5A-486C-A8C5-ECC9F3942E4B}">
                <a14:imgProps xmlns:a14="http://schemas.microsoft.com/office/drawing/2010/main">
                  <a14:imgLayer r:embed="rId5">
                    <a14:imgEffect>
                      <a14:backgroundRemoval t="0" b="100000" l="0" r="100000">
                        <a14:foregroundMark x1="9180" y1="79412" x2="9180" y2="79412"/>
                        <a14:foregroundMark x1="46875" y1="86555" x2="46875" y2="86555"/>
                        <a14:foregroundMark x1="77734" y1="87815" x2="77734" y2="87815"/>
                        <a14:foregroundMark x1="90039" y1="75210" x2="90039" y2="75210"/>
                        <a14:foregroundMark x1="88672" y1="69328" x2="88672" y2="69328"/>
                        <a14:foregroundMark x1="88867" y1="65546" x2="88867" y2="65546"/>
                        <a14:foregroundMark x1="87891" y1="74790" x2="88281" y2="76050"/>
                        <a14:foregroundMark x1="94727" y1="78571" x2="94727" y2="78571"/>
                        <a14:foregroundMark x1="94727" y1="78571" x2="94727" y2="78571"/>
                        <a14:foregroundMark x1="95313" y1="78571" x2="95508" y2="80252"/>
                        <a14:foregroundMark x1="94922" y1="85714" x2="94922" y2="85714"/>
                        <a14:foregroundMark x1="90039" y1="86555" x2="88867" y2="87815"/>
                        <a14:foregroundMark x1="85156" y1="88655" x2="85156" y2="88655"/>
                        <a14:foregroundMark x1="82617" y1="89496" x2="81836" y2="87815"/>
                        <a14:foregroundMark x1="65820" y1="86134" x2="65234" y2="86134"/>
                        <a14:foregroundMark x1="62891" y1="86134" x2="62891" y2="86134"/>
                        <a14:foregroundMark x1="48242" y1="86134" x2="47266" y2="86134"/>
                        <a14:foregroundMark x1="40039" y1="86134" x2="38477" y2="86134"/>
                        <a14:foregroundMark x1="29102" y1="86134" x2="29102" y2="86134"/>
                        <a14:foregroundMark x1="28125" y1="86134" x2="28125" y2="86134"/>
                        <a14:foregroundMark x1="30859" y1="83613" x2="30859" y2="83613"/>
                        <a14:foregroundMark x1="31250" y1="81513" x2="31250" y2="81513"/>
                        <a14:foregroundMark x1="32031" y1="79412" x2="32031" y2="79412"/>
                        <a14:foregroundMark x1="36133" y1="79832" x2="33203" y2="81513"/>
                        <a14:foregroundMark x1="11719" y1="81933" x2="11719" y2="81933"/>
                        <a14:foregroundMark x1="9570" y1="81933" x2="9570" y2="81933"/>
                        <a14:foregroundMark x1="9570" y1="81933" x2="9570" y2="81933"/>
                        <a14:foregroundMark x1="9570" y1="81933" x2="9570" y2="81933"/>
                        <a14:backgroundMark x1="12500" y1="43697" x2="12500" y2="43697"/>
                        <a14:backgroundMark x1="24219" y1="10924" x2="24219" y2="10924"/>
                        <a14:backgroundMark x1="61133" y1="10924" x2="61133" y2="10924"/>
                        <a14:backgroundMark x1="30664" y1="64286" x2="30664" y2="64286"/>
                        <a14:backgroundMark x1="78711" y1="26050" x2="78711" y2="26050"/>
                      </a14:backgroundRemoval>
                    </a14:imgEffect>
                  </a14:imgLayer>
                </a14:imgProps>
              </a:ext>
              <a:ext uri="{28A0092B-C50C-407E-A947-70E740481C1C}">
                <a14:useLocalDpi xmlns:a14="http://schemas.microsoft.com/office/drawing/2010/main" val="0"/>
              </a:ext>
            </a:extLst>
          </a:blip>
          <a:stretch>
            <a:fillRect/>
          </a:stretch>
        </p:blipFill>
        <p:spPr>
          <a:xfrm>
            <a:off x="1704256" y="5749740"/>
            <a:ext cx="5316338" cy="2471267"/>
          </a:xfrm>
          <a:prstGeom prst="rect">
            <a:avLst/>
          </a:prstGeom>
        </p:spPr>
      </p:pic>
      <p:sp>
        <p:nvSpPr>
          <p:cNvPr id="13" name="직사각형 12"/>
          <p:cNvSpPr/>
          <p:nvPr/>
        </p:nvSpPr>
        <p:spPr>
          <a:xfrm>
            <a:off x="336104" y="1432248"/>
            <a:ext cx="8573896" cy="720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79953" rtl="0" eaLnBrk="1" fontAlgn="auto" latinLnBrk="1" hangingPunct="1">
              <a:lnSpc>
                <a:spcPct val="100000"/>
              </a:lnSpc>
              <a:spcBef>
                <a:spcPts val="0"/>
              </a:spcBef>
              <a:spcAft>
                <a:spcPts val="0"/>
              </a:spcAft>
              <a:buClrTx/>
              <a:buSzTx/>
              <a:buFontTx/>
              <a:buNone/>
              <a:tabLst/>
              <a:defRPr/>
            </a:pPr>
            <a:r>
              <a:rPr kumimoji="0" lang="en-US" altLang="ko-KR" sz="2400" b="0" i="0" u="none" strike="noStrike" kern="1200" cap="none" spc="0" normalizeH="0" baseline="0" noProof="0" dirty="0">
                <a:ln>
                  <a:noFill/>
                </a:ln>
                <a:solidFill>
                  <a:prstClr val="black"/>
                </a:solidFill>
                <a:effectLst/>
                <a:uLnTx/>
                <a:uFillTx/>
                <a:latin typeface="HY헤드라인M" pitchFamily="18" charset="-127"/>
                <a:ea typeface="HY헤드라인M" pitchFamily="18" charset="-127"/>
                <a:cs typeface="+mn-cs"/>
              </a:rPr>
              <a:t>1st Set (   times) -&gt;  2nd Set (  times) -&gt;  3rd Set (  times)</a:t>
            </a:r>
            <a:endParaRPr kumimoji="0" lang="ko-KR" altLang="en-US" sz="2400" b="0" i="0" u="none" strike="noStrike" kern="1200" cap="none" spc="0" normalizeH="0" baseline="0" noProof="0" dirty="0">
              <a:ln>
                <a:noFill/>
              </a:ln>
              <a:solidFill>
                <a:prstClr val="black"/>
              </a:solidFill>
              <a:effectLst/>
              <a:uLnTx/>
              <a:uFillTx/>
              <a:latin typeface="HY헤드라인M" pitchFamily="18" charset="-127"/>
              <a:ea typeface="HY헤드라인M" pitchFamily="18" charset="-127"/>
              <a:cs typeface="+mn-cs"/>
            </a:endParaRPr>
          </a:p>
        </p:txBody>
      </p:sp>
    </p:spTree>
    <p:extLst>
      <p:ext uri="{BB962C8B-B14F-4D97-AF65-F5344CB8AC3E}">
        <p14:creationId xmlns:p14="http://schemas.microsoft.com/office/powerpoint/2010/main" val="394706068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직사각형 6"/>
          <p:cNvSpPr/>
          <p:nvPr/>
        </p:nvSpPr>
        <p:spPr>
          <a:xfrm>
            <a:off x="912168" y="42730"/>
            <a:ext cx="7968672" cy="1898531"/>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altLang="ko-KR" sz="5000" dirty="0">
                <a:solidFill>
                  <a:srgbClr val="FF0000"/>
                </a:solidFill>
                <a:latin typeface="HY헤드라인M" pitchFamily="18" charset="-127"/>
                <a:ea typeface="HY헤드라인M" pitchFamily="18" charset="-127"/>
              </a:rPr>
              <a:t>McKenzie Extension Exercise</a:t>
            </a:r>
          </a:p>
        </p:txBody>
      </p:sp>
      <p:sp>
        <p:nvSpPr>
          <p:cNvPr id="62" name="직사각형 61"/>
          <p:cNvSpPr/>
          <p:nvPr/>
        </p:nvSpPr>
        <p:spPr>
          <a:xfrm>
            <a:off x="288000" y="11081320"/>
            <a:ext cx="9000000" cy="853622"/>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fontAlgn="base"/>
            <a:r>
              <a:rPr lang="en-US" altLang="ko-KR" sz="1800" b="1" dirty="0">
                <a:solidFill>
                  <a:srgbClr val="363636"/>
                </a:solidFill>
                <a:latin typeface="HY헤드라인M" pitchFamily="18" charset="-127"/>
                <a:ea typeface="HY헤드라인M" pitchFamily="18" charset="-127"/>
              </a:rPr>
              <a:t>Caution</a:t>
            </a:r>
          </a:p>
          <a:p>
            <a:pPr fontAlgn="base"/>
            <a:r>
              <a:rPr lang="en-US" altLang="ko-KR" sz="1800" b="1" dirty="0">
                <a:solidFill>
                  <a:srgbClr val="363636"/>
                </a:solidFill>
                <a:latin typeface="HY헤드라인M" pitchFamily="18" charset="-127"/>
                <a:ea typeface="HY헤드라인M" pitchFamily="18" charset="-127"/>
              </a:rPr>
              <a:t>Relax during the motions and </a:t>
            </a:r>
            <a:r>
              <a:rPr lang="en-US" altLang="ko-KR" sz="1800" b="1" dirty="0">
                <a:solidFill>
                  <a:schemeClr val="tx1">
                    <a:lumMod val="75000"/>
                    <a:lumOff val="25000"/>
                  </a:schemeClr>
                </a:solidFill>
                <a:latin typeface="HY헤드라인M" pitchFamily="18" charset="-127"/>
                <a:ea typeface="HY헤드라인M" pitchFamily="18" charset="-127"/>
              </a:rPr>
              <a:t>make</a:t>
            </a:r>
            <a:r>
              <a:rPr lang="en-US" altLang="ko-KR" sz="1800" b="1" dirty="0">
                <a:solidFill>
                  <a:srgbClr val="363636"/>
                </a:solidFill>
                <a:latin typeface="HY헤드라인M" pitchFamily="18" charset="-127"/>
                <a:ea typeface="HY헤드라인M" pitchFamily="18" charset="-127"/>
              </a:rPr>
              <a:t> </a:t>
            </a:r>
            <a:r>
              <a:rPr lang="en-US" altLang="ko-KR" sz="1800" b="1" dirty="0">
                <a:solidFill>
                  <a:schemeClr val="tx1">
                    <a:lumMod val="75000"/>
                    <a:lumOff val="25000"/>
                  </a:schemeClr>
                </a:solidFill>
                <a:latin typeface="HY헤드라인M" pitchFamily="18" charset="-127"/>
                <a:ea typeface="HY헤드라인M" pitchFamily="18" charset="-127"/>
              </a:rPr>
              <a:t>sure you feel no pain</a:t>
            </a:r>
            <a:r>
              <a:rPr lang="en-US" altLang="ko-KR" sz="1800" b="1" dirty="0">
                <a:solidFill>
                  <a:srgbClr val="363636"/>
                </a:solidFill>
                <a:latin typeface="HY헤드라인M" pitchFamily="18" charset="-127"/>
                <a:ea typeface="HY헤드라인M" pitchFamily="18" charset="-127"/>
              </a:rPr>
              <a:t>.</a:t>
            </a:r>
          </a:p>
        </p:txBody>
      </p:sp>
      <p:pic>
        <p:nvPicPr>
          <p:cNvPr id="1026" name="Picture 2"/>
          <p:cNvPicPr preferRelativeResize="0">
            <a:picLocks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6588008" y="12060000"/>
            <a:ext cx="2700000" cy="54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9" name="직사각형 8"/>
          <p:cNvSpPr/>
          <p:nvPr/>
        </p:nvSpPr>
        <p:spPr>
          <a:xfrm>
            <a:off x="288001" y="9425136"/>
            <a:ext cx="8746134" cy="1656184"/>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8925" indent="-288925" algn="just">
              <a:buAutoNum type="arabicPeriod"/>
            </a:pPr>
            <a:r>
              <a:rPr lang="en-US" altLang="ko-KR" sz="2000" dirty="0">
                <a:solidFill>
                  <a:schemeClr val="tx1"/>
                </a:solidFill>
                <a:latin typeface="HY헤드라인M" pitchFamily="18" charset="-127"/>
                <a:ea typeface="HY헤드라인M" pitchFamily="18" charset="-127"/>
              </a:rPr>
              <a:t>Support you back with your hands.</a:t>
            </a:r>
          </a:p>
          <a:p>
            <a:pPr marL="288925" indent="-288925" algn="just">
              <a:buAutoNum type="arabicPeriod"/>
            </a:pPr>
            <a:r>
              <a:rPr lang="en-US" altLang="ko-KR" sz="2000" dirty="0">
                <a:solidFill>
                  <a:schemeClr val="tx1"/>
                </a:solidFill>
                <a:latin typeface="HY헤드라인M" pitchFamily="18" charset="-127"/>
                <a:ea typeface="HY헤드라인M" pitchFamily="18" charset="-127"/>
              </a:rPr>
              <a:t>Breathe in through your nose and arch your torso backwards.</a:t>
            </a:r>
          </a:p>
          <a:p>
            <a:pPr marL="288925" indent="-288925" algn="just">
              <a:buAutoNum type="arabicPeriod"/>
            </a:pPr>
            <a:r>
              <a:rPr lang="en-US" altLang="ko-KR" sz="2000" dirty="0">
                <a:solidFill>
                  <a:schemeClr val="tx1"/>
                </a:solidFill>
                <a:latin typeface="HY헤드라인M" pitchFamily="18" charset="-127"/>
                <a:ea typeface="HY헤드라인M" pitchFamily="18" charset="-127"/>
              </a:rPr>
              <a:t>Hold your breath and maintain the position for 5 seconds.</a:t>
            </a:r>
          </a:p>
          <a:p>
            <a:pPr marL="288925" indent="-288925" algn="just">
              <a:buAutoNum type="arabicPeriod"/>
            </a:pPr>
            <a:r>
              <a:rPr lang="en-US" altLang="ko-KR" sz="2000" dirty="0">
                <a:solidFill>
                  <a:schemeClr val="tx1"/>
                </a:solidFill>
                <a:latin typeface="HY헤드라인M" pitchFamily="18" charset="-127"/>
                <a:ea typeface="HY헤드라인M" pitchFamily="18" charset="-127"/>
              </a:rPr>
              <a:t>Purse your lips and breathe out slowly. Resume your original position.</a:t>
            </a:r>
            <a:endParaRPr lang="ko-KR" altLang="en-US" sz="2000" dirty="0">
              <a:solidFill>
                <a:schemeClr val="tx1"/>
              </a:solidFill>
              <a:latin typeface="HY헤드라인M" pitchFamily="18" charset="-127"/>
              <a:ea typeface="HY헤드라인M" pitchFamily="18" charset="-127"/>
            </a:endParaRPr>
          </a:p>
        </p:txBody>
      </p:sp>
      <p:grpSp>
        <p:nvGrpSpPr>
          <p:cNvPr id="2" name="그룹 1"/>
          <p:cNvGrpSpPr/>
          <p:nvPr/>
        </p:nvGrpSpPr>
        <p:grpSpPr>
          <a:xfrm>
            <a:off x="2317494" y="2512086"/>
            <a:ext cx="4608584" cy="6769034"/>
            <a:chOff x="4717638" y="2368072"/>
            <a:chExt cx="4608584" cy="6769034"/>
          </a:xfrm>
        </p:grpSpPr>
        <p:sp>
          <p:nvSpPr>
            <p:cNvPr id="27" name="모서리가 둥근 직사각형 26"/>
            <p:cNvSpPr/>
            <p:nvPr/>
          </p:nvSpPr>
          <p:spPr>
            <a:xfrm>
              <a:off x="6952547" y="2368072"/>
              <a:ext cx="2081588" cy="6769034"/>
            </a:xfrm>
            <a:prstGeom prst="roundRect">
              <a:avLst/>
            </a:prstGeom>
            <a:solidFill>
              <a:schemeClr val="bg1"/>
            </a:solidFill>
            <a:ln w="50800">
              <a:solidFill>
                <a:srgbClr val="689E1D"/>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26" name="모서리가 둥근 직사각형 25"/>
            <p:cNvSpPr/>
            <p:nvPr/>
          </p:nvSpPr>
          <p:spPr>
            <a:xfrm>
              <a:off x="4717638" y="2368072"/>
              <a:ext cx="2081588" cy="6769034"/>
            </a:xfrm>
            <a:prstGeom prst="roundRect">
              <a:avLst/>
            </a:prstGeom>
            <a:solidFill>
              <a:schemeClr val="bg1"/>
            </a:solidFill>
            <a:ln w="50800">
              <a:solidFill>
                <a:srgbClr val="689E1D"/>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39" name="순서도: 지연 18"/>
            <p:cNvSpPr/>
            <p:nvPr/>
          </p:nvSpPr>
          <p:spPr>
            <a:xfrm>
              <a:off x="4824480" y="2500884"/>
              <a:ext cx="1894866" cy="1584000"/>
            </a:xfrm>
            <a:custGeom>
              <a:avLst/>
              <a:gdLst>
                <a:gd name="connsiteX0" fmla="*/ 0 w 3072440"/>
                <a:gd name="connsiteY0" fmla="*/ 0 h 1512168"/>
                <a:gd name="connsiteX1" fmla="*/ 1536220 w 3072440"/>
                <a:gd name="connsiteY1" fmla="*/ 0 h 1512168"/>
                <a:gd name="connsiteX2" fmla="*/ 3072440 w 3072440"/>
                <a:gd name="connsiteY2" fmla="*/ 756084 h 1512168"/>
                <a:gd name="connsiteX3" fmla="*/ 1536220 w 3072440"/>
                <a:gd name="connsiteY3" fmla="*/ 1512168 h 1512168"/>
                <a:gd name="connsiteX4" fmla="*/ 0 w 3072440"/>
                <a:gd name="connsiteY4" fmla="*/ 1512168 h 1512168"/>
                <a:gd name="connsiteX5" fmla="*/ 0 w 3072440"/>
                <a:gd name="connsiteY5" fmla="*/ 0 h 1512168"/>
                <a:gd name="connsiteX0" fmla="*/ 0 w 3144931"/>
                <a:gd name="connsiteY0" fmla="*/ 0 h 1512168"/>
                <a:gd name="connsiteX1" fmla="*/ 2378903 w 3144931"/>
                <a:gd name="connsiteY1" fmla="*/ 17929 h 1512168"/>
                <a:gd name="connsiteX2" fmla="*/ 3072440 w 3144931"/>
                <a:gd name="connsiteY2" fmla="*/ 756084 h 1512168"/>
                <a:gd name="connsiteX3" fmla="*/ 1536220 w 3144931"/>
                <a:gd name="connsiteY3" fmla="*/ 1512168 h 1512168"/>
                <a:gd name="connsiteX4" fmla="*/ 0 w 3144931"/>
                <a:gd name="connsiteY4" fmla="*/ 1512168 h 1512168"/>
                <a:gd name="connsiteX5" fmla="*/ 0 w 3144931"/>
                <a:gd name="connsiteY5" fmla="*/ 0 h 1512168"/>
                <a:gd name="connsiteX0" fmla="*/ 0 w 3086098"/>
                <a:gd name="connsiteY0" fmla="*/ 0 h 1512168"/>
                <a:gd name="connsiteX1" fmla="*/ 2378903 w 3086098"/>
                <a:gd name="connsiteY1" fmla="*/ 17929 h 1512168"/>
                <a:gd name="connsiteX2" fmla="*/ 3072440 w 3086098"/>
                <a:gd name="connsiteY2" fmla="*/ 756084 h 1512168"/>
                <a:gd name="connsiteX3" fmla="*/ 2343043 w 3086098"/>
                <a:gd name="connsiteY3" fmla="*/ 1494239 h 1512168"/>
                <a:gd name="connsiteX4" fmla="*/ 0 w 3086098"/>
                <a:gd name="connsiteY4" fmla="*/ 1512168 h 1512168"/>
                <a:gd name="connsiteX5" fmla="*/ 0 w 3086098"/>
                <a:gd name="connsiteY5" fmla="*/ 0 h 1512168"/>
                <a:gd name="connsiteX0" fmla="*/ 0 w 3086098"/>
                <a:gd name="connsiteY0" fmla="*/ 35859 h 1548027"/>
                <a:gd name="connsiteX1" fmla="*/ 2378903 w 3086098"/>
                <a:gd name="connsiteY1" fmla="*/ 0 h 1548027"/>
                <a:gd name="connsiteX2" fmla="*/ 3072440 w 3086098"/>
                <a:gd name="connsiteY2" fmla="*/ 791943 h 1548027"/>
                <a:gd name="connsiteX3" fmla="*/ 2343043 w 3086098"/>
                <a:gd name="connsiteY3" fmla="*/ 1530098 h 1548027"/>
                <a:gd name="connsiteX4" fmla="*/ 0 w 3086098"/>
                <a:gd name="connsiteY4" fmla="*/ 1548027 h 1548027"/>
                <a:gd name="connsiteX5" fmla="*/ 0 w 3086098"/>
                <a:gd name="connsiteY5" fmla="*/ 35859 h 1548027"/>
                <a:gd name="connsiteX0" fmla="*/ 0 w 3081850"/>
                <a:gd name="connsiteY0" fmla="*/ 0 h 1512168"/>
                <a:gd name="connsiteX1" fmla="*/ 2360973 w 3081850"/>
                <a:gd name="connsiteY1" fmla="*/ 17929 h 1512168"/>
                <a:gd name="connsiteX2" fmla="*/ 3072440 w 3081850"/>
                <a:gd name="connsiteY2" fmla="*/ 756084 h 1512168"/>
                <a:gd name="connsiteX3" fmla="*/ 2343043 w 3081850"/>
                <a:gd name="connsiteY3" fmla="*/ 1494239 h 1512168"/>
                <a:gd name="connsiteX4" fmla="*/ 0 w 3081850"/>
                <a:gd name="connsiteY4" fmla="*/ 1512168 h 1512168"/>
                <a:gd name="connsiteX5" fmla="*/ 0 w 3081850"/>
                <a:gd name="connsiteY5" fmla="*/ 0 h 151216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3081850" h="1512168">
                  <a:moveTo>
                    <a:pt x="0" y="0"/>
                  </a:moveTo>
                  <a:lnTo>
                    <a:pt x="2360973" y="17929"/>
                  </a:lnTo>
                  <a:cubicBezTo>
                    <a:pt x="3209404" y="17929"/>
                    <a:pt x="3075428" y="510032"/>
                    <a:pt x="3072440" y="756084"/>
                  </a:cubicBezTo>
                  <a:cubicBezTo>
                    <a:pt x="3069452" y="1002136"/>
                    <a:pt x="3191474" y="1494239"/>
                    <a:pt x="2343043" y="1494239"/>
                  </a:cubicBezTo>
                  <a:lnTo>
                    <a:pt x="0" y="1512168"/>
                  </a:lnTo>
                  <a:lnTo>
                    <a:pt x="0" y="0"/>
                  </a:lnTo>
                  <a:close/>
                </a:path>
              </a:pathLst>
            </a:custGeom>
            <a:solidFill>
              <a:srgbClr val="FDF00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2400" dirty="0">
                  <a:solidFill>
                    <a:srgbClr val="106E0E"/>
                  </a:solidFill>
                  <a:latin typeface="HY헤드라인M" pitchFamily="18" charset="-127"/>
                  <a:ea typeface="HY헤드라인M" pitchFamily="18" charset="-127"/>
                </a:rPr>
                <a:t>Sitting</a:t>
              </a:r>
            </a:p>
            <a:p>
              <a:pPr algn="ctr"/>
              <a:r>
                <a:rPr lang="en-US" altLang="ko-KR" sz="2400" dirty="0">
                  <a:solidFill>
                    <a:srgbClr val="106E0E"/>
                  </a:solidFill>
                  <a:latin typeface="HY헤드라인M" pitchFamily="18" charset="-127"/>
                  <a:ea typeface="HY헤드라인M" pitchFamily="18" charset="-127"/>
                </a:rPr>
                <a:t>Preparation</a:t>
              </a:r>
            </a:p>
          </p:txBody>
        </p:sp>
        <p:sp>
          <p:nvSpPr>
            <p:cNvPr id="41" name="순서도: 지연 18"/>
            <p:cNvSpPr/>
            <p:nvPr/>
          </p:nvSpPr>
          <p:spPr>
            <a:xfrm>
              <a:off x="7093341" y="2518525"/>
              <a:ext cx="1800000" cy="1584000"/>
            </a:xfrm>
            <a:custGeom>
              <a:avLst/>
              <a:gdLst>
                <a:gd name="connsiteX0" fmla="*/ 0 w 3072440"/>
                <a:gd name="connsiteY0" fmla="*/ 0 h 1512168"/>
                <a:gd name="connsiteX1" fmla="*/ 1536220 w 3072440"/>
                <a:gd name="connsiteY1" fmla="*/ 0 h 1512168"/>
                <a:gd name="connsiteX2" fmla="*/ 3072440 w 3072440"/>
                <a:gd name="connsiteY2" fmla="*/ 756084 h 1512168"/>
                <a:gd name="connsiteX3" fmla="*/ 1536220 w 3072440"/>
                <a:gd name="connsiteY3" fmla="*/ 1512168 h 1512168"/>
                <a:gd name="connsiteX4" fmla="*/ 0 w 3072440"/>
                <a:gd name="connsiteY4" fmla="*/ 1512168 h 1512168"/>
                <a:gd name="connsiteX5" fmla="*/ 0 w 3072440"/>
                <a:gd name="connsiteY5" fmla="*/ 0 h 1512168"/>
                <a:gd name="connsiteX0" fmla="*/ 0 w 3144931"/>
                <a:gd name="connsiteY0" fmla="*/ 0 h 1512168"/>
                <a:gd name="connsiteX1" fmla="*/ 2378903 w 3144931"/>
                <a:gd name="connsiteY1" fmla="*/ 17929 h 1512168"/>
                <a:gd name="connsiteX2" fmla="*/ 3072440 w 3144931"/>
                <a:gd name="connsiteY2" fmla="*/ 756084 h 1512168"/>
                <a:gd name="connsiteX3" fmla="*/ 1536220 w 3144931"/>
                <a:gd name="connsiteY3" fmla="*/ 1512168 h 1512168"/>
                <a:gd name="connsiteX4" fmla="*/ 0 w 3144931"/>
                <a:gd name="connsiteY4" fmla="*/ 1512168 h 1512168"/>
                <a:gd name="connsiteX5" fmla="*/ 0 w 3144931"/>
                <a:gd name="connsiteY5" fmla="*/ 0 h 1512168"/>
                <a:gd name="connsiteX0" fmla="*/ 0 w 3086098"/>
                <a:gd name="connsiteY0" fmla="*/ 0 h 1512168"/>
                <a:gd name="connsiteX1" fmla="*/ 2378903 w 3086098"/>
                <a:gd name="connsiteY1" fmla="*/ 17929 h 1512168"/>
                <a:gd name="connsiteX2" fmla="*/ 3072440 w 3086098"/>
                <a:gd name="connsiteY2" fmla="*/ 756084 h 1512168"/>
                <a:gd name="connsiteX3" fmla="*/ 2343043 w 3086098"/>
                <a:gd name="connsiteY3" fmla="*/ 1494239 h 1512168"/>
                <a:gd name="connsiteX4" fmla="*/ 0 w 3086098"/>
                <a:gd name="connsiteY4" fmla="*/ 1512168 h 1512168"/>
                <a:gd name="connsiteX5" fmla="*/ 0 w 3086098"/>
                <a:gd name="connsiteY5" fmla="*/ 0 h 1512168"/>
                <a:gd name="connsiteX0" fmla="*/ 0 w 3086098"/>
                <a:gd name="connsiteY0" fmla="*/ 35859 h 1548027"/>
                <a:gd name="connsiteX1" fmla="*/ 2378903 w 3086098"/>
                <a:gd name="connsiteY1" fmla="*/ 0 h 1548027"/>
                <a:gd name="connsiteX2" fmla="*/ 3072440 w 3086098"/>
                <a:gd name="connsiteY2" fmla="*/ 791943 h 1548027"/>
                <a:gd name="connsiteX3" fmla="*/ 2343043 w 3086098"/>
                <a:gd name="connsiteY3" fmla="*/ 1530098 h 1548027"/>
                <a:gd name="connsiteX4" fmla="*/ 0 w 3086098"/>
                <a:gd name="connsiteY4" fmla="*/ 1548027 h 1548027"/>
                <a:gd name="connsiteX5" fmla="*/ 0 w 3086098"/>
                <a:gd name="connsiteY5" fmla="*/ 35859 h 1548027"/>
                <a:gd name="connsiteX0" fmla="*/ 0 w 3081850"/>
                <a:gd name="connsiteY0" fmla="*/ 0 h 1512168"/>
                <a:gd name="connsiteX1" fmla="*/ 2360973 w 3081850"/>
                <a:gd name="connsiteY1" fmla="*/ 17929 h 1512168"/>
                <a:gd name="connsiteX2" fmla="*/ 3072440 w 3081850"/>
                <a:gd name="connsiteY2" fmla="*/ 756084 h 1512168"/>
                <a:gd name="connsiteX3" fmla="*/ 2343043 w 3081850"/>
                <a:gd name="connsiteY3" fmla="*/ 1494239 h 1512168"/>
                <a:gd name="connsiteX4" fmla="*/ 0 w 3081850"/>
                <a:gd name="connsiteY4" fmla="*/ 1512168 h 1512168"/>
                <a:gd name="connsiteX5" fmla="*/ 0 w 3081850"/>
                <a:gd name="connsiteY5" fmla="*/ 0 h 151216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3081850" h="1512168">
                  <a:moveTo>
                    <a:pt x="0" y="0"/>
                  </a:moveTo>
                  <a:lnTo>
                    <a:pt x="2360973" y="17929"/>
                  </a:lnTo>
                  <a:cubicBezTo>
                    <a:pt x="3209404" y="17929"/>
                    <a:pt x="3075428" y="510032"/>
                    <a:pt x="3072440" y="756084"/>
                  </a:cubicBezTo>
                  <a:cubicBezTo>
                    <a:pt x="3069452" y="1002136"/>
                    <a:pt x="3191474" y="1494239"/>
                    <a:pt x="2343043" y="1494239"/>
                  </a:cubicBezTo>
                  <a:lnTo>
                    <a:pt x="0" y="1512168"/>
                  </a:lnTo>
                  <a:lnTo>
                    <a:pt x="0" y="0"/>
                  </a:lnTo>
                  <a:close/>
                </a:path>
              </a:pathLst>
            </a:custGeom>
            <a:solidFill>
              <a:srgbClr val="FDF00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2400" dirty="0">
                  <a:solidFill>
                    <a:srgbClr val="106E0E"/>
                  </a:solidFill>
                  <a:latin typeface="HY헤드라인M" pitchFamily="18" charset="-127"/>
                  <a:ea typeface="HY헤드라인M" pitchFamily="18" charset="-127"/>
                </a:rPr>
                <a:t>Sitting</a:t>
              </a:r>
            </a:p>
            <a:p>
              <a:pPr algn="ctr"/>
              <a:r>
                <a:rPr lang="en-US" altLang="ko-KR" sz="2400" dirty="0">
                  <a:solidFill>
                    <a:srgbClr val="106E0E"/>
                  </a:solidFill>
                  <a:latin typeface="HY헤드라인M" pitchFamily="18" charset="-127"/>
                  <a:ea typeface="HY헤드라인M" pitchFamily="18" charset="-127"/>
                </a:rPr>
                <a:t>Exercise</a:t>
              </a:r>
            </a:p>
          </p:txBody>
        </p:sp>
        <p:pic>
          <p:nvPicPr>
            <p:cNvPr id="2053" name="_x87539368" descr="DRW000006a035c0"/>
            <p:cNvPicPr>
              <a:picLocks noChangeAspect="1" noChangeArrowheads="1"/>
            </p:cNvPicPr>
            <p:nvPr/>
          </p:nvPicPr>
          <p:blipFill>
            <a:blip r:embed="rId4">
              <a:extLst>
                <a:ext uri="{BEBA8EAE-BF5A-486C-A8C5-ECC9F3942E4B}">
                  <a14:imgProps xmlns:a14="http://schemas.microsoft.com/office/drawing/2010/main">
                    <a14:imgLayer r:embed="rId5">
                      <a14:imgEffect>
                        <a14:backgroundRemoval t="0" b="99723" l="0" r="98864">
                          <a14:backgroundMark x1="5682" y1="2770" x2="5682" y2="2770"/>
                          <a14:backgroundMark x1="71023" y1="16343" x2="71023" y2="16343"/>
                          <a14:backgroundMark x1="73295" y1="10803" x2="73295" y2="10803"/>
                          <a14:backgroundMark x1="73864" y1="10249" x2="73864" y2="10249"/>
                          <a14:backgroundMark x1="69318" y1="7479" x2="69318" y2="7479"/>
                          <a14:backgroundMark x1="68750" y1="7479" x2="67045" y2="8033"/>
                          <a14:backgroundMark x1="65909" y1="8864" x2="65341" y2="11080"/>
                          <a14:backgroundMark x1="61364" y1="17175" x2="61364" y2="17175"/>
                          <a14:backgroundMark x1="59659" y1="21330" x2="59659" y2="22161"/>
                          <a14:backgroundMark x1="59659" y1="23546" x2="63068" y2="26039"/>
                          <a14:backgroundMark x1="75000" y1="25485" x2="76136" y2="22992"/>
                          <a14:backgroundMark x1="81250" y1="18560" x2="81250" y2="17452"/>
                          <a14:backgroundMark x1="81818" y1="16620" x2="82955" y2="11911"/>
                          <a14:backgroundMark x1="82955" y1="8864" x2="82955" y2="8310"/>
                          <a14:backgroundMark x1="82955" y1="7202" x2="82955" y2="7202"/>
                          <a14:backgroundMark x1="82955" y1="7756" x2="84091" y2="16343"/>
                          <a14:backgroundMark x1="83523" y1="16898" x2="83523" y2="16898"/>
                          <a14:backgroundMark x1="79545" y1="16066" x2="76705" y2="14681"/>
                          <a14:backgroundMark x1="67614" y1="13850" x2="67614" y2="13850"/>
                          <a14:backgroundMark x1="61932" y1="14681" x2="60795" y2="17175"/>
                          <a14:backgroundMark x1="61364" y1="27424" x2="62500" y2="31856"/>
                          <a14:backgroundMark x1="65341" y1="36011" x2="66477" y2="40166"/>
                          <a14:backgroundMark x1="67045" y1="42105" x2="67614" y2="45429"/>
                          <a14:backgroundMark x1="68182" y1="46537" x2="70455" y2="50693"/>
                          <a14:backgroundMark x1="76136" y1="52632" x2="76136" y2="52632"/>
                          <a14:backgroundMark x1="77841" y1="51524" x2="81250" y2="46260"/>
                          <a14:backgroundMark x1="90341" y1="35457" x2="90341" y2="35457"/>
                          <a14:backgroundMark x1="90909" y1="33518" x2="91477" y2="34349"/>
                          <a14:backgroundMark x1="92045" y1="44321" x2="92045" y2="45152"/>
                          <a14:backgroundMark x1="92045" y1="47922" x2="92614" y2="52355"/>
                          <a14:backgroundMark x1="92614" y1="53740" x2="92614" y2="54848"/>
                          <a14:backgroundMark x1="94886" y1="58172" x2="94886" y2="61219"/>
                          <a14:backgroundMark x1="94886" y1="64543" x2="94886" y2="64543"/>
                          <a14:backgroundMark x1="95455" y1="66205" x2="95455" y2="66205"/>
                          <a14:backgroundMark x1="94886" y1="64820" x2="89205" y2="57895"/>
                          <a14:backgroundMark x1="88636" y1="56510" x2="88636" y2="56510"/>
                          <a14:backgroundMark x1="88636" y1="55956" x2="88636" y2="55956"/>
                          <a14:backgroundMark x1="76705" y1="48753" x2="76705" y2="48753"/>
                          <a14:backgroundMark x1="65909" y1="46537" x2="65341" y2="44321"/>
                          <a14:backgroundMark x1="64773" y1="39612" x2="63636" y2="38227"/>
                          <a14:backgroundMark x1="61932" y1="34072" x2="61932" y2="34072"/>
                          <a14:backgroundMark x1="61932" y1="34072" x2="62500" y2="43213"/>
                          <a14:backgroundMark x1="61364" y1="45152" x2="61364" y2="45152"/>
                          <a14:backgroundMark x1="62500" y1="47922" x2="63068" y2="48753"/>
                          <a14:backgroundMark x1="66477" y1="50693" x2="68750" y2="51801"/>
                          <a14:backgroundMark x1="72159" y1="52632" x2="72159" y2="52632"/>
                          <a14:backgroundMark x1="82386" y1="54017" x2="82386" y2="54017"/>
                          <a14:backgroundMark x1="84659" y1="57895" x2="86364" y2="60665"/>
                          <a14:backgroundMark x1="86932" y1="61773" x2="86932" y2="61773"/>
                          <a14:backgroundMark x1="80682" y1="59003" x2="80682" y2="59003"/>
                          <a14:backgroundMark x1="75000" y1="59280" x2="75000" y2="59280"/>
                          <a14:backgroundMark x1="88636" y1="60665" x2="88636" y2="60665"/>
                          <a14:backgroundMark x1="92045" y1="66482" x2="92045" y2="66482"/>
                          <a14:backgroundMark x1="92045" y1="70083" x2="92045" y2="73961"/>
                          <a14:backgroundMark x1="92045" y1="75069" x2="92045" y2="75069"/>
                          <a14:backgroundMark x1="92045" y1="77285" x2="92045" y2="78947"/>
                          <a14:backgroundMark x1="93182" y1="90028" x2="93182" y2="90028"/>
                          <a14:backgroundMark x1="93182" y1="90028" x2="93182" y2="90028"/>
                          <a14:backgroundMark x1="93182" y1="90028" x2="93182" y2="90028"/>
                          <a14:backgroundMark x1="45455" y1="84211" x2="45455" y2="84211"/>
                          <a14:backgroundMark x1="45455" y1="84211" x2="45455" y2="84211"/>
                          <a14:backgroundMark x1="45455" y1="84211" x2="45455" y2="84211"/>
                          <a14:backgroundMark x1="45455" y1="84211" x2="45455" y2="84211"/>
                          <a14:backgroundMark x1="40909" y1="81440" x2="40909" y2="81440"/>
                          <a14:backgroundMark x1="39773" y1="81163" x2="39773" y2="81163"/>
                          <a14:backgroundMark x1="51705" y1="77285" x2="51705" y2="77285"/>
                          <a14:backgroundMark x1="52273" y1="77008" x2="52273" y2="77008"/>
                          <a14:backgroundMark x1="52273" y1="79778" x2="52273" y2="79778"/>
                          <a14:backgroundMark x1="52841" y1="83934" x2="52841" y2="83934"/>
                          <a14:backgroundMark x1="52841" y1="84488" x2="53409" y2="85596"/>
                          <a14:backgroundMark x1="57955" y1="90859" x2="57955" y2="90859"/>
                          <a14:backgroundMark x1="57955" y1="90859" x2="57955" y2="90859"/>
                          <a14:backgroundMark x1="55682" y1="92244" x2="55682" y2="92244"/>
                          <a14:backgroundMark x1="55682" y1="92244" x2="55682" y2="92244"/>
                          <a14:backgroundMark x1="43750" y1="89751" x2="43750" y2="89751"/>
                          <a14:backgroundMark x1="43750" y1="89751" x2="43750" y2="89751"/>
                          <a14:backgroundMark x1="43750" y1="90028" x2="43750" y2="90028"/>
                          <a14:backgroundMark x1="43750" y1="90028" x2="43750" y2="90028"/>
                          <a14:backgroundMark x1="43750" y1="90028" x2="43750" y2="90028"/>
                          <a14:backgroundMark x1="45455" y1="89751" x2="45455" y2="89751"/>
                          <a14:backgroundMark x1="45455" y1="89751" x2="45455" y2="89751"/>
                          <a14:backgroundMark x1="46591" y1="88920" x2="46591" y2="88920"/>
                          <a14:backgroundMark x1="47159" y1="88643" x2="47159" y2="88643"/>
                          <a14:backgroundMark x1="47159" y1="88643" x2="47159" y2="88643"/>
                          <a14:backgroundMark x1="47159" y1="88643" x2="47159" y2="88643"/>
                          <a14:backgroundMark x1="47159" y1="88643" x2="47159" y2="88643"/>
                          <a14:backgroundMark x1="47159" y1="88643" x2="47159" y2="88643"/>
                          <a14:backgroundMark x1="47159" y1="88643" x2="47159" y2="88643"/>
                          <a14:backgroundMark x1="47159" y1="88643" x2="47159" y2="88643"/>
                          <a14:backgroundMark x1="47727" y1="86981" x2="47727" y2="86981"/>
                          <a14:backgroundMark x1="47727" y1="84211" x2="47727" y2="84211"/>
                          <a14:backgroundMark x1="47727" y1="83102" x2="47727" y2="83102"/>
                          <a14:backgroundMark x1="50568" y1="47368" x2="50568" y2="47368"/>
                          <a14:backgroundMark x1="50568" y1="47368" x2="50568" y2="47368"/>
                          <a14:backgroundMark x1="50568" y1="46814" x2="50568" y2="46814"/>
                          <a14:backgroundMark x1="48864" y1="14958" x2="48864" y2="14958"/>
                          <a14:backgroundMark x1="50000" y1="16066" x2="50000" y2="16066"/>
                          <a14:backgroundMark x1="50568" y1="18283" x2="50568" y2="18283"/>
                          <a14:backgroundMark x1="50568" y1="18560" x2="50568" y2="18560"/>
                          <a14:backgroundMark x1="49432" y1="19391" x2="49432" y2="19391"/>
                          <a14:backgroundMark x1="48864" y1="16898" x2="48864" y2="16898"/>
                          <a14:backgroundMark x1="48864" y1="16898" x2="48864" y2="16898"/>
                          <a14:backgroundMark x1="48864" y1="16898" x2="48864" y2="16898"/>
                          <a14:backgroundMark x1="48864" y1="16898" x2="48864" y2="16898"/>
                          <a14:backgroundMark x1="55114" y1="6371" x2="55114" y2="6371"/>
                          <a14:backgroundMark x1="55114" y1="4155" x2="55114" y2="4155"/>
                          <a14:backgroundMark x1="55114" y1="3601" x2="55114" y2="3601"/>
                          <a14:backgroundMark x1="55114" y1="3601" x2="55114" y2="3601"/>
                          <a14:backgroundMark x1="73295" y1="4432" x2="73295" y2="4432"/>
                          <a14:backgroundMark x1="73295" y1="4432" x2="75000" y2="8864"/>
                          <a14:backgroundMark x1="76136" y1="13573" x2="76136" y2="16620"/>
                          <a14:backgroundMark x1="78409" y1="20776" x2="81250" y2="28255"/>
                          <a14:backgroundMark x1="85227" y1="33518" x2="86932" y2="40166"/>
                          <a14:backgroundMark x1="90909" y1="45983" x2="91477" y2="47922"/>
                          <a14:backgroundMark x1="92045" y1="48753" x2="92045" y2="49584"/>
                          <a14:backgroundMark x1="92045" y1="51247" x2="92045" y2="51247"/>
                          <a14:backgroundMark x1="6818" y1="18006" x2="6818" y2="18006"/>
                        </a14:backgroundRemoval>
                      </a14:imgEffect>
                    </a14:imgLayer>
                  </a14:imgProps>
                </a:ext>
                <a:ext uri="{28A0092B-C50C-407E-A947-70E740481C1C}">
                  <a14:useLocalDpi xmlns:a14="http://schemas.microsoft.com/office/drawing/2010/main" val="0"/>
                </a:ext>
              </a:extLst>
            </a:blip>
            <a:srcRect/>
            <a:stretch>
              <a:fillRect/>
            </a:stretch>
          </p:blipFill>
          <p:spPr bwMode="auto">
            <a:xfrm>
              <a:off x="4822652" y="4102525"/>
              <a:ext cx="2382691" cy="4882711"/>
            </a:xfrm>
            <a:prstGeom prst="rect">
              <a:avLst/>
            </a:prstGeom>
            <a:noFill/>
            <a:extLst>
              <a:ext uri="{909E8E84-426E-40DD-AFC4-6F175D3DCCD1}">
                <a14:hiddenFill xmlns:a14="http://schemas.microsoft.com/office/drawing/2010/main">
                  <a:solidFill>
                    <a:srgbClr val="FFFFFF"/>
                  </a:solidFill>
                </a14:hiddenFill>
              </a:ext>
            </a:extLst>
          </p:spPr>
        </p:pic>
        <p:pic>
          <p:nvPicPr>
            <p:cNvPr id="2055" name="_x198530248" descr="DRW000006a035cb"/>
            <p:cNvPicPr>
              <a:picLocks noChangeAspect="1" noChangeArrowheads="1"/>
            </p:cNvPicPr>
            <p:nvPr/>
          </p:nvPicPr>
          <p:blipFill>
            <a:blip r:embed="rId6">
              <a:extLst>
                <a:ext uri="{BEBA8EAE-BF5A-486C-A8C5-ECC9F3942E4B}">
                  <a14:imgProps xmlns:a14="http://schemas.microsoft.com/office/drawing/2010/main">
                    <a14:imgLayer r:embed="rId7">
                      <a14:imgEffect>
                        <a14:backgroundRemoval t="0" b="100000" l="0" r="100000">
                          <a14:foregroundMark x1="36970" y1="5525" x2="36970" y2="5525"/>
                          <a14:foregroundMark x1="33939" y1="9945" x2="33939" y2="9945"/>
                          <a14:foregroundMark x1="31515" y1="7182" x2="31515" y2="7182"/>
                          <a14:foregroundMark x1="14545" y1="6354" x2="14545" y2="6354"/>
                          <a14:foregroundMark x1="30303" y1="4420" x2="30909" y2="4420"/>
                          <a14:foregroundMark x1="33939" y1="3591" x2="33939" y2="3591"/>
                          <a14:foregroundMark x1="32727" y1="8287" x2="32727" y2="8287"/>
                          <a14:foregroundMark x1="35152" y1="3591" x2="35152" y2="3591"/>
                          <a14:foregroundMark x1="33939" y1="11878" x2="33939" y2="11878"/>
                          <a14:foregroundMark x1="31515" y1="14917" x2="31515" y2="14917"/>
                          <a14:foregroundMark x1="32121" y1="15470" x2="32121" y2="15470"/>
                          <a14:foregroundMark x1="32727" y1="15746" x2="35758" y2="18508"/>
                          <a14:foregroundMark x1="39394" y1="19613" x2="39394" y2="19613"/>
                          <a14:foregroundMark x1="39394" y1="21823" x2="39394" y2="23481"/>
                          <a14:foregroundMark x1="39394" y1="24862" x2="39394" y2="25414"/>
                          <a14:foregroundMark x1="40606" y1="27348" x2="40606" y2="28177"/>
                          <a14:foregroundMark x1="40606" y1="29282" x2="40606" y2="29558"/>
                          <a14:foregroundMark x1="30303" y1="36464" x2="30303" y2="36464"/>
                          <a14:foregroundMark x1="30909" y1="46685" x2="30909" y2="46685"/>
                          <a14:foregroundMark x1="27273" y1="51381" x2="27273" y2="51381"/>
                          <a14:foregroundMark x1="29091" y1="42818" x2="29091" y2="42818"/>
                          <a14:foregroundMark x1="29697" y1="41713" x2="29697" y2="41713"/>
                          <a14:foregroundMark x1="29697" y1="40884" x2="29697" y2="40884"/>
                          <a14:foregroundMark x1="29697" y1="40884" x2="29697" y2="40331"/>
                          <a14:foregroundMark x1="29697" y1="40055" x2="29697" y2="40055"/>
                          <a14:foregroundMark x1="29697" y1="39779" x2="29697" y2="39779"/>
                          <a14:foregroundMark x1="30303" y1="39227" x2="30303" y2="39227"/>
                          <a14:foregroundMark x1="65455" y1="56630" x2="65455" y2="56630"/>
                          <a14:foregroundMark x1="87273" y1="90055" x2="87273" y2="90055"/>
                          <a14:foregroundMark x1="75758" y1="80939" x2="75758" y2="80939"/>
                          <a14:foregroundMark x1="90909" y1="80387" x2="90909" y2="80387"/>
                          <a14:foregroundMark x1="93333" y1="80387" x2="93333" y2="80387"/>
                          <a14:foregroundMark x1="93333" y1="80663" x2="93333" y2="80663"/>
                          <a14:foregroundMark x1="91515" y1="80387" x2="91515" y2="80387"/>
                          <a14:foregroundMark x1="91515" y1="80387" x2="91515" y2="80387"/>
                          <a14:foregroundMark x1="90909" y1="80110" x2="90909" y2="80110"/>
                          <a14:foregroundMark x1="90909" y1="79558" x2="90909" y2="79558"/>
                          <a14:foregroundMark x1="90909" y1="79558" x2="90909" y2="79558"/>
                          <a14:foregroundMark x1="92121" y1="79834" x2="92121" y2="79834"/>
                          <a14:foregroundMark x1="92121" y1="79834" x2="92121" y2="79834"/>
                          <a14:foregroundMark x1="93333" y1="80110" x2="93333" y2="80110"/>
                          <a14:foregroundMark x1="93333" y1="80110" x2="93333" y2="80110"/>
                          <a14:foregroundMark x1="93333" y1="80110" x2="93333" y2="80110"/>
                          <a14:foregroundMark x1="93333" y1="80110" x2="93333" y2="80110"/>
                          <a14:foregroundMark x1="91515" y1="80663" x2="91515" y2="80663"/>
                          <a14:foregroundMark x1="90303" y1="80663" x2="90303" y2="80663"/>
                          <a14:foregroundMark x1="87879" y1="80939" x2="87879" y2="80939"/>
                          <a14:foregroundMark x1="88485" y1="82320" x2="90909" y2="82044"/>
                          <a14:foregroundMark x1="92121" y1="81768" x2="92121" y2="81768"/>
                          <a14:foregroundMark x1="92121" y1="81768" x2="92121" y2="81768"/>
                          <a14:foregroundMark x1="93333" y1="81215" x2="93333" y2="81215"/>
                          <a14:foregroundMark x1="94545" y1="81215" x2="94545" y2="81215"/>
                          <a14:backgroundMark x1="69091" y1="27901" x2="69091" y2="27901"/>
                          <a14:backgroundMark x1="75758" y1="21823" x2="75758" y2="21823"/>
                          <a14:backgroundMark x1="77576" y1="23757" x2="77576" y2="23757"/>
                          <a14:backgroundMark x1="77576" y1="31768" x2="77576" y2="31768"/>
                          <a14:backgroundMark x1="95152" y1="50829" x2="95152" y2="50829"/>
                          <a14:backgroundMark x1="86061" y1="54696" x2="86061" y2="54696"/>
                          <a14:backgroundMark x1="86061" y1="39779" x2="86061" y2="39779"/>
                          <a14:backgroundMark x1="86061" y1="32873" x2="87273" y2="32320"/>
                          <a14:backgroundMark x1="86061" y1="27901" x2="86061" y2="27072"/>
                          <a14:backgroundMark x1="86061" y1="25414" x2="85455" y2="22652"/>
                          <a14:backgroundMark x1="82424" y1="19613" x2="82424" y2="18785"/>
                          <a14:backgroundMark x1="75758" y1="15746" x2="72727" y2="15193"/>
                          <a14:backgroundMark x1="44242" y1="14641" x2="44242" y2="14641"/>
                          <a14:backgroundMark x1="45455" y1="16575" x2="45455" y2="16575"/>
                          <a14:backgroundMark x1="44242" y1="17127" x2="44242" y2="17127"/>
                          <a14:backgroundMark x1="45455" y1="15746" x2="45455" y2="15746"/>
                        </a14:backgroundRemoval>
                      </a14:imgEffect>
                    </a14:imgLayer>
                  </a14:imgProps>
                </a:ext>
                <a:ext uri="{28A0092B-C50C-407E-A947-70E740481C1C}">
                  <a14:useLocalDpi xmlns:a14="http://schemas.microsoft.com/office/drawing/2010/main" val="0"/>
                </a:ext>
              </a:extLst>
            </a:blip>
            <a:srcRect/>
            <a:stretch>
              <a:fillRect/>
            </a:stretch>
          </p:blipFill>
          <p:spPr bwMode="auto">
            <a:xfrm>
              <a:off x="7098232" y="4102524"/>
              <a:ext cx="2227990" cy="4882711"/>
            </a:xfrm>
            <a:prstGeom prst="rect">
              <a:avLst/>
            </a:prstGeom>
            <a:noFill/>
            <a:extLst>
              <a:ext uri="{909E8E84-426E-40DD-AFC4-6F175D3DCCD1}">
                <a14:hiddenFill xmlns:a14="http://schemas.microsoft.com/office/drawing/2010/main">
                  <a:solidFill>
                    <a:srgbClr val="FFFFFF"/>
                  </a:solidFill>
                </a14:hiddenFill>
              </a:ext>
            </a:extLst>
          </p:spPr>
        </p:pic>
        <p:sp>
          <p:nvSpPr>
            <p:cNvPr id="22" name="_x198096200"/>
            <p:cNvSpPr>
              <a:spLocks noChangeArrowheads="1"/>
            </p:cNvSpPr>
            <p:nvPr/>
          </p:nvSpPr>
          <p:spPr bwMode="auto">
            <a:xfrm>
              <a:off x="6952547" y="7154664"/>
              <a:ext cx="530079" cy="321816"/>
            </a:xfrm>
            <a:custGeom>
              <a:avLst/>
              <a:gdLst>
                <a:gd name="T0" fmla="*/ 77 w 168"/>
                <a:gd name="T1" fmla="*/ 28 h 112"/>
                <a:gd name="T2" fmla="*/ 77 w 168"/>
                <a:gd name="T3" fmla="*/ 0 h 112"/>
                <a:gd name="T4" fmla="*/ 0 w 168"/>
                <a:gd name="T5" fmla="*/ 55 h 112"/>
                <a:gd name="T6" fmla="*/ 77 w 168"/>
                <a:gd name="T7" fmla="*/ 112 h 112"/>
                <a:gd name="T8" fmla="*/ 77 w 168"/>
                <a:gd name="T9" fmla="*/ 82 h 112"/>
                <a:gd name="T10" fmla="*/ 168 w 168"/>
                <a:gd name="T11" fmla="*/ 82 h 112"/>
                <a:gd name="T12" fmla="*/ 168 w 168"/>
                <a:gd name="T13" fmla="*/ 28 h 112"/>
              </a:gdLst>
              <a:ahLst/>
              <a:cxnLst>
                <a:cxn ang="0">
                  <a:pos x="T0" y="T1"/>
                </a:cxn>
                <a:cxn ang="0">
                  <a:pos x="T2" y="T3"/>
                </a:cxn>
                <a:cxn ang="0">
                  <a:pos x="T4" y="T5"/>
                </a:cxn>
                <a:cxn ang="0">
                  <a:pos x="T6" y="T7"/>
                </a:cxn>
                <a:cxn ang="0">
                  <a:pos x="T8" y="T9"/>
                </a:cxn>
                <a:cxn ang="0">
                  <a:pos x="T10" y="T11"/>
                </a:cxn>
                <a:cxn ang="0">
                  <a:pos x="T12" y="T13"/>
                </a:cxn>
              </a:cxnLst>
              <a:rect l="0" t="0" r="r" b="b"/>
              <a:pathLst>
                <a:path w="168" h="112">
                  <a:moveTo>
                    <a:pt x="77" y="28"/>
                  </a:moveTo>
                  <a:lnTo>
                    <a:pt x="77" y="0"/>
                  </a:lnTo>
                  <a:lnTo>
                    <a:pt x="0" y="55"/>
                  </a:lnTo>
                  <a:lnTo>
                    <a:pt x="77" y="112"/>
                  </a:lnTo>
                  <a:lnTo>
                    <a:pt x="77" y="82"/>
                  </a:lnTo>
                  <a:lnTo>
                    <a:pt x="168" y="82"/>
                  </a:lnTo>
                  <a:lnTo>
                    <a:pt x="168" y="28"/>
                  </a:lnTo>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ko-KR" altLang="en-US"/>
            </a:p>
          </p:txBody>
        </p:sp>
      </p:grpSp>
      <p:sp>
        <p:nvSpPr>
          <p:cNvPr id="23" name="직사각형 22"/>
          <p:cNvSpPr/>
          <p:nvPr/>
        </p:nvSpPr>
        <p:spPr>
          <a:xfrm>
            <a:off x="2784376" y="1720280"/>
            <a:ext cx="3353454" cy="781332"/>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fontAlgn="base"/>
            <a:r>
              <a:rPr lang="en-US" altLang="ko-KR" sz="2000" b="1" dirty="0">
                <a:solidFill>
                  <a:srgbClr val="363636"/>
                </a:solidFill>
                <a:latin typeface="HY헤드라인M" pitchFamily="18" charset="-127"/>
                <a:ea typeface="HY헤드라인M" pitchFamily="18" charset="-127"/>
              </a:rPr>
              <a:t>Sitting position: Rest for </a:t>
            </a:r>
          </a:p>
          <a:p>
            <a:pPr fontAlgn="base"/>
            <a:r>
              <a:rPr lang="en-US" altLang="ko-KR" sz="2000" b="1" dirty="0">
                <a:solidFill>
                  <a:srgbClr val="363636"/>
                </a:solidFill>
                <a:latin typeface="HY헤드라인M" pitchFamily="18" charset="-127"/>
                <a:ea typeface="HY헤드라인M" pitchFamily="18" charset="-127"/>
              </a:rPr>
              <a:t>15 minutes between sets.</a:t>
            </a:r>
            <a:endParaRPr lang="en-US" altLang="ko-KR" sz="1800" b="1" dirty="0">
              <a:solidFill>
                <a:srgbClr val="363636"/>
              </a:solidFill>
              <a:latin typeface="HY헤드라인M" pitchFamily="18" charset="-127"/>
              <a:ea typeface="HY헤드라인M" pitchFamily="18" charset="-127"/>
            </a:endParaRPr>
          </a:p>
        </p:txBody>
      </p:sp>
    </p:spTree>
    <p:extLst>
      <p:ext uri="{BB962C8B-B14F-4D97-AF65-F5344CB8AC3E}">
        <p14:creationId xmlns:p14="http://schemas.microsoft.com/office/powerpoint/2010/main" val="239692731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직사각형 6"/>
          <p:cNvSpPr/>
          <p:nvPr/>
        </p:nvSpPr>
        <p:spPr>
          <a:xfrm>
            <a:off x="984176" y="280120"/>
            <a:ext cx="7755340" cy="108012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altLang="ko-KR" sz="5000" dirty="0">
                <a:solidFill>
                  <a:srgbClr val="FF0000"/>
                </a:solidFill>
                <a:latin typeface="HY헤드라인M" pitchFamily="18" charset="-127"/>
                <a:ea typeface="HY헤드라인M" pitchFamily="18" charset="-127"/>
              </a:rPr>
              <a:t>Abdominal Bracing</a:t>
            </a:r>
          </a:p>
        </p:txBody>
      </p:sp>
      <p:grpSp>
        <p:nvGrpSpPr>
          <p:cNvPr id="72" name="그룹 71"/>
          <p:cNvGrpSpPr/>
          <p:nvPr/>
        </p:nvGrpSpPr>
        <p:grpSpPr>
          <a:xfrm>
            <a:off x="192088" y="6832848"/>
            <a:ext cx="9289032" cy="5102094"/>
            <a:chOff x="192088" y="6832848"/>
            <a:chExt cx="9289032" cy="5102094"/>
          </a:xfrm>
        </p:grpSpPr>
        <p:sp>
          <p:nvSpPr>
            <p:cNvPr id="46" name="직사각형 45"/>
            <p:cNvSpPr/>
            <p:nvPr/>
          </p:nvSpPr>
          <p:spPr>
            <a:xfrm>
              <a:off x="288008" y="6832848"/>
              <a:ext cx="9000000" cy="197989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dirty="0">
                <a:latin typeface="HY헤드라인M" pitchFamily="18" charset="-127"/>
                <a:ea typeface="HY헤드라인M" pitchFamily="18" charset="-127"/>
              </a:endParaRPr>
            </a:p>
          </p:txBody>
        </p:sp>
        <p:grpSp>
          <p:nvGrpSpPr>
            <p:cNvPr id="53" name="그룹 52"/>
            <p:cNvGrpSpPr/>
            <p:nvPr/>
          </p:nvGrpSpPr>
          <p:grpSpPr>
            <a:xfrm>
              <a:off x="192088" y="7120880"/>
              <a:ext cx="9289032" cy="3678986"/>
              <a:chOff x="192088" y="1989858"/>
              <a:chExt cx="9289032" cy="3678986"/>
            </a:xfrm>
          </p:grpSpPr>
          <p:sp>
            <p:nvSpPr>
              <p:cNvPr id="56" name="직사각형 55"/>
              <p:cNvSpPr/>
              <p:nvPr/>
            </p:nvSpPr>
            <p:spPr>
              <a:xfrm>
                <a:off x="288000" y="1989858"/>
                <a:ext cx="9000000" cy="361472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457200" indent="-457200" algn="just">
                  <a:buAutoNum type="arabicPeriod"/>
                </a:pPr>
                <a:r>
                  <a:rPr lang="en-US" altLang="ko-KR" sz="2400" dirty="0">
                    <a:solidFill>
                      <a:schemeClr val="tx1"/>
                    </a:solidFill>
                    <a:latin typeface="HY헤드라인M" pitchFamily="18" charset="-127"/>
                    <a:ea typeface="HY헤드라인M" pitchFamily="18" charset="-127"/>
                  </a:rPr>
                  <a:t>Standing up or sitting down, slowly push your abdomen and pelvis forward until you feel your back muscles relax.</a:t>
                </a:r>
              </a:p>
              <a:p>
                <a:pPr marL="457200" indent="-457200" algn="just">
                  <a:buAutoNum type="arabicPeriod"/>
                </a:pPr>
                <a:endParaRPr lang="en-US" altLang="ko-KR" sz="2400" dirty="0">
                  <a:solidFill>
                    <a:schemeClr val="tx1"/>
                  </a:solidFill>
                  <a:latin typeface="HY헤드라인M" pitchFamily="18" charset="-127"/>
                  <a:ea typeface="HY헤드라인M" pitchFamily="18" charset="-127"/>
                </a:endParaRPr>
              </a:p>
              <a:p>
                <a:pPr marL="457200" indent="-457200" algn="just">
                  <a:buAutoNum type="arabicPeriod"/>
                </a:pPr>
                <a:r>
                  <a:rPr lang="en-US" altLang="ko-KR" sz="2400" dirty="0">
                    <a:solidFill>
                      <a:schemeClr val="tx1"/>
                    </a:solidFill>
                    <a:latin typeface="HY헤드라인M" pitchFamily="18" charset="-127"/>
                    <a:ea typeface="HY헤드라인M" pitchFamily="18" charset="-127"/>
                  </a:rPr>
                  <a:t>When you have found the position in which your back muscles are relaxed, lightly cough a few times and check if your abdominal muscles have tightened. </a:t>
                </a:r>
              </a:p>
              <a:p>
                <a:pPr marL="457200" indent="-457200" algn="just">
                  <a:buAutoNum type="arabicPeriod"/>
                </a:pPr>
                <a:endParaRPr lang="en-US" altLang="ko-KR" sz="2400" dirty="0">
                  <a:solidFill>
                    <a:schemeClr val="tx1"/>
                  </a:solidFill>
                  <a:latin typeface="HY헤드라인M" pitchFamily="18" charset="-127"/>
                  <a:ea typeface="HY헤드라인M" pitchFamily="18" charset="-127"/>
                </a:endParaRPr>
              </a:p>
              <a:p>
                <a:pPr marL="457200" indent="-457200" algn="just">
                  <a:buAutoNum type="arabicPeriod"/>
                </a:pPr>
                <a:r>
                  <a:rPr lang="en-US" altLang="ko-KR" sz="2400" dirty="0">
                    <a:solidFill>
                      <a:schemeClr val="tx1"/>
                    </a:solidFill>
                    <a:latin typeface="HY헤드라인M" pitchFamily="18" charset="-127"/>
                    <a:ea typeface="HY헤드라인M" pitchFamily="18" charset="-127"/>
                  </a:rPr>
                  <a:t>Practice repeatedly to protect and stabilize your back during daily activities such as sitting, walking, and lifting objects. </a:t>
                </a:r>
                <a:endParaRPr lang="ko-KR" altLang="en-US" sz="2400" dirty="0">
                  <a:solidFill>
                    <a:schemeClr val="tx1"/>
                  </a:solidFill>
                  <a:latin typeface="HY헤드라인M" pitchFamily="18" charset="-127"/>
                  <a:ea typeface="HY헤드라인M" pitchFamily="18" charset="-127"/>
                </a:endParaRPr>
              </a:p>
            </p:txBody>
          </p:sp>
          <p:sp>
            <p:nvSpPr>
              <p:cNvPr id="58" name="직사각형 57"/>
              <p:cNvSpPr/>
              <p:nvPr/>
            </p:nvSpPr>
            <p:spPr>
              <a:xfrm>
                <a:off x="192088" y="2493914"/>
                <a:ext cx="9289032" cy="317493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altLang="ko-KR" sz="1800" dirty="0">
                  <a:solidFill>
                    <a:srgbClr val="363636"/>
                  </a:solidFill>
                  <a:latin typeface="HY헤드라인M" pitchFamily="18" charset="-127"/>
                  <a:ea typeface="HY헤드라인M" pitchFamily="18" charset="-127"/>
                </a:endParaRPr>
              </a:p>
            </p:txBody>
          </p:sp>
        </p:grpSp>
        <p:sp>
          <p:nvSpPr>
            <p:cNvPr id="62" name="직사각형 61"/>
            <p:cNvSpPr/>
            <p:nvPr/>
          </p:nvSpPr>
          <p:spPr>
            <a:xfrm>
              <a:off x="288000" y="11081320"/>
              <a:ext cx="9000000" cy="853622"/>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fontAlgn="base"/>
              <a:r>
                <a:rPr lang="en-US" altLang="ko-KR" sz="1800" b="1" dirty="0">
                  <a:solidFill>
                    <a:srgbClr val="363636"/>
                  </a:solidFill>
                  <a:latin typeface="HY헤드라인M" pitchFamily="18" charset="-127"/>
                  <a:ea typeface="HY헤드라인M" pitchFamily="18" charset="-127"/>
                </a:rPr>
                <a:t>Caution</a:t>
              </a:r>
            </a:p>
            <a:p>
              <a:pPr fontAlgn="base"/>
              <a:r>
                <a:rPr lang="en-US" altLang="ko-KR" sz="1800" b="1" dirty="0">
                  <a:solidFill>
                    <a:srgbClr val="363636"/>
                  </a:solidFill>
                  <a:latin typeface="HY헤드라인M" pitchFamily="18" charset="-127"/>
                  <a:ea typeface="HY헤드라인M" pitchFamily="18" charset="-127"/>
                </a:rPr>
                <a:t>Make </a:t>
              </a:r>
              <a:r>
                <a:rPr lang="en-US" altLang="ko-KR" sz="1800" b="1" dirty="0">
                  <a:solidFill>
                    <a:schemeClr val="tx1">
                      <a:lumMod val="75000"/>
                      <a:lumOff val="25000"/>
                    </a:schemeClr>
                  </a:solidFill>
                  <a:latin typeface="HY헤드라인M" pitchFamily="18" charset="-127"/>
                  <a:ea typeface="HY헤드라인M" pitchFamily="18" charset="-127"/>
                </a:rPr>
                <a:t>sure your sitting posture stays intact while bracing and relaxing.</a:t>
              </a:r>
            </a:p>
          </p:txBody>
        </p:sp>
      </p:grpSp>
      <p:pic>
        <p:nvPicPr>
          <p:cNvPr id="1026" name="Picture 2"/>
          <p:cNvPicPr preferRelativeResize="0">
            <a:picLocks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6588008" y="12060000"/>
            <a:ext cx="2700000" cy="54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 name="그림 2"/>
          <p:cNvPicPr>
            <a:picLocks noChangeAspect="1"/>
          </p:cNvPicPr>
          <p:nvPr/>
        </p:nvPicPr>
        <p:blipFill>
          <a:blip r:embed="rId4">
            <a:extLst>
              <a:ext uri="{BEBA8EAE-BF5A-486C-A8C5-ECC9F3942E4B}">
                <a14:imgProps xmlns:a14="http://schemas.microsoft.com/office/drawing/2010/main">
                  <a14:imgLayer r:embed="rId5">
                    <a14:imgEffect>
                      <a14:backgroundRemoval t="0" b="99669" l="0" r="100000"/>
                    </a14:imgEffect>
                  </a14:imgLayer>
                </a14:imgProps>
              </a:ext>
              <a:ext uri="{28A0092B-C50C-407E-A947-70E740481C1C}">
                <a14:useLocalDpi xmlns:a14="http://schemas.microsoft.com/office/drawing/2010/main" val="0"/>
              </a:ext>
            </a:extLst>
          </a:blip>
          <a:stretch>
            <a:fillRect/>
          </a:stretch>
        </p:blipFill>
        <p:spPr>
          <a:xfrm>
            <a:off x="3384244" y="1266627"/>
            <a:ext cx="2987785" cy="4774133"/>
          </a:xfrm>
          <a:prstGeom prst="rect">
            <a:avLst/>
          </a:prstGeom>
        </p:spPr>
      </p:pic>
      <p:sp>
        <p:nvSpPr>
          <p:cNvPr id="12" name="직사각형 11"/>
          <p:cNvSpPr/>
          <p:nvPr/>
        </p:nvSpPr>
        <p:spPr>
          <a:xfrm>
            <a:off x="287206" y="5835210"/>
            <a:ext cx="9000000" cy="853622"/>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fontAlgn="base"/>
            <a:r>
              <a:rPr lang="en-US" altLang="ko-KR" sz="1800" b="1" dirty="0">
                <a:solidFill>
                  <a:srgbClr val="363636"/>
                </a:solidFill>
                <a:latin typeface="HY헤드라인M" pitchFamily="18" charset="-127"/>
                <a:ea typeface="HY헤드라인M" pitchFamily="18" charset="-127"/>
              </a:rPr>
              <a:t>Method</a:t>
            </a:r>
          </a:p>
          <a:p>
            <a:pPr fontAlgn="base"/>
            <a:r>
              <a:rPr lang="en-US" altLang="ko-KR" sz="1800" b="1" dirty="0">
                <a:solidFill>
                  <a:srgbClr val="363636"/>
                </a:solidFill>
                <a:latin typeface="HY헤드라인M" pitchFamily="18" charset="-127"/>
                <a:ea typeface="HY헤드라인M" pitchFamily="18" charset="-127"/>
              </a:rPr>
              <a:t>Brace for 5 seconds and relax for 5 seconds. Repeat the motion </a:t>
            </a:r>
            <a:r>
              <a:rPr lang="en-US" altLang="ko-KR" sz="1800" b="1" dirty="0">
                <a:solidFill>
                  <a:schemeClr val="tx1">
                    <a:lumMod val="75000"/>
                    <a:lumOff val="25000"/>
                  </a:schemeClr>
                </a:solidFill>
                <a:latin typeface="HY헤드라인M" pitchFamily="18" charset="-127"/>
                <a:ea typeface="HY헤드라인M" pitchFamily="18" charset="-127"/>
              </a:rPr>
              <a:t>for 30/50</a:t>
            </a:r>
            <a:r>
              <a:rPr lang="en-US" altLang="ko-KR" sz="2400" b="1" dirty="0">
                <a:solidFill>
                  <a:schemeClr val="tx1">
                    <a:lumMod val="75000"/>
                    <a:lumOff val="25000"/>
                  </a:schemeClr>
                </a:solidFill>
                <a:latin typeface="HY헤드라인M" pitchFamily="18" charset="-127"/>
                <a:ea typeface="HY헤드라인M" pitchFamily="18" charset="-127"/>
              </a:rPr>
              <a:t> </a:t>
            </a:r>
            <a:r>
              <a:rPr lang="en-US" altLang="ko-KR" sz="1800" b="1" dirty="0">
                <a:solidFill>
                  <a:schemeClr val="tx1">
                    <a:lumMod val="75000"/>
                    <a:lumOff val="25000"/>
                  </a:schemeClr>
                </a:solidFill>
                <a:latin typeface="HY헤드라인M" pitchFamily="18" charset="-127"/>
                <a:ea typeface="HY헤드라인M" pitchFamily="18" charset="-127"/>
              </a:rPr>
              <a:t>sets and exercise 3 times a day (morning/afternoon/evening).</a:t>
            </a:r>
          </a:p>
        </p:txBody>
      </p:sp>
    </p:spTree>
    <p:extLst>
      <p:ext uri="{BB962C8B-B14F-4D97-AF65-F5344CB8AC3E}">
        <p14:creationId xmlns:p14="http://schemas.microsoft.com/office/powerpoint/2010/main" val="73295217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모서리가 둥근 직사각형 15"/>
          <p:cNvSpPr/>
          <p:nvPr/>
        </p:nvSpPr>
        <p:spPr>
          <a:xfrm>
            <a:off x="5003170" y="2202730"/>
            <a:ext cx="3973040" cy="4453604"/>
          </a:xfrm>
          <a:prstGeom prst="roundRect">
            <a:avLst/>
          </a:prstGeom>
          <a:solidFill>
            <a:schemeClr val="bg1"/>
          </a:solidFill>
          <a:ln w="50800">
            <a:solidFill>
              <a:srgbClr val="689E1D"/>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3" name="모서리가 둥근 직사각형 12"/>
          <p:cNvSpPr/>
          <p:nvPr/>
        </p:nvSpPr>
        <p:spPr>
          <a:xfrm>
            <a:off x="651148" y="2202730"/>
            <a:ext cx="3973040" cy="4453604"/>
          </a:xfrm>
          <a:prstGeom prst="roundRect">
            <a:avLst/>
          </a:prstGeom>
          <a:solidFill>
            <a:schemeClr val="bg1"/>
          </a:solidFill>
          <a:ln w="50800">
            <a:solidFill>
              <a:srgbClr val="689E1D"/>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7" name="직사각형 6"/>
          <p:cNvSpPr/>
          <p:nvPr/>
        </p:nvSpPr>
        <p:spPr>
          <a:xfrm>
            <a:off x="1125500" y="42730"/>
            <a:ext cx="7755340" cy="2160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altLang="ko-KR" sz="5000" dirty="0">
                <a:solidFill>
                  <a:srgbClr val="FF0000"/>
                </a:solidFill>
                <a:latin typeface="HY헤드라인M" pitchFamily="18" charset="-127"/>
                <a:ea typeface="HY헤드라인M" pitchFamily="18" charset="-127"/>
              </a:rPr>
              <a:t>Sitting Posture</a:t>
            </a:r>
          </a:p>
        </p:txBody>
      </p:sp>
      <p:grpSp>
        <p:nvGrpSpPr>
          <p:cNvPr id="72" name="그룹 71"/>
          <p:cNvGrpSpPr/>
          <p:nvPr/>
        </p:nvGrpSpPr>
        <p:grpSpPr>
          <a:xfrm>
            <a:off x="192088" y="6739847"/>
            <a:ext cx="9289032" cy="5349583"/>
            <a:chOff x="192088" y="6736271"/>
            <a:chExt cx="9289032" cy="5353266"/>
          </a:xfrm>
        </p:grpSpPr>
        <p:sp>
          <p:nvSpPr>
            <p:cNvPr id="46" name="직사각형 45"/>
            <p:cNvSpPr/>
            <p:nvPr/>
          </p:nvSpPr>
          <p:spPr>
            <a:xfrm>
              <a:off x="288008" y="6818520"/>
              <a:ext cx="9000000" cy="197989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dirty="0">
                <a:latin typeface="HY헤드라인M" pitchFamily="18" charset="-127"/>
                <a:ea typeface="HY헤드라인M" pitchFamily="18" charset="-127"/>
              </a:endParaRPr>
            </a:p>
          </p:txBody>
        </p:sp>
        <p:grpSp>
          <p:nvGrpSpPr>
            <p:cNvPr id="53" name="그룹 52"/>
            <p:cNvGrpSpPr/>
            <p:nvPr/>
          </p:nvGrpSpPr>
          <p:grpSpPr>
            <a:xfrm>
              <a:off x="192088" y="6736271"/>
              <a:ext cx="9289032" cy="4489065"/>
              <a:chOff x="192088" y="1605249"/>
              <a:chExt cx="9289032" cy="4489065"/>
            </a:xfrm>
          </p:grpSpPr>
          <p:sp>
            <p:nvSpPr>
              <p:cNvPr id="56" name="직사각형 55"/>
              <p:cNvSpPr/>
              <p:nvPr/>
            </p:nvSpPr>
            <p:spPr>
              <a:xfrm>
                <a:off x="288000" y="1605249"/>
                <a:ext cx="9000000" cy="448906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457200" indent="-457200" algn="just">
                  <a:buAutoNum type="arabicPeriod"/>
                </a:pPr>
                <a:r>
                  <a:rPr lang="en-US" altLang="ko-KR" dirty="0">
                    <a:solidFill>
                      <a:schemeClr val="tx1"/>
                    </a:solidFill>
                    <a:latin typeface="HY헤드라인M" pitchFamily="18" charset="-127"/>
                    <a:ea typeface="HY헤드라인M" pitchFamily="18" charset="-127"/>
                  </a:rPr>
                  <a:t>Spread your legs with the same distance as your shoulders and sit with your back straight. </a:t>
                </a:r>
              </a:p>
              <a:p>
                <a:pPr marL="457200" indent="-457200" algn="just">
                  <a:buAutoNum type="arabicPeriod"/>
                </a:pPr>
                <a:endParaRPr lang="en-US" altLang="ko-KR" dirty="0">
                  <a:solidFill>
                    <a:schemeClr val="tx1"/>
                  </a:solidFill>
                  <a:latin typeface="HY헤드라인M" pitchFamily="18" charset="-127"/>
                  <a:ea typeface="HY헤드라인M" pitchFamily="18" charset="-127"/>
                </a:endParaRPr>
              </a:p>
              <a:p>
                <a:pPr marL="457200" indent="-457200" algn="just">
                  <a:buAutoNum type="arabicPeriod"/>
                </a:pPr>
                <a:r>
                  <a:rPr lang="en-US" altLang="ko-KR" dirty="0">
                    <a:solidFill>
                      <a:schemeClr val="tx1"/>
                    </a:solidFill>
                    <a:latin typeface="HY헤드라인M" pitchFamily="18" charset="-127"/>
                    <a:ea typeface="HY헤드라인M" pitchFamily="18" charset="-127"/>
                  </a:rPr>
                  <a:t>If your chin sticks forward, you are more likely to  stoop, so make sure your chin is tucked in and keep your spine straight. </a:t>
                </a:r>
              </a:p>
              <a:p>
                <a:pPr marL="457200" indent="-457200" algn="just">
                  <a:buAutoNum type="arabicPeriod"/>
                </a:pPr>
                <a:endParaRPr lang="en-US" altLang="ko-KR" dirty="0">
                  <a:solidFill>
                    <a:schemeClr val="tx1"/>
                  </a:solidFill>
                  <a:latin typeface="HY헤드라인M" pitchFamily="18" charset="-127"/>
                  <a:ea typeface="HY헤드라인M" pitchFamily="18" charset="-127"/>
                </a:endParaRPr>
              </a:p>
              <a:p>
                <a:pPr marL="457200" indent="-457200" algn="just">
                  <a:buAutoNum type="arabicPeriod"/>
                </a:pPr>
                <a:r>
                  <a:rPr lang="en-US" altLang="ko-KR" dirty="0">
                    <a:solidFill>
                      <a:schemeClr val="tx1"/>
                    </a:solidFill>
                    <a:latin typeface="HY헤드라인M" pitchFamily="18" charset="-127"/>
                    <a:ea typeface="HY헤드라인M" pitchFamily="18" charset="-127"/>
                  </a:rPr>
                  <a:t>Straighten your chest and shoulders so that your scapulae would come closer. </a:t>
                </a:r>
              </a:p>
              <a:p>
                <a:pPr marL="457200" indent="-457200" algn="just">
                  <a:buAutoNum type="arabicPeriod"/>
                </a:pPr>
                <a:endParaRPr lang="en-US" altLang="ko-KR" dirty="0">
                  <a:solidFill>
                    <a:schemeClr val="tx1"/>
                  </a:solidFill>
                  <a:latin typeface="HY헤드라인M" pitchFamily="18" charset="-127"/>
                  <a:ea typeface="HY헤드라인M" pitchFamily="18" charset="-127"/>
                </a:endParaRPr>
              </a:p>
              <a:p>
                <a:pPr marL="457200" indent="-457200" algn="just">
                  <a:buAutoNum type="arabicPeriod"/>
                </a:pPr>
                <a:r>
                  <a:rPr lang="en-US" altLang="ko-KR" dirty="0">
                    <a:solidFill>
                      <a:schemeClr val="tx1"/>
                    </a:solidFill>
                    <a:latin typeface="HY헤드라인M" pitchFamily="18" charset="-127"/>
                    <a:ea typeface="HY헤드라인M" pitchFamily="18" charset="-127"/>
                  </a:rPr>
                  <a:t>Slightly tighten your abdomen as in light coughing.</a:t>
                </a:r>
                <a:endParaRPr lang="ko-KR" altLang="en-US" dirty="0">
                  <a:solidFill>
                    <a:schemeClr val="tx1"/>
                  </a:solidFill>
                  <a:latin typeface="HY헤드라인M" pitchFamily="18" charset="-127"/>
                  <a:ea typeface="HY헤드라인M" pitchFamily="18" charset="-127"/>
                </a:endParaRPr>
              </a:p>
            </p:txBody>
          </p:sp>
          <p:sp>
            <p:nvSpPr>
              <p:cNvPr id="58" name="직사각형 57"/>
              <p:cNvSpPr/>
              <p:nvPr/>
            </p:nvSpPr>
            <p:spPr>
              <a:xfrm>
                <a:off x="192088" y="2493914"/>
                <a:ext cx="9289032" cy="317493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altLang="ko-KR" sz="1800" dirty="0">
                  <a:solidFill>
                    <a:srgbClr val="363636"/>
                  </a:solidFill>
                  <a:latin typeface="HY헤드라인M" pitchFamily="18" charset="-127"/>
                  <a:ea typeface="HY헤드라인M" pitchFamily="18" charset="-127"/>
                </a:endParaRPr>
              </a:p>
            </p:txBody>
          </p:sp>
        </p:grpSp>
        <p:sp>
          <p:nvSpPr>
            <p:cNvPr id="62" name="직사각형 61"/>
            <p:cNvSpPr/>
            <p:nvPr/>
          </p:nvSpPr>
          <p:spPr>
            <a:xfrm>
              <a:off x="288000" y="11235915"/>
              <a:ext cx="9000000" cy="853622"/>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fontAlgn="base"/>
              <a:r>
                <a:rPr lang="en-US" altLang="ko-KR" sz="1800" b="1" dirty="0">
                  <a:solidFill>
                    <a:srgbClr val="363636"/>
                  </a:solidFill>
                  <a:latin typeface="HY헤드라인M" pitchFamily="18" charset="-127"/>
                  <a:ea typeface="HY헤드라인M" pitchFamily="18" charset="-127"/>
                </a:rPr>
                <a:t>Caution</a:t>
              </a:r>
            </a:p>
            <a:p>
              <a:pPr fontAlgn="base"/>
              <a:r>
                <a:rPr lang="en-US" altLang="ko-KR" sz="1800" b="1" dirty="0">
                  <a:solidFill>
                    <a:srgbClr val="363636"/>
                  </a:solidFill>
                  <a:latin typeface="HY헤드라인M" pitchFamily="18" charset="-127"/>
                  <a:ea typeface="HY헤드라인M" pitchFamily="18" charset="-127"/>
                </a:rPr>
                <a:t>Make sure </a:t>
              </a:r>
              <a:r>
                <a:rPr lang="en-US" altLang="ko-KR" sz="1800" b="1" dirty="0">
                  <a:solidFill>
                    <a:schemeClr val="tx1">
                      <a:lumMod val="75000"/>
                      <a:lumOff val="25000"/>
                    </a:schemeClr>
                  </a:solidFill>
                  <a:latin typeface="HY헤드라인M" pitchFamily="18" charset="-127"/>
                  <a:ea typeface="HY헤드라인M" pitchFamily="18" charset="-127"/>
                </a:rPr>
                <a:t>your sitting posture stays intact while</a:t>
              </a:r>
              <a:r>
                <a:rPr lang="en-US" altLang="ko-KR" sz="1800" b="1" dirty="0">
                  <a:solidFill>
                    <a:srgbClr val="FF0000"/>
                  </a:solidFill>
                  <a:latin typeface="HY헤드라인M" pitchFamily="18" charset="-127"/>
                  <a:ea typeface="HY헤드라인M" pitchFamily="18" charset="-127"/>
                </a:rPr>
                <a:t> </a:t>
              </a:r>
              <a:r>
                <a:rPr lang="en-US" altLang="ko-KR" sz="1800" b="1" dirty="0">
                  <a:solidFill>
                    <a:srgbClr val="363636"/>
                  </a:solidFill>
                  <a:latin typeface="HY헤드라인M" pitchFamily="18" charset="-127"/>
                  <a:ea typeface="HY헤드라인M" pitchFamily="18" charset="-127"/>
                </a:rPr>
                <a:t>bracing and relaxing.</a:t>
              </a:r>
            </a:p>
          </p:txBody>
        </p:sp>
      </p:grpSp>
      <p:pic>
        <p:nvPicPr>
          <p:cNvPr id="1026" name="Picture 2"/>
          <p:cNvPicPr preferRelativeResize="0">
            <a:picLocks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6588008" y="12060000"/>
            <a:ext cx="2700000" cy="54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054" name="Picture 6"/>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1125500" y="1360240"/>
            <a:ext cx="3024336" cy="529609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055" name="Picture 7"/>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5677146" y="1576264"/>
            <a:ext cx="2625087" cy="516358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326103152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직사각형 6"/>
          <p:cNvSpPr/>
          <p:nvPr/>
        </p:nvSpPr>
        <p:spPr>
          <a:xfrm>
            <a:off x="1125500" y="42730"/>
            <a:ext cx="7755340" cy="2160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altLang="ko-KR" sz="5000" dirty="0">
                <a:solidFill>
                  <a:srgbClr val="FF0000"/>
                </a:solidFill>
                <a:latin typeface="HY헤드라인M" pitchFamily="18" charset="-127"/>
                <a:ea typeface="HY헤드라인M" pitchFamily="18" charset="-127"/>
              </a:rPr>
              <a:t>Standing Posture</a:t>
            </a:r>
          </a:p>
        </p:txBody>
      </p:sp>
      <p:grpSp>
        <p:nvGrpSpPr>
          <p:cNvPr id="72" name="그룹 71"/>
          <p:cNvGrpSpPr/>
          <p:nvPr/>
        </p:nvGrpSpPr>
        <p:grpSpPr>
          <a:xfrm>
            <a:off x="192088" y="6818520"/>
            <a:ext cx="9289032" cy="5270912"/>
            <a:chOff x="192088" y="6818520"/>
            <a:chExt cx="9289032" cy="5270912"/>
          </a:xfrm>
        </p:grpSpPr>
        <p:sp>
          <p:nvSpPr>
            <p:cNvPr id="46" name="직사각형 45"/>
            <p:cNvSpPr/>
            <p:nvPr/>
          </p:nvSpPr>
          <p:spPr>
            <a:xfrm>
              <a:off x="288008" y="6818520"/>
              <a:ext cx="9000000" cy="197989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dirty="0">
                <a:latin typeface="HY헤드라인M" pitchFamily="18" charset="-127"/>
                <a:ea typeface="HY헤드라인M" pitchFamily="18" charset="-127"/>
              </a:endParaRPr>
            </a:p>
          </p:txBody>
        </p:sp>
        <p:grpSp>
          <p:nvGrpSpPr>
            <p:cNvPr id="53" name="그룹 52"/>
            <p:cNvGrpSpPr/>
            <p:nvPr/>
          </p:nvGrpSpPr>
          <p:grpSpPr>
            <a:xfrm>
              <a:off x="192088" y="6818520"/>
              <a:ext cx="9289032" cy="4406816"/>
              <a:chOff x="192088" y="1687498"/>
              <a:chExt cx="9289032" cy="4406816"/>
            </a:xfrm>
          </p:grpSpPr>
          <p:sp>
            <p:nvSpPr>
              <p:cNvPr id="56" name="직사각형 55"/>
              <p:cNvSpPr/>
              <p:nvPr/>
            </p:nvSpPr>
            <p:spPr>
              <a:xfrm>
                <a:off x="288000" y="1687498"/>
                <a:ext cx="9000000" cy="440681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457200" indent="-457200" algn="just">
                  <a:buFontTx/>
                  <a:buAutoNum type="arabicPeriod"/>
                </a:pPr>
                <a:r>
                  <a:rPr lang="en-US" altLang="ko-KR" dirty="0">
                    <a:solidFill>
                      <a:schemeClr val="tx1"/>
                    </a:solidFill>
                    <a:latin typeface="HY헤드라인M" pitchFamily="18" charset="-127"/>
                    <a:ea typeface="HY헤드라인M" pitchFamily="18" charset="-127"/>
                  </a:rPr>
                  <a:t>Spread your legs with the same distance as your shoulders and stand with your back straight. </a:t>
                </a:r>
              </a:p>
              <a:p>
                <a:pPr marL="457200" indent="-457200" algn="just">
                  <a:buFontTx/>
                  <a:buAutoNum type="arabicPeriod"/>
                </a:pPr>
                <a:endParaRPr lang="en-US" altLang="ko-KR" dirty="0">
                  <a:solidFill>
                    <a:schemeClr val="tx1"/>
                  </a:solidFill>
                  <a:latin typeface="HY헤드라인M" pitchFamily="18" charset="-127"/>
                  <a:ea typeface="HY헤드라인M" pitchFamily="18" charset="-127"/>
                </a:endParaRPr>
              </a:p>
              <a:p>
                <a:pPr marL="457200" indent="-457200" algn="just">
                  <a:buAutoNum type="arabicPeriod"/>
                </a:pPr>
                <a:r>
                  <a:rPr lang="en-US" altLang="ko-KR" dirty="0">
                    <a:solidFill>
                      <a:schemeClr val="tx1"/>
                    </a:solidFill>
                    <a:latin typeface="HY헤드라인M" pitchFamily="18" charset="-127"/>
                    <a:ea typeface="HY헤드라인M" pitchFamily="18" charset="-127"/>
                  </a:rPr>
                  <a:t>If your chin sticks forward, you are more likely to  stoop, so make sure your chin is tucked in and keep your spine straight. </a:t>
                </a:r>
              </a:p>
              <a:p>
                <a:pPr marL="457200" indent="-457200" algn="just">
                  <a:buAutoNum type="arabicPeriod"/>
                </a:pPr>
                <a:endParaRPr lang="en-US" altLang="ko-KR" dirty="0">
                  <a:solidFill>
                    <a:schemeClr val="tx1"/>
                  </a:solidFill>
                  <a:latin typeface="HY헤드라인M" pitchFamily="18" charset="-127"/>
                  <a:ea typeface="HY헤드라인M" pitchFamily="18" charset="-127"/>
                </a:endParaRPr>
              </a:p>
              <a:p>
                <a:pPr marL="457200" indent="-457200" algn="just">
                  <a:buAutoNum type="arabicPeriod"/>
                </a:pPr>
                <a:r>
                  <a:rPr lang="en-US" altLang="ko-KR" dirty="0">
                    <a:solidFill>
                      <a:schemeClr val="tx1"/>
                    </a:solidFill>
                    <a:latin typeface="HY헤드라인M" pitchFamily="18" charset="-127"/>
                    <a:ea typeface="HY헤드라인M" pitchFamily="18" charset="-127"/>
                  </a:rPr>
                  <a:t>Straighten your chest and shoulders so that your scapulae would come closer. </a:t>
                </a:r>
              </a:p>
              <a:p>
                <a:pPr marL="457200" indent="-457200" algn="just">
                  <a:buAutoNum type="arabicPeriod"/>
                </a:pPr>
                <a:endParaRPr lang="en-US" altLang="ko-KR" dirty="0">
                  <a:solidFill>
                    <a:schemeClr val="tx1"/>
                  </a:solidFill>
                  <a:latin typeface="HY헤드라인M" pitchFamily="18" charset="-127"/>
                  <a:ea typeface="HY헤드라인M" pitchFamily="18" charset="-127"/>
                </a:endParaRPr>
              </a:p>
              <a:p>
                <a:pPr marL="457200" indent="-457200" algn="just">
                  <a:buAutoNum type="arabicPeriod"/>
                </a:pPr>
                <a:r>
                  <a:rPr lang="en-US" altLang="ko-KR" dirty="0">
                    <a:solidFill>
                      <a:schemeClr val="tx1"/>
                    </a:solidFill>
                    <a:latin typeface="HY헤드라인M" pitchFamily="18" charset="-127"/>
                    <a:ea typeface="HY헤드라인M" pitchFamily="18" charset="-127"/>
                  </a:rPr>
                  <a:t>Slightly tighten your abdomen as in light coughing</a:t>
                </a:r>
                <a:r>
                  <a:rPr lang="en-US" altLang="ko-KR" dirty="0">
                    <a:solidFill>
                      <a:srgbClr val="FF0000"/>
                    </a:solidFill>
                    <a:latin typeface="HY헤드라인M" pitchFamily="18" charset="-127"/>
                    <a:ea typeface="HY헤드라인M" pitchFamily="18" charset="-127"/>
                  </a:rPr>
                  <a:t>.</a:t>
                </a:r>
                <a:endParaRPr lang="ko-KR" altLang="en-US" dirty="0">
                  <a:solidFill>
                    <a:schemeClr val="tx1"/>
                  </a:solidFill>
                  <a:latin typeface="HY헤드라인M" pitchFamily="18" charset="-127"/>
                  <a:ea typeface="HY헤드라인M" pitchFamily="18" charset="-127"/>
                </a:endParaRPr>
              </a:p>
            </p:txBody>
          </p:sp>
          <p:sp>
            <p:nvSpPr>
              <p:cNvPr id="58" name="직사각형 57"/>
              <p:cNvSpPr/>
              <p:nvPr/>
            </p:nvSpPr>
            <p:spPr>
              <a:xfrm>
                <a:off x="192088" y="2493914"/>
                <a:ext cx="9289032" cy="317493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altLang="ko-KR" sz="1800" dirty="0">
                  <a:solidFill>
                    <a:srgbClr val="363636"/>
                  </a:solidFill>
                  <a:latin typeface="HY헤드라인M" pitchFamily="18" charset="-127"/>
                  <a:ea typeface="HY헤드라인M" pitchFamily="18" charset="-127"/>
                </a:endParaRPr>
              </a:p>
            </p:txBody>
          </p:sp>
        </p:grpSp>
        <p:sp>
          <p:nvSpPr>
            <p:cNvPr id="62" name="직사각형 61"/>
            <p:cNvSpPr/>
            <p:nvPr/>
          </p:nvSpPr>
          <p:spPr>
            <a:xfrm>
              <a:off x="288000" y="11235810"/>
              <a:ext cx="9000000" cy="853622"/>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fontAlgn="base"/>
              <a:r>
                <a:rPr lang="en-US" altLang="ko-KR" sz="1800" b="1" dirty="0">
                  <a:solidFill>
                    <a:srgbClr val="363636"/>
                  </a:solidFill>
                  <a:latin typeface="HY헤드라인M" pitchFamily="18" charset="-127"/>
                  <a:ea typeface="HY헤드라인M" pitchFamily="18" charset="-127"/>
                </a:rPr>
                <a:t>Caution</a:t>
              </a:r>
            </a:p>
            <a:p>
              <a:pPr fontAlgn="base"/>
              <a:r>
                <a:rPr lang="en-US" altLang="ko-KR" sz="1800" b="1" dirty="0">
                  <a:solidFill>
                    <a:srgbClr val="363636"/>
                  </a:solidFill>
                  <a:latin typeface="HY헤드라인M" pitchFamily="18" charset="-127"/>
                  <a:ea typeface="HY헤드라인M" pitchFamily="18" charset="-127"/>
                </a:rPr>
                <a:t>Make sure you </a:t>
              </a:r>
              <a:r>
                <a:rPr lang="en-US" altLang="ko-KR" sz="1800" b="1" dirty="0">
                  <a:solidFill>
                    <a:schemeClr val="tx1">
                      <a:lumMod val="75000"/>
                      <a:lumOff val="25000"/>
                    </a:schemeClr>
                  </a:solidFill>
                  <a:latin typeface="HY헤드라인M" pitchFamily="18" charset="-127"/>
                  <a:ea typeface="HY헤드라인M" pitchFamily="18" charset="-127"/>
                </a:rPr>
                <a:t>your sitting posture stays intact while </a:t>
              </a:r>
              <a:r>
                <a:rPr lang="en-US" altLang="ko-KR" sz="1800" b="1" dirty="0">
                  <a:solidFill>
                    <a:srgbClr val="363636"/>
                  </a:solidFill>
                  <a:latin typeface="HY헤드라인M" pitchFamily="18" charset="-127"/>
                  <a:ea typeface="HY헤드라인M" pitchFamily="18" charset="-127"/>
                </a:rPr>
                <a:t>bracing and relaxing.</a:t>
              </a:r>
            </a:p>
          </p:txBody>
        </p:sp>
      </p:grpSp>
      <p:pic>
        <p:nvPicPr>
          <p:cNvPr id="1026" name="Picture 2"/>
          <p:cNvPicPr preferRelativeResize="0">
            <a:picLocks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6588008" y="12060000"/>
            <a:ext cx="2700000" cy="54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4" name="그림 3"/>
          <p:cNvPicPr>
            <a:picLocks noChangeAspect="1"/>
          </p:cNvPicPr>
          <p:nvPr/>
        </p:nvPicPr>
        <p:blipFill>
          <a:blip r:embed="rId4">
            <a:extLst>
              <a:ext uri="{BEBA8EAE-BF5A-486C-A8C5-ECC9F3942E4B}">
                <a14:imgProps xmlns:a14="http://schemas.microsoft.com/office/drawing/2010/main">
                  <a14:imgLayer r:embed="rId5">
                    <a14:imgEffect>
                      <a14:backgroundRemoval t="0" b="100000" l="0" r="100000">
                        <a14:foregroundMark x1="11233" y1="37748" x2="11233" y2="37748"/>
                        <a14:foregroundMark x1="48899" y1="39073" x2="48899" y2="39073"/>
                        <a14:foregroundMark x1="79075" y1="41391" x2="79075" y2="41391"/>
                        <a14:foregroundMark x1="74449" y1="32119" x2="74449" y2="32119"/>
                        <a14:foregroundMark x1="80396" y1="22848" x2="80396" y2="22848"/>
                        <a14:foregroundMark x1="77533" y1="71192" x2="77533" y2="71192"/>
                        <a14:foregroundMark x1="9251" y1="6623" x2="9251" y2="6623"/>
                        <a14:foregroundMark x1="14978" y1="6623" x2="14978" y2="6623"/>
                        <a14:foregroundMark x1="21366" y1="6623" x2="21366" y2="6623"/>
                        <a14:foregroundMark x1="22907" y1="5629" x2="22907" y2="5629"/>
                        <a14:foregroundMark x1="25771" y1="4636" x2="25771" y2="4636"/>
                        <a14:foregroundMark x1="21586" y1="5629" x2="21586" y2="5629"/>
                        <a14:foregroundMark x1="18722" y1="4967" x2="18722" y2="4967"/>
                        <a14:foregroundMark x1="17621" y1="4967" x2="17621" y2="4967"/>
                        <a14:foregroundMark x1="15198" y1="4967" x2="15198" y2="4967"/>
                        <a14:foregroundMark x1="10793" y1="5298" x2="10793" y2="5298"/>
                        <a14:foregroundMark x1="8590" y1="5298" x2="8590" y2="5298"/>
                        <a14:foregroundMark x1="5947" y1="5298" x2="5947" y2="5298"/>
                        <a14:foregroundMark x1="36344" y1="4636" x2="36344" y2="4636"/>
                        <a14:foregroundMark x1="38326" y1="4636" x2="38326" y2="4636"/>
                        <a14:foregroundMark x1="39868" y1="4636" x2="39868" y2="4636"/>
                        <a14:foregroundMark x1="42511" y1="4967" x2="42511" y2="4967"/>
                        <a14:foregroundMark x1="46256" y1="5629" x2="46256" y2="5629"/>
                        <a14:foregroundMark x1="47577" y1="5629" x2="47577" y2="5629"/>
                        <a14:foregroundMark x1="49559" y1="5629" x2="49559" y2="5629"/>
                        <a14:foregroundMark x1="51101" y1="5298" x2="51101" y2="5298"/>
                        <a14:foregroundMark x1="53965" y1="5298" x2="53965" y2="5298"/>
                        <a14:foregroundMark x1="55727" y1="4636" x2="55727" y2="4636"/>
                        <a14:foregroundMark x1="57709" y1="4967" x2="57709" y2="4967"/>
                        <a14:foregroundMark x1="69383" y1="5298" x2="69383" y2="5298"/>
                        <a14:foregroundMark x1="71586" y1="5298" x2="71586" y2="5298"/>
                        <a14:foregroundMark x1="73789" y1="5298" x2="73789" y2="5298"/>
                        <a14:foregroundMark x1="74890" y1="4967" x2="74890" y2="4967"/>
                        <a14:foregroundMark x1="75110" y1="5629" x2="75110" y2="5629"/>
                        <a14:foregroundMark x1="78414" y1="5960" x2="78414" y2="5960"/>
                        <a14:foregroundMark x1="79515" y1="5629" x2="79515" y2="5629"/>
                        <a14:foregroundMark x1="81278" y1="4967" x2="81278" y2="4967"/>
                        <a14:foregroundMark x1="84141" y1="4967" x2="84141" y2="4967"/>
                        <a14:foregroundMark x1="84581" y1="4967" x2="84581" y2="4967"/>
                        <a14:foregroundMark x1="87225" y1="4967" x2="87225" y2="4967"/>
                        <a14:foregroundMark x1="88546" y1="5298" x2="88546" y2="5298"/>
                        <a14:foregroundMark x1="66520" y1="15232" x2="66520" y2="15232"/>
                        <a14:foregroundMark x1="69163" y1="15232" x2="69163" y2="15232"/>
                        <a14:foregroundMark x1="70705" y1="15232" x2="70705" y2="15232"/>
                        <a14:foregroundMark x1="71806" y1="15232" x2="71806" y2="15232"/>
                        <a14:foregroundMark x1="72687" y1="15232" x2="72687" y2="15232"/>
                        <a14:foregroundMark x1="74449" y1="15894" x2="74449" y2="15894"/>
                        <a14:foregroundMark x1="74890" y1="15894" x2="74890" y2="15894"/>
                        <a14:foregroundMark x1="69604" y1="20861" x2="69604" y2="20861"/>
                        <a14:foregroundMark x1="70044" y1="20199" x2="70044" y2="20199"/>
                        <a14:foregroundMark x1="68722" y1="19868" x2="68722" y2="19868"/>
                        <a14:foregroundMark x1="68062" y1="20199" x2="68062" y2="20199"/>
                        <a14:foregroundMark x1="68502" y1="47020" x2="68502" y2="47020"/>
                        <a14:foregroundMark x1="70485" y1="46689" x2="70485" y2="46689"/>
                        <a14:foregroundMark x1="72026" y1="46689" x2="72026" y2="46689"/>
                        <a14:foregroundMark x1="73348" y1="45695" x2="73348" y2="45695"/>
                        <a14:foregroundMark x1="72687" y1="46026" x2="71806" y2="46358"/>
                        <a14:foregroundMark x1="70044" y1="46358" x2="69604" y2="46358"/>
                        <a14:foregroundMark x1="69604" y1="46358" x2="69604" y2="46358"/>
                        <a14:foregroundMark x1="68502" y1="45695" x2="68502" y2="45695"/>
                        <a14:foregroundMark x1="68502" y1="45695" x2="68502" y2="45695"/>
                        <a14:foregroundMark x1="68502" y1="45695" x2="68502" y2="45695"/>
                        <a14:foregroundMark x1="68943" y1="46689" x2="68943" y2="46689"/>
                        <a14:foregroundMark x1="69604" y1="46689" x2="69824" y2="46689"/>
                        <a14:foregroundMark x1="70264" y1="46358" x2="70264" y2="46358"/>
                        <a14:foregroundMark x1="83700" y1="28477" x2="83700" y2="28477"/>
                        <a14:foregroundMark x1="83700" y1="28477" x2="83700" y2="28477"/>
                        <a14:foregroundMark x1="85463" y1="28146" x2="85463" y2="28146"/>
                        <a14:foregroundMark x1="86564" y1="28146" x2="86564" y2="28146"/>
                        <a14:foregroundMark x1="89648" y1="28146" x2="89648" y2="28146"/>
                        <a14:foregroundMark x1="89648" y1="28146" x2="89648" y2="28146"/>
                        <a14:foregroundMark x1="90529" y1="28146" x2="90529" y2="28146"/>
                        <a14:foregroundMark x1="91189" y1="28146" x2="91630" y2="28146"/>
                        <a14:foregroundMark x1="92952" y1="27815" x2="92952" y2="27815"/>
                        <a14:foregroundMark x1="83040" y1="33113" x2="83040" y2="33113"/>
                        <a14:foregroundMark x1="83040" y1="33113" x2="83040" y2="33113"/>
                        <a14:foregroundMark x1="83260" y1="33113" x2="83260" y2="33113"/>
                        <a14:foregroundMark x1="84581" y1="33113" x2="84581" y2="33113"/>
                        <a14:foregroundMark x1="85683" y1="33113" x2="86123" y2="33113"/>
                        <a14:foregroundMark x1="88326" y1="33113" x2="88326" y2="33113"/>
                        <a14:foregroundMark x1="88326" y1="33113" x2="88326" y2="33113"/>
                        <a14:foregroundMark x1="88546" y1="33444" x2="88546" y2="33444"/>
                        <a14:foregroundMark x1="87665" y1="33444" x2="87665" y2="33444"/>
                        <a14:foregroundMark x1="87225" y1="33444" x2="87225" y2="33444"/>
                        <a14:foregroundMark x1="86784" y1="33775" x2="86784" y2="33775"/>
                        <a14:foregroundMark x1="87445" y1="33113" x2="87885" y2="33113"/>
                        <a14:foregroundMark x1="89868" y1="33113" x2="89868" y2="33113"/>
                        <a14:foregroundMark x1="90969" y1="32450" x2="90969" y2="32450"/>
                        <a14:foregroundMark x1="91850" y1="32119" x2="91850" y2="32119"/>
                        <a14:foregroundMark x1="91850" y1="32119" x2="92070" y2="32450"/>
                        <a14:foregroundMark x1="92291" y1="32119" x2="92291" y2="32119"/>
                        <a14:foregroundMark x1="92291" y1="32119" x2="92291" y2="32119"/>
                        <a14:foregroundMark x1="92291" y1="33113" x2="92291" y2="33113"/>
                        <a14:foregroundMark x1="92511" y1="32450" x2="92511" y2="32450"/>
                        <a14:foregroundMark x1="92511" y1="32450" x2="92511" y2="32450"/>
                        <a14:foregroundMark x1="90969" y1="32450" x2="90969" y2="32450"/>
                        <a14:foregroundMark x1="87665" y1="40066" x2="87665" y2="40066"/>
                        <a14:foregroundMark x1="88987" y1="39735" x2="88987" y2="39735"/>
                        <a14:foregroundMark x1="88987" y1="39735" x2="88987" y2="39735"/>
                        <a14:foregroundMark x1="90969" y1="39073" x2="90969" y2="39073"/>
                        <a14:foregroundMark x1="90969" y1="39073" x2="90969" y2="39073"/>
                        <a14:foregroundMark x1="91189" y1="38742" x2="91189" y2="38742"/>
                        <a14:foregroundMark x1="92511" y1="38742" x2="92511" y2="38742"/>
                        <a14:foregroundMark x1="84581" y1="45033" x2="84581" y2="45033"/>
                        <a14:foregroundMark x1="86784" y1="45033" x2="86784" y2="45033"/>
                        <a14:foregroundMark x1="89207" y1="45364" x2="89207" y2="45364"/>
                        <a14:foregroundMark x1="90308" y1="45033" x2="90308" y2="45033"/>
                        <a14:foregroundMark x1="91410" y1="45364" x2="91410" y2="45364"/>
                        <a14:foregroundMark x1="93392" y1="45033" x2="93392" y2="45033"/>
                        <a14:foregroundMark x1="94714" y1="44371" x2="94714" y2="44371"/>
                        <a14:foregroundMark x1="96476" y1="44371" x2="96476" y2="44371"/>
                        <a14:foregroundMark x1="85683" y1="50000" x2="85683" y2="50000"/>
                        <a14:foregroundMark x1="87004" y1="49669" x2="87004" y2="49669"/>
                        <a14:foregroundMark x1="87885" y1="49669" x2="87885" y2="49669"/>
                        <a14:foregroundMark x1="88546" y1="49338" x2="88546" y2="49338"/>
                        <a14:foregroundMark x1="88987" y1="49338" x2="88987" y2="49338"/>
                        <a14:foregroundMark x1="89427" y1="49338" x2="89427" y2="49338"/>
                        <a14:foregroundMark x1="90088" y1="49338" x2="90088" y2="49338"/>
                        <a14:foregroundMark x1="90749" y1="49338" x2="90749" y2="49338"/>
                        <a14:foregroundMark x1="91410" y1="49338" x2="91410" y2="49338"/>
                        <a14:foregroundMark x1="92291" y1="49338" x2="92291" y2="49338"/>
                        <a14:foregroundMark x1="92952" y1="49338" x2="92952" y2="49338"/>
                        <a14:foregroundMark x1="92952" y1="49338" x2="92952" y2="49338"/>
                        <a14:foregroundMark x1="93612" y1="49338" x2="93612" y2="49338"/>
                        <a14:foregroundMark x1="94273" y1="49338" x2="94273" y2="49338"/>
                        <a14:foregroundMark x1="94273" y1="49669" x2="94273" y2="49669"/>
                        <a14:foregroundMark x1="31278" y1="42715" x2="31278" y2="42715"/>
                        <a14:foregroundMark x1="33040" y1="42715" x2="33040" y2="42715"/>
                        <a14:foregroundMark x1="35022" y1="43709" x2="35022" y2="43709"/>
                        <a14:foregroundMark x1="34141" y1="43377" x2="34141" y2="43377"/>
                        <a14:foregroundMark x1="36784" y1="43709" x2="36784" y2="43709"/>
                        <a14:foregroundMark x1="37445" y1="43709" x2="37445" y2="43709"/>
                        <a14:foregroundMark x1="38106" y1="43377" x2="38106" y2="43377"/>
                        <a14:foregroundMark x1="38767" y1="43377" x2="38767" y2="43377"/>
                        <a14:foregroundMark x1="39427" y1="43377" x2="39427" y2="43377"/>
                        <a14:foregroundMark x1="40969" y1="43046" x2="40969" y2="43046"/>
                        <a14:foregroundMark x1="40969" y1="43046" x2="40969" y2="43046"/>
                        <a14:foregroundMark x1="32379" y1="48013" x2="32379" y2="48013"/>
                        <a14:foregroundMark x1="34361" y1="47351" x2="34361" y2="47351"/>
                        <a14:foregroundMark x1="36344" y1="48013" x2="36344" y2="48013"/>
                        <a14:foregroundMark x1="37665" y1="48013" x2="37665" y2="48013"/>
                        <a14:foregroundMark x1="38106" y1="48013" x2="38106" y2="48013"/>
                        <a14:foregroundMark x1="39868" y1="48013" x2="39868" y2="48013"/>
                        <a14:foregroundMark x1="38987" y1="47682" x2="38987" y2="47682"/>
                        <a14:foregroundMark x1="39427" y1="47682" x2="39427" y2="47682"/>
                        <a14:foregroundMark x1="32599" y1="52649" x2="32599" y2="52649"/>
                        <a14:foregroundMark x1="34361" y1="52649" x2="34361" y2="52649"/>
                        <a14:foregroundMark x1="37445" y1="51656" x2="37445" y2="51656"/>
                        <a14:foregroundMark x1="37004" y1="51987" x2="37004" y2="51987"/>
                        <a14:foregroundMark x1="38546" y1="51656" x2="38546" y2="51656"/>
                        <a14:foregroundMark x1="39207" y1="51656" x2="39207" y2="51656"/>
                        <a14:foregroundMark x1="39868" y1="50993" x2="39868" y2="50993"/>
                        <a14:foregroundMark x1="39648" y1="51325" x2="39648" y2="51325"/>
                        <a14:foregroundMark x1="4626" y1="17219" x2="4626" y2="17219"/>
                        <a14:foregroundMark x1="4185" y1="16556" x2="4185" y2="16556"/>
                        <a14:foregroundMark x1="5286" y1="15894" x2="5286" y2="15894"/>
                        <a14:foregroundMark x1="7048" y1="15563" x2="7048" y2="15563"/>
                        <a14:foregroundMark x1="7489" y1="15563" x2="7489" y2="15563"/>
                        <a14:foregroundMark x1="9251" y1="15563" x2="9251" y2="15563"/>
                        <a14:foregroundMark x1="10793" y1="15563" x2="10793" y2="15563"/>
                        <a14:foregroundMark x1="12115" y1="15563" x2="12115" y2="15563"/>
                        <a14:foregroundMark x1="4405" y1="15894" x2="4405" y2="15894"/>
                        <a14:foregroundMark x1="4185" y1="16225" x2="4185" y2="16225"/>
                        <a14:foregroundMark x1="5727" y1="21523" x2="5727" y2="21523"/>
                        <a14:foregroundMark x1="7489" y1="20199" x2="7489" y2="20199"/>
                        <a14:foregroundMark x1="9471" y1="20199" x2="9471" y2="20199"/>
                        <a14:foregroundMark x1="9912" y1="19868" x2="9912" y2="19868"/>
                        <a14:foregroundMark x1="5947" y1="20199" x2="5947" y2="20199"/>
                        <a14:foregroundMark x1="10132" y1="21523" x2="10132" y2="21523"/>
                        <a14:foregroundMark x1="3965" y1="42384" x2="3965" y2="42384"/>
                        <a14:foregroundMark x1="5286" y1="42715" x2="5286" y2="42715"/>
                        <a14:foregroundMark x1="6828" y1="42715" x2="6828" y2="42715"/>
                        <a14:foregroundMark x1="6388" y1="43377" x2="6388" y2="43377"/>
                        <a14:foregroundMark x1="4626" y1="42715" x2="4626" y2="42715"/>
                        <a14:foregroundMark x1="4185" y1="42715" x2="4185" y2="42715"/>
                        <a14:foregroundMark x1="3965" y1="42715" x2="3965" y2="42715"/>
                        <a14:foregroundMark x1="3965" y1="42715" x2="3965" y2="42715"/>
                        <a14:foregroundMark x1="3965" y1="42715" x2="3524" y2="42384"/>
                        <a14:foregroundMark x1="3524" y1="42384" x2="3524" y2="42384"/>
                        <a14:foregroundMark x1="3524" y1="42384" x2="3524" y2="42384"/>
                        <a14:foregroundMark x1="3524" y1="42384" x2="3524" y2="42384"/>
                        <a14:foregroundMark x1="3304" y1="42053" x2="3304" y2="42053"/>
                        <a14:foregroundMark x1="3744" y1="42715" x2="3744" y2="42715"/>
                        <a14:foregroundMark x1="3304" y1="47682" x2="3304" y2="47682"/>
                        <a14:foregroundMark x1="3304" y1="47682" x2="3304" y2="47682"/>
                        <a14:foregroundMark x1="3304" y1="47682" x2="3304" y2="47682"/>
                        <a14:foregroundMark x1="3304" y1="47682" x2="3304" y2="47682"/>
                        <a14:foregroundMark x1="3304" y1="47682" x2="3304" y2="47682"/>
                        <a14:foregroundMark x1="3304" y1="47682" x2="3304" y2="47682"/>
                        <a14:foregroundMark x1="3304" y1="47682" x2="3304" y2="47682"/>
                        <a14:foregroundMark x1="2863" y1="47682" x2="2863" y2="47682"/>
                        <a14:foregroundMark x1="3965" y1="48013" x2="3965" y2="48013"/>
                        <a14:foregroundMark x1="5066" y1="48013" x2="5066" y2="48013"/>
                        <a14:foregroundMark x1="5947" y1="47351" x2="5947" y2="47351"/>
                        <a14:foregroundMark x1="5947" y1="47351" x2="5947" y2="47351"/>
                        <a14:foregroundMark x1="5947" y1="47351" x2="5947" y2="47351"/>
                        <a14:foregroundMark x1="6388" y1="47351" x2="6388" y2="47351"/>
                        <a14:foregroundMark x1="6388" y1="47351" x2="6388" y2="47351"/>
                        <a14:foregroundMark x1="6608" y1="47351" x2="6608" y2="47351"/>
                        <a14:foregroundMark x1="3744" y1="14570" x2="3744" y2="14570"/>
                        <a14:foregroundMark x1="3744" y1="14570" x2="3744" y2="14570"/>
                        <a14:foregroundMark x1="4846" y1="15232" x2="4846" y2="15232"/>
                        <a14:foregroundMark x1="5066" y1="14901" x2="5066" y2="14901"/>
                        <a14:foregroundMark x1="5727" y1="14570" x2="5727" y2="14570"/>
                        <a14:foregroundMark x1="5286" y1="15894" x2="5286" y2="15894"/>
                        <a14:foregroundMark x1="6167" y1="15894" x2="6167" y2="15894"/>
                        <a14:foregroundMark x1="6167" y1="15894" x2="6167" y2="15894"/>
                        <a14:foregroundMark x1="68722" y1="46358" x2="68722" y2="46358"/>
                        <a14:foregroundMark x1="69163" y1="46689" x2="69163" y2="46689"/>
                        <a14:foregroundMark x1="70044" y1="46689" x2="70044" y2="46689"/>
                        <a14:foregroundMark x1="70044" y1="46689" x2="70044" y2="46689"/>
                        <a14:foregroundMark x1="70705" y1="47020" x2="72907" y2="47020"/>
                        <a14:foregroundMark x1="82819" y1="27483" x2="82819" y2="27483"/>
                        <a14:foregroundMark x1="82819" y1="27483" x2="82819" y2="27483"/>
                        <a14:foregroundMark x1="83040" y1="27815" x2="83040" y2="27815"/>
                        <a14:foregroundMark x1="84361" y1="27815" x2="84361" y2="27815"/>
                        <a14:foregroundMark x1="84802" y1="27815" x2="84802" y2="27815"/>
                        <a14:foregroundMark x1="85683" y1="27815" x2="85683" y2="27815"/>
                        <a14:foregroundMark x1="86784" y1="27815" x2="87225" y2="27815"/>
                        <a14:foregroundMark x1="87445" y1="27815" x2="87445" y2="27815"/>
                        <a14:foregroundMark x1="88326" y1="27483" x2="88326" y2="27483"/>
                        <a14:foregroundMark x1="88326" y1="27483" x2="88767" y2="27152"/>
                        <a14:foregroundMark x1="88987" y1="27152" x2="89427" y2="27152"/>
                        <a14:foregroundMark x1="89648" y1="27152" x2="89648" y2="27152"/>
                        <a14:foregroundMark x1="90088" y1="27152" x2="90088" y2="27152"/>
                        <a14:foregroundMark x1="90088" y1="27152" x2="90529" y2="27152"/>
                        <a14:foregroundMark x1="90749" y1="27152" x2="90749" y2="27152"/>
                        <a14:foregroundMark x1="90749" y1="27152" x2="90749" y2="27152"/>
                        <a14:foregroundMark x1="90969" y1="26821" x2="90969" y2="26821"/>
                        <a14:foregroundMark x1="91189" y1="26821" x2="91630" y2="26821"/>
                        <a14:foregroundMark x1="91850" y1="27152" x2="91850" y2="27152"/>
                        <a14:foregroundMark x1="92291" y1="27152" x2="92291" y2="27152"/>
                        <a14:foregroundMark x1="92291" y1="27152" x2="92291" y2="27152"/>
                        <a14:foregroundMark x1="88546" y1="39404" x2="88546" y2="39404"/>
                        <a14:foregroundMark x1="88546" y1="39404" x2="88546" y2="39404"/>
                        <a14:foregroundMark x1="88546" y1="39404" x2="88987" y2="39404"/>
                        <a14:foregroundMark x1="90088" y1="39404" x2="90529" y2="39404"/>
                        <a14:foregroundMark x1="91410" y1="39735" x2="91410" y2="39735"/>
                        <a14:foregroundMark x1="92070" y1="39735" x2="92731" y2="39735"/>
                        <a14:foregroundMark x1="88326" y1="28477" x2="88326" y2="28477"/>
                        <a14:foregroundMark x1="66960" y1="14901" x2="66960" y2="14901"/>
                        <a14:foregroundMark x1="67621" y1="15563" x2="67621" y2="15563"/>
                        <a14:foregroundMark x1="68062" y1="15563" x2="68062" y2="15563"/>
                        <a14:foregroundMark x1="68502" y1="15563" x2="68502" y2="15563"/>
                        <a14:foregroundMark x1="68722" y1="15563" x2="68722" y2="15563"/>
                        <a14:foregroundMark x1="69163" y1="15563" x2="69824" y2="15563"/>
                        <a14:foregroundMark x1="70485" y1="15232" x2="70485" y2="15232"/>
                        <a14:foregroundMark x1="71145" y1="15232" x2="71145" y2="15232"/>
                        <a14:foregroundMark x1="71366" y1="15232" x2="71366" y2="15232"/>
                        <a14:foregroundMark x1="90088" y1="28808" x2="90088" y2="28808"/>
                        <a14:foregroundMark x1="84141" y1="28146" x2="84141" y2="28146"/>
                        <a14:foregroundMark x1="83921" y1="28146" x2="83921" y2="28146"/>
                        <a14:foregroundMark x1="83260" y1="27815" x2="83260" y2="27815"/>
                        <a14:foregroundMark x1="67181" y1="15563" x2="67181" y2="15563"/>
                        <a14:foregroundMark x1="67401" y1="15894" x2="67401" y2="15894"/>
                        <a14:foregroundMark x1="68282" y1="15894" x2="68282" y2="15894"/>
                        <a14:foregroundMark x1="69163" y1="15894" x2="69163" y2="15894"/>
                        <a14:foregroundMark x1="70264" y1="15232" x2="70264" y2="15232"/>
                        <a14:foregroundMark x1="71145" y1="15232" x2="71145" y2="15232"/>
                        <a14:foregroundMark x1="72247" y1="15232" x2="72247" y2="15232"/>
                        <a14:foregroundMark x1="73128" y1="14901" x2="73128" y2="14901"/>
                        <a14:foregroundMark x1="75110" y1="16225" x2="75110" y2="16225"/>
                        <a14:foregroundMark x1="69383" y1="16225" x2="69383" y2="16225"/>
                        <a14:foregroundMark x1="66079" y1="15232" x2="66079" y2="15232"/>
                        <a14:foregroundMark x1="68722" y1="21854" x2="68722" y2="21854"/>
                        <a14:foregroundMark x1="69163" y1="21523" x2="69163" y2="21523"/>
                        <a14:foregroundMark x1="70925" y1="20861" x2="70925" y2="20861"/>
                        <a14:foregroundMark x1="72026" y1="20199" x2="72026" y2="20199"/>
                        <a14:foregroundMark x1="72026" y1="20199" x2="72026" y2="20199"/>
                        <a14:foregroundMark x1="74009" y1="20199" x2="74009" y2="20199"/>
                        <a14:foregroundMark x1="68502" y1="46358" x2="68502" y2="46358"/>
                        <a14:foregroundMark x1="68943" y1="46689" x2="68943" y2="46689"/>
                        <a14:foregroundMark x1="68722" y1="51656" x2="68722" y2="51656"/>
                        <a14:foregroundMark x1="69163" y1="50000" x2="69163" y2="50000"/>
                        <a14:foregroundMark x1="70044" y1="50000" x2="70705" y2="50000"/>
                        <a14:foregroundMark x1="71366" y1="50331" x2="71366" y2="50331"/>
                        <a14:foregroundMark x1="71366" y1="50331" x2="71366" y2="50331"/>
                        <a14:foregroundMark x1="71366" y1="50331" x2="71366" y2="50331"/>
                        <a14:foregroundMark x1="92291" y1="40066" x2="92291" y2="40066"/>
                        <a14:foregroundMark x1="92731" y1="40066" x2="92731" y2="40066"/>
                        <a14:foregroundMark x1="92731" y1="40066" x2="92731" y2="40066"/>
                        <a14:foregroundMark x1="94934" y1="45695" x2="94934" y2="45695"/>
                        <a14:foregroundMark x1="95595" y1="45695" x2="95595" y2="45695"/>
                        <a14:backgroundMark x1="88326" y1="29801" x2="88326" y2="29801"/>
                        <a14:backgroundMark x1="68722" y1="48013" x2="68722" y2="48013"/>
                        <a14:backgroundMark x1="70264" y1="48344" x2="70485" y2="47682"/>
                      </a14:backgroundRemoval>
                    </a14:imgEffect>
                  </a14:imgLayer>
                </a14:imgProps>
              </a:ext>
              <a:ext uri="{28A0092B-C50C-407E-A947-70E740481C1C}">
                <a14:useLocalDpi xmlns:a14="http://schemas.microsoft.com/office/drawing/2010/main" val="0"/>
              </a:ext>
            </a:extLst>
          </a:blip>
          <a:stretch>
            <a:fillRect/>
          </a:stretch>
        </p:blipFill>
        <p:spPr>
          <a:xfrm>
            <a:off x="1681479" y="2202730"/>
            <a:ext cx="6643382" cy="4419166"/>
          </a:xfrm>
          <a:prstGeom prst="rect">
            <a:avLst/>
          </a:prstGeom>
        </p:spPr>
      </p:pic>
    </p:spTree>
    <p:extLst>
      <p:ext uri="{BB962C8B-B14F-4D97-AF65-F5344CB8AC3E}">
        <p14:creationId xmlns:p14="http://schemas.microsoft.com/office/powerpoint/2010/main" val="212829992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 name="모서리가 둥근 직사각형 20"/>
          <p:cNvSpPr/>
          <p:nvPr/>
        </p:nvSpPr>
        <p:spPr>
          <a:xfrm>
            <a:off x="4788000" y="2202730"/>
            <a:ext cx="4622858" cy="4938738"/>
          </a:xfrm>
          <a:prstGeom prst="roundRect">
            <a:avLst/>
          </a:prstGeom>
          <a:solidFill>
            <a:schemeClr val="bg1"/>
          </a:solidFill>
          <a:ln w="50800">
            <a:solidFill>
              <a:srgbClr val="689E1D"/>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20" name="모서리가 둥근 직사각형 19"/>
          <p:cNvSpPr/>
          <p:nvPr/>
        </p:nvSpPr>
        <p:spPr>
          <a:xfrm>
            <a:off x="70230" y="2202730"/>
            <a:ext cx="4622858" cy="4938738"/>
          </a:xfrm>
          <a:prstGeom prst="roundRect">
            <a:avLst/>
          </a:prstGeom>
          <a:solidFill>
            <a:schemeClr val="bg1"/>
          </a:solidFill>
          <a:ln w="50800">
            <a:solidFill>
              <a:srgbClr val="689E1D"/>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7" name="직사각형 6"/>
          <p:cNvSpPr/>
          <p:nvPr/>
        </p:nvSpPr>
        <p:spPr>
          <a:xfrm>
            <a:off x="912169" y="-7912"/>
            <a:ext cx="8280920" cy="2160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altLang="ko-KR" sz="5000" dirty="0">
                <a:solidFill>
                  <a:srgbClr val="FF0000"/>
                </a:solidFill>
                <a:latin typeface="HY헤드라인M" pitchFamily="18" charset="-127"/>
                <a:ea typeface="HY헤드라인M" pitchFamily="18" charset="-127"/>
              </a:rPr>
              <a:t>Abdominal Bracing with Deep Breathing</a:t>
            </a:r>
          </a:p>
          <a:p>
            <a:r>
              <a:rPr lang="en-US" altLang="ko-KR" sz="2400" dirty="0">
                <a:solidFill>
                  <a:srgbClr val="FF0000"/>
                </a:solidFill>
                <a:latin typeface="HY헤드라인M" pitchFamily="18" charset="-127"/>
                <a:ea typeface="HY헤드라인M" pitchFamily="18" charset="-127"/>
              </a:rPr>
              <a:t>1st Set (10 times), 2nd Set (10 times), and 3rd Set           (10 times) 3 times/day</a:t>
            </a:r>
          </a:p>
        </p:txBody>
      </p:sp>
      <p:grpSp>
        <p:nvGrpSpPr>
          <p:cNvPr id="72" name="그룹 71"/>
          <p:cNvGrpSpPr/>
          <p:nvPr/>
        </p:nvGrpSpPr>
        <p:grpSpPr>
          <a:xfrm>
            <a:off x="193088" y="2701392"/>
            <a:ext cx="9000000" cy="9316032"/>
            <a:chOff x="288000" y="2701392"/>
            <a:chExt cx="9000000" cy="9316032"/>
          </a:xfrm>
        </p:grpSpPr>
        <p:sp>
          <p:nvSpPr>
            <p:cNvPr id="19" name="순서도: 지연 18"/>
            <p:cNvSpPr/>
            <p:nvPr/>
          </p:nvSpPr>
          <p:spPr>
            <a:xfrm>
              <a:off x="305936" y="2701392"/>
              <a:ext cx="1800000" cy="1584000"/>
            </a:xfrm>
            <a:custGeom>
              <a:avLst/>
              <a:gdLst>
                <a:gd name="connsiteX0" fmla="*/ 0 w 3072440"/>
                <a:gd name="connsiteY0" fmla="*/ 0 h 1512168"/>
                <a:gd name="connsiteX1" fmla="*/ 1536220 w 3072440"/>
                <a:gd name="connsiteY1" fmla="*/ 0 h 1512168"/>
                <a:gd name="connsiteX2" fmla="*/ 3072440 w 3072440"/>
                <a:gd name="connsiteY2" fmla="*/ 756084 h 1512168"/>
                <a:gd name="connsiteX3" fmla="*/ 1536220 w 3072440"/>
                <a:gd name="connsiteY3" fmla="*/ 1512168 h 1512168"/>
                <a:gd name="connsiteX4" fmla="*/ 0 w 3072440"/>
                <a:gd name="connsiteY4" fmla="*/ 1512168 h 1512168"/>
                <a:gd name="connsiteX5" fmla="*/ 0 w 3072440"/>
                <a:gd name="connsiteY5" fmla="*/ 0 h 1512168"/>
                <a:gd name="connsiteX0" fmla="*/ 0 w 3144931"/>
                <a:gd name="connsiteY0" fmla="*/ 0 h 1512168"/>
                <a:gd name="connsiteX1" fmla="*/ 2378903 w 3144931"/>
                <a:gd name="connsiteY1" fmla="*/ 17929 h 1512168"/>
                <a:gd name="connsiteX2" fmla="*/ 3072440 w 3144931"/>
                <a:gd name="connsiteY2" fmla="*/ 756084 h 1512168"/>
                <a:gd name="connsiteX3" fmla="*/ 1536220 w 3144931"/>
                <a:gd name="connsiteY3" fmla="*/ 1512168 h 1512168"/>
                <a:gd name="connsiteX4" fmla="*/ 0 w 3144931"/>
                <a:gd name="connsiteY4" fmla="*/ 1512168 h 1512168"/>
                <a:gd name="connsiteX5" fmla="*/ 0 w 3144931"/>
                <a:gd name="connsiteY5" fmla="*/ 0 h 1512168"/>
                <a:gd name="connsiteX0" fmla="*/ 0 w 3086098"/>
                <a:gd name="connsiteY0" fmla="*/ 0 h 1512168"/>
                <a:gd name="connsiteX1" fmla="*/ 2378903 w 3086098"/>
                <a:gd name="connsiteY1" fmla="*/ 17929 h 1512168"/>
                <a:gd name="connsiteX2" fmla="*/ 3072440 w 3086098"/>
                <a:gd name="connsiteY2" fmla="*/ 756084 h 1512168"/>
                <a:gd name="connsiteX3" fmla="*/ 2343043 w 3086098"/>
                <a:gd name="connsiteY3" fmla="*/ 1494239 h 1512168"/>
                <a:gd name="connsiteX4" fmla="*/ 0 w 3086098"/>
                <a:gd name="connsiteY4" fmla="*/ 1512168 h 1512168"/>
                <a:gd name="connsiteX5" fmla="*/ 0 w 3086098"/>
                <a:gd name="connsiteY5" fmla="*/ 0 h 1512168"/>
                <a:gd name="connsiteX0" fmla="*/ 0 w 3086098"/>
                <a:gd name="connsiteY0" fmla="*/ 35859 h 1548027"/>
                <a:gd name="connsiteX1" fmla="*/ 2378903 w 3086098"/>
                <a:gd name="connsiteY1" fmla="*/ 0 h 1548027"/>
                <a:gd name="connsiteX2" fmla="*/ 3072440 w 3086098"/>
                <a:gd name="connsiteY2" fmla="*/ 791943 h 1548027"/>
                <a:gd name="connsiteX3" fmla="*/ 2343043 w 3086098"/>
                <a:gd name="connsiteY3" fmla="*/ 1530098 h 1548027"/>
                <a:gd name="connsiteX4" fmla="*/ 0 w 3086098"/>
                <a:gd name="connsiteY4" fmla="*/ 1548027 h 1548027"/>
                <a:gd name="connsiteX5" fmla="*/ 0 w 3086098"/>
                <a:gd name="connsiteY5" fmla="*/ 35859 h 1548027"/>
                <a:gd name="connsiteX0" fmla="*/ 0 w 3081850"/>
                <a:gd name="connsiteY0" fmla="*/ 0 h 1512168"/>
                <a:gd name="connsiteX1" fmla="*/ 2360973 w 3081850"/>
                <a:gd name="connsiteY1" fmla="*/ 17929 h 1512168"/>
                <a:gd name="connsiteX2" fmla="*/ 3072440 w 3081850"/>
                <a:gd name="connsiteY2" fmla="*/ 756084 h 1512168"/>
                <a:gd name="connsiteX3" fmla="*/ 2343043 w 3081850"/>
                <a:gd name="connsiteY3" fmla="*/ 1494239 h 1512168"/>
                <a:gd name="connsiteX4" fmla="*/ 0 w 3081850"/>
                <a:gd name="connsiteY4" fmla="*/ 1512168 h 1512168"/>
                <a:gd name="connsiteX5" fmla="*/ 0 w 3081850"/>
                <a:gd name="connsiteY5" fmla="*/ 0 h 151216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3081850" h="1512168">
                  <a:moveTo>
                    <a:pt x="0" y="0"/>
                  </a:moveTo>
                  <a:lnTo>
                    <a:pt x="2360973" y="17929"/>
                  </a:lnTo>
                  <a:cubicBezTo>
                    <a:pt x="3209404" y="17929"/>
                    <a:pt x="3075428" y="510032"/>
                    <a:pt x="3072440" y="756084"/>
                  </a:cubicBezTo>
                  <a:cubicBezTo>
                    <a:pt x="3069452" y="1002136"/>
                    <a:pt x="3191474" y="1494239"/>
                    <a:pt x="2343043" y="1494239"/>
                  </a:cubicBezTo>
                  <a:lnTo>
                    <a:pt x="0" y="1512168"/>
                  </a:lnTo>
                  <a:lnTo>
                    <a:pt x="0" y="0"/>
                  </a:lnTo>
                  <a:close/>
                </a:path>
              </a:pathLst>
            </a:custGeom>
            <a:solidFill>
              <a:srgbClr val="FDF00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dirty="0">
                  <a:solidFill>
                    <a:srgbClr val="106E0E"/>
                  </a:solidFill>
                  <a:latin typeface="HY헤드라인M" pitchFamily="18" charset="-127"/>
                  <a:ea typeface="HY헤드라인M" pitchFamily="18" charset="-127"/>
                </a:rPr>
                <a:t>Inhale</a:t>
              </a:r>
            </a:p>
          </p:txBody>
        </p:sp>
        <p:sp>
          <p:nvSpPr>
            <p:cNvPr id="62" name="직사각형 61"/>
            <p:cNvSpPr/>
            <p:nvPr/>
          </p:nvSpPr>
          <p:spPr>
            <a:xfrm>
              <a:off x="288000" y="11163802"/>
              <a:ext cx="9000000" cy="853622"/>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fontAlgn="base"/>
              <a:r>
                <a:rPr lang="en-US" altLang="ko-KR" sz="1800" b="1" dirty="0">
                  <a:solidFill>
                    <a:srgbClr val="363636"/>
                  </a:solidFill>
                  <a:latin typeface="HY헤드라인M" pitchFamily="18" charset="-127"/>
                  <a:ea typeface="HY헤드라인M" pitchFamily="18" charset="-127"/>
                </a:rPr>
                <a:t>Caution</a:t>
              </a:r>
            </a:p>
            <a:p>
              <a:pPr fontAlgn="base"/>
              <a:r>
                <a:rPr lang="en-US" altLang="ko-KR" sz="1800" b="1" dirty="0">
                  <a:solidFill>
                    <a:srgbClr val="363636"/>
                  </a:solidFill>
                  <a:latin typeface="HY헤드라인M" pitchFamily="18" charset="-127"/>
                  <a:ea typeface="HY헤드라인M" pitchFamily="18" charset="-127"/>
                </a:rPr>
                <a:t>Relax during the motions and make </a:t>
              </a:r>
              <a:r>
                <a:rPr lang="en-US" altLang="ko-KR" sz="1800" b="1" dirty="0">
                  <a:solidFill>
                    <a:schemeClr val="tx1">
                      <a:lumMod val="75000"/>
                      <a:lumOff val="25000"/>
                    </a:schemeClr>
                  </a:solidFill>
                  <a:latin typeface="HY헤드라인M" pitchFamily="18" charset="-127"/>
                  <a:ea typeface="HY헤드라인M" pitchFamily="18" charset="-127"/>
                </a:rPr>
                <a:t>sure you feel no pain</a:t>
              </a:r>
              <a:r>
                <a:rPr lang="en-US" altLang="ko-KR" sz="1800" b="1" dirty="0">
                  <a:solidFill>
                    <a:srgbClr val="363636"/>
                  </a:solidFill>
                  <a:latin typeface="HY헤드라인M" pitchFamily="18" charset="-127"/>
                  <a:ea typeface="HY헤드라인M" pitchFamily="18" charset="-127"/>
                </a:rPr>
                <a:t>.</a:t>
              </a:r>
            </a:p>
          </p:txBody>
        </p:sp>
      </p:grpSp>
      <p:pic>
        <p:nvPicPr>
          <p:cNvPr id="1026" name="Picture 2"/>
          <p:cNvPicPr preferRelativeResize="0">
            <a:picLocks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6588008" y="12060000"/>
            <a:ext cx="2700000" cy="54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2" name="직사각형 41"/>
          <p:cNvSpPr/>
          <p:nvPr/>
        </p:nvSpPr>
        <p:spPr>
          <a:xfrm>
            <a:off x="288000" y="7264896"/>
            <a:ext cx="9000000" cy="381642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342900" indent="-342900" algn="just">
              <a:buFontTx/>
              <a:buChar char="-"/>
            </a:pPr>
            <a:r>
              <a:rPr lang="en-US" altLang="ko-KR" dirty="0">
                <a:solidFill>
                  <a:schemeClr val="tx1"/>
                </a:solidFill>
                <a:latin typeface="HY헤드라인M" pitchFamily="18" charset="-127"/>
                <a:ea typeface="HY헤드라인M" pitchFamily="18" charset="-127"/>
              </a:rPr>
              <a:t>Sitting or Standing Posture</a:t>
            </a:r>
          </a:p>
          <a:p>
            <a:pPr marL="457200" indent="-457200" algn="just">
              <a:buFontTx/>
              <a:buAutoNum type="arabicPeriod"/>
            </a:pPr>
            <a:r>
              <a:rPr lang="en-US" altLang="ko-KR" dirty="0">
                <a:solidFill>
                  <a:schemeClr val="tx1"/>
                </a:solidFill>
                <a:latin typeface="HY헤드라인M" pitchFamily="18" charset="-127"/>
                <a:ea typeface="HY헤드라인M" pitchFamily="18" charset="-127"/>
              </a:rPr>
              <a:t>Slightly push your abdomen and pelvis forward until you feel your back muscles relax (sitting position).</a:t>
            </a:r>
          </a:p>
          <a:p>
            <a:pPr marL="457200" indent="-457200" algn="just">
              <a:buFontTx/>
              <a:buAutoNum type="arabicPeriod"/>
            </a:pPr>
            <a:endParaRPr lang="en-US" altLang="ko-KR" dirty="0">
              <a:solidFill>
                <a:schemeClr val="tx1"/>
              </a:solidFill>
              <a:latin typeface="HY헤드라인M" pitchFamily="18" charset="-127"/>
              <a:ea typeface="HY헤드라인M" pitchFamily="18" charset="-127"/>
            </a:endParaRPr>
          </a:p>
          <a:p>
            <a:pPr marL="457200" indent="-457200" algn="just">
              <a:buAutoNum type="arabicPeriod"/>
            </a:pPr>
            <a:r>
              <a:rPr lang="en-US" altLang="ko-KR" dirty="0">
                <a:solidFill>
                  <a:schemeClr val="tx1"/>
                </a:solidFill>
                <a:latin typeface="HY헤드라인M" pitchFamily="18" charset="-127"/>
                <a:ea typeface="HY헤드라인M" pitchFamily="18" charset="-127"/>
              </a:rPr>
              <a:t>When you have found the position in which your back muscles are relaxed, lightly cough a few times and check if your abdominal muscles have tightened. </a:t>
            </a:r>
          </a:p>
          <a:p>
            <a:pPr marL="457200" indent="-457200" algn="just">
              <a:buAutoNum type="arabicPeriod"/>
            </a:pPr>
            <a:endParaRPr lang="en-US" altLang="ko-KR" dirty="0">
              <a:solidFill>
                <a:schemeClr val="tx1"/>
              </a:solidFill>
              <a:latin typeface="HY헤드라인M" pitchFamily="18" charset="-127"/>
              <a:ea typeface="HY헤드라인M" pitchFamily="18" charset="-127"/>
            </a:endParaRPr>
          </a:p>
          <a:p>
            <a:pPr marL="457200" indent="-457200" algn="just">
              <a:buAutoNum type="arabicPeriod"/>
            </a:pPr>
            <a:r>
              <a:rPr lang="en-US" altLang="ko-KR" dirty="0">
                <a:solidFill>
                  <a:schemeClr val="tx1"/>
                </a:solidFill>
                <a:latin typeface="HY헤드라인M" pitchFamily="18" charset="-127"/>
                <a:ea typeface="HY헤드라인M" pitchFamily="18" charset="-127"/>
              </a:rPr>
              <a:t>Keep your abdomen tight and proceed with deep breathing.</a:t>
            </a:r>
            <a:endParaRPr lang="ko-KR" altLang="en-US" dirty="0">
              <a:solidFill>
                <a:schemeClr val="tx1"/>
              </a:solidFill>
              <a:latin typeface="HY헤드라인M" pitchFamily="18" charset="-127"/>
              <a:ea typeface="HY헤드라인M" pitchFamily="18" charset="-127"/>
            </a:endParaRPr>
          </a:p>
        </p:txBody>
      </p:sp>
      <p:sp>
        <p:nvSpPr>
          <p:cNvPr id="49" name="순서도: 지연 18"/>
          <p:cNvSpPr/>
          <p:nvPr/>
        </p:nvSpPr>
        <p:spPr>
          <a:xfrm>
            <a:off x="4949214" y="2718632"/>
            <a:ext cx="1800000" cy="1584000"/>
          </a:xfrm>
          <a:custGeom>
            <a:avLst/>
            <a:gdLst>
              <a:gd name="connsiteX0" fmla="*/ 0 w 3072440"/>
              <a:gd name="connsiteY0" fmla="*/ 0 h 1512168"/>
              <a:gd name="connsiteX1" fmla="*/ 1536220 w 3072440"/>
              <a:gd name="connsiteY1" fmla="*/ 0 h 1512168"/>
              <a:gd name="connsiteX2" fmla="*/ 3072440 w 3072440"/>
              <a:gd name="connsiteY2" fmla="*/ 756084 h 1512168"/>
              <a:gd name="connsiteX3" fmla="*/ 1536220 w 3072440"/>
              <a:gd name="connsiteY3" fmla="*/ 1512168 h 1512168"/>
              <a:gd name="connsiteX4" fmla="*/ 0 w 3072440"/>
              <a:gd name="connsiteY4" fmla="*/ 1512168 h 1512168"/>
              <a:gd name="connsiteX5" fmla="*/ 0 w 3072440"/>
              <a:gd name="connsiteY5" fmla="*/ 0 h 1512168"/>
              <a:gd name="connsiteX0" fmla="*/ 0 w 3144931"/>
              <a:gd name="connsiteY0" fmla="*/ 0 h 1512168"/>
              <a:gd name="connsiteX1" fmla="*/ 2378903 w 3144931"/>
              <a:gd name="connsiteY1" fmla="*/ 17929 h 1512168"/>
              <a:gd name="connsiteX2" fmla="*/ 3072440 w 3144931"/>
              <a:gd name="connsiteY2" fmla="*/ 756084 h 1512168"/>
              <a:gd name="connsiteX3" fmla="*/ 1536220 w 3144931"/>
              <a:gd name="connsiteY3" fmla="*/ 1512168 h 1512168"/>
              <a:gd name="connsiteX4" fmla="*/ 0 w 3144931"/>
              <a:gd name="connsiteY4" fmla="*/ 1512168 h 1512168"/>
              <a:gd name="connsiteX5" fmla="*/ 0 w 3144931"/>
              <a:gd name="connsiteY5" fmla="*/ 0 h 1512168"/>
              <a:gd name="connsiteX0" fmla="*/ 0 w 3086098"/>
              <a:gd name="connsiteY0" fmla="*/ 0 h 1512168"/>
              <a:gd name="connsiteX1" fmla="*/ 2378903 w 3086098"/>
              <a:gd name="connsiteY1" fmla="*/ 17929 h 1512168"/>
              <a:gd name="connsiteX2" fmla="*/ 3072440 w 3086098"/>
              <a:gd name="connsiteY2" fmla="*/ 756084 h 1512168"/>
              <a:gd name="connsiteX3" fmla="*/ 2343043 w 3086098"/>
              <a:gd name="connsiteY3" fmla="*/ 1494239 h 1512168"/>
              <a:gd name="connsiteX4" fmla="*/ 0 w 3086098"/>
              <a:gd name="connsiteY4" fmla="*/ 1512168 h 1512168"/>
              <a:gd name="connsiteX5" fmla="*/ 0 w 3086098"/>
              <a:gd name="connsiteY5" fmla="*/ 0 h 1512168"/>
              <a:gd name="connsiteX0" fmla="*/ 0 w 3086098"/>
              <a:gd name="connsiteY0" fmla="*/ 35859 h 1548027"/>
              <a:gd name="connsiteX1" fmla="*/ 2378903 w 3086098"/>
              <a:gd name="connsiteY1" fmla="*/ 0 h 1548027"/>
              <a:gd name="connsiteX2" fmla="*/ 3072440 w 3086098"/>
              <a:gd name="connsiteY2" fmla="*/ 791943 h 1548027"/>
              <a:gd name="connsiteX3" fmla="*/ 2343043 w 3086098"/>
              <a:gd name="connsiteY3" fmla="*/ 1530098 h 1548027"/>
              <a:gd name="connsiteX4" fmla="*/ 0 w 3086098"/>
              <a:gd name="connsiteY4" fmla="*/ 1548027 h 1548027"/>
              <a:gd name="connsiteX5" fmla="*/ 0 w 3086098"/>
              <a:gd name="connsiteY5" fmla="*/ 35859 h 1548027"/>
              <a:gd name="connsiteX0" fmla="*/ 0 w 3081850"/>
              <a:gd name="connsiteY0" fmla="*/ 0 h 1512168"/>
              <a:gd name="connsiteX1" fmla="*/ 2360973 w 3081850"/>
              <a:gd name="connsiteY1" fmla="*/ 17929 h 1512168"/>
              <a:gd name="connsiteX2" fmla="*/ 3072440 w 3081850"/>
              <a:gd name="connsiteY2" fmla="*/ 756084 h 1512168"/>
              <a:gd name="connsiteX3" fmla="*/ 2343043 w 3081850"/>
              <a:gd name="connsiteY3" fmla="*/ 1494239 h 1512168"/>
              <a:gd name="connsiteX4" fmla="*/ 0 w 3081850"/>
              <a:gd name="connsiteY4" fmla="*/ 1512168 h 1512168"/>
              <a:gd name="connsiteX5" fmla="*/ 0 w 3081850"/>
              <a:gd name="connsiteY5" fmla="*/ 0 h 151216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3081850" h="1512168">
                <a:moveTo>
                  <a:pt x="0" y="0"/>
                </a:moveTo>
                <a:lnTo>
                  <a:pt x="2360973" y="17929"/>
                </a:lnTo>
                <a:cubicBezTo>
                  <a:pt x="3209404" y="17929"/>
                  <a:pt x="3075428" y="510032"/>
                  <a:pt x="3072440" y="756084"/>
                </a:cubicBezTo>
                <a:cubicBezTo>
                  <a:pt x="3069452" y="1002136"/>
                  <a:pt x="3191474" y="1494239"/>
                  <a:pt x="2343043" y="1494239"/>
                </a:cubicBezTo>
                <a:lnTo>
                  <a:pt x="0" y="1512168"/>
                </a:lnTo>
                <a:lnTo>
                  <a:pt x="0" y="0"/>
                </a:lnTo>
                <a:close/>
              </a:path>
            </a:pathLst>
          </a:custGeom>
          <a:solidFill>
            <a:srgbClr val="FDF00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dirty="0">
                <a:solidFill>
                  <a:srgbClr val="106E0E"/>
                </a:solidFill>
                <a:latin typeface="HY헤드라인M" pitchFamily="18" charset="-127"/>
                <a:ea typeface="HY헤드라인M" pitchFamily="18" charset="-127"/>
              </a:rPr>
              <a:t>Exhale</a:t>
            </a:r>
          </a:p>
        </p:txBody>
      </p:sp>
      <p:pic>
        <p:nvPicPr>
          <p:cNvPr id="15" name="그림 14"/>
          <p:cNvPicPr>
            <a:picLocks noChangeAspect="1"/>
          </p:cNvPicPr>
          <p:nvPr/>
        </p:nvPicPr>
        <p:blipFill>
          <a:blip r:embed="rId4">
            <a:extLst>
              <a:ext uri="{BEBA8EAE-BF5A-486C-A8C5-ECC9F3942E4B}">
                <a14:imgProps xmlns:a14="http://schemas.microsoft.com/office/drawing/2010/main">
                  <a14:imgLayer r:embed="rId5">
                    <a14:imgEffect>
                      <a14:backgroundRemoval t="0" b="100000" l="0" r="100000">
                        <a14:foregroundMark x1="24280" y1="88251" x2="24280" y2="88251"/>
                        <a14:foregroundMark x1="38272" y1="18799" x2="38272" y2="18799"/>
                        <a14:foregroundMark x1="41152" y1="25326" x2="41152" y2="25326"/>
                        <a14:foregroundMark x1="39918" y1="45953" x2="39918" y2="45953"/>
                        <a14:foregroundMark x1="51440" y1="37598" x2="51440" y2="37598"/>
                        <a14:foregroundMark x1="22222" y1="89295" x2="22222" y2="89295"/>
                        <a14:foregroundMark x1="30864" y1="89556" x2="30864" y2="89556"/>
                        <a14:foregroundMark x1="34156" y1="85640" x2="34156" y2="85640"/>
                        <a14:foregroundMark x1="33333" y1="85640" x2="33333" y2="85640"/>
                        <a14:foregroundMark x1="33333" y1="85640" x2="33333" y2="85640"/>
                        <a14:foregroundMark x1="19753" y1="83290" x2="19753" y2="83290"/>
                        <a14:foregroundMark x1="20988" y1="85379" x2="20988" y2="85379"/>
                        <a14:foregroundMark x1="47325" y1="22454" x2="47325" y2="22454"/>
                        <a14:foregroundMark x1="45267" y1="24282" x2="45267" y2="24282"/>
                        <a14:foregroundMark x1="46091" y1="23760" x2="46091" y2="23760"/>
                        <a14:foregroundMark x1="44033" y1="23238" x2="44033" y2="23238"/>
                        <a14:foregroundMark x1="44033" y1="23238" x2="44033" y2="23238"/>
                        <a14:foregroundMark x1="43621" y1="22977" x2="43621" y2="22977"/>
                        <a14:foregroundMark x1="41975" y1="22977" x2="41975" y2="22977"/>
                        <a14:foregroundMark x1="41152" y1="22977" x2="40741" y2="23499"/>
                        <a14:foregroundMark x1="34568" y1="42820" x2="34568" y2="42820"/>
                        <a14:foregroundMark x1="40329" y1="42037" x2="40329" y2="42037"/>
                        <a14:foregroundMark x1="41564" y1="41253" x2="41564" y2="41253"/>
                        <a14:foregroundMark x1="44033" y1="40470" x2="44033" y2="40470"/>
                        <a14:foregroundMark x1="45679" y1="39687" x2="45679" y2="39687"/>
                        <a14:foregroundMark x1="45679" y1="39687" x2="45679" y2="39687"/>
                        <a14:foregroundMark x1="45679" y1="39687" x2="45679" y2="39687"/>
                        <a14:foregroundMark x1="46502" y1="45431" x2="46502" y2="45431"/>
                        <a14:foregroundMark x1="46091" y1="45953" x2="46091" y2="45953"/>
                        <a14:foregroundMark x1="45679" y1="46214" x2="45679" y2="46214"/>
                        <a14:foregroundMark x1="43210" y1="46475" x2="43210" y2="46475"/>
                        <a14:foregroundMark x1="35391" y1="87990" x2="35391" y2="87990"/>
                        <a14:foregroundMark x1="30453" y1="80157" x2="30453" y2="80157"/>
                        <a14:foregroundMark x1="19753" y1="81723" x2="19753" y2="81723"/>
                        <a14:backgroundMark x1="58436" y1="83551" x2="58436" y2="83551"/>
                        <a14:backgroundMark x1="58848" y1="71802" x2="58848" y2="71802"/>
                        <a14:backgroundMark x1="60494" y1="72324" x2="60494" y2="72324"/>
                        <a14:backgroundMark x1="83128" y1="65796" x2="83128" y2="65796"/>
                        <a14:backgroundMark x1="78189" y1="53264" x2="78189" y2="53264"/>
                        <a14:backgroundMark x1="67490" y1="51175" x2="67490" y2="51175"/>
                        <a14:backgroundMark x1="74897" y1="52219" x2="74897" y2="52219"/>
                        <a14:backgroundMark x1="74897" y1="55352" x2="74897" y2="55352"/>
                        <a14:backgroundMark x1="72428" y1="46997" x2="72428" y2="46997"/>
                        <a14:backgroundMark x1="81481" y1="42037" x2="81481" y2="42037"/>
                        <a14:backgroundMark x1="87654" y1="33420" x2="87654" y2="33420"/>
                        <a14:backgroundMark x1="79424" y1="27154" x2="79424" y2="27154"/>
                        <a14:backgroundMark x1="60494" y1="14621" x2="60494" y2="14621"/>
                        <a14:backgroundMark x1="52263" y1="6527" x2="52263" y2="6527"/>
                        <a14:backgroundMark x1="32099" y1="5483" x2="32099" y2="5483"/>
                        <a14:backgroundMark x1="11523" y1="8877" x2="11523" y2="8877"/>
                        <a14:backgroundMark x1="71605" y1="17493" x2="71605" y2="17493"/>
                        <a14:backgroundMark x1="64609" y1="20888" x2="64609" y2="20888"/>
                        <a14:backgroundMark x1="66667" y1="16710" x2="66667" y2="16710"/>
                        <a14:backgroundMark x1="84362" y1="15927" x2="84362" y2="15927"/>
                        <a14:backgroundMark x1="93827" y1="14621" x2="93827" y2="14621"/>
                        <a14:backgroundMark x1="91358" y1="22977" x2="91358" y2="22977"/>
                        <a14:backgroundMark x1="76955" y1="38120" x2="76955" y2="38120"/>
                        <a14:backgroundMark x1="64609" y1="40992" x2="64609" y2="40992"/>
                        <a14:backgroundMark x1="68313" y1="27415" x2="68313" y2="27415"/>
                        <a14:backgroundMark x1="69136" y1="4700" x2="69136" y2="4700"/>
                        <a14:backgroundMark x1="53909" y1="12533" x2="53909" y2="12533"/>
                        <a14:backgroundMark x1="44856" y1="10183" x2="44856" y2="10183"/>
                        <a14:backgroundMark x1="37037" y1="8877" x2="37037" y2="8877"/>
                        <a14:backgroundMark x1="57202" y1="11227" x2="57202" y2="11227"/>
                        <a14:backgroundMark x1="63786" y1="9399" x2="63786" y2="9399"/>
                        <a14:backgroundMark x1="79012" y1="10444" x2="79012" y2="10444"/>
                        <a14:backgroundMark x1="81481" y1="17755" x2="81481" y2="17755"/>
                        <a14:backgroundMark x1="68724" y1="17232" x2="68724" y2="17232"/>
                        <a14:backgroundMark x1="69547" y1="14621" x2="69547" y2="14621"/>
                        <a14:backgroundMark x1="69547" y1="14621" x2="69547" y2="14621"/>
                        <a14:backgroundMark x1="71193" y1="13055" x2="71193" y2="13055"/>
                        <a14:backgroundMark x1="70370" y1="17755" x2="70370" y2="17755"/>
                        <a14:backgroundMark x1="70370" y1="17755" x2="70370" y2="17755"/>
                        <a14:backgroundMark x1="66667" y1="20888" x2="66667" y2="20888"/>
                        <a14:backgroundMark x1="66667" y1="20888" x2="66667" y2="20888"/>
                        <a14:backgroundMark x1="68724" y1="23499" x2="69547" y2="24021"/>
                        <a14:backgroundMark x1="75309" y1="26632" x2="76132" y2="27154"/>
                        <a14:backgroundMark x1="80247" y1="27154" x2="82305" y2="27154"/>
                        <a14:backgroundMark x1="85185" y1="26110" x2="87243" y2="23760"/>
                        <a14:backgroundMark x1="88066" y1="21149" x2="88066" y2="21149"/>
                        <a14:backgroundMark x1="88066" y1="21149" x2="88889" y2="20104"/>
                        <a14:backgroundMark x1="88889" y1="14621" x2="88889" y2="14621"/>
                        <a14:backgroundMark x1="83128" y1="32898" x2="83128" y2="32898"/>
                        <a14:backgroundMark x1="79012" y1="40209" x2="79012" y2="40209"/>
                        <a14:backgroundMark x1="79012" y1="40209" x2="79012" y2="40209"/>
                        <a14:backgroundMark x1="79424" y1="40992" x2="79424" y2="40992"/>
                        <a14:backgroundMark x1="75720" y1="40731" x2="73251" y2="37337"/>
                        <a14:backgroundMark x1="73251" y1="37337" x2="73251" y2="37337"/>
                        <a14:backgroundMark x1="73251" y1="35770" x2="73251" y2="35770"/>
                        <a14:backgroundMark x1="73251" y1="35770" x2="72428" y2="34726"/>
                        <a14:backgroundMark x1="57613" y1="20627" x2="57613" y2="20627"/>
                        <a14:backgroundMark x1="64198" y1="18799" x2="64198" y2="18799"/>
                        <a14:backgroundMark x1="67078" y1="38642" x2="67078" y2="38642"/>
                        <a14:backgroundMark x1="68724" y1="38642" x2="68724" y2="38642"/>
                        <a14:backgroundMark x1="44444" y1="28721" x2="44444" y2="28721"/>
                      </a14:backgroundRemoval>
                    </a14:imgEffect>
                  </a14:imgLayer>
                </a14:imgProps>
              </a:ext>
              <a:ext uri="{28A0092B-C50C-407E-A947-70E740481C1C}">
                <a14:useLocalDpi xmlns:a14="http://schemas.microsoft.com/office/drawing/2010/main" val="0"/>
              </a:ext>
            </a:extLst>
          </a:blip>
          <a:stretch>
            <a:fillRect/>
          </a:stretch>
        </p:blipFill>
        <p:spPr>
          <a:xfrm>
            <a:off x="1285808" y="1621552"/>
            <a:ext cx="3502192" cy="5519916"/>
          </a:xfrm>
          <a:prstGeom prst="rect">
            <a:avLst/>
          </a:prstGeom>
        </p:spPr>
      </p:pic>
      <p:sp>
        <p:nvSpPr>
          <p:cNvPr id="18" name="_x198096200"/>
          <p:cNvSpPr>
            <a:spLocks noChangeArrowheads="1"/>
          </p:cNvSpPr>
          <p:nvPr/>
        </p:nvSpPr>
        <p:spPr bwMode="auto">
          <a:xfrm>
            <a:off x="3096683" y="2701392"/>
            <a:ext cx="266700" cy="177800"/>
          </a:xfrm>
          <a:custGeom>
            <a:avLst/>
            <a:gdLst>
              <a:gd name="T0" fmla="*/ 77 w 168"/>
              <a:gd name="T1" fmla="*/ 28 h 112"/>
              <a:gd name="T2" fmla="*/ 77 w 168"/>
              <a:gd name="T3" fmla="*/ 0 h 112"/>
              <a:gd name="T4" fmla="*/ 0 w 168"/>
              <a:gd name="T5" fmla="*/ 55 h 112"/>
              <a:gd name="T6" fmla="*/ 77 w 168"/>
              <a:gd name="T7" fmla="*/ 112 h 112"/>
              <a:gd name="T8" fmla="*/ 77 w 168"/>
              <a:gd name="T9" fmla="*/ 82 h 112"/>
              <a:gd name="T10" fmla="*/ 168 w 168"/>
              <a:gd name="T11" fmla="*/ 82 h 112"/>
              <a:gd name="T12" fmla="*/ 168 w 168"/>
              <a:gd name="T13" fmla="*/ 28 h 112"/>
            </a:gdLst>
            <a:ahLst/>
            <a:cxnLst>
              <a:cxn ang="0">
                <a:pos x="T0" y="T1"/>
              </a:cxn>
              <a:cxn ang="0">
                <a:pos x="T2" y="T3"/>
              </a:cxn>
              <a:cxn ang="0">
                <a:pos x="T4" y="T5"/>
              </a:cxn>
              <a:cxn ang="0">
                <a:pos x="T6" y="T7"/>
              </a:cxn>
              <a:cxn ang="0">
                <a:pos x="T8" y="T9"/>
              </a:cxn>
              <a:cxn ang="0">
                <a:pos x="T10" y="T11"/>
              </a:cxn>
              <a:cxn ang="0">
                <a:pos x="T12" y="T13"/>
              </a:cxn>
            </a:cxnLst>
            <a:rect l="0" t="0" r="r" b="b"/>
            <a:pathLst>
              <a:path w="168" h="112">
                <a:moveTo>
                  <a:pt x="77" y="28"/>
                </a:moveTo>
                <a:lnTo>
                  <a:pt x="77" y="0"/>
                </a:lnTo>
                <a:lnTo>
                  <a:pt x="0" y="55"/>
                </a:lnTo>
                <a:lnTo>
                  <a:pt x="77" y="112"/>
                </a:lnTo>
                <a:lnTo>
                  <a:pt x="77" y="82"/>
                </a:lnTo>
                <a:lnTo>
                  <a:pt x="168" y="82"/>
                </a:lnTo>
                <a:lnTo>
                  <a:pt x="168" y="28"/>
                </a:lnTo>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ko-KR" altLang="en-US"/>
          </a:p>
        </p:txBody>
      </p:sp>
      <p:sp>
        <p:nvSpPr>
          <p:cNvPr id="25" name="_x25313760"/>
          <p:cNvSpPr>
            <a:spLocks noChangeArrowheads="1"/>
          </p:cNvSpPr>
          <p:nvPr/>
        </p:nvSpPr>
        <p:spPr bwMode="auto">
          <a:xfrm>
            <a:off x="7983598" y="2910298"/>
            <a:ext cx="265113" cy="179388"/>
          </a:xfrm>
          <a:custGeom>
            <a:avLst/>
            <a:gdLst>
              <a:gd name="T0" fmla="*/ 90 w 167"/>
              <a:gd name="T1" fmla="*/ 84 h 113"/>
              <a:gd name="T2" fmla="*/ 90 w 167"/>
              <a:gd name="T3" fmla="*/ 113 h 113"/>
              <a:gd name="T4" fmla="*/ 167 w 167"/>
              <a:gd name="T5" fmla="*/ 57 h 113"/>
              <a:gd name="T6" fmla="*/ 91 w 167"/>
              <a:gd name="T7" fmla="*/ 0 h 113"/>
              <a:gd name="T8" fmla="*/ 91 w 167"/>
              <a:gd name="T9" fmla="*/ 30 h 113"/>
              <a:gd name="T10" fmla="*/ 0 w 167"/>
              <a:gd name="T11" fmla="*/ 30 h 113"/>
              <a:gd name="T12" fmla="*/ 0 w 167"/>
              <a:gd name="T13" fmla="*/ 84 h 113"/>
            </a:gdLst>
            <a:ahLst/>
            <a:cxnLst>
              <a:cxn ang="0">
                <a:pos x="T0" y="T1"/>
              </a:cxn>
              <a:cxn ang="0">
                <a:pos x="T2" y="T3"/>
              </a:cxn>
              <a:cxn ang="0">
                <a:pos x="T4" y="T5"/>
              </a:cxn>
              <a:cxn ang="0">
                <a:pos x="T6" y="T7"/>
              </a:cxn>
              <a:cxn ang="0">
                <a:pos x="T8" y="T9"/>
              </a:cxn>
              <a:cxn ang="0">
                <a:pos x="T10" y="T11"/>
              </a:cxn>
              <a:cxn ang="0">
                <a:pos x="T12" y="T13"/>
              </a:cxn>
            </a:cxnLst>
            <a:rect l="0" t="0" r="r" b="b"/>
            <a:pathLst>
              <a:path w="167" h="113">
                <a:moveTo>
                  <a:pt x="90" y="84"/>
                </a:moveTo>
                <a:lnTo>
                  <a:pt x="90" y="113"/>
                </a:lnTo>
                <a:lnTo>
                  <a:pt x="167" y="57"/>
                </a:lnTo>
                <a:lnTo>
                  <a:pt x="91" y="0"/>
                </a:lnTo>
                <a:lnTo>
                  <a:pt x="91" y="30"/>
                </a:lnTo>
                <a:lnTo>
                  <a:pt x="0" y="30"/>
                </a:lnTo>
                <a:lnTo>
                  <a:pt x="0" y="84"/>
                </a:lnTo>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ko-KR" altLang="en-US"/>
          </a:p>
        </p:txBody>
      </p:sp>
      <p:pic>
        <p:nvPicPr>
          <p:cNvPr id="23" name="그림 22"/>
          <p:cNvPicPr>
            <a:picLocks noChangeAspect="1"/>
          </p:cNvPicPr>
          <p:nvPr/>
        </p:nvPicPr>
        <p:blipFill>
          <a:blip r:embed="rId4">
            <a:extLst>
              <a:ext uri="{BEBA8EAE-BF5A-486C-A8C5-ECC9F3942E4B}">
                <a14:imgProps xmlns:a14="http://schemas.microsoft.com/office/drawing/2010/main">
                  <a14:imgLayer r:embed="rId5">
                    <a14:imgEffect>
                      <a14:backgroundRemoval t="0" b="100000" l="0" r="100000">
                        <a14:foregroundMark x1="24280" y1="88251" x2="24280" y2="88251"/>
                        <a14:foregroundMark x1="38272" y1="18799" x2="38272" y2="18799"/>
                        <a14:foregroundMark x1="41152" y1="25326" x2="41152" y2="25326"/>
                        <a14:foregroundMark x1="39918" y1="45953" x2="39918" y2="45953"/>
                        <a14:foregroundMark x1="51440" y1="37598" x2="51440" y2="37598"/>
                        <a14:foregroundMark x1="22222" y1="89295" x2="22222" y2="89295"/>
                        <a14:foregroundMark x1="30864" y1="89556" x2="30864" y2="89556"/>
                        <a14:foregroundMark x1="34156" y1="85640" x2="34156" y2="85640"/>
                        <a14:foregroundMark x1="33333" y1="85640" x2="33333" y2="85640"/>
                        <a14:foregroundMark x1="33333" y1="85640" x2="33333" y2="85640"/>
                        <a14:foregroundMark x1="19753" y1="83290" x2="19753" y2="83290"/>
                        <a14:foregroundMark x1="20988" y1="85379" x2="20988" y2="85379"/>
                        <a14:foregroundMark x1="47325" y1="22454" x2="47325" y2="22454"/>
                        <a14:foregroundMark x1="45267" y1="24282" x2="45267" y2="24282"/>
                        <a14:foregroundMark x1="46091" y1="23760" x2="46091" y2="23760"/>
                        <a14:foregroundMark x1="44033" y1="23238" x2="44033" y2="23238"/>
                        <a14:foregroundMark x1="44033" y1="23238" x2="44033" y2="23238"/>
                        <a14:foregroundMark x1="43621" y1="22977" x2="43621" y2="22977"/>
                        <a14:foregroundMark x1="41975" y1="22977" x2="41975" y2="22977"/>
                        <a14:foregroundMark x1="41152" y1="22977" x2="40741" y2="23499"/>
                        <a14:foregroundMark x1="34568" y1="42820" x2="34568" y2="42820"/>
                        <a14:foregroundMark x1="40329" y1="42037" x2="40329" y2="42037"/>
                        <a14:foregroundMark x1="41564" y1="41253" x2="41564" y2="41253"/>
                        <a14:foregroundMark x1="44033" y1="40470" x2="44033" y2="40470"/>
                        <a14:foregroundMark x1="45679" y1="39687" x2="45679" y2="39687"/>
                        <a14:foregroundMark x1="45679" y1="39687" x2="45679" y2="39687"/>
                        <a14:foregroundMark x1="45679" y1="39687" x2="45679" y2="39687"/>
                        <a14:foregroundMark x1="46502" y1="45431" x2="46502" y2="45431"/>
                        <a14:foregroundMark x1="46091" y1="45953" x2="46091" y2="45953"/>
                        <a14:foregroundMark x1="45679" y1="46214" x2="45679" y2="46214"/>
                        <a14:foregroundMark x1="43210" y1="46475" x2="43210" y2="46475"/>
                        <a14:foregroundMark x1="35391" y1="87990" x2="35391" y2="87990"/>
                        <a14:foregroundMark x1="30453" y1="80157" x2="30453" y2="80157"/>
                        <a14:foregroundMark x1="19753" y1="81723" x2="19753" y2="81723"/>
                        <a14:backgroundMark x1="58436" y1="83551" x2="58436" y2="83551"/>
                        <a14:backgroundMark x1="58848" y1="71802" x2="58848" y2="71802"/>
                        <a14:backgroundMark x1="60494" y1="72324" x2="60494" y2="72324"/>
                        <a14:backgroundMark x1="83128" y1="65796" x2="83128" y2="65796"/>
                        <a14:backgroundMark x1="78189" y1="53264" x2="78189" y2="53264"/>
                        <a14:backgroundMark x1="67490" y1="51175" x2="67490" y2="51175"/>
                        <a14:backgroundMark x1="74897" y1="52219" x2="74897" y2="52219"/>
                        <a14:backgroundMark x1="74897" y1="55352" x2="74897" y2="55352"/>
                        <a14:backgroundMark x1="72428" y1="46997" x2="72428" y2="46997"/>
                        <a14:backgroundMark x1="81481" y1="42037" x2="81481" y2="42037"/>
                        <a14:backgroundMark x1="87654" y1="33420" x2="87654" y2="33420"/>
                        <a14:backgroundMark x1="79424" y1="27154" x2="79424" y2="27154"/>
                        <a14:backgroundMark x1="60494" y1="14621" x2="60494" y2="14621"/>
                        <a14:backgroundMark x1="52263" y1="6527" x2="52263" y2="6527"/>
                        <a14:backgroundMark x1="32099" y1="5483" x2="32099" y2="5483"/>
                        <a14:backgroundMark x1="11523" y1="8877" x2="11523" y2="8877"/>
                        <a14:backgroundMark x1="71605" y1="17493" x2="71605" y2="17493"/>
                        <a14:backgroundMark x1="64609" y1="20888" x2="64609" y2="20888"/>
                        <a14:backgroundMark x1="66667" y1="16710" x2="66667" y2="16710"/>
                        <a14:backgroundMark x1="84362" y1="15927" x2="84362" y2="15927"/>
                        <a14:backgroundMark x1="93827" y1="14621" x2="93827" y2="14621"/>
                        <a14:backgroundMark x1="91358" y1="22977" x2="91358" y2="22977"/>
                        <a14:backgroundMark x1="76955" y1="38120" x2="76955" y2="38120"/>
                        <a14:backgroundMark x1="64609" y1="40992" x2="64609" y2="40992"/>
                        <a14:backgroundMark x1="68313" y1="27415" x2="68313" y2="27415"/>
                        <a14:backgroundMark x1="69136" y1="4700" x2="69136" y2="4700"/>
                        <a14:backgroundMark x1="53909" y1="12533" x2="53909" y2="12533"/>
                        <a14:backgroundMark x1="44856" y1="10183" x2="44856" y2="10183"/>
                        <a14:backgroundMark x1="37037" y1="8877" x2="37037" y2="8877"/>
                        <a14:backgroundMark x1="57202" y1="11227" x2="57202" y2="11227"/>
                        <a14:backgroundMark x1="63786" y1="9399" x2="63786" y2="9399"/>
                        <a14:backgroundMark x1="79012" y1="10444" x2="79012" y2="10444"/>
                        <a14:backgroundMark x1="81481" y1="17755" x2="81481" y2="17755"/>
                        <a14:backgroundMark x1="68724" y1="17232" x2="68724" y2="17232"/>
                        <a14:backgroundMark x1="69547" y1="14621" x2="69547" y2="14621"/>
                        <a14:backgroundMark x1="69547" y1="14621" x2="69547" y2="14621"/>
                        <a14:backgroundMark x1="71193" y1="13055" x2="71193" y2="13055"/>
                        <a14:backgroundMark x1="70370" y1="17755" x2="70370" y2="17755"/>
                        <a14:backgroundMark x1="70370" y1="17755" x2="70370" y2="17755"/>
                        <a14:backgroundMark x1="66667" y1="20888" x2="66667" y2="20888"/>
                        <a14:backgroundMark x1="66667" y1="20888" x2="66667" y2="20888"/>
                        <a14:backgroundMark x1="68724" y1="23499" x2="69547" y2="24021"/>
                        <a14:backgroundMark x1="75309" y1="26632" x2="76132" y2="27154"/>
                        <a14:backgroundMark x1="80247" y1="27154" x2="82305" y2="27154"/>
                        <a14:backgroundMark x1="85185" y1="26110" x2="87243" y2="23760"/>
                        <a14:backgroundMark x1="88066" y1="21149" x2="88066" y2="21149"/>
                        <a14:backgroundMark x1="88066" y1="21149" x2="88889" y2="20104"/>
                        <a14:backgroundMark x1="88889" y1="14621" x2="88889" y2="14621"/>
                        <a14:backgroundMark x1="83128" y1="32898" x2="83128" y2="32898"/>
                        <a14:backgroundMark x1="79012" y1="40209" x2="79012" y2="40209"/>
                        <a14:backgroundMark x1="79012" y1="40209" x2="79012" y2="40209"/>
                        <a14:backgroundMark x1="79424" y1="40992" x2="79424" y2="40992"/>
                        <a14:backgroundMark x1="75720" y1="40731" x2="73251" y2="37337"/>
                        <a14:backgroundMark x1="73251" y1="37337" x2="73251" y2="37337"/>
                        <a14:backgroundMark x1="73251" y1="35770" x2="73251" y2="35770"/>
                        <a14:backgroundMark x1="73251" y1="35770" x2="72428" y2="34726"/>
                        <a14:backgroundMark x1="57613" y1="20627" x2="57613" y2="20627"/>
                        <a14:backgroundMark x1="64198" y1="18799" x2="64198" y2="18799"/>
                        <a14:backgroundMark x1="67078" y1="38642" x2="67078" y2="38642"/>
                        <a14:backgroundMark x1="68724" y1="38642" x2="68724" y2="38642"/>
                        <a14:backgroundMark x1="44444" y1="28721" x2="44444" y2="28721"/>
                      </a14:backgroundRemoval>
                    </a14:imgEffect>
                  </a14:imgLayer>
                </a14:imgProps>
              </a:ext>
              <a:ext uri="{28A0092B-C50C-407E-A947-70E740481C1C}">
                <a14:useLocalDpi xmlns:a14="http://schemas.microsoft.com/office/drawing/2010/main" val="0"/>
              </a:ext>
            </a:extLst>
          </a:blip>
          <a:stretch>
            <a:fillRect/>
          </a:stretch>
        </p:blipFill>
        <p:spPr>
          <a:xfrm>
            <a:off x="6099008" y="1611098"/>
            <a:ext cx="3502192" cy="5519916"/>
          </a:xfrm>
          <a:prstGeom prst="rect">
            <a:avLst/>
          </a:prstGeom>
        </p:spPr>
      </p:pic>
    </p:spTree>
    <p:extLst>
      <p:ext uri="{BB962C8B-B14F-4D97-AF65-F5344CB8AC3E}">
        <p14:creationId xmlns:p14="http://schemas.microsoft.com/office/powerpoint/2010/main" val="373106852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직사각형 6"/>
          <p:cNvSpPr/>
          <p:nvPr/>
        </p:nvSpPr>
        <p:spPr>
          <a:xfrm>
            <a:off x="1125500" y="42730"/>
            <a:ext cx="7755340" cy="2160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altLang="ko-KR" sz="5000" dirty="0">
                <a:solidFill>
                  <a:srgbClr val="FF0000"/>
                </a:solidFill>
                <a:latin typeface="HY헤드라인M" pitchFamily="18" charset="-127"/>
                <a:ea typeface="HY헤드라인M" pitchFamily="18" charset="-127"/>
              </a:rPr>
              <a:t>Sitting to Standing</a:t>
            </a:r>
          </a:p>
        </p:txBody>
      </p:sp>
      <p:grpSp>
        <p:nvGrpSpPr>
          <p:cNvPr id="72" name="그룹 71"/>
          <p:cNvGrpSpPr/>
          <p:nvPr/>
        </p:nvGrpSpPr>
        <p:grpSpPr>
          <a:xfrm>
            <a:off x="288000" y="6818520"/>
            <a:ext cx="9000008" cy="5116422"/>
            <a:chOff x="288000" y="6818520"/>
            <a:chExt cx="9000008" cy="5116422"/>
          </a:xfrm>
          <a:solidFill>
            <a:schemeClr val="bg1"/>
          </a:solidFill>
        </p:grpSpPr>
        <p:sp>
          <p:nvSpPr>
            <p:cNvPr id="46" name="직사각형 45"/>
            <p:cNvSpPr/>
            <p:nvPr/>
          </p:nvSpPr>
          <p:spPr>
            <a:xfrm>
              <a:off x="288008" y="6818520"/>
              <a:ext cx="9000000" cy="1979896"/>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dirty="0">
                <a:latin typeface="HY헤드라인M" pitchFamily="18" charset="-127"/>
                <a:ea typeface="HY헤드라인M" pitchFamily="18" charset="-127"/>
              </a:endParaRPr>
            </a:p>
          </p:txBody>
        </p:sp>
        <p:sp>
          <p:nvSpPr>
            <p:cNvPr id="56" name="직사각형 55"/>
            <p:cNvSpPr/>
            <p:nvPr/>
          </p:nvSpPr>
          <p:spPr>
            <a:xfrm>
              <a:off x="288000" y="6818520"/>
              <a:ext cx="9000000" cy="4406816"/>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457200" indent="-457200" algn="just">
                <a:buAutoNum type="arabicPeriod"/>
              </a:pPr>
              <a:r>
                <a:rPr lang="en-US" altLang="ko-KR" dirty="0">
                  <a:solidFill>
                    <a:schemeClr val="tx1"/>
                  </a:solidFill>
                  <a:latin typeface="HY헤드라인M" pitchFamily="18" charset="-127"/>
                  <a:ea typeface="HY헤드라인M" pitchFamily="18" charset="-127"/>
                </a:rPr>
                <a:t>Spread your legs with the distance of your shoulders and maintain your back’s natural curve. Slightly tighten your abdomen and straighten your chest.</a:t>
              </a:r>
              <a:r>
                <a:rPr lang="ko-KR" altLang="en-US" dirty="0">
                  <a:solidFill>
                    <a:schemeClr val="tx1"/>
                  </a:solidFill>
                  <a:latin typeface="HY헤드라인M" pitchFamily="18" charset="-127"/>
                  <a:ea typeface="HY헤드라인M" pitchFamily="18" charset="-127"/>
                </a:rPr>
                <a:t> </a:t>
              </a:r>
              <a:endParaRPr lang="en-US" altLang="ko-KR" dirty="0">
                <a:solidFill>
                  <a:schemeClr val="tx1"/>
                </a:solidFill>
                <a:latin typeface="HY헤드라인M" pitchFamily="18" charset="-127"/>
                <a:ea typeface="HY헤드라인M" pitchFamily="18" charset="-127"/>
              </a:endParaRPr>
            </a:p>
            <a:p>
              <a:pPr marL="457200" indent="-457200" algn="just">
                <a:buAutoNum type="arabicPeriod"/>
              </a:pPr>
              <a:endParaRPr lang="en-US" altLang="ko-KR" dirty="0">
                <a:solidFill>
                  <a:schemeClr val="tx1"/>
                </a:solidFill>
                <a:latin typeface="HY헤드라인M" pitchFamily="18" charset="-127"/>
                <a:ea typeface="HY헤드라인M" pitchFamily="18" charset="-127"/>
              </a:endParaRPr>
            </a:p>
            <a:p>
              <a:pPr marL="457200" indent="-457200" algn="just">
                <a:buAutoNum type="arabicPeriod"/>
              </a:pPr>
              <a:r>
                <a:rPr lang="en-US" altLang="ko-KR" dirty="0">
                  <a:solidFill>
                    <a:schemeClr val="tx1"/>
                  </a:solidFill>
                  <a:latin typeface="HY헤드라인M" pitchFamily="18" charset="-127"/>
                  <a:ea typeface="HY헤드라인M" pitchFamily="18" charset="-127"/>
                </a:rPr>
                <a:t>Lean your torso forward with your back straight and feel the weight on your knees. Use the strength of your knees to stand up. </a:t>
              </a:r>
            </a:p>
            <a:p>
              <a:pPr marL="457200" indent="-457200" algn="just">
                <a:buAutoNum type="arabicPeriod"/>
              </a:pPr>
              <a:endParaRPr lang="en-US" altLang="ko-KR" dirty="0">
                <a:solidFill>
                  <a:schemeClr val="tx1"/>
                </a:solidFill>
                <a:latin typeface="HY헤드라인M" pitchFamily="18" charset="-127"/>
                <a:ea typeface="HY헤드라인M" pitchFamily="18" charset="-127"/>
              </a:endParaRPr>
            </a:p>
            <a:p>
              <a:pPr marL="457200" indent="-457200" algn="just">
                <a:buAutoNum type="arabicPeriod"/>
              </a:pPr>
              <a:r>
                <a:rPr lang="en-US" altLang="ko-KR" dirty="0">
                  <a:solidFill>
                    <a:schemeClr val="tx1"/>
                  </a:solidFill>
                  <a:latin typeface="HY헤드라인M" pitchFamily="18" charset="-127"/>
                  <a:ea typeface="HY헤드라인M" pitchFamily="18" charset="-127"/>
                </a:rPr>
                <a:t>When returning to a sitting position, keep your back straight and push your hip backward. </a:t>
              </a:r>
            </a:p>
          </p:txBody>
        </p:sp>
        <p:sp>
          <p:nvSpPr>
            <p:cNvPr id="62" name="직사각형 61"/>
            <p:cNvSpPr/>
            <p:nvPr/>
          </p:nvSpPr>
          <p:spPr>
            <a:xfrm>
              <a:off x="288000" y="11081320"/>
              <a:ext cx="9000000" cy="853622"/>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fontAlgn="base"/>
              <a:r>
                <a:rPr lang="en-US" altLang="ko-KR" sz="1800" b="1" dirty="0">
                  <a:solidFill>
                    <a:schemeClr val="tx1">
                      <a:lumMod val="75000"/>
                      <a:lumOff val="25000"/>
                    </a:schemeClr>
                  </a:solidFill>
                  <a:latin typeface="HY헤드라인M" pitchFamily="18" charset="-127"/>
                  <a:ea typeface="HY헤드라인M" pitchFamily="18" charset="-127"/>
                </a:rPr>
                <a:t>Caution</a:t>
              </a:r>
            </a:p>
            <a:p>
              <a:pPr fontAlgn="base"/>
              <a:r>
                <a:rPr lang="en-US" altLang="ko-KR" sz="1800" b="1" dirty="0">
                  <a:solidFill>
                    <a:schemeClr val="tx1">
                      <a:lumMod val="75000"/>
                      <a:lumOff val="25000"/>
                    </a:schemeClr>
                  </a:solidFill>
                  <a:latin typeface="HY헤드라인M" pitchFamily="18" charset="-127"/>
                  <a:ea typeface="HY헤드라인M" pitchFamily="18" charset="-127"/>
                </a:rPr>
                <a:t>When standing or sitting down, make sure your knees don’t stick out farther than your feet.</a:t>
              </a:r>
            </a:p>
          </p:txBody>
        </p:sp>
      </p:grpSp>
      <p:pic>
        <p:nvPicPr>
          <p:cNvPr id="1026" name="Picture 2"/>
          <p:cNvPicPr preferRelativeResize="0">
            <a:picLocks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6588008" y="12060000"/>
            <a:ext cx="2700000" cy="54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 name="그림 1"/>
          <p:cNvPicPr>
            <a:picLocks noChangeAspect="1"/>
          </p:cNvPicPr>
          <p:nvPr/>
        </p:nvPicPr>
        <p:blipFill>
          <a:blip r:embed="rId4">
            <a:extLst>
              <a:ext uri="{BEBA8EAE-BF5A-486C-A8C5-ECC9F3942E4B}">
                <a14:imgProps xmlns:a14="http://schemas.microsoft.com/office/drawing/2010/main">
                  <a14:imgLayer r:embed="rId5">
                    <a14:imgEffect>
                      <a14:backgroundRemoval t="0" b="100000" l="0" r="100000">
                        <a14:foregroundMark x1="40682" y1="23810" x2="40682" y2="23810"/>
                        <a14:foregroundMark x1="40682" y1="26531" x2="40682" y2="26531"/>
                        <a14:foregroundMark x1="43409" y1="23469" x2="43409" y2="23469"/>
                        <a14:foregroundMark x1="41364" y1="27891" x2="41364" y2="27891"/>
                        <a14:foregroundMark x1="28636" y1="40136" x2="28636" y2="40136"/>
                        <a14:foregroundMark x1="34773" y1="56122" x2="34773" y2="56122"/>
                        <a14:foregroundMark x1="31818" y1="56122" x2="31818" y2="56122"/>
                        <a14:foregroundMark x1="30682" y1="59184" x2="30682" y2="59184"/>
                        <a14:foregroundMark x1="28409" y1="53401" x2="28409" y2="53401"/>
                        <a14:foregroundMark x1="24545" y1="53401" x2="24545" y2="53401"/>
                        <a14:foregroundMark x1="81818" y1="48639" x2="81818" y2="48639"/>
                        <a14:foregroundMark x1="82273" y1="41837" x2="82273" y2="41837"/>
                        <a14:foregroundMark x1="88409" y1="19728" x2="88409" y2="19728"/>
                        <a14:foregroundMark x1="88409" y1="16327" x2="88409" y2="16327"/>
                        <a14:foregroundMark x1="87045" y1="13605" x2="87045" y2="13605"/>
                        <a14:foregroundMark x1="89773" y1="13946" x2="89773" y2="13946"/>
                        <a14:foregroundMark x1="88182" y1="19048" x2="88182" y2="19048"/>
                        <a14:foregroundMark x1="87273" y1="20748" x2="87273" y2="20748"/>
                        <a14:foregroundMark x1="82273" y1="48639" x2="82273" y2="48639"/>
                        <a14:foregroundMark x1="84318" y1="56803" x2="84318" y2="56803"/>
                        <a14:foregroundMark x1="84773" y1="62585" x2="84773" y2="62585"/>
                        <a14:foregroundMark x1="73182" y1="65986" x2="73182" y2="65986"/>
                        <a14:foregroundMark x1="68864" y1="65986" x2="68864" y2="65986"/>
                        <a14:foregroundMark x1="65455" y1="66667" x2="65455" y2="66667"/>
                      </a14:backgroundRemoval>
                    </a14:imgEffect>
                  </a14:imgLayer>
                </a14:imgProps>
              </a:ext>
              <a:ext uri="{28A0092B-C50C-407E-A947-70E740481C1C}">
                <a14:useLocalDpi xmlns:a14="http://schemas.microsoft.com/office/drawing/2010/main" val="0"/>
              </a:ext>
            </a:extLst>
          </a:blip>
          <a:stretch>
            <a:fillRect/>
          </a:stretch>
        </p:blipFill>
        <p:spPr>
          <a:xfrm>
            <a:off x="1770157" y="2191320"/>
            <a:ext cx="6466025" cy="4320480"/>
          </a:xfrm>
          <a:prstGeom prst="rect">
            <a:avLst/>
          </a:prstGeom>
        </p:spPr>
      </p:pic>
    </p:spTree>
    <p:extLst>
      <p:ext uri="{BB962C8B-B14F-4D97-AF65-F5344CB8AC3E}">
        <p14:creationId xmlns:p14="http://schemas.microsoft.com/office/powerpoint/2010/main" val="412146827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직사각형 6"/>
          <p:cNvSpPr/>
          <p:nvPr/>
        </p:nvSpPr>
        <p:spPr>
          <a:xfrm>
            <a:off x="1125500" y="42730"/>
            <a:ext cx="7755340" cy="2160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altLang="ko-KR" sz="5000" dirty="0">
                <a:solidFill>
                  <a:srgbClr val="FF0000"/>
                </a:solidFill>
                <a:latin typeface="HY헤드라인M" pitchFamily="18" charset="-127"/>
                <a:ea typeface="HY헤드라인M" pitchFamily="18" charset="-127"/>
              </a:rPr>
              <a:t>Abdominal Bracing with Walking</a:t>
            </a:r>
          </a:p>
          <a:p>
            <a:endParaRPr lang="en-US" altLang="ko-KR" sz="3200" dirty="0">
              <a:solidFill>
                <a:schemeClr val="bg1"/>
              </a:solidFill>
              <a:latin typeface="HY헤드라인M" pitchFamily="18" charset="-127"/>
              <a:ea typeface="HY헤드라인M" pitchFamily="18" charset="-127"/>
            </a:endParaRPr>
          </a:p>
        </p:txBody>
      </p:sp>
      <p:grpSp>
        <p:nvGrpSpPr>
          <p:cNvPr id="72" name="그룹 71"/>
          <p:cNvGrpSpPr/>
          <p:nvPr/>
        </p:nvGrpSpPr>
        <p:grpSpPr>
          <a:xfrm>
            <a:off x="192088" y="6818520"/>
            <a:ext cx="9289032" cy="5764494"/>
            <a:chOff x="192088" y="6818520"/>
            <a:chExt cx="9289032" cy="5764494"/>
          </a:xfrm>
        </p:grpSpPr>
        <p:sp>
          <p:nvSpPr>
            <p:cNvPr id="46" name="직사각형 45"/>
            <p:cNvSpPr/>
            <p:nvPr/>
          </p:nvSpPr>
          <p:spPr>
            <a:xfrm>
              <a:off x="288008" y="6818520"/>
              <a:ext cx="9000000" cy="197989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dirty="0">
                <a:latin typeface="HY헤드라인M" pitchFamily="18" charset="-127"/>
                <a:ea typeface="HY헤드라인M" pitchFamily="18" charset="-127"/>
              </a:endParaRPr>
            </a:p>
          </p:txBody>
        </p:sp>
        <p:grpSp>
          <p:nvGrpSpPr>
            <p:cNvPr id="53" name="그룹 52"/>
            <p:cNvGrpSpPr/>
            <p:nvPr/>
          </p:nvGrpSpPr>
          <p:grpSpPr>
            <a:xfrm>
              <a:off x="192088" y="6818520"/>
              <a:ext cx="9289032" cy="3981346"/>
              <a:chOff x="192088" y="1687498"/>
              <a:chExt cx="9289032" cy="3981346"/>
            </a:xfrm>
          </p:grpSpPr>
          <p:sp>
            <p:nvSpPr>
              <p:cNvPr id="56" name="직사각형 55"/>
              <p:cNvSpPr/>
              <p:nvPr/>
            </p:nvSpPr>
            <p:spPr>
              <a:xfrm>
                <a:off x="288000" y="1687498"/>
                <a:ext cx="9000000" cy="361472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457200" indent="-457200" algn="just">
                  <a:buFont typeface="+mj-lt"/>
                  <a:buAutoNum type="arabicPeriod"/>
                </a:pPr>
                <a:endParaRPr lang="en-US" altLang="ko-KR" sz="2400" dirty="0">
                  <a:solidFill>
                    <a:schemeClr val="tx1"/>
                  </a:solidFill>
                  <a:latin typeface="HY헤드라인M" pitchFamily="18" charset="-127"/>
                  <a:ea typeface="HY헤드라인M" pitchFamily="18" charset="-127"/>
                </a:endParaRPr>
              </a:p>
              <a:p>
                <a:pPr marL="457200" indent="-457200" algn="just">
                  <a:buFont typeface="+mj-lt"/>
                  <a:buAutoNum type="arabicPeriod"/>
                </a:pPr>
                <a:endParaRPr lang="en-US" altLang="ko-KR" sz="2400" dirty="0">
                  <a:solidFill>
                    <a:schemeClr val="tx1"/>
                  </a:solidFill>
                  <a:latin typeface="HY헤드라인M" pitchFamily="18" charset="-127"/>
                  <a:ea typeface="HY헤드라인M" pitchFamily="18" charset="-127"/>
                </a:endParaRPr>
              </a:p>
              <a:p>
                <a:pPr marL="457200" indent="-457200" algn="just">
                  <a:buFont typeface="+mj-lt"/>
                  <a:buAutoNum type="arabicPeriod"/>
                </a:pPr>
                <a:endParaRPr lang="en-US" altLang="ko-KR" sz="2400" dirty="0">
                  <a:solidFill>
                    <a:schemeClr val="tx1"/>
                  </a:solidFill>
                  <a:latin typeface="HY헤드라인M" pitchFamily="18" charset="-127"/>
                  <a:ea typeface="HY헤드라인M" pitchFamily="18" charset="-127"/>
                </a:endParaRPr>
              </a:p>
              <a:p>
                <a:pPr marL="457200" indent="-457200" algn="just">
                  <a:buFont typeface="+mj-lt"/>
                  <a:buAutoNum type="arabicPeriod"/>
                </a:pPr>
                <a:r>
                  <a:rPr lang="en-US" altLang="ko-KR" sz="2400" dirty="0">
                    <a:solidFill>
                      <a:schemeClr val="tx1"/>
                    </a:solidFill>
                    <a:latin typeface="HY헤드라인M" pitchFamily="18" charset="-127"/>
                    <a:ea typeface="HY헤드라인M" pitchFamily="18" charset="-127"/>
                  </a:rPr>
                  <a:t>Standing straight, clench your fists. Lift one hand to your chest and slightly pull the other hand back right above your pelvis.</a:t>
                </a:r>
              </a:p>
              <a:p>
                <a:pPr marL="457200" indent="-457200" algn="just">
                  <a:buFont typeface="+mj-lt"/>
                  <a:buAutoNum type="arabicPeriod"/>
                </a:pPr>
                <a:endParaRPr lang="en-US" altLang="ko-KR" sz="2400" dirty="0">
                  <a:solidFill>
                    <a:schemeClr val="tx1"/>
                  </a:solidFill>
                  <a:latin typeface="HY헤드라인M" pitchFamily="18" charset="-127"/>
                  <a:ea typeface="HY헤드라인M" pitchFamily="18" charset="-127"/>
                </a:endParaRPr>
              </a:p>
              <a:p>
                <a:pPr marL="457200" indent="-457200" algn="just">
                  <a:buFont typeface="+mj-lt"/>
                  <a:buAutoNum type="arabicPeriod"/>
                </a:pPr>
                <a:r>
                  <a:rPr lang="en-US" altLang="ko-KR" sz="2400" dirty="0">
                    <a:solidFill>
                      <a:schemeClr val="tx1"/>
                    </a:solidFill>
                    <a:latin typeface="HY헤드라인M" pitchFamily="18" charset="-127"/>
                    <a:ea typeface="HY헤드라인M" pitchFamily="18" charset="-127"/>
                  </a:rPr>
                  <a:t>Your feet should touch the ground in the heel-horizontal level-big toe order. An adequate stride is usually your height minus 100 cm.</a:t>
                </a:r>
              </a:p>
              <a:p>
                <a:pPr marL="457200" indent="-457200" algn="just">
                  <a:buFont typeface="+mj-lt"/>
                  <a:buAutoNum type="arabicPeriod"/>
                </a:pPr>
                <a:endParaRPr lang="en-US" altLang="ko-KR" sz="2400" dirty="0">
                  <a:solidFill>
                    <a:schemeClr val="tx1"/>
                  </a:solidFill>
                  <a:latin typeface="HY헤드라인M" pitchFamily="18" charset="-127"/>
                  <a:ea typeface="HY헤드라인M" pitchFamily="18" charset="-127"/>
                </a:endParaRPr>
              </a:p>
              <a:p>
                <a:pPr marL="457200" indent="-457200" algn="just">
                  <a:buFont typeface="+mj-lt"/>
                  <a:buAutoNum type="arabicPeriod"/>
                </a:pPr>
                <a:r>
                  <a:rPr lang="en-US" altLang="ko-KR" sz="2400" dirty="0">
                    <a:solidFill>
                      <a:schemeClr val="tx1"/>
                    </a:solidFill>
                    <a:latin typeface="HY헤드라인M" pitchFamily="18" charset="-127"/>
                    <a:ea typeface="HY헤드라인M" pitchFamily="18" charset="-127"/>
                  </a:rPr>
                  <a:t>Slightly bend your knees and walk in an 11 shape, with your knees brushing each other.</a:t>
                </a:r>
              </a:p>
              <a:p>
                <a:pPr marL="457200" indent="-457200" algn="just">
                  <a:buFont typeface="+mj-lt"/>
                  <a:buAutoNum type="arabicPeriod"/>
                </a:pPr>
                <a:endParaRPr lang="en-US" altLang="ko-KR" sz="2400" dirty="0">
                  <a:solidFill>
                    <a:schemeClr val="tx1"/>
                  </a:solidFill>
                  <a:latin typeface="HY헤드라인M" pitchFamily="18" charset="-127"/>
                  <a:ea typeface="HY헤드라인M" pitchFamily="18" charset="-127"/>
                </a:endParaRPr>
              </a:p>
              <a:p>
                <a:pPr marL="457200" indent="-457200" algn="just">
                  <a:buFont typeface="+mj-lt"/>
                  <a:buAutoNum type="arabicPeriod"/>
                </a:pPr>
                <a:r>
                  <a:rPr lang="en-US" altLang="ko-KR" sz="2400" dirty="0">
                    <a:solidFill>
                      <a:schemeClr val="tx1"/>
                    </a:solidFill>
                    <a:latin typeface="HY헤드라인M" pitchFamily="18" charset="-127"/>
                    <a:ea typeface="HY헤드라인M" pitchFamily="18" charset="-127"/>
                  </a:rPr>
                  <a:t>Keep your chest and back straight, and your chin tucked in. Brace your abdomen while walking.</a:t>
                </a:r>
              </a:p>
            </p:txBody>
          </p:sp>
          <p:sp>
            <p:nvSpPr>
              <p:cNvPr id="58" name="직사각형 57"/>
              <p:cNvSpPr/>
              <p:nvPr/>
            </p:nvSpPr>
            <p:spPr>
              <a:xfrm>
                <a:off x="192088" y="2493914"/>
                <a:ext cx="9289032" cy="317493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altLang="ko-KR" sz="1800" dirty="0">
                  <a:solidFill>
                    <a:srgbClr val="363636"/>
                  </a:solidFill>
                  <a:latin typeface="HY헤드라인M" pitchFamily="18" charset="-127"/>
                  <a:ea typeface="HY헤드라인M" pitchFamily="18" charset="-127"/>
                </a:endParaRPr>
              </a:p>
            </p:txBody>
          </p:sp>
        </p:grpSp>
        <p:sp>
          <p:nvSpPr>
            <p:cNvPr id="62" name="직사각형 61"/>
            <p:cNvSpPr/>
            <p:nvPr/>
          </p:nvSpPr>
          <p:spPr>
            <a:xfrm>
              <a:off x="288000" y="11729392"/>
              <a:ext cx="9000000" cy="853622"/>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fontAlgn="base"/>
              <a:r>
                <a:rPr lang="en-US" altLang="ko-KR" sz="1800" b="1" dirty="0">
                  <a:solidFill>
                    <a:srgbClr val="363636"/>
                  </a:solidFill>
                  <a:latin typeface="HY헤드라인M" pitchFamily="18" charset="-127"/>
                  <a:ea typeface="HY헤드라인M" pitchFamily="18" charset="-127"/>
                </a:rPr>
                <a:t>Caution</a:t>
              </a:r>
            </a:p>
            <a:p>
              <a:pPr fontAlgn="base"/>
              <a:r>
                <a:rPr lang="en-US" altLang="ko-KR" sz="1800" b="1" dirty="0">
                  <a:solidFill>
                    <a:srgbClr val="363636"/>
                  </a:solidFill>
                  <a:latin typeface="HY헤드라인M" pitchFamily="18" charset="-127"/>
                  <a:ea typeface="HY헤드라인M" pitchFamily="18" charset="-127"/>
                </a:rPr>
                <a:t>It is important to brace your abdomen while walking.</a:t>
              </a:r>
            </a:p>
          </p:txBody>
        </p:sp>
      </p:grpSp>
      <p:pic>
        <p:nvPicPr>
          <p:cNvPr id="1026" name="Picture 2"/>
          <p:cNvPicPr preferRelativeResize="0">
            <a:picLocks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6588008" y="12060000"/>
            <a:ext cx="2700000" cy="54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 name="그림 1"/>
          <p:cNvPicPr>
            <a:picLocks noChangeAspect="1"/>
          </p:cNvPicPr>
          <p:nvPr/>
        </p:nvPicPr>
        <p:blipFill>
          <a:blip r:embed="rId4">
            <a:extLst>
              <a:ext uri="{BEBA8EAE-BF5A-486C-A8C5-ECC9F3942E4B}">
                <a14:imgProps xmlns:a14="http://schemas.microsoft.com/office/drawing/2010/main">
                  <a14:imgLayer r:embed="rId5">
                    <a14:imgEffect>
                      <a14:backgroundRemoval t="0" b="100000" l="0" r="100000">
                        <a14:foregroundMark x1="72619" y1="72647" x2="72619" y2="72647"/>
                        <a14:foregroundMark x1="74702" y1="74706" x2="74702" y2="74706"/>
                        <a14:foregroundMark x1="78274" y1="78529" x2="78274" y2="78529"/>
                        <a14:foregroundMark x1="76786" y1="72353" x2="76786" y2="72353"/>
                        <a14:foregroundMark x1="72917" y1="69412" x2="72917" y2="69412"/>
                        <a14:foregroundMark x1="73214" y1="48529" x2="73214" y2="48529"/>
                        <a14:foregroundMark x1="71131" y1="51765" x2="71131" y2="51765"/>
                        <a14:foregroundMark x1="69345" y1="56176" x2="69345" y2="56176"/>
                        <a14:foregroundMark x1="69345" y1="57353" x2="69345" y2="58235"/>
                        <a14:foregroundMark x1="69345" y1="58529" x2="70238" y2="53824"/>
                        <a14:foregroundMark x1="70238" y1="53235" x2="70238" y2="53235"/>
                        <a14:foregroundMark x1="70238" y1="53235" x2="70238" y2="54118"/>
                        <a14:foregroundMark x1="70833" y1="44412" x2="70833" y2="44412"/>
                        <a14:foregroundMark x1="75000" y1="42647" x2="75000" y2="42647"/>
                        <a14:foregroundMark x1="79762" y1="40000" x2="79762" y2="40000"/>
                        <a14:foregroundMark x1="78571" y1="36471" x2="78571" y2="36471"/>
                        <a14:foregroundMark x1="75298" y1="30882" x2="75298" y2="30882"/>
                        <a14:foregroundMark x1="46429" y1="20294" x2="46429" y2="20294"/>
                        <a14:foregroundMark x1="46429" y1="22353" x2="46429" y2="22353"/>
                        <a14:foregroundMark x1="47024" y1="25000" x2="47024" y2="25000"/>
                        <a14:foregroundMark x1="74107" y1="88235" x2="74107" y2="88235"/>
                        <a14:foregroundMark x1="77381" y1="87941" x2="77381" y2="87941"/>
                        <a14:foregroundMark x1="79762" y1="87941" x2="79762" y2="87941"/>
                        <a14:foregroundMark x1="81548" y1="87941" x2="81548" y2="87941"/>
                        <a14:foregroundMark x1="76488" y1="88235" x2="76488" y2="88235"/>
                        <a14:foregroundMark x1="75595" y1="88824" x2="75595" y2="88824"/>
                        <a14:foregroundMark x1="75000" y1="89118" x2="75000" y2="89118"/>
                        <a14:backgroundMark x1="45536" y1="10294" x2="45536" y2="10294"/>
                        <a14:backgroundMark x1="52976" y1="8235" x2="52976" y2="8235"/>
                        <a14:backgroundMark x1="74405" y1="6176" x2="74405" y2="6176"/>
                        <a14:backgroundMark x1="86905" y1="6471" x2="86905" y2="6471"/>
                        <a14:backgroundMark x1="87500" y1="26765" x2="87500" y2="26765"/>
                        <a14:backgroundMark x1="81845" y1="31471" x2="81845" y2="31471"/>
                        <a14:backgroundMark x1="47321" y1="45294" x2="47321" y2="45294"/>
                        <a14:backgroundMark x1="52679" y1="59706" x2="52679" y2="59706"/>
                        <a14:backgroundMark x1="50000" y1="70294" x2="50000" y2="70294"/>
                        <a14:backgroundMark x1="53274" y1="78824" x2="53274" y2="78824"/>
                        <a14:backgroundMark x1="57440" y1="73235" x2="57440" y2="73235"/>
                        <a14:backgroundMark x1="42857" y1="78235" x2="42857" y2="78235"/>
                        <a14:backgroundMark x1="42560" y1="84118" x2="42560" y2="84118"/>
                        <a14:backgroundMark x1="39881" y1="64412" x2="39881" y2="64412"/>
                        <a14:backgroundMark x1="44940" y1="58529" x2="44940" y2="58529"/>
                        <a14:backgroundMark x1="50893" y1="57059" x2="50893" y2="57059"/>
                        <a14:backgroundMark x1="83333" y1="59118" x2="83333" y2="59118"/>
                        <a14:backgroundMark x1="86310" y1="61765" x2="86310" y2="61765"/>
                        <a14:backgroundMark x1="82143" y1="63824" x2="82143" y2="63824"/>
                        <a14:backgroundMark x1="83929" y1="65882" x2="83929" y2="65882"/>
                        <a14:backgroundMark x1="83333" y1="67353" x2="83333" y2="67353"/>
                        <a14:backgroundMark x1="83929" y1="70294" x2="83929" y2="70294"/>
                        <a14:backgroundMark x1="84226" y1="70882" x2="84226" y2="70882"/>
                        <a14:backgroundMark x1="84226" y1="70882" x2="84226" y2="70882"/>
                        <a14:backgroundMark x1="86310" y1="77941" x2="86310" y2="77941"/>
                        <a14:backgroundMark x1="87202" y1="87059" x2="87202" y2="87059"/>
                        <a14:backgroundMark x1="87500" y1="91471" x2="87500" y2="91471"/>
                        <a14:backgroundMark x1="85714" y1="95000" x2="85714" y2="95000"/>
                        <a14:backgroundMark x1="89583" y1="90588" x2="89583" y2="90588"/>
                        <a14:backgroundMark x1="89286" y1="89118" x2="89286" y2="89118"/>
                        <a14:backgroundMark x1="88393" y1="85882" x2="88393" y2="85882"/>
                        <a14:backgroundMark x1="88393" y1="80588" x2="88393" y2="80588"/>
                        <a14:backgroundMark x1="87798" y1="75882" x2="87798" y2="75882"/>
                        <a14:backgroundMark x1="87798" y1="72647" x2="87798" y2="72647"/>
                        <a14:backgroundMark x1="82738" y1="74706" x2="82738" y2="74706"/>
                        <a14:backgroundMark x1="83631" y1="77941" x2="83631" y2="77941"/>
                        <a14:backgroundMark x1="80655" y1="74706" x2="80655" y2="74706"/>
                        <a14:backgroundMark x1="80357" y1="74118" x2="80357" y2="74118"/>
                        <a14:backgroundMark x1="80060" y1="72059" x2="80060" y2="72059"/>
                        <a14:backgroundMark x1="80060" y1="67941" x2="80060" y2="67941"/>
                        <a14:backgroundMark x1="80060" y1="67353" x2="80060" y2="66765"/>
                        <a14:backgroundMark x1="80357" y1="62941" x2="80357" y2="62941"/>
                        <a14:backgroundMark x1="70833" y1="84412" x2="70833" y2="84412"/>
                        <a14:backgroundMark x1="70833" y1="84412" x2="70833" y2="84412"/>
                        <a14:backgroundMark x1="71131" y1="81471" x2="71131" y2="81471"/>
                        <a14:backgroundMark x1="71131" y1="80294" x2="71131" y2="80294"/>
                        <a14:backgroundMark x1="71131" y1="78824" x2="71131" y2="78824"/>
                        <a14:backgroundMark x1="70238" y1="79412" x2="70238" y2="79412"/>
                        <a14:backgroundMark x1="70536" y1="77647" x2="70536" y2="77647"/>
                        <a14:backgroundMark x1="70536" y1="76765" x2="70536" y2="76765"/>
                        <a14:backgroundMark x1="52381" y1="78235" x2="52381" y2="78235"/>
                        <a14:backgroundMark x1="52083" y1="76176" x2="52083" y2="76176"/>
                        <a14:backgroundMark x1="55952" y1="76765" x2="55952" y2="76765"/>
                        <a14:backgroundMark x1="61310" y1="74412" x2="61310" y2="74412"/>
                        <a14:backgroundMark x1="60417" y1="75882" x2="60417" y2="75882"/>
                        <a14:backgroundMark x1="59524" y1="77647" x2="59524" y2="77647"/>
                        <a14:backgroundMark x1="60714" y1="80000" x2="60714" y2="80000"/>
                        <a14:backgroundMark x1="61607" y1="75588" x2="61607" y2="75588"/>
                        <a14:backgroundMark x1="51786" y1="78824" x2="51786" y2="78824"/>
                        <a14:backgroundMark x1="62202" y1="74706" x2="62202" y2="74706"/>
                        <a14:backgroundMark x1="61607" y1="75588" x2="61607" y2="75588"/>
                        <a14:backgroundMark x1="61905" y1="74412" x2="61905" y2="74412"/>
                        <a14:backgroundMark x1="62202" y1="74118" x2="62202" y2="74118"/>
                        <a14:backgroundMark x1="62500" y1="74412" x2="62500" y2="74412"/>
                        <a14:backgroundMark x1="61607" y1="76765" x2="61607" y2="76765"/>
                        <a14:backgroundMark x1="61905" y1="75882" x2="61905" y2="75882"/>
                        <a14:backgroundMark x1="61905" y1="76176" x2="61905" y2="76176"/>
                        <a14:backgroundMark x1="38393" y1="82353" x2="38393" y2="82353"/>
                        <a14:backgroundMark x1="40179" y1="80882" x2="40179" y2="80882"/>
                        <a14:backgroundMark x1="41964" y1="51471" x2="41964" y2="51471"/>
                        <a14:backgroundMark x1="41964" y1="41765" x2="41964" y2="41765"/>
                        <a14:backgroundMark x1="38988" y1="36471" x2="38988" y2="36471"/>
                        <a14:backgroundMark x1="39583" y1="31471" x2="39583" y2="31471"/>
                        <a14:backgroundMark x1="43155" y1="9412" x2="43155" y2="9412"/>
                        <a14:backgroundMark x1="41667" y1="6176" x2="44940" y2="5882"/>
                        <a14:backgroundMark x1="55952" y1="5294" x2="56845" y2="5294"/>
                        <a14:backgroundMark x1="75595" y1="2353" x2="75595" y2="2353"/>
                        <a14:backgroundMark x1="81548" y1="6176" x2="81548" y2="6176"/>
                        <a14:backgroundMark x1="81548" y1="6471" x2="81548" y2="6471"/>
                        <a14:backgroundMark x1="83333" y1="5882" x2="83333" y2="5882"/>
                        <a14:backgroundMark x1="83929" y1="5588" x2="83929" y2="5588"/>
                        <a14:backgroundMark x1="85119" y1="4412" x2="85119" y2="4412"/>
                        <a14:backgroundMark x1="85714" y1="3824" x2="85714" y2="3824"/>
                        <a14:backgroundMark x1="82440" y1="3529" x2="79464" y2="3824"/>
                        <a14:backgroundMark x1="79167" y1="3824" x2="79167" y2="3824"/>
                        <a14:backgroundMark x1="84226" y1="11176" x2="84226" y2="11176"/>
                        <a14:backgroundMark x1="86607" y1="10882" x2="86607" y2="10882"/>
                        <a14:backgroundMark x1="86607" y1="14706" x2="86607" y2="14706"/>
                        <a14:backgroundMark x1="88095" y1="21471" x2="88095" y2="21471"/>
                        <a14:backgroundMark x1="88393" y1="25294" x2="88393" y2="25294"/>
                        <a14:backgroundMark x1="88393" y1="25588" x2="88393" y2="25588"/>
                        <a14:backgroundMark x1="86607" y1="26176" x2="86607" y2="26176"/>
                        <a14:backgroundMark x1="80655" y1="26176" x2="80655" y2="26176"/>
                        <a14:backgroundMark x1="80060" y1="23235" x2="80060" y2="23235"/>
                        <a14:backgroundMark x1="80060" y1="22059" x2="80060" y2="22059"/>
                        <a14:backgroundMark x1="80060" y1="20000" x2="80060" y2="19118"/>
                        <a14:backgroundMark x1="80060" y1="16765" x2="80060" y2="16765"/>
                        <a14:backgroundMark x1="80060" y1="16471" x2="80060" y2="16471"/>
                        <a14:backgroundMark x1="76488" y1="22353" x2="76488" y2="22353"/>
                        <a14:backgroundMark x1="75893" y1="19706" x2="75893" y2="19706"/>
                        <a14:backgroundMark x1="76190" y1="19412" x2="76488" y2="18235"/>
                        <a14:backgroundMark x1="76488" y1="17941" x2="76488" y2="17941"/>
                        <a14:backgroundMark x1="76488" y1="17941" x2="76488" y2="16471"/>
                        <a14:backgroundMark x1="76488" y1="16471" x2="76488" y2="16471"/>
                        <a14:backgroundMark x1="76488" y1="15588" x2="76488" y2="15588"/>
                        <a14:backgroundMark x1="76786" y1="18235" x2="76786" y2="18235"/>
                        <a14:backgroundMark x1="77083" y1="22647" x2="77083" y2="22647"/>
                        <a14:backgroundMark x1="77381" y1="22941" x2="79167" y2="24706"/>
                        <a14:backgroundMark x1="82738" y1="25882" x2="82738" y2="25882"/>
                        <a14:backgroundMark x1="84226" y1="27059" x2="84524" y2="27647"/>
                        <a14:backgroundMark x1="85417" y1="29412" x2="85417" y2="29412"/>
                        <a14:backgroundMark x1="72619" y1="21765" x2="72619" y2="21765"/>
                        <a14:backgroundMark x1="73214" y1="18529" x2="73214" y2="18529"/>
                        <a14:backgroundMark x1="81250" y1="24706" x2="81250" y2="25294"/>
                        <a14:backgroundMark x1="83929" y1="32059" x2="84821" y2="36471"/>
                        <a14:backgroundMark x1="89286" y1="40882" x2="89286" y2="40882"/>
                        <a14:backgroundMark x1="88988" y1="42647" x2="88988" y2="42647"/>
                        <a14:backgroundMark x1="88095" y1="44118" x2="88095" y2="45000"/>
                        <a14:backgroundMark x1="87202" y1="46765" x2="86905" y2="47647"/>
                        <a14:backgroundMark x1="85714" y1="48824" x2="85417" y2="49118"/>
                        <a14:backgroundMark x1="84821" y1="51176" x2="84821" y2="51176"/>
                        <a14:backgroundMark x1="83929" y1="52059" x2="83929" y2="52059"/>
                        <a14:backgroundMark x1="83631" y1="52353" x2="83036" y2="48529"/>
                        <a14:backgroundMark x1="83036" y1="47941" x2="83036" y2="47941"/>
                        <a14:backgroundMark x1="81250" y1="45882" x2="81250" y2="45882"/>
                        <a14:backgroundMark x1="81250" y1="45882" x2="81250" y2="45882"/>
                        <a14:backgroundMark x1="85417" y1="42353" x2="85417" y2="42353"/>
                        <a14:backgroundMark x1="85417" y1="42353" x2="85417" y2="42353"/>
                        <a14:backgroundMark x1="87798" y1="49706" x2="87798" y2="49706"/>
                        <a14:backgroundMark x1="77976" y1="45588" x2="77976" y2="45588"/>
                        <a14:backgroundMark x1="75298" y1="37059" x2="75298" y2="37059"/>
                        <a14:backgroundMark x1="75893" y1="38235" x2="75893" y2="38235"/>
                        <a14:backgroundMark x1="75000" y1="38824" x2="75000" y2="38824"/>
                        <a14:backgroundMark x1="74702" y1="39412" x2="74702" y2="39412"/>
                        <a14:backgroundMark x1="37500" y1="26765" x2="37500" y2="26765"/>
                        <a14:backgroundMark x1="48810" y1="43824" x2="48810" y2="43824"/>
                        <a14:backgroundMark x1="41964" y1="41765" x2="41964" y2="41765"/>
                        <a14:backgroundMark x1="39583" y1="48529" x2="39583" y2="48529"/>
                        <a14:backgroundMark x1="42262" y1="36765" x2="42262" y2="36765"/>
                        <a14:backgroundMark x1="40179" y1="26765" x2="40179" y2="26765"/>
                        <a14:backgroundMark x1="39583" y1="25000" x2="39583" y2="25000"/>
                        <a14:backgroundMark x1="39583" y1="25000" x2="39583" y2="25000"/>
                        <a14:backgroundMark x1="41964" y1="25000" x2="41964" y2="25000"/>
                        <a14:backgroundMark x1="42262" y1="30000" x2="42262" y2="30000"/>
                        <a14:backgroundMark x1="42262" y1="30294" x2="42560" y2="30588"/>
                        <a14:backgroundMark x1="42560" y1="31471" x2="42560" y2="31471"/>
                        <a14:backgroundMark x1="42560" y1="31765" x2="42560" y2="31765"/>
                        <a14:backgroundMark x1="44048" y1="38235" x2="44048" y2="38529"/>
                        <a14:backgroundMark x1="45238" y1="44706" x2="45238" y2="44706"/>
                        <a14:backgroundMark x1="45536" y1="45294" x2="45536" y2="45294"/>
                        <a14:backgroundMark x1="46429" y1="46471" x2="46429" y2="46471"/>
                        <a14:backgroundMark x1="45833" y1="47647" x2="45833" y2="47647"/>
                        <a14:backgroundMark x1="44643" y1="49412" x2="44643" y2="49412"/>
                        <a14:backgroundMark x1="43452" y1="51471" x2="43155" y2="51765"/>
                        <a14:backgroundMark x1="43155" y1="53235" x2="43750" y2="54412"/>
                        <a14:backgroundMark x1="44048" y1="54412" x2="45238" y2="54412"/>
                        <a14:backgroundMark x1="50893" y1="52941" x2="50893" y2="52941"/>
                        <a14:backgroundMark x1="51786" y1="51471" x2="52381" y2="50588"/>
                        <a14:backgroundMark x1="52381" y1="49412" x2="52381" y2="47647"/>
                        <a14:backgroundMark x1="52381" y1="45588" x2="52381" y2="45588"/>
                        <a14:backgroundMark x1="52381" y1="45294" x2="52381" y2="44706"/>
                        <a14:backgroundMark x1="53274" y1="40588" x2="53274" y2="40588"/>
                        <a14:backgroundMark x1="53869" y1="40294" x2="53869" y2="40294"/>
                        <a14:backgroundMark x1="54167" y1="41176" x2="55060" y2="43824"/>
                        <a14:backgroundMark x1="55060" y1="43824" x2="55060" y2="44706"/>
                        <a14:backgroundMark x1="55060" y1="46471" x2="55060" y2="47059"/>
                        <a14:backgroundMark x1="55060" y1="48824" x2="55357" y2="51176"/>
                        <a14:backgroundMark x1="56250" y1="55000" x2="56250" y2="57353"/>
                        <a14:backgroundMark x1="56548" y1="60000" x2="56845" y2="61471"/>
                        <a14:backgroundMark x1="56845" y1="62353" x2="56548" y2="63235"/>
                        <a14:backgroundMark x1="55357" y1="64706" x2="54464" y2="65882"/>
                        <a14:backgroundMark x1="53571" y1="67941" x2="53274" y2="69706"/>
                        <a14:backgroundMark x1="54762" y1="69412" x2="54762" y2="69412"/>
                        <a14:backgroundMark x1="59821" y1="65882" x2="59821" y2="65882"/>
                        <a14:backgroundMark x1="61607" y1="66471" x2="61607" y2="66471"/>
                        <a14:backgroundMark x1="61905" y1="67059" x2="61905" y2="67059"/>
                        <a14:backgroundMark x1="59524" y1="71176" x2="59524" y2="71176"/>
                        <a14:backgroundMark x1="57738" y1="72353" x2="57143" y2="72941"/>
                        <a14:backgroundMark x1="54167" y1="73529" x2="54167" y2="73529"/>
                        <a14:backgroundMark x1="54167" y1="73529" x2="54167" y2="73529"/>
                        <a14:backgroundMark x1="53869" y1="73824" x2="53869" y2="74706"/>
                        <a14:backgroundMark x1="51488" y1="76765" x2="51488" y2="76765"/>
                        <a14:backgroundMark x1="51190" y1="78235" x2="50000" y2="83529"/>
                        <a14:backgroundMark x1="50000" y1="84118" x2="50000" y2="84118"/>
                        <a14:backgroundMark x1="50000" y1="84412" x2="50000" y2="84412"/>
                        <a14:backgroundMark x1="48810" y1="86176" x2="48214" y2="86765"/>
                        <a14:backgroundMark x1="47619" y1="87647" x2="47321" y2="88529"/>
                        <a14:backgroundMark x1="46429" y1="90000" x2="46131" y2="90588"/>
                        <a14:backgroundMark x1="45833" y1="91471" x2="45833" y2="91471"/>
                        <a14:backgroundMark x1="70238" y1="96765" x2="70238" y2="96765"/>
                        <a14:backgroundMark x1="70238" y1="96765" x2="70238" y2="96765"/>
                        <a14:backgroundMark x1="70238" y1="96176" x2="70238" y2="96176"/>
                        <a14:backgroundMark x1="70833" y1="95588" x2="70833" y2="95588"/>
                        <a14:backgroundMark x1="71429" y1="95588" x2="71429" y2="95588"/>
                        <a14:backgroundMark x1="73810" y1="96176" x2="73810" y2="96176"/>
                        <a14:backgroundMark x1="77381" y1="96765" x2="77381" y2="96765"/>
                        <a14:backgroundMark x1="77381" y1="96765" x2="77381" y2="96765"/>
                        <a14:backgroundMark x1="66369" y1="96471" x2="66369" y2="96471"/>
                        <a14:backgroundMark x1="66369" y1="96176" x2="66369" y2="96176"/>
                        <a14:backgroundMark x1="67262" y1="95882" x2="67262" y2="95882"/>
                        <a14:backgroundMark x1="62500" y1="96765" x2="62500" y2="96765"/>
                        <a14:backgroundMark x1="61310" y1="97647" x2="61310" y2="97647"/>
                        <a14:backgroundMark x1="60119" y1="97941" x2="60119" y2="97941"/>
                        <a14:backgroundMark x1="59524" y1="97941" x2="59524" y2="97941"/>
                        <a14:backgroundMark x1="58631" y1="97941" x2="58631" y2="97941"/>
                        <a14:backgroundMark x1="52381" y1="97941" x2="52381" y2="97941"/>
                        <a14:backgroundMark x1="58333" y1="41176" x2="58333" y2="41176"/>
                        <a14:backgroundMark x1="52381" y1="21176" x2="52381" y2="21176"/>
                        <a14:backgroundMark x1="54762" y1="17941" x2="54762" y2="17941"/>
                        <a14:backgroundMark x1="55952" y1="21765" x2="55952" y2="21765"/>
                        <a14:backgroundMark x1="54762" y1="25588" x2="54762" y2="25588"/>
                        <a14:backgroundMark x1="56250" y1="24412" x2="56250" y2="24412"/>
                        <a14:backgroundMark x1="57440" y1="23824" x2="57440" y2="23824"/>
                        <a14:backgroundMark x1="57440" y1="23824" x2="57440" y2="23824"/>
                      </a14:backgroundRemoval>
                    </a14:imgEffect>
                  </a14:imgLayer>
                </a14:imgProps>
              </a:ext>
              <a:ext uri="{28A0092B-C50C-407E-A947-70E740481C1C}">
                <a14:useLocalDpi xmlns:a14="http://schemas.microsoft.com/office/drawing/2010/main" val="0"/>
              </a:ext>
            </a:extLst>
          </a:blip>
          <a:stretch>
            <a:fillRect/>
          </a:stretch>
        </p:blipFill>
        <p:spPr>
          <a:xfrm>
            <a:off x="1992008" y="1030033"/>
            <a:ext cx="4778286" cy="4835170"/>
          </a:xfrm>
          <a:prstGeom prst="rect">
            <a:avLst/>
          </a:prstGeom>
        </p:spPr>
      </p:pic>
      <p:sp>
        <p:nvSpPr>
          <p:cNvPr id="14" name="직사각형 13"/>
          <p:cNvSpPr/>
          <p:nvPr/>
        </p:nvSpPr>
        <p:spPr>
          <a:xfrm>
            <a:off x="3189758" y="2666858"/>
            <a:ext cx="1826866" cy="853622"/>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fontAlgn="base"/>
            <a:r>
              <a:rPr lang="en-US" altLang="ko-KR" sz="1800" dirty="0">
                <a:solidFill>
                  <a:schemeClr val="tx1">
                    <a:lumMod val="75000"/>
                    <a:lumOff val="25000"/>
                  </a:schemeClr>
                </a:solidFill>
                <a:latin typeface="HY헤드라인M" pitchFamily="18" charset="-127"/>
                <a:ea typeface="HY헤드라인M" pitchFamily="18" charset="-127"/>
              </a:rPr>
              <a:t>Hands</a:t>
            </a:r>
            <a:r>
              <a:rPr lang="ko-KR" altLang="en-US" sz="1800" dirty="0">
                <a:solidFill>
                  <a:schemeClr val="tx1">
                    <a:lumMod val="75000"/>
                    <a:lumOff val="25000"/>
                  </a:schemeClr>
                </a:solidFill>
                <a:latin typeface="HY헤드라인M" pitchFamily="18" charset="-127"/>
                <a:ea typeface="HY헤드라인M" pitchFamily="18" charset="-127"/>
              </a:rPr>
              <a:t> </a:t>
            </a:r>
            <a:endParaRPr lang="en-US" altLang="ko-KR" sz="1800" dirty="0">
              <a:solidFill>
                <a:schemeClr val="tx1">
                  <a:lumMod val="75000"/>
                  <a:lumOff val="25000"/>
                </a:schemeClr>
              </a:solidFill>
              <a:latin typeface="HY헤드라인M" pitchFamily="18" charset="-127"/>
              <a:ea typeface="HY헤드라인M" pitchFamily="18" charset="-127"/>
            </a:endParaRPr>
          </a:p>
          <a:p>
            <a:pPr fontAlgn="base"/>
            <a:r>
              <a:rPr lang="en-US" altLang="ko-KR" sz="1800" dirty="0">
                <a:solidFill>
                  <a:schemeClr val="tx1">
                    <a:lumMod val="75000"/>
                    <a:lumOff val="25000"/>
                  </a:schemeClr>
                </a:solidFill>
                <a:latin typeface="HY헤드라인M" pitchFamily="18" charset="-127"/>
                <a:ea typeface="HY헤드라인M" pitchFamily="18" charset="-127"/>
              </a:rPr>
              <a:t>Pretend that you are holding eggs.</a:t>
            </a:r>
          </a:p>
        </p:txBody>
      </p:sp>
      <p:sp>
        <p:nvSpPr>
          <p:cNvPr id="15" name="직사각형 14"/>
          <p:cNvSpPr/>
          <p:nvPr/>
        </p:nvSpPr>
        <p:spPr>
          <a:xfrm>
            <a:off x="438315" y="1761504"/>
            <a:ext cx="2634093" cy="139893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fontAlgn="base"/>
            <a:r>
              <a:rPr lang="en-US" altLang="ko-KR" sz="1800" dirty="0">
                <a:solidFill>
                  <a:srgbClr val="363636"/>
                </a:solidFill>
                <a:latin typeface="HY헤드라인M" pitchFamily="18" charset="-127"/>
                <a:ea typeface="HY헤드라인M" pitchFamily="18" charset="-127"/>
              </a:rPr>
              <a:t>Breathing</a:t>
            </a:r>
          </a:p>
          <a:p>
            <a:pPr fontAlgn="base"/>
            <a:r>
              <a:rPr lang="en-US" altLang="ko-KR" sz="1800" dirty="0">
                <a:solidFill>
                  <a:srgbClr val="363636"/>
                </a:solidFill>
                <a:latin typeface="HY헤드라인M" pitchFamily="18" charset="-127"/>
                <a:ea typeface="HY헤드라인M" pitchFamily="18" charset="-127"/>
              </a:rPr>
              <a:t>Inhale deeply through your nose and exhale through your </a:t>
            </a:r>
            <a:r>
              <a:rPr lang="en-US" altLang="ko-KR" sz="1800" dirty="0">
                <a:solidFill>
                  <a:schemeClr val="tx1">
                    <a:lumMod val="75000"/>
                    <a:lumOff val="25000"/>
                  </a:schemeClr>
                </a:solidFill>
                <a:latin typeface="HY헤드라인M" pitchFamily="18" charset="-127"/>
                <a:ea typeface="HY헤드라인M" pitchFamily="18" charset="-127"/>
              </a:rPr>
              <a:t>mouth.</a:t>
            </a:r>
          </a:p>
        </p:txBody>
      </p:sp>
      <p:sp>
        <p:nvSpPr>
          <p:cNvPr id="16" name="직사각형 15"/>
          <p:cNvSpPr/>
          <p:nvPr/>
        </p:nvSpPr>
        <p:spPr>
          <a:xfrm>
            <a:off x="5736704" y="1432248"/>
            <a:ext cx="1800200" cy="853622"/>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fontAlgn="base"/>
            <a:r>
              <a:rPr lang="en-US" altLang="ko-KR" sz="1800" dirty="0">
                <a:solidFill>
                  <a:schemeClr val="tx1">
                    <a:lumMod val="75000"/>
                    <a:lumOff val="25000"/>
                  </a:schemeClr>
                </a:solidFill>
                <a:latin typeface="HY헤드라인M" pitchFamily="18" charset="-127"/>
                <a:ea typeface="HY헤드라인M" pitchFamily="18" charset="-127"/>
              </a:rPr>
              <a:t>Body</a:t>
            </a:r>
          </a:p>
          <a:p>
            <a:pPr fontAlgn="base"/>
            <a:r>
              <a:rPr lang="en-US" altLang="ko-KR" sz="1800" dirty="0">
                <a:solidFill>
                  <a:schemeClr val="tx1">
                    <a:lumMod val="75000"/>
                    <a:lumOff val="25000"/>
                  </a:schemeClr>
                </a:solidFill>
                <a:latin typeface="HY헤드라인M" pitchFamily="18" charset="-127"/>
                <a:ea typeface="HY헤드라인M" pitchFamily="18" charset="-127"/>
              </a:rPr>
              <a:t>Lean forward by 5 degrees.</a:t>
            </a:r>
          </a:p>
        </p:txBody>
      </p:sp>
      <p:sp>
        <p:nvSpPr>
          <p:cNvPr id="17" name="직사각형 16"/>
          <p:cNvSpPr/>
          <p:nvPr/>
        </p:nvSpPr>
        <p:spPr>
          <a:xfrm>
            <a:off x="6038744" y="2800400"/>
            <a:ext cx="2842096" cy="108012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fontAlgn="base"/>
            <a:r>
              <a:rPr lang="en-US" altLang="ko-KR" sz="1800" dirty="0">
                <a:solidFill>
                  <a:schemeClr val="tx1">
                    <a:lumMod val="75000"/>
                    <a:lumOff val="25000"/>
                  </a:schemeClr>
                </a:solidFill>
                <a:latin typeface="HY헤드라인M" pitchFamily="18" charset="-127"/>
                <a:ea typeface="HY헤드라인M" pitchFamily="18" charset="-127"/>
              </a:rPr>
              <a:t>Arms</a:t>
            </a:r>
          </a:p>
          <a:p>
            <a:pPr fontAlgn="base"/>
            <a:r>
              <a:rPr lang="en-US" altLang="ko-KR" sz="1800" dirty="0">
                <a:solidFill>
                  <a:schemeClr val="tx1">
                    <a:lumMod val="75000"/>
                    <a:lumOff val="25000"/>
                  </a:schemeClr>
                </a:solidFill>
                <a:latin typeface="HY헤드라인M" pitchFamily="18" charset="-127"/>
                <a:ea typeface="HY헤드라인M" pitchFamily="18" charset="-127"/>
              </a:rPr>
              <a:t>Form an L</a:t>
            </a:r>
            <a:r>
              <a:rPr lang="ko-KR" altLang="en-US" sz="1800" dirty="0">
                <a:solidFill>
                  <a:schemeClr val="tx1">
                    <a:lumMod val="75000"/>
                    <a:lumOff val="25000"/>
                  </a:schemeClr>
                </a:solidFill>
                <a:latin typeface="HY헤드라인M" pitchFamily="18" charset="-127"/>
                <a:ea typeface="HY헤드라인M" pitchFamily="18" charset="-127"/>
              </a:rPr>
              <a:t> </a:t>
            </a:r>
            <a:r>
              <a:rPr lang="en-US" altLang="ko-KR" sz="1800" dirty="0">
                <a:solidFill>
                  <a:schemeClr val="tx1">
                    <a:lumMod val="75000"/>
                    <a:lumOff val="25000"/>
                  </a:schemeClr>
                </a:solidFill>
                <a:latin typeface="HY헤드라인M" pitchFamily="18" charset="-127"/>
                <a:ea typeface="HY헤드라인M" pitchFamily="18" charset="-127"/>
              </a:rPr>
              <a:t>or</a:t>
            </a:r>
            <a:r>
              <a:rPr lang="ko-KR" altLang="en-US" sz="1800" dirty="0">
                <a:solidFill>
                  <a:schemeClr val="tx1">
                    <a:lumMod val="75000"/>
                    <a:lumOff val="25000"/>
                  </a:schemeClr>
                </a:solidFill>
                <a:latin typeface="HY헤드라인M" pitchFamily="18" charset="-127"/>
                <a:ea typeface="HY헤드라인M" pitchFamily="18" charset="-127"/>
              </a:rPr>
              <a:t> </a:t>
            </a:r>
            <a:r>
              <a:rPr lang="en-US" altLang="ko-KR" sz="1800" dirty="0">
                <a:solidFill>
                  <a:schemeClr val="tx1">
                    <a:lumMod val="75000"/>
                    <a:lumOff val="25000"/>
                  </a:schemeClr>
                </a:solidFill>
                <a:latin typeface="HY헤드라인M" pitchFamily="18" charset="-127"/>
                <a:ea typeface="HY헤드라인M" pitchFamily="18" charset="-127"/>
              </a:rPr>
              <a:t>V</a:t>
            </a:r>
            <a:r>
              <a:rPr lang="ko-KR" altLang="en-US" sz="1800" dirty="0">
                <a:solidFill>
                  <a:schemeClr val="tx1">
                    <a:lumMod val="75000"/>
                    <a:lumOff val="25000"/>
                  </a:schemeClr>
                </a:solidFill>
                <a:latin typeface="HY헤드라인M" pitchFamily="18" charset="-127"/>
                <a:ea typeface="HY헤드라인M" pitchFamily="18" charset="-127"/>
              </a:rPr>
              <a:t> </a:t>
            </a:r>
            <a:r>
              <a:rPr lang="en-US" altLang="ko-KR" sz="1800" dirty="0">
                <a:solidFill>
                  <a:schemeClr val="tx1">
                    <a:lumMod val="75000"/>
                    <a:lumOff val="25000"/>
                  </a:schemeClr>
                </a:solidFill>
                <a:latin typeface="HY헤드라인M" pitchFamily="18" charset="-127"/>
                <a:ea typeface="HY헤드라인M" pitchFamily="18" charset="-127"/>
              </a:rPr>
              <a:t>shape.</a:t>
            </a:r>
          </a:p>
          <a:p>
            <a:pPr fontAlgn="base"/>
            <a:r>
              <a:rPr lang="en-US" altLang="ko-KR" sz="1800" dirty="0">
                <a:solidFill>
                  <a:schemeClr val="tx1">
                    <a:lumMod val="75000"/>
                    <a:lumOff val="25000"/>
                  </a:schemeClr>
                </a:solidFill>
                <a:latin typeface="HY헤드라인M" pitchFamily="18" charset="-127"/>
                <a:ea typeface="HY헤드라인M" pitchFamily="18" charset="-127"/>
              </a:rPr>
              <a:t>(Preferably keep a 90-degree angle.)</a:t>
            </a:r>
          </a:p>
        </p:txBody>
      </p:sp>
      <p:sp>
        <p:nvSpPr>
          <p:cNvPr id="18" name="직사각형 17"/>
          <p:cNvSpPr/>
          <p:nvPr/>
        </p:nvSpPr>
        <p:spPr>
          <a:xfrm>
            <a:off x="1785165" y="4619221"/>
            <a:ext cx="2691730" cy="853622"/>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fontAlgn="base"/>
            <a:r>
              <a:rPr lang="en-US" altLang="ko-KR" sz="1800" dirty="0">
                <a:solidFill>
                  <a:schemeClr val="tx1">
                    <a:lumMod val="75000"/>
                    <a:lumOff val="25000"/>
                  </a:schemeClr>
                </a:solidFill>
                <a:latin typeface="HY헤드라인M" pitchFamily="18" charset="-127"/>
                <a:ea typeface="HY헤드라인M" pitchFamily="18" charset="-127"/>
              </a:rPr>
              <a:t>Feet</a:t>
            </a:r>
          </a:p>
          <a:p>
            <a:pPr fontAlgn="base"/>
            <a:r>
              <a:rPr lang="en-US" altLang="ko-KR" sz="1800" dirty="0">
                <a:solidFill>
                  <a:schemeClr val="tx1">
                    <a:lumMod val="75000"/>
                    <a:lumOff val="25000"/>
                  </a:schemeClr>
                </a:solidFill>
                <a:latin typeface="HY헤드라인M" pitchFamily="18" charset="-127"/>
                <a:ea typeface="HY헤드라인M" pitchFamily="18" charset="-127"/>
              </a:rPr>
              <a:t>Start with your heel and then touch the floor with your whole sole.</a:t>
            </a:r>
          </a:p>
        </p:txBody>
      </p:sp>
      <p:sp>
        <p:nvSpPr>
          <p:cNvPr id="19" name="직사각형 18"/>
          <p:cNvSpPr/>
          <p:nvPr/>
        </p:nvSpPr>
        <p:spPr>
          <a:xfrm>
            <a:off x="5457574" y="5248672"/>
            <a:ext cx="2079330" cy="853622"/>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fontAlgn="base"/>
            <a:r>
              <a:rPr lang="en-US" altLang="ko-KR" sz="1800" dirty="0">
                <a:solidFill>
                  <a:schemeClr val="tx1">
                    <a:lumMod val="75000"/>
                    <a:lumOff val="25000"/>
                  </a:schemeClr>
                </a:solidFill>
                <a:latin typeface="HY헤드라인M" pitchFamily="18" charset="-127"/>
                <a:ea typeface="HY헤드라인M" pitchFamily="18" charset="-127"/>
              </a:rPr>
              <a:t>Stride</a:t>
            </a:r>
            <a:r>
              <a:rPr lang="ko-KR" altLang="en-US" sz="1800" dirty="0">
                <a:solidFill>
                  <a:schemeClr val="tx1">
                    <a:lumMod val="75000"/>
                    <a:lumOff val="25000"/>
                  </a:schemeClr>
                </a:solidFill>
                <a:latin typeface="HY헤드라인M" pitchFamily="18" charset="-127"/>
                <a:ea typeface="HY헤드라인M" pitchFamily="18" charset="-127"/>
              </a:rPr>
              <a:t> </a:t>
            </a:r>
            <a:endParaRPr lang="en-US" altLang="ko-KR" sz="1800" dirty="0">
              <a:solidFill>
                <a:schemeClr val="tx1">
                  <a:lumMod val="75000"/>
                  <a:lumOff val="25000"/>
                </a:schemeClr>
              </a:solidFill>
              <a:latin typeface="HY헤드라인M" pitchFamily="18" charset="-127"/>
              <a:ea typeface="HY헤드라인M" pitchFamily="18" charset="-127"/>
            </a:endParaRPr>
          </a:p>
          <a:p>
            <a:pPr fontAlgn="base"/>
            <a:r>
              <a:rPr lang="en-US" altLang="ko-KR" sz="1800" dirty="0">
                <a:solidFill>
                  <a:schemeClr val="tx1">
                    <a:lumMod val="75000"/>
                    <a:lumOff val="25000"/>
                  </a:schemeClr>
                </a:solidFill>
                <a:latin typeface="HY헤드라인M" pitchFamily="18" charset="-127"/>
                <a:ea typeface="HY헤드라인M" pitchFamily="18" charset="-127"/>
              </a:rPr>
              <a:t>Height - 100 cm</a:t>
            </a:r>
          </a:p>
        </p:txBody>
      </p:sp>
    </p:spTree>
    <p:extLst>
      <p:ext uri="{BB962C8B-B14F-4D97-AF65-F5344CB8AC3E}">
        <p14:creationId xmlns:p14="http://schemas.microsoft.com/office/powerpoint/2010/main" val="146695750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제목 1"/>
          <p:cNvSpPr>
            <a:spLocks noGrp="1"/>
          </p:cNvSpPr>
          <p:nvPr>
            <p:ph type="ctrTitle"/>
          </p:nvPr>
        </p:nvSpPr>
        <p:spPr/>
        <p:txBody>
          <a:bodyPr>
            <a:noAutofit/>
          </a:bodyPr>
          <a:lstStyle/>
          <a:p>
            <a:r>
              <a:rPr lang="en-US" altLang="ko-KR" sz="8800" dirty="0">
                <a:solidFill>
                  <a:srgbClr val="01358B"/>
                </a:solidFill>
                <a:latin typeface="HY헤드라인M" pitchFamily="18" charset="-127"/>
                <a:ea typeface="HY헤드라인M" pitchFamily="18" charset="-127"/>
              </a:rPr>
              <a:t>Low</a:t>
            </a:r>
            <a:r>
              <a:rPr lang="en-US" altLang="ko-KR" sz="8800" dirty="0">
                <a:solidFill>
                  <a:schemeClr val="tx2"/>
                </a:solidFill>
                <a:latin typeface="HY헤드라인M" pitchFamily="18" charset="-127"/>
                <a:ea typeface="HY헤드라인M" pitchFamily="18" charset="-127"/>
              </a:rPr>
              <a:t>er </a:t>
            </a:r>
            <a:r>
              <a:rPr lang="en-US" altLang="ko-KR" sz="8800" dirty="0">
                <a:solidFill>
                  <a:srgbClr val="01358B"/>
                </a:solidFill>
                <a:latin typeface="HY헤드라인M" pitchFamily="18" charset="-127"/>
                <a:ea typeface="HY헤드라인M" pitchFamily="18" charset="-127"/>
              </a:rPr>
              <a:t>Back Exercises</a:t>
            </a:r>
            <a:endParaRPr lang="ko-KR" altLang="en-US" sz="8800" dirty="0">
              <a:solidFill>
                <a:srgbClr val="01358B"/>
              </a:solidFill>
              <a:latin typeface="HY헤드라인M" pitchFamily="18" charset="-127"/>
              <a:ea typeface="HY헤드라인M" pitchFamily="18" charset="-127"/>
            </a:endParaRPr>
          </a:p>
        </p:txBody>
      </p:sp>
      <p:sp>
        <p:nvSpPr>
          <p:cNvPr id="3" name="부제목 2"/>
          <p:cNvSpPr>
            <a:spLocks noGrp="1"/>
          </p:cNvSpPr>
          <p:nvPr>
            <p:ph type="subTitle" idx="1"/>
          </p:nvPr>
        </p:nvSpPr>
        <p:spPr>
          <a:xfrm>
            <a:off x="1440180" y="7254240"/>
            <a:ext cx="6720840" cy="946760"/>
          </a:xfrm>
        </p:spPr>
        <p:txBody>
          <a:bodyPr/>
          <a:lstStyle/>
          <a:p>
            <a:r>
              <a:rPr lang="en-US" altLang="ko-KR" dirty="0">
                <a:solidFill>
                  <a:srgbClr val="01358B"/>
                </a:solidFill>
                <a:latin typeface="HY헤드라인M" pitchFamily="18" charset="-127"/>
                <a:ea typeface="HY헤드라인M" pitchFamily="18" charset="-127"/>
              </a:rPr>
              <a:t>- Stage 2 -</a:t>
            </a:r>
            <a:endParaRPr lang="ko-KR" altLang="en-US" dirty="0">
              <a:solidFill>
                <a:srgbClr val="01358B"/>
              </a:solidFill>
              <a:latin typeface="HY헤드라인M" pitchFamily="18" charset="-127"/>
              <a:ea typeface="HY헤드라인M" pitchFamily="18" charset="-127"/>
            </a:endParaRPr>
          </a:p>
        </p:txBody>
      </p:sp>
      <p:sp>
        <p:nvSpPr>
          <p:cNvPr id="5" name="부제목 2"/>
          <p:cNvSpPr txBox="1">
            <a:spLocks/>
          </p:cNvSpPr>
          <p:nvPr/>
        </p:nvSpPr>
        <p:spPr>
          <a:xfrm>
            <a:off x="0" y="0"/>
            <a:ext cx="8328992" cy="1360240"/>
          </a:xfrm>
          <a:prstGeom prst="rect">
            <a:avLst/>
          </a:prstGeom>
        </p:spPr>
        <p:txBody>
          <a:bodyPr vert="horz" lIns="127995" tIns="63998" rIns="127995" bIns="63998" rtlCol="0">
            <a:normAutofit fontScale="70000" lnSpcReduction="20000"/>
          </a:bodyPr>
          <a:lstStyle>
            <a:lvl1pPr marL="0" indent="0" algn="ctr" defTabSz="1279953" rtl="0" eaLnBrk="1" latinLnBrk="1" hangingPunct="1">
              <a:spcBef>
                <a:spcPct val="20000"/>
              </a:spcBef>
              <a:buFont typeface="Arial" pitchFamily="34" charset="0"/>
              <a:buNone/>
              <a:defRPr sz="4500" kern="1200">
                <a:solidFill>
                  <a:schemeClr val="tx1">
                    <a:tint val="75000"/>
                  </a:schemeClr>
                </a:solidFill>
                <a:latin typeface="+mn-lt"/>
                <a:ea typeface="+mn-ea"/>
                <a:cs typeface="+mn-cs"/>
              </a:defRPr>
            </a:lvl1pPr>
            <a:lvl2pPr marL="639976" indent="0" algn="ctr" defTabSz="1279953" rtl="0" eaLnBrk="1" latinLnBrk="1" hangingPunct="1">
              <a:spcBef>
                <a:spcPct val="20000"/>
              </a:spcBef>
              <a:buFont typeface="Arial" pitchFamily="34" charset="0"/>
              <a:buNone/>
              <a:defRPr sz="3900" kern="1200">
                <a:solidFill>
                  <a:schemeClr val="tx1">
                    <a:tint val="75000"/>
                  </a:schemeClr>
                </a:solidFill>
                <a:latin typeface="+mn-lt"/>
                <a:ea typeface="+mn-ea"/>
                <a:cs typeface="+mn-cs"/>
              </a:defRPr>
            </a:lvl2pPr>
            <a:lvl3pPr marL="1279953" indent="0" algn="ctr" defTabSz="1279953" rtl="0" eaLnBrk="1" latinLnBrk="1" hangingPunct="1">
              <a:spcBef>
                <a:spcPct val="20000"/>
              </a:spcBef>
              <a:buFont typeface="Arial" pitchFamily="34" charset="0"/>
              <a:buNone/>
              <a:defRPr sz="3400" kern="1200">
                <a:solidFill>
                  <a:schemeClr val="tx1">
                    <a:tint val="75000"/>
                  </a:schemeClr>
                </a:solidFill>
                <a:latin typeface="+mn-lt"/>
                <a:ea typeface="+mn-ea"/>
                <a:cs typeface="+mn-cs"/>
              </a:defRPr>
            </a:lvl3pPr>
            <a:lvl4pPr marL="1919929" indent="0" algn="ctr" defTabSz="1279953" rtl="0" eaLnBrk="1" latinLnBrk="1" hangingPunct="1">
              <a:spcBef>
                <a:spcPct val="20000"/>
              </a:spcBef>
              <a:buFont typeface="Arial" pitchFamily="34" charset="0"/>
              <a:buNone/>
              <a:defRPr sz="2800" kern="1200">
                <a:solidFill>
                  <a:schemeClr val="tx1">
                    <a:tint val="75000"/>
                  </a:schemeClr>
                </a:solidFill>
                <a:latin typeface="+mn-lt"/>
                <a:ea typeface="+mn-ea"/>
                <a:cs typeface="+mn-cs"/>
              </a:defRPr>
            </a:lvl4pPr>
            <a:lvl5pPr marL="2559906" indent="0" algn="ctr" defTabSz="1279953" rtl="0" eaLnBrk="1" latinLnBrk="1" hangingPunct="1">
              <a:spcBef>
                <a:spcPct val="20000"/>
              </a:spcBef>
              <a:buFont typeface="Arial" pitchFamily="34" charset="0"/>
              <a:buNone/>
              <a:defRPr sz="2800" kern="1200">
                <a:solidFill>
                  <a:schemeClr val="tx1">
                    <a:tint val="75000"/>
                  </a:schemeClr>
                </a:solidFill>
                <a:latin typeface="+mn-lt"/>
                <a:ea typeface="+mn-ea"/>
                <a:cs typeface="+mn-cs"/>
              </a:defRPr>
            </a:lvl5pPr>
            <a:lvl6pPr marL="3199882" indent="0" algn="ctr" defTabSz="1279953" rtl="0" eaLnBrk="1" latinLnBrk="1" hangingPunct="1">
              <a:spcBef>
                <a:spcPct val="20000"/>
              </a:spcBef>
              <a:buFont typeface="Arial" pitchFamily="34" charset="0"/>
              <a:buNone/>
              <a:defRPr sz="2800" kern="1200">
                <a:solidFill>
                  <a:schemeClr val="tx1">
                    <a:tint val="75000"/>
                  </a:schemeClr>
                </a:solidFill>
                <a:latin typeface="+mn-lt"/>
                <a:ea typeface="+mn-ea"/>
                <a:cs typeface="+mn-cs"/>
              </a:defRPr>
            </a:lvl6pPr>
            <a:lvl7pPr marL="3839859" indent="0" algn="ctr" defTabSz="1279953" rtl="0" eaLnBrk="1" latinLnBrk="1" hangingPunct="1">
              <a:spcBef>
                <a:spcPct val="20000"/>
              </a:spcBef>
              <a:buFont typeface="Arial" pitchFamily="34" charset="0"/>
              <a:buNone/>
              <a:defRPr sz="2800" kern="1200">
                <a:solidFill>
                  <a:schemeClr val="tx1">
                    <a:tint val="75000"/>
                  </a:schemeClr>
                </a:solidFill>
                <a:latin typeface="+mn-lt"/>
                <a:ea typeface="+mn-ea"/>
                <a:cs typeface="+mn-cs"/>
              </a:defRPr>
            </a:lvl7pPr>
            <a:lvl8pPr marL="4479835" indent="0" algn="ctr" defTabSz="1279953" rtl="0" eaLnBrk="1" latinLnBrk="1" hangingPunct="1">
              <a:spcBef>
                <a:spcPct val="20000"/>
              </a:spcBef>
              <a:buFont typeface="Arial" pitchFamily="34" charset="0"/>
              <a:buNone/>
              <a:defRPr sz="2800" kern="1200">
                <a:solidFill>
                  <a:schemeClr val="tx1">
                    <a:tint val="75000"/>
                  </a:schemeClr>
                </a:solidFill>
                <a:latin typeface="+mn-lt"/>
                <a:ea typeface="+mn-ea"/>
                <a:cs typeface="+mn-cs"/>
              </a:defRPr>
            </a:lvl8pPr>
            <a:lvl9pPr marL="5119812" indent="0" algn="ctr" defTabSz="1279953" rtl="0" eaLnBrk="1" latinLnBrk="1" hangingPunct="1">
              <a:spcBef>
                <a:spcPct val="20000"/>
              </a:spcBef>
              <a:buFont typeface="Arial" pitchFamily="34" charset="0"/>
              <a:buNone/>
              <a:defRPr sz="2800" kern="1200">
                <a:solidFill>
                  <a:schemeClr val="tx1">
                    <a:tint val="75000"/>
                  </a:schemeClr>
                </a:solidFill>
                <a:latin typeface="+mn-lt"/>
                <a:ea typeface="+mn-ea"/>
                <a:cs typeface="+mn-cs"/>
              </a:defRPr>
            </a:lvl9pPr>
          </a:lstStyle>
          <a:p>
            <a:pPr marL="0" marR="0" lvl="0" indent="0" algn="l" defTabSz="1279953" rtl="0" eaLnBrk="1" fontAlgn="auto" latinLnBrk="1" hangingPunct="1">
              <a:lnSpc>
                <a:spcPct val="100000"/>
              </a:lnSpc>
              <a:spcBef>
                <a:spcPct val="20000"/>
              </a:spcBef>
              <a:spcAft>
                <a:spcPts val="0"/>
              </a:spcAft>
              <a:buClrTx/>
              <a:buSzTx/>
              <a:buFont typeface="Arial" pitchFamily="34" charset="0"/>
              <a:buNone/>
              <a:tabLst/>
              <a:defRPr/>
            </a:pPr>
            <a:r>
              <a:rPr kumimoji="0" lang="en-US" altLang="ko-KR" sz="4500" b="0" i="0" u="none" strike="noStrike" kern="1200" cap="none" spc="0" normalizeH="0" baseline="0" noProof="0" dirty="0">
                <a:ln>
                  <a:noFill/>
                </a:ln>
                <a:solidFill>
                  <a:srgbClr val="01358B"/>
                </a:solidFill>
                <a:effectLst/>
                <a:uLnTx/>
                <a:uFillTx/>
                <a:latin typeface="HY헤드라인M" pitchFamily="18" charset="-127"/>
                <a:ea typeface="HY헤드라인M" pitchFamily="18" charset="-127"/>
                <a:cs typeface="+mn-cs"/>
              </a:rPr>
              <a:t>Physical Therapy Room</a:t>
            </a:r>
            <a:endParaRPr kumimoji="0" lang="ko-KR" altLang="en-US" sz="4500" b="0" i="0" u="none" strike="noStrike" kern="1200" cap="none" spc="0" normalizeH="0" baseline="0" noProof="0" dirty="0">
              <a:ln>
                <a:noFill/>
              </a:ln>
              <a:solidFill>
                <a:srgbClr val="01358B"/>
              </a:solidFill>
              <a:effectLst/>
              <a:uLnTx/>
              <a:uFillTx/>
              <a:latin typeface="HY헤드라인M" pitchFamily="18" charset="-127"/>
              <a:ea typeface="HY헤드라인M" pitchFamily="18" charset="-127"/>
              <a:cs typeface="+mn-cs"/>
            </a:endParaRPr>
          </a:p>
          <a:p>
            <a:pPr marL="0" marR="0" lvl="0" indent="0" algn="l" defTabSz="1279953" rtl="0" eaLnBrk="1" fontAlgn="auto" latinLnBrk="1" hangingPunct="1">
              <a:lnSpc>
                <a:spcPct val="100000"/>
              </a:lnSpc>
              <a:spcBef>
                <a:spcPct val="20000"/>
              </a:spcBef>
              <a:spcAft>
                <a:spcPts val="0"/>
              </a:spcAft>
              <a:buClrTx/>
              <a:buSzTx/>
              <a:buFont typeface="Arial" pitchFamily="34" charset="0"/>
              <a:buNone/>
              <a:tabLst/>
              <a:defRPr/>
            </a:pPr>
            <a:r>
              <a:rPr kumimoji="0" lang="en-US" altLang="ko-KR" sz="4500" b="0" i="0" u="none" strike="noStrike" kern="1200" cap="none" spc="0" normalizeH="0" baseline="0" noProof="0" dirty="0">
                <a:ln>
                  <a:noFill/>
                </a:ln>
                <a:solidFill>
                  <a:srgbClr val="01358B"/>
                </a:solidFill>
                <a:effectLst/>
                <a:uLnTx/>
                <a:uFillTx/>
                <a:latin typeface="HY헤드라인M" pitchFamily="18" charset="-127"/>
                <a:ea typeface="HY헤드라인M" pitchFamily="18" charset="-127"/>
                <a:cs typeface="+mn-cs"/>
              </a:rPr>
              <a:t>Department of Rehabilitation Medicine</a:t>
            </a:r>
            <a:endParaRPr kumimoji="0" lang="ko-KR" altLang="en-US" sz="4500" b="0" i="0" u="none" strike="noStrike" kern="1200" cap="none" spc="0" normalizeH="0" baseline="0" noProof="0" dirty="0">
              <a:ln>
                <a:noFill/>
              </a:ln>
              <a:solidFill>
                <a:srgbClr val="01358B"/>
              </a:solidFill>
              <a:effectLst/>
              <a:uLnTx/>
              <a:uFillTx/>
              <a:latin typeface="HY헤드라인M" pitchFamily="18" charset="-127"/>
              <a:ea typeface="HY헤드라인M" pitchFamily="18" charset="-127"/>
              <a:cs typeface="+mn-cs"/>
            </a:endParaRPr>
          </a:p>
        </p:txBody>
      </p:sp>
    </p:spTree>
    <p:extLst>
      <p:ext uri="{BB962C8B-B14F-4D97-AF65-F5344CB8AC3E}">
        <p14:creationId xmlns:p14="http://schemas.microsoft.com/office/powerpoint/2010/main" val="2711300865"/>
      </p:ext>
    </p:extLst>
  </p:cSld>
  <p:clrMapOvr>
    <a:masterClrMapping/>
  </p:clrMapOvr>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맑은 고딕"/>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chemeClr val="bg1"/>
        </a:solidFill>
        <a:ln>
          <a:noFill/>
        </a:ln>
      </a:spPr>
      <a:bodyPr rtlCol="0" anchor="ctr"/>
      <a:lstStyle>
        <a:defPPr algn="ctr">
          <a:defRPr dirty="0">
            <a:latin typeface="HY헤드라인M" pitchFamily="18" charset="-127"/>
            <a:ea typeface="HY헤드라인M" pitchFamily="18" charset="-127"/>
          </a:defRPr>
        </a:defPPr>
      </a:lstStyle>
      <a:style>
        <a:lnRef idx="2">
          <a:schemeClr val="accent1">
            <a:shade val="50000"/>
          </a:schemeClr>
        </a:lnRef>
        <a:fillRef idx="1">
          <a:schemeClr val="accent1"/>
        </a:fillRef>
        <a:effectRef idx="0">
          <a:schemeClr val="accent1"/>
        </a:effectRef>
        <a:fontRef idx="minor">
          <a:schemeClr val="lt1"/>
        </a:fontRef>
      </a:style>
    </a:spDef>
  </a:objectDefaults>
  <a:extraClrSchemeLst/>
</a:theme>
</file>

<file path=ppt/theme/theme2.xml><?xml version="1.0" encoding="utf-8"?>
<a:theme xmlns:a="http://schemas.openxmlformats.org/drawingml/2006/main" name="1_Office 테마">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맑은 고딕"/>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rtlCol="0" anchor="ctr"/>
      <a:lstStyle>
        <a:defPPr algn="ctr">
          <a:defRPr/>
        </a:defPPr>
      </a:lstStyle>
      <a:style>
        <a:lnRef idx="2">
          <a:schemeClr val="accent1">
            <a:shade val="50000"/>
          </a:schemeClr>
        </a:lnRef>
        <a:fillRef idx="1">
          <a:schemeClr val="accent1"/>
        </a:fillRef>
        <a:effectRef idx="0">
          <a:schemeClr val="accent1"/>
        </a:effectRef>
        <a:fontRef idx="minor">
          <a:schemeClr val="lt1"/>
        </a:fontRef>
      </a:style>
    </a:spDef>
  </a:objectDefaults>
  <a:extraClrSchemeLst/>
</a:theme>
</file>

<file path=ppt/theme/theme3.xml><?xml version="1.0" encoding="utf-8"?>
<a:theme xmlns:a="http://schemas.openxmlformats.org/drawingml/2006/main" name="Office 테마">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맑은 고딕"/>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053</TotalTime>
  <Words>1457</Words>
  <Application>Microsoft Office PowerPoint</Application>
  <PresentationFormat>A3 용지(297x420mm)</PresentationFormat>
  <Paragraphs>179</Paragraphs>
  <Slides>16</Slides>
  <Notes>7</Notes>
  <HiddenSlides>0</HiddenSlides>
  <MMClips>0</MMClips>
  <ScaleCrop>false</ScaleCrop>
  <HeadingPairs>
    <vt:vector size="6" baseType="variant">
      <vt:variant>
        <vt:lpstr>사용한 글꼴</vt:lpstr>
      </vt:variant>
      <vt:variant>
        <vt:i4>3</vt:i4>
      </vt:variant>
      <vt:variant>
        <vt:lpstr>테마</vt:lpstr>
      </vt:variant>
      <vt:variant>
        <vt:i4>2</vt:i4>
      </vt:variant>
      <vt:variant>
        <vt:lpstr>슬라이드 제목</vt:lpstr>
      </vt:variant>
      <vt:variant>
        <vt:i4>16</vt:i4>
      </vt:variant>
    </vt:vector>
  </HeadingPairs>
  <TitlesOfParts>
    <vt:vector size="21" baseType="lpstr">
      <vt:lpstr>HY헤드라인M</vt:lpstr>
      <vt:lpstr>맑은 고딕</vt:lpstr>
      <vt:lpstr>Arial</vt:lpstr>
      <vt:lpstr>Office 테마</vt:lpstr>
      <vt:lpstr>1_Office 테마</vt:lpstr>
      <vt:lpstr>Lower Back Exercises</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Lower Back Exercises</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snuh</dc:creator>
  <cp:lastModifiedBy>hyunsuk kim</cp:lastModifiedBy>
  <cp:revision>156</cp:revision>
  <cp:lastPrinted>2014-08-13T08:29:11Z</cp:lastPrinted>
  <dcterms:created xsi:type="dcterms:W3CDTF">2014-04-13T11:14:04Z</dcterms:created>
  <dcterms:modified xsi:type="dcterms:W3CDTF">2024-12-11T12:50:02Z</dcterms:modified>
</cp:coreProperties>
</file>